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notesSlides/notesSlide1.xml" ContentType="application/vnd.openxmlformats-officedocument.presentationml.notesSlide+xml"/>
  <Override PartName="/ppt/tags/tag2.xml" ContentType="application/vnd.openxmlformats-officedocument.presentationml.tags+xml"/>
  <Override PartName="/ppt/notesSlides/notesSlide2.xml" ContentType="application/vnd.openxmlformats-officedocument.presentationml.notesSlide+xml"/>
  <Override PartName="/ppt/tags/tag3.xml" ContentType="application/vnd.openxmlformats-officedocument.presentationml.tags+xml"/>
  <Override PartName="/ppt/notesSlides/notesSlide3.xml" ContentType="application/vnd.openxmlformats-officedocument.presentationml.notesSlide+xml"/>
  <Override PartName="/ppt/tags/tag4.xml" ContentType="application/vnd.openxmlformats-officedocument.presentationml.tags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1351" r:id="rId2"/>
    <p:sldId id="1242" r:id="rId3"/>
    <p:sldId id="1343" r:id="rId4"/>
    <p:sldId id="1334" r:id="rId5"/>
    <p:sldId id="1335" r:id="rId6"/>
    <p:sldId id="1350" r:id="rId7"/>
    <p:sldId id="1349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2" d="100"/>
          <a:sy n="122" d="100"/>
        </p:scale>
        <p:origin x="11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268F86-CA10-4695-B7FE-A1D4ED193C39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161CB7-913D-4FE4-9FAE-75EF5E2C8F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6567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lvl="0" indent="-171450">
              <a:buFont typeface="Wingdings" panose="05000000000000000000" pitchFamily="2" charset="2"/>
              <a:buChar char="§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24F008-302C-4585-9054-B77F6C92DCB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0412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175CC-D84D-4653-B07C-B34F2E1FFBF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02994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175CC-D84D-4653-B07C-B34F2E1FFBF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68631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lvl="0" indent="-171450">
              <a:buFont typeface="Wingdings" panose="05000000000000000000" pitchFamily="2" charset="2"/>
              <a:buChar char="§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24F008-302C-4585-9054-B77F6C92DCBD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6463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96EA86-EAD5-4B4E-B68A-77970E5C85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0708936-AC82-42AC-9683-45E4330E93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DBA3FC-ECE1-453F-949A-BBFC566B1E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69E149-5AF6-4BC5-990B-822F7CA63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72ECBA-2FC2-4E5F-AF63-5099AA988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912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3BEE87-3D03-4F57-A483-99FECE07CC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4DD0F7-B165-4B7B-AA91-345FDF3E3E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85538E-98DE-47F3-B8B5-93CC59487D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EBB28C-EC84-4B0D-AA00-E51C8E172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977450-8B92-46C5-B1F4-D26ACDCFD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54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24ED81E-8CAF-4AEE-86E7-46098C5114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49EB65-C97E-4C7A-ADF3-A35D557310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AC5C72-80D0-492F-9151-AABF9332A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55747C-197E-4AAA-BBD2-4F19249442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B9B756-270D-4D59-84E5-74227C8AE6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008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62AFF9-C64A-49D9-8A6D-BCE7B055A3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E53862-A38D-4BFC-9066-C805781E86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B309ED-7580-4E0C-9F71-12ADB33A4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8D6664-116D-4FF5-80B8-2F11E33E2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51636A-72BD-4556-8AA2-F5276C5FB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780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F754ED-5A80-4193-993A-F0FFC9B75D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F2419C-DD14-4758-A5F1-1895C70EF9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B5EF7E-9619-45D3-A1DB-29DCDA961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3DF83E-5952-43B1-9AA7-2D02D57738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EFAD10-212D-4232-B77E-14659EE45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5693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3AF93A-4CB5-4125-934A-2330D7C34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0386CC-7B02-4815-9EA6-1683E47661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342758-90E6-4B7B-B336-5B69EEF9A7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56D0DC-F61D-4622-83DB-42588D91F7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40D6B5-99EB-4F66-AFDE-AC585F5A6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333253-0849-46C0-89FE-0F208A2AA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988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4552ED-E66B-44E4-A56C-7D63F21209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76B9F1-6E48-45C2-912A-1A92E8639A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26FDAD-4082-4307-A2C4-E0DA1859AF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66C8EF9-9510-449C-834B-D94053576D3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E1EFC8E-E322-4535-B280-AF11A2663E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918222-5BB7-43D4-9AB4-64EBDD803B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1988B9D-8F6F-41F0-B452-9560F49F0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B876DED-FE07-4A7E-B726-E055DD031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935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D61B2A-D369-4DD7-854A-F4CB6AE47B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13ED94A-B1B3-4C33-AB8F-B2541CD88A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13EFC7A-CACD-4A1E-94F3-4689B16A65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9DBEF4-A625-4050-AC58-4D6BF3406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4605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E3A05A9-4EEE-46FA-810D-680DE39843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6ADAA0B-923B-4938-B908-C638D54D4C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04C205-4C1B-4BCD-938B-8742340A6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212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577C02-794B-4348-9345-B1E461A12A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705D2A-1A9E-4C08-AA1D-94CF60AEF7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F64E5C-EAFD-4515-88EA-ACF8076023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D05B85-D020-4900-AFA3-7FCDB0DA0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F538B5-5AAD-4685-98C3-F09BCBA479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F3888E-96B5-4E10-9321-49411EF115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090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F7FEB6-53D0-40FA-A6CB-901F10D358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53EA4FB-F475-4A73-BD21-772765C802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9D3F31-D8DC-4D6A-8DE5-A0B5814CE7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E476C5-B8DA-40A2-8187-71B0996E8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EC496B-EB56-4087-97AD-4231A3AB0A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BCDF54-CD92-4C93-BC7C-31D1A6DA7B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1886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21AE9FB-6390-4133-BC52-9E1EC97C75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53CE6F-FEDF-4D55-B0E8-D8CC20F2B1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D56E89-B95A-4C31-9FD8-D2357FDBD5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9EE796-A05B-4890-9E27-B92E5FD06BE2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BB07A0-34ED-4F94-910B-E1F25CBF6DA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4765C4-9235-4FCE-912C-14311B1B62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738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4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4B52CA3-EF67-43C1-B464-0CFD70FDDAC3}"/>
              </a:ext>
            </a:extLst>
          </p:cNvPr>
          <p:cNvSpPr txBox="1"/>
          <p:nvPr/>
        </p:nvSpPr>
        <p:spPr>
          <a:xfrm>
            <a:off x="1049153" y="2156060"/>
            <a:ext cx="898999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 File: An illustration of an example of a 2-person mixture profile of which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R (STRmix) &gt; 1000*LR (EFM)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play of the per-locus LRs and profiles LRs obtained from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mix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FM reports (original runs and reruns) assigned to a POI corresponding to the minor contributor.</a:t>
            </a:r>
          </a:p>
        </p:txBody>
      </p:sp>
    </p:spTree>
    <p:extLst>
      <p:ext uri="{BB962C8B-B14F-4D97-AF65-F5344CB8AC3E}">
        <p14:creationId xmlns:p14="http://schemas.microsoft.com/office/powerpoint/2010/main" val="20474227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Rectangle 31">
            <a:extLst>
              <a:ext uri="{FF2B5EF4-FFF2-40B4-BE49-F238E27FC236}">
                <a16:creationId xmlns:a16="http://schemas.microsoft.com/office/drawing/2014/main" id="{18CC41C2-EDB2-49E9-83B1-1624A30A2BA0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2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 LR (</a:t>
            </a:r>
            <a:r>
              <a:rPr lang="en-US" sz="28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mix</a:t>
            </a:r>
            <a:r>
              <a:rPr lang="en-US" sz="2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&gt; LR (EFM)</a:t>
            </a:r>
          </a:p>
        </p:txBody>
      </p:sp>
      <p:graphicFrame>
        <p:nvGraphicFramePr>
          <p:cNvPr id="31" name="Table 2">
            <a:extLst>
              <a:ext uri="{FF2B5EF4-FFF2-40B4-BE49-F238E27FC236}">
                <a16:creationId xmlns:a16="http://schemas.microsoft.com/office/drawing/2014/main" id="{9545FA2B-3B80-437C-9045-E92B3CED44D3}"/>
              </a:ext>
            </a:extLst>
          </p:cNvPr>
          <p:cNvGraphicFramePr>
            <a:graphicFrameLocks noGrp="1"/>
          </p:cNvGraphicFramePr>
          <p:nvPr/>
        </p:nvGraphicFramePr>
        <p:xfrm>
          <a:off x="6311088" y="2165669"/>
          <a:ext cx="5353932" cy="282193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39849">
                  <a:extLst>
                    <a:ext uri="{9D8B030D-6E8A-4147-A177-3AD203B41FA5}">
                      <a16:colId xmlns:a16="http://schemas.microsoft.com/office/drawing/2014/main" val="2608619990"/>
                    </a:ext>
                  </a:extLst>
                </a:gridCol>
                <a:gridCol w="1990019">
                  <a:extLst>
                    <a:ext uri="{9D8B030D-6E8A-4147-A177-3AD203B41FA5}">
                      <a16:colId xmlns:a16="http://schemas.microsoft.com/office/drawing/2014/main" val="338413170"/>
                    </a:ext>
                  </a:extLst>
                </a:gridCol>
                <a:gridCol w="1524064">
                  <a:extLst>
                    <a:ext uri="{9D8B030D-6E8A-4147-A177-3AD203B41FA5}">
                      <a16:colId xmlns:a16="http://schemas.microsoft.com/office/drawing/2014/main" val="2733097487"/>
                    </a:ext>
                  </a:extLst>
                </a:gridCol>
              </a:tblGrid>
              <a:tr h="77088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ftware</a:t>
                      </a:r>
                    </a:p>
                    <a:p>
                      <a:pPr algn="ctr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</a:t>
                      </a:r>
                      <a:r>
                        <a:rPr lang="en-US" sz="1800" b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8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C1 (major)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</a:t>
                      </a:r>
                      <a:r>
                        <a:rPr lang="en-US" sz="1800" b="1" baseline="-250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800" b="1" i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</a:t>
                      </a: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C2 (minor)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3107896"/>
                  </a:ext>
                </a:extLst>
              </a:tr>
              <a:tr h="54247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6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42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6814504"/>
                  </a:ext>
                </a:extLst>
              </a:tr>
              <a:tr h="54247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</a:t>
                      </a:r>
                    </a:p>
                    <a:p>
                      <a:pPr algn="ctr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9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99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3276261"/>
                  </a:ext>
                </a:extLst>
              </a:tr>
              <a:tr h="77088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- EFM </a:t>
                      </a:r>
                    </a:p>
                    <a:p>
                      <a:pPr algn="ctr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9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i="1" u="sng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3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8879562"/>
                  </a:ext>
                </a:extLst>
              </a:tr>
            </a:tbl>
          </a:graphicData>
        </a:graphic>
      </p:graphicFrame>
      <p:sp>
        <p:nvSpPr>
          <p:cNvPr id="33" name="TextBox 32">
            <a:extLst>
              <a:ext uri="{FF2B5EF4-FFF2-40B4-BE49-F238E27FC236}">
                <a16:creationId xmlns:a16="http://schemas.microsoft.com/office/drawing/2014/main" id="{E4BE7B22-9D61-46AE-BA4A-0C31D6384F71}"/>
              </a:ext>
            </a:extLst>
          </p:cNvPr>
          <p:cNvSpPr txBox="1"/>
          <p:nvPr/>
        </p:nvSpPr>
        <p:spPr>
          <a:xfrm>
            <a:off x="6311088" y="1664486"/>
            <a:ext cx="77014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stine DNA of total template amount 315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Ratio 1:4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20B3A7DC-38B7-4417-84E3-5F30E6AC5B9A}"/>
              </a:ext>
            </a:extLst>
          </p:cNvPr>
          <p:cNvSpPr/>
          <p:nvPr/>
        </p:nvSpPr>
        <p:spPr>
          <a:xfrm>
            <a:off x="395567" y="5539275"/>
            <a:ext cx="4699061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mix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og</a:t>
            </a:r>
            <a:r>
              <a:rPr lang="en-US" sz="2000" b="1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R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13DFD5AD-F531-45EE-894F-F33E6E8E3BB8}"/>
              </a:ext>
            </a:extLst>
          </p:cNvPr>
          <p:cNvSpPr/>
          <p:nvPr/>
        </p:nvSpPr>
        <p:spPr>
          <a:xfrm rot="16200000">
            <a:off x="-1593950" y="3348035"/>
            <a:ext cx="4699061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M Log</a:t>
            </a:r>
            <a:r>
              <a:rPr lang="en-US" sz="2000" b="1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R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101DD338-3635-4975-AAEC-88F3DEB20668}"/>
              </a:ext>
            </a:extLst>
          </p:cNvPr>
          <p:cNvGrpSpPr/>
          <p:nvPr/>
        </p:nvGrpSpPr>
        <p:grpSpPr>
          <a:xfrm>
            <a:off x="928728" y="1605751"/>
            <a:ext cx="3931920" cy="3796106"/>
            <a:chOff x="403625" y="1397524"/>
            <a:chExt cx="3931920" cy="3796106"/>
          </a:xfrm>
        </p:grpSpPr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185F1287-4607-443B-AA72-2B17EE697D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19" t="7824" r="4805" b="5597"/>
            <a:stretch/>
          </p:blipFill>
          <p:spPr>
            <a:xfrm>
              <a:off x="403625" y="1397524"/>
              <a:ext cx="3931920" cy="3796106"/>
            </a:xfrm>
            <a:prstGeom prst="rect">
              <a:avLst/>
            </a:prstGeom>
          </p:spPr>
        </p:pic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B2D6457D-4FE8-471D-8159-6AD6F39DC3FE}"/>
                </a:ext>
              </a:extLst>
            </p:cNvPr>
            <p:cNvSpPr/>
            <p:nvPr/>
          </p:nvSpPr>
          <p:spPr>
            <a:xfrm>
              <a:off x="2948451" y="4381819"/>
              <a:ext cx="1335024" cy="5439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F02E97DA-5353-46B8-9ECE-B43F118D91F4}"/>
              </a:ext>
            </a:extLst>
          </p:cNvPr>
          <p:cNvGrpSpPr/>
          <p:nvPr/>
        </p:nvGrpSpPr>
        <p:grpSpPr>
          <a:xfrm>
            <a:off x="1219297" y="1676060"/>
            <a:ext cx="2096781" cy="869929"/>
            <a:chOff x="5304134" y="5819738"/>
            <a:chExt cx="2096781" cy="869929"/>
          </a:xfrm>
          <a:noFill/>
        </p:grpSpPr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A40473E1-BD3C-4B5B-A017-3C568E01674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351760" y="5840513"/>
              <a:ext cx="572157" cy="316192"/>
            </a:xfrm>
            <a:prstGeom prst="rect">
              <a:avLst/>
            </a:prstGeom>
            <a:grpFill/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E61B4E9B-A5E8-4DDA-9BC2-84B310C6B7F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318952" y="6131884"/>
              <a:ext cx="632385" cy="248437"/>
            </a:xfrm>
            <a:prstGeom prst="rect">
              <a:avLst/>
            </a:prstGeom>
            <a:grpFill/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91B05B01-3524-4F71-81B6-256A47B1F87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304134" y="6388532"/>
              <a:ext cx="654969" cy="301135"/>
            </a:xfrm>
            <a:prstGeom prst="rect">
              <a:avLst/>
            </a:prstGeom>
            <a:grpFill/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E9416106-937F-4204-ADE3-4DAE87E9415D}"/>
                </a:ext>
              </a:extLst>
            </p:cNvPr>
            <p:cNvSpPr txBox="1"/>
            <p:nvPr/>
          </p:nvSpPr>
          <p:spPr>
            <a:xfrm>
              <a:off x="5870200" y="5819738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6E08AD84-0392-47D2-8C7E-3086691ED54D}"/>
                </a:ext>
              </a:extLst>
            </p:cNvPr>
            <p:cNvSpPr txBox="1"/>
            <p:nvPr/>
          </p:nvSpPr>
          <p:spPr>
            <a:xfrm>
              <a:off x="5863493" y="6100504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9550B8A5-BD2F-4297-8A68-09E74B6DB581}"/>
                </a:ext>
              </a:extLst>
            </p:cNvPr>
            <p:cNvSpPr txBox="1"/>
            <p:nvPr/>
          </p:nvSpPr>
          <p:spPr>
            <a:xfrm>
              <a:off x="5855530" y="6353649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8" name="Rounded Rectangle 6">
            <a:extLst>
              <a:ext uri="{FF2B5EF4-FFF2-40B4-BE49-F238E27FC236}">
                <a16:creationId xmlns:a16="http://schemas.microsoft.com/office/drawing/2014/main" id="{4DCD6E7E-3EE5-4D8F-A406-2AA5133E0C2B}"/>
              </a:ext>
            </a:extLst>
          </p:cNvPr>
          <p:cNvSpPr/>
          <p:nvPr/>
        </p:nvSpPr>
        <p:spPr>
          <a:xfrm>
            <a:off x="1243524" y="894409"/>
            <a:ext cx="721432" cy="50638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P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B7A8D0C5-CE6B-44DA-A1E6-28AD1E6ADD4E}"/>
              </a:ext>
            </a:extLst>
          </p:cNvPr>
          <p:cNvCxnSpPr>
            <a:cxnSpLocks/>
          </p:cNvCxnSpPr>
          <p:nvPr/>
        </p:nvCxnSpPr>
        <p:spPr>
          <a:xfrm flipV="1">
            <a:off x="1285826" y="1696835"/>
            <a:ext cx="3503849" cy="3460904"/>
          </a:xfrm>
          <a:prstGeom prst="line">
            <a:avLst/>
          </a:prstGeom>
          <a:ln w="19050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Oval 49">
            <a:extLst>
              <a:ext uri="{FF2B5EF4-FFF2-40B4-BE49-F238E27FC236}">
                <a16:creationId xmlns:a16="http://schemas.microsoft.com/office/drawing/2014/main" id="{E7F76510-839A-47F5-8C5B-8901ACD5A24B}"/>
              </a:ext>
            </a:extLst>
          </p:cNvPr>
          <p:cNvSpPr/>
          <p:nvPr/>
        </p:nvSpPr>
        <p:spPr>
          <a:xfrm>
            <a:off x="3893317" y="2792522"/>
            <a:ext cx="278301" cy="309932"/>
          </a:xfrm>
          <a:prstGeom prst="ellipse">
            <a:avLst/>
          </a:prstGeom>
          <a:noFill/>
          <a:ln w="53975">
            <a:solidFill>
              <a:srgbClr val="0000FF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925CE8AD-677C-43B7-B478-FE3B60A665F4}"/>
              </a:ext>
            </a:extLst>
          </p:cNvPr>
          <p:cNvCxnSpPr>
            <a:cxnSpLocks/>
          </p:cNvCxnSpPr>
          <p:nvPr/>
        </p:nvCxnSpPr>
        <p:spPr>
          <a:xfrm flipH="1">
            <a:off x="4277017" y="2947488"/>
            <a:ext cx="1420450" cy="0"/>
          </a:xfrm>
          <a:prstGeom prst="straightConnector1">
            <a:avLst/>
          </a:prstGeom>
          <a:ln w="127000">
            <a:solidFill>
              <a:srgbClr val="00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  <p:extLst>
      <p:ext uri="{BB962C8B-B14F-4D97-AF65-F5344CB8AC3E}">
        <p14:creationId xmlns:p14="http://schemas.microsoft.com/office/powerpoint/2010/main" val="419415763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88570"/>
    </mc:Choice>
    <mc:Fallback xmlns="">
      <p:transition spd="slow" advTm="88570"/>
    </mc:Fallback>
  </mc:AlternateContent>
  <p:extLst>
    <p:ext uri="{3A86A75C-4F4B-4683-9AE1-C65F6400EC91}">
      <p14:laserTraceLst xmlns:p14="http://schemas.microsoft.com/office/powerpoint/2010/main">
        <p14:tracePtLst>
          <p14:tracePt t="1806" x="12136438" y="2693988"/>
          <p14:tracePt t="1816" x="12118975" y="2684463"/>
          <p14:tracePt t="1825" x="12109450" y="2684463"/>
          <p14:tracePt t="1855" x="12082463" y="2657475"/>
          <p14:tracePt t="1866" x="12077700" y="2657475"/>
          <p14:tracePt t="1871" x="12068175" y="2657475"/>
          <p14:tracePt t="1882" x="12018963" y="2635250"/>
          <p14:tracePt t="1887" x="12009438" y="2630488"/>
          <p14:tracePt t="1898" x="11972925" y="2620963"/>
          <p14:tracePt t="1903" x="11963400" y="2611438"/>
          <p14:tracePt t="1914" x="11958638" y="2601913"/>
          <p14:tracePt t="1923" x="11950700" y="2584450"/>
          <p14:tracePt t="1927" x="11931650" y="2574925"/>
          <p14:tracePt t="1943" x="11922125" y="2570163"/>
          <p14:tracePt t="1953" x="11895138" y="2562225"/>
          <p14:tracePt t="1964" x="11877675" y="2552700"/>
          <p14:tracePt t="1967" x="11858625" y="2543175"/>
          <p14:tracePt t="1978" x="11785600" y="2528888"/>
          <p14:tracePt t="1984" x="11766550" y="2520950"/>
          <p14:tracePt t="1993" x="11698288" y="2497138"/>
          <p14:tracePt t="2003" x="11603038" y="2497138"/>
          <p14:tracePt t="2010" x="11576050" y="2484438"/>
          <p14:tracePt t="2019" x="11461750" y="2460625"/>
          <p14:tracePt t="2024" x="11420475" y="2460625"/>
          <p14:tracePt t="2034" x="11301413" y="2419350"/>
          <p14:tracePt t="2044" x="11228388" y="2419350"/>
          <p14:tracePt t="2050" x="11177588" y="2387600"/>
          <p14:tracePt t="2060" x="11014075" y="2341563"/>
          <p14:tracePt t="2064" x="10953750" y="2328863"/>
          <p14:tracePt t="2073" x="10785475" y="2282825"/>
          <p14:tracePt t="2084" x="10671175" y="2224088"/>
          <p14:tracePt t="2089" x="10625138" y="2200275"/>
          <p14:tracePt t="2100" x="10398125" y="2078038"/>
          <p14:tracePt t="2103" x="10337800" y="2068513"/>
          <p14:tracePt t="2115" x="10031413" y="1935163"/>
          <p14:tracePt t="2127" x="9882188" y="1890713"/>
          <p14:tracePt t="2130" x="9817100" y="1849438"/>
          <p14:tracePt t="2146" x="9520238" y="1757363"/>
          <p14:tracePt t="2155" x="9320213" y="1652588"/>
          <p14:tracePt t="2166" x="9186863" y="1593850"/>
          <p14:tracePt t="2169" x="9145588" y="1579563"/>
          <p14:tracePt t="2180" x="8826500" y="1343025"/>
          <p14:tracePt t="2185" x="8758238" y="1287463"/>
          <p14:tracePt t="2196" x="8475663" y="1119188"/>
          <p14:tracePt t="2205" x="8337550" y="1027113"/>
          <p14:tracePt t="2210" x="8274050" y="1000125"/>
          <p14:tracePt t="2219" x="8050213" y="900113"/>
          <p14:tracePt t="2226" x="7991475" y="871538"/>
          <p14:tracePt t="2235" x="7785100" y="754063"/>
          <p14:tracePt t="2246" x="7653338" y="681038"/>
          <p14:tracePt t="2251" x="7602538" y="644525"/>
          <p14:tracePt t="2263" x="7402513" y="525463"/>
          <p14:tracePt t="2266" x="7351713" y="488950"/>
          <p14:tracePt t="2275" x="7169150" y="355600"/>
          <p14:tracePt t="2285" x="7032625" y="219075"/>
          <p14:tracePt t="2293" x="7000875" y="187325"/>
          <p14:tracePt t="2769" x="1265238" y="50800"/>
          <p14:tracePt t="2775" x="1255713" y="55563"/>
          <p14:tracePt t="2786" x="1238250" y="82550"/>
          <p14:tracePt t="2789" x="1228725" y="92075"/>
          <p14:tracePt t="2801" x="1200150" y="131763"/>
          <p14:tracePt t="2810" x="1177925" y="160338"/>
          <p14:tracePt t="2816" x="1173163" y="168275"/>
          <p14:tracePt t="2826" x="1155700" y="204788"/>
          <p14:tracePt t="2835" x="1136650" y="204788"/>
          <p14:tracePt t="2843" x="1127125" y="223838"/>
          <p14:tracePt t="2852" x="1119188" y="233363"/>
          <p14:tracePt t="2855" x="1119188" y="241300"/>
          <p14:tracePt t="2866" x="1109663" y="260350"/>
          <p14:tracePt t="2871" x="1109663" y="265113"/>
          <p14:tracePt t="2882" x="1100138" y="292100"/>
          <p14:tracePt t="2893" x="1090613" y="301625"/>
          <p14:tracePt t="2896" x="1090613" y="319088"/>
          <p14:tracePt t="2905" x="1082675" y="374650"/>
          <p14:tracePt t="2917" x="1073150" y="392113"/>
          <p14:tracePt t="2921" x="1063625" y="433388"/>
          <p14:tracePt t="2932" x="1063625" y="442913"/>
          <p14:tracePt t="2937" x="1063625" y="469900"/>
          <p14:tracePt t="2948" x="1050925" y="511175"/>
          <p14:tracePt t="2951" x="1041400" y="530225"/>
          <p14:tracePt t="2962" x="1041400" y="571500"/>
          <p14:tracePt t="2971" x="1031875" y="588963"/>
          <p14:tracePt t="2982" x="1031875" y="598488"/>
          <p14:tracePt t="3008" x="1031875" y="603250"/>
          <p14:tracePt t="3077" x="1031875" y="611188"/>
          <p14:tracePt t="3083" x="1031875" y="630238"/>
          <p14:tracePt t="3094" x="1022350" y="647700"/>
          <p14:tracePt t="3103" x="1022350" y="657225"/>
          <p14:tracePt t="3109" x="1022350" y="661988"/>
          <p14:tracePt t="3117" x="1004888" y="681038"/>
          <p14:tracePt t="3124" x="1004888" y="688975"/>
          <p14:tracePt t="3148" x="973138" y="730250"/>
          <p14:tracePt t="3153" x="963613" y="739775"/>
          <p14:tracePt t="3164" x="941388" y="803275"/>
          <p14:tracePt t="3173" x="931863" y="822325"/>
          <p14:tracePt t="3181" x="931863" y="830263"/>
          <p14:tracePt t="3189" x="912813" y="881063"/>
          <p14:tracePt t="3195" x="904875" y="900113"/>
          <p14:tracePt t="3203" x="881063" y="939800"/>
          <p14:tracePt t="3214" x="844550" y="1004888"/>
          <p14:tracePt t="3220" x="844550" y="1014413"/>
          <p14:tracePt t="3230" x="831850" y="1077913"/>
          <p14:tracePt t="3234" x="831850" y="1104900"/>
          <p14:tracePt t="3246" x="798513" y="1150938"/>
          <p14:tracePt t="3254" x="798513" y="1204913"/>
          <p14:tracePt t="3260" x="798513" y="1223963"/>
          <p14:tracePt t="3269" x="798513" y="1309688"/>
          <p14:tracePt t="3275" x="798513" y="1314450"/>
          <p14:tracePt t="3285" x="798513" y="1401763"/>
          <p14:tracePt t="3296" x="798513" y="1433513"/>
          <p14:tracePt t="3300" x="798513" y="1474788"/>
          <p14:tracePt t="3309" x="798513" y="1543050"/>
          <p14:tracePt t="3316" x="798513" y="1570038"/>
          <p14:tracePt t="3326" x="785813" y="1698625"/>
          <p14:tracePt t="3335" x="776288" y="1744663"/>
          <p14:tracePt t="3339" x="776288" y="1771650"/>
          <p14:tracePt t="3350" x="776288" y="1839913"/>
          <p14:tracePt t="3355" x="776288" y="1849438"/>
          <p14:tracePt t="3367" x="766763" y="1898650"/>
          <p14:tracePt t="3376" x="766763" y="1927225"/>
          <p14:tracePt t="3381" x="757238" y="1935163"/>
          <p14:tracePt t="3393" x="749300" y="1973263"/>
          <p14:tracePt t="3396" x="739775" y="2005013"/>
          <p14:tracePt t="3405" x="730250" y="2022475"/>
          <p14:tracePt t="3416" x="720725" y="2041525"/>
          <p14:tracePt t="3421" x="712788" y="2058988"/>
          <p14:tracePt t="3432" x="712788" y="2078038"/>
          <p14:tracePt t="3435" x="712788" y="2095500"/>
          <p14:tracePt t="3446" x="676275" y="2151063"/>
          <p14:tracePt t="3455" x="666750" y="2182813"/>
          <p14:tracePt t="3462" x="657225" y="2200275"/>
          <p14:tracePt t="3471" x="615950" y="2273300"/>
          <p14:tracePt t="3478" x="608013" y="2292350"/>
          <p14:tracePt t="3485" x="584200" y="2365375"/>
          <p14:tracePt t="3496" x="561975" y="2411413"/>
          <p14:tracePt t="3502" x="561975" y="2428875"/>
          <p14:tracePt t="3513" x="552450" y="2484438"/>
          <p14:tracePt t="3517" x="552450" y="2501900"/>
          <p14:tracePt t="3528" x="530225" y="2547938"/>
          <p14:tracePt t="3537" x="530225" y="2574925"/>
          <p14:tracePt t="3552" x="530225" y="2584450"/>
          <p14:tracePt t="3568" x="530225" y="2589213"/>
          <p14:tracePt t="3577" x="520700" y="2616200"/>
          <p14:tracePt t="3608" x="520700" y="2625725"/>
          <p14:tracePt t="3658" x="520700" y="2635250"/>
          <p14:tracePt t="3687" x="520700" y="2638425"/>
          <p14:tracePt t="3698" x="520700" y="2657475"/>
          <p14:tracePt t="3708" x="520700" y="2667000"/>
          <p14:tracePt t="3724" x="520700" y="2679700"/>
          <p14:tracePt t="3750" x="520700" y="2689225"/>
          <p14:tracePt t="3753" x="520700" y="2698750"/>
          <p14:tracePt t="3761" x="520700" y="2703513"/>
          <p14:tracePt t="3769" x="520700" y="2720975"/>
          <p14:tracePt t="3780" x="520700" y="2730500"/>
          <p14:tracePt t="3783" x="520700" y="2735263"/>
          <p14:tracePt t="3799" x="520700" y="2762250"/>
          <p14:tracePt t="3819" x="520700" y="2771775"/>
          <p14:tracePt t="3860" x="520700" y="2781300"/>
          <p14:tracePt t="3895" x="520700" y="2794000"/>
          <p14:tracePt t="3965" x="520700" y="2803525"/>
          <p14:tracePt t="3969" x="520700" y="2813050"/>
          <p14:tracePt t="3982" x="520700" y="2825750"/>
          <p14:tracePt t="4045" x="520700" y="2857500"/>
          <p14:tracePt t="4109" x="520700" y="2862263"/>
          <p14:tracePt t="4121" x="520700" y="2881313"/>
          <p14:tracePt t="4151" x="520700" y="2890838"/>
          <p14:tracePt t="4167" x="520700" y="2903538"/>
          <p14:tracePt t="4737" x="520700" y="2913063"/>
          <p14:tracePt t="4742" x="520700" y="2922588"/>
          <p14:tracePt t="14593" x="520700" y="2930525"/>
          <p14:tracePt t="14608" x="1871663" y="3670300"/>
          <p14:tracePt t="14614" x="1890713" y="3670300"/>
          <p14:tracePt t="14619" x="1908175" y="3679825"/>
          <p14:tracePt t="14628" x="1939925" y="3679825"/>
          <p14:tracePt t="14631" x="1958975" y="3679825"/>
          <p14:tracePt t="14645" x="2041525" y="3679825"/>
          <p14:tracePt t="14654" x="2082800" y="3679825"/>
          <p14:tracePt t="14662" x="2124075" y="3670300"/>
          <p14:tracePt t="14667" x="2255838" y="3630613"/>
          <p14:tracePt t="14677" x="2287588" y="3621088"/>
          <p14:tracePt t="14683" x="2501900" y="3543300"/>
          <p14:tracePt t="14695" x="2620963" y="3470275"/>
          <p14:tracePt t="14698" x="2767013" y="3424238"/>
          <p14:tracePt t="14710" x="2990850" y="3336925"/>
          <p14:tracePt t="14713" x="3100388" y="3309938"/>
          <p14:tracePt t="14725" x="3648075" y="3136900"/>
          <p14:tracePt t="14733" x="4000500" y="2981325"/>
          <p14:tracePt t="14736" x="4302125" y="2881313"/>
          <p14:tracePt t="14747" x="4638675" y="2776538"/>
          <p14:tracePt t="14753" x="4752975" y="2747963"/>
          <p14:tracePt t="14763" x="5241925" y="2598738"/>
          <p14:tracePt t="14780" x="5643563" y="2516188"/>
          <p14:tracePt t="14791" x="5794375" y="2474913"/>
          <p14:tracePt t="14798" x="5835650" y="2460625"/>
          <p14:tracePt t="14804" x="5949950" y="2447925"/>
          <p14:tracePt t="14814" x="5981700" y="2428875"/>
          <p14:tracePt t="14822" x="5986463" y="2419350"/>
          <p14:tracePt t="14830" x="6013450" y="2401888"/>
          <p14:tracePt t="14840" x="6013450" y="2392363"/>
          <p14:tracePt t="14849" x="6013450" y="2387600"/>
          <p14:tracePt t="14853" x="6022975" y="2370138"/>
          <p14:tracePt t="14941" x="6022975" y="2360613"/>
          <p14:tracePt t="14956" x="6022975" y="2346325"/>
          <p14:tracePt t="14969" x="6022975" y="2328863"/>
          <p14:tracePt t="14980" x="6022975" y="2309813"/>
          <p14:tracePt t="15001" x="6032500" y="2301875"/>
          <p14:tracePt t="15243" x="6040438" y="2301875"/>
          <p14:tracePt t="15253" x="6040438" y="2305050"/>
          <p14:tracePt t="15257" x="6037263" y="2324100"/>
          <p14:tracePt t="15267" x="6027738" y="2328863"/>
          <p14:tracePt t="15278" x="6027738" y="2338388"/>
          <p14:tracePt t="15287" x="6008688" y="2346325"/>
          <p14:tracePt t="15298" x="6003925" y="2355850"/>
          <p14:tracePt t="15707" x="5995988" y="2355850"/>
          <p14:tracePt t="15718" x="5964238" y="2319338"/>
          <p14:tracePt t="15722" x="5954713" y="2301875"/>
          <p14:tracePt t="15733" x="5922963" y="2255838"/>
          <p14:tracePt t="15745" x="5899150" y="2209800"/>
          <p14:tracePt t="15749" x="5867400" y="2178050"/>
          <p14:tracePt t="15758" x="5813425" y="2114550"/>
          <p14:tracePt t="15765" x="5803900" y="2095500"/>
          <p14:tracePt t="15772" x="5757863" y="2049463"/>
          <p14:tracePt t="15782" x="5748338" y="2017713"/>
          <p14:tracePt t="15787" x="5740400" y="1985963"/>
          <p14:tracePt t="15863" x="5730875" y="1981200"/>
          <p14:tracePt t="15908" x="5730875" y="1973263"/>
          <p14:tracePt t="16020" x="5730875" y="1963738"/>
          <p14:tracePt t="16434" x="5735638" y="1927225"/>
          <p14:tracePt t="16446" x="5891213" y="1835150"/>
          <p14:tracePt t="16451" x="6256338" y="1611313"/>
          <p14:tracePt t="16462" x="6981825" y="1246188"/>
          <p14:tracePt t="16467" x="7699375" y="973138"/>
          <p14:tracePt t="16480" x="8548688" y="757238"/>
          <p14:tracePt t="16490" x="9374188" y="684213"/>
          <p14:tracePt t="16501" x="9821863" y="684213"/>
          <p14:tracePt t="16505" x="10196513" y="684213"/>
          <p14:tracePt t="16515" x="10461625" y="684213"/>
          <p14:tracePt t="16521" x="10571163" y="684213"/>
          <p14:tracePt t="16531" x="10963275" y="720725"/>
          <p14:tracePt t="16542" x="11160125" y="735013"/>
          <p14:tracePt t="16546" x="11347450" y="785813"/>
          <p14:tracePt t="16555" x="11493500" y="812800"/>
          <p14:tracePt t="16561" x="11557000" y="827088"/>
          <p14:tracePt t="16571" x="11763375" y="858838"/>
          <p14:tracePt t="16581" x="11909425" y="885825"/>
          <p14:tracePt t="16585" x="12041188" y="944563"/>
          <p14:tracePt t="18851" x="11917363" y="3584575"/>
          <p14:tracePt t="18862" x="11447463" y="3679825"/>
          <p14:tracePt t="18866" x="11369675" y="3689350"/>
          <p14:tracePt t="18876" x="11055350" y="3748088"/>
          <p14:tracePt t="18882" x="10977563" y="3757613"/>
          <p14:tracePt t="18893" x="10795000" y="3789363"/>
          <p14:tracePt t="18902" x="10471150" y="3867150"/>
          <p14:tracePt t="18905" x="10379075" y="3881438"/>
          <p14:tracePt t="18917" x="10036175" y="3935413"/>
          <p14:tracePt t="18922" x="9958388" y="3935413"/>
          <p14:tracePt t="18932" x="9775825" y="3967163"/>
          <p14:tracePt t="18943" x="9515475" y="4000500"/>
          <p14:tracePt t="18948" x="9461500" y="4000500"/>
          <p14:tracePt t="18960" x="9242425" y="4000500"/>
          <p14:tracePt t="18962" x="9201150" y="4000500"/>
          <p14:tracePt t="18971" x="9086850" y="4000500"/>
          <p14:tracePt t="18982" x="8863013" y="4000500"/>
          <p14:tracePt t="18988" x="8809038" y="4000500"/>
          <p14:tracePt t="18999" x="8643938" y="4000500"/>
          <p14:tracePt t="19001" x="8616950" y="4000500"/>
          <p14:tracePt t="19012" x="8502650" y="3990975"/>
          <p14:tracePt t="19022" x="8332788" y="3963988"/>
          <p14:tracePt t="19027" x="8315325" y="3963988"/>
          <p14:tracePt t="19038" x="8183563" y="3894138"/>
          <p14:tracePt t="19044" x="8164513" y="3886200"/>
          <p14:tracePt t="19053" x="8064500" y="3849688"/>
          <p14:tracePt t="19064" x="7867650" y="3767138"/>
          <p14:tracePt t="19067" x="7826375" y="3757613"/>
          <p14:tracePt t="19077" x="7585075" y="3689350"/>
          <p14:tracePt t="19083" x="7543800" y="3675063"/>
          <p14:tracePt t="19094" x="7373938" y="3616325"/>
          <p14:tracePt t="19104" x="7059613" y="3560763"/>
          <p14:tracePt t="19109" x="7018338" y="3552825"/>
          <p14:tracePt t="19129" x="6757988" y="3475038"/>
          <p14:tracePt t="19133" x="6611938" y="3455988"/>
          <p14:tracePt t="19144" x="6351588" y="3424238"/>
          <p14:tracePt t="19150" x="6278563" y="3424238"/>
          <p14:tracePt t="19159" x="6008688" y="3351213"/>
          <p14:tracePt t="19164" x="5954713" y="3351213"/>
          <p14:tracePt t="19175" x="5845175" y="3351213"/>
          <p14:tracePt t="19183" x="5680075" y="3351213"/>
          <p14:tracePt t="19190" x="5653088" y="3351213"/>
          <p14:tracePt t="19200" x="5524500" y="3351213"/>
          <p14:tracePt t="19203" x="5492750" y="3351213"/>
          <p14:tracePt t="19214" x="5424488" y="3351213"/>
          <p14:tracePt t="19226" x="5260975" y="3351213"/>
          <p14:tracePt t="19231" x="5241925" y="3351213"/>
          <p14:tracePt t="19239" x="5114925" y="3336925"/>
          <p14:tracePt t="19246" x="5095875" y="3336925"/>
          <p14:tracePt t="19253" x="5041900" y="3336925"/>
          <p14:tracePt t="19266" x="4949825" y="3336925"/>
          <p14:tracePt t="19269" x="4922838" y="3336925"/>
          <p14:tracePt t="19280" x="4849813" y="3336925"/>
          <p14:tracePt t="19285" x="4835525" y="3336925"/>
          <p14:tracePt t="19296" x="4781550" y="3336925"/>
          <p14:tracePt t="19306" x="4721225" y="3336925"/>
          <p14:tracePt t="19312" x="4694238" y="3336925"/>
          <p14:tracePt t="19319" x="4606925" y="3336925"/>
          <p14:tracePt t="19326" x="4565650" y="3336925"/>
          <p14:tracePt t="19335" x="4497388" y="3328988"/>
          <p14:tracePt t="19346" x="4351338" y="3314700"/>
          <p14:tracePt t="19350" x="4319588" y="3314700"/>
          <p14:tracePt t="19360" x="4219575" y="3287713"/>
          <p14:tracePt t="19366" x="4210050" y="3287713"/>
          <p14:tracePt t="19377" x="4164013" y="3278188"/>
          <p14:tracePt t="19385" x="4119563" y="3255963"/>
          <p14:tracePt t="19393" x="4110038" y="3255963"/>
          <p14:tracePt t="19401" x="4083050" y="3246438"/>
          <p14:tracePt t="19405" x="4078288" y="3236913"/>
          <p14:tracePt t="19421" x="4068763" y="3236913"/>
          <p14:tracePt t="19426" x="4059238" y="3236913"/>
          <p14:tracePt t="19432" x="4049713" y="3232150"/>
          <p14:tracePt t="19501" x="4044950" y="3224213"/>
          <p14:tracePt t="19511" x="4017963" y="3214688"/>
          <p14:tracePt t="19522" x="4000500" y="3214688"/>
          <p14:tracePt t="19531" x="3981450" y="3205163"/>
          <p14:tracePt t="19537" x="3971925" y="3205163"/>
          <p14:tracePt t="19548" x="3944938" y="3195638"/>
          <p14:tracePt t="20980" x="3944938" y="3178175"/>
          <p14:tracePt t="20984" x="4000500" y="3168650"/>
          <p14:tracePt t="20996" x="4095750" y="3141663"/>
          <p14:tracePt t="21006" x="4205288" y="3127375"/>
          <p14:tracePt t="21012" x="4237038" y="3114675"/>
          <p14:tracePt t="21020" x="4370388" y="3049588"/>
          <p14:tracePt t="21027" x="4387850" y="3041650"/>
          <p14:tracePt t="21036" x="4475163" y="3005138"/>
          <p14:tracePt t="21047" x="4594225" y="2930525"/>
          <p14:tracePt t="21049" x="4625975" y="2908300"/>
          <p14:tracePt t="21062" x="4745038" y="2830513"/>
          <p14:tracePt t="21066" x="4772025" y="2798763"/>
          <p14:tracePt t="21079" x="4821238" y="2762250"/>
          <p14:tracePt t="21085" x="4940300" y="2689225"/>
          <p14:tracePt t="21089" x="4968875" y="2667000"/>
          <p14:tracePt t="21099" x="5118100" y="2584450"/>
          <p14:tracePt t="21105" x="5164138" y="2574925"/>
          <p14:tracePt t="21115" x="5278438" y="2516188"/>
          <p14:tracePt t="21125" x="5529263" y="2411413"/>
          <p14:tracePt t="21147" x="5830888" y="2265363"/>
          <p14:tracePt t="21156" x="5930900" y="2236788"/>
          <p14:tracePt t="21165" x="6064250" y="2178050"/>
          <p14:tracePt t="21171" x="6096000" y="2168525"/>
          <p14:tracePt t="21182" x="6183313" y="2146300"/>
          <p14:tracePt t="21185" x="6200775" y="2136775"/>
          <p14:tracePt t="21197" x="6227763" y="2136775"/>
          <p14:tracePt t="21205" x="6273800" y="2085975"/>
          <p14:tracePt t="21212" x="6283325" y="2085975"/>
          <p14:tracePt t="21224" x="6319838" y="2085975"/>
          <p14:tracePt t="21227" x="6329363" y="2085975"/>
          <p14:tracePt t="21242" x="6342063" y="2085975"/>
          <p14:tracePt t="21248" x="6351588" y="2085975"/>
          <p14:tracePt t="21251" x="6361113" y="2082800"/>
          <p14:tracePt t="21262" x="6373813" y="2082800"/>
          <p14:tracePt t="21267" x="6383338" y="2082800"/>
          <p14:tracePt t="21279" x="6402388" y="2082800"/>
          <p14:tracePt t="21287" x="6429375" y="2082800"/>
          <p14:tracePt t="21301" x="6446838" y="2082800"/>
          <p14:tracePt t="21309" x="6465888" y="2082800"/>
          <p14:tracePt t="23668" x="6470650" y="2082800"/>
          <p14:tracePt t="23674" x="6480175" y="2082800"/>
          <p14:tracePt t="23684" x="6488113" y="2082800"/>
          <p14:tracePt t="23688" x="6492875" y="2082800"/>
          <p14:tracePt t="23699" x="6543675" y="2082800"/>
          <p14:tracePt t="23711" x="6584950" y="2082800"/>
          <p14:tracePt t="23714" x="6626225" y="2082800"/>
          <p14:tracePt t="23728" x="6670675" y="2082800"/>
          <p14:tracePt t="23737" x="6740525" y="2082800"/>
          <p14:tracePt t="23748" x="6780213" y="2082800"/>
          <p14:tracePt t="23753" x="6850063" y="2082800"/>
          <p14:tracePt t="23764" x="6908800" y="2082800"/>
          <p14:tracePt t="23769" x="6935788" y="2082800"/>
          <p14:tracePt t="23780" x="7037388" y="2082800"/>
          <p14:tracePt t="23793" x="7169150" y="2082800"/>
          <p14:tracePt t="23803" x="7242175" y="2082800"/>
          <p14:tracePt t="23809" x="7269163" y="2082800"/>
          <p14:tracePt t="23819" x="7342188" y="2085975"/>
          <p14:tracePt t="23830" x="7370763" y="2085975"/>
          <p14:tracePt t="23833" x="7410450" y="2085975"/>
          <p14:tracePt t="23844" x="7419975" y="2085975"/>
          <p14:tracePt t="23849" x="7429500" y="2085975"/>
          <p14:tracePt t="24023" x="7424738" y="2085975"/>
          <p14:tracePt t="24033" x="7397750" y="2085975"/>
          <p14:tracePt t="24038" x="7388225" y="2085975"/>
          <p14:tracePt t="24049" x="7373938" y="2085975"/>
          <p14:tracePt t="24058" x="7342188" y="2085975"/>
          <p14:tracePt t="24066" x="7337425" y="2085975"/>
          <p14:tracePt t="24072" x="7319963" y="2085975"/>
          <p14:tracePt t="24075" x="7300913" y="2085975"/>
          <p14:tracePt t="24087" x="7283450" y="2085975"/>
          <p14:tracePt t="24093" x="7264400" y="2085975"/>
          <p14:tracePt t="24103" x="7227888" y="2085975"/>
          <p14:tracePt t="24118" x="7169150" y="2085975"/>
          <p14:tracePt t="24128" x="7127875" y="2082800"/>
          <p14:tracePt t="24131" x="7110413" y="2082800"/>
          <p14:tracePt t="24144" x="7069138" y="2082800"/>
          <p14:tracePt t="24150" x="7027863" y="2082800"/>
          <p14:tracePt t="24159" x="7008813" y="2082800"/>
          <p14:tracePt t="24166" x="6967538" y="2082800"/>
          <p14:tracePt t="24177" x="6935788" y="2082800"/>
          <p14:tracePt t="24180" x="6908800" y="2073275"/>
          <p14:tracePt t="24197" x="6899275" y="2073275"/>
          <p14:tracePt t="24767" x="6889750" y="2073275"/>
          <p14:tracePt t="25003" x="6904038" y="2073275"/>
          <p14:tracePt t="25013" x="6923088" y="2073275"/>
          <p14:tracePt t="25020" x="6940550" y="2073275"/>
          <p14:tracePt t="25030" x="6996113" y="2073275"/>
          <p14:tracePt t="25035" x="7000875" y="2073275"/>
          <p14:tracePt t="25046" x="7077075" y="2073275"/>
          <p14:tracePt t="25056" x="7150100" y="2073275"/>
          <p14:tracePt t="25063" x="7191375" y="2073275"/>
          <p14:tracePt t="25070" x="7246938" y="2073275"/>
          <p14:tracePt t="25078" x="7273925" y="2073275"/>
          <p14:tracePt t="25086" x="7315200" y="2073275"/>
          <p14:tracePt t="25097" x="7346950" y="2073275"/>
          <p14:tracePt t="25106" x="7351713" y="2073275"/>
          <p14:tracePt t="25112" x="7361238" y="2073275"/>
          <p14:tracePt t="25116" x="7370763" y="2073275"/>
          <p14:tracePt t="25128" x="7373938" y="2073275"/>
          <p14:tracePt t="25145" x="7434263" y="2073275"/>
          <p14:tracePt t="25150" x="7461250" y="2073275"/>
          <p14:tracePt t="25155" x="7493000" y="2073275"/>
          <p14:tracePt t="25165" x="7561263" y="2073275"/>
          <p14:tracePt t="25176" x="7634288" y="2073275"/>
          <p14:tracePt t="25182" x="7675563" y="2073275"/>
          <p14:tracePt t="25190" x="7731125" y="2073275"/>
          <p14:tracePt t="25195" x="7740650" y="2073275"/>
          <p14:tracePt t="25206" x="7767638" y="2073275"/>
          <p14:tracePt t="25217" x="7780338" y="2073275"/>
          <p14:tracePt t="25288" x="7799388" y="2073275"/>
          <p14:tracePt t="25342" x="7816850" y="2073275"/>
          <p14:tracePt t="25352" x="7826375" y="2073275"/>
          <p14:tracePt t="25363" x="7835900" y="2073275"/>
          <p14:tracePt t="25368" x="7850188" y="2073275"/>
          <p14:tracePt t="25379" x="7858125" y="2073275"/>
          <p14:tracePt t="25383" x="7867650" y="2073275"/>
          <p14:tracePt t="25394" x="7872413" y="2073275"/>
          <p14:tracePt t="25404" x="7889875" y="2073275"/>
          <p14:tracePt t="25415" x="7899400" y="2073275"/>
          <p14:tracePt t="25430" x="7923213" y="2073275"/>
          <p14:tracePt t="25433" x="7940675" y="2073275"/>
          <p14:tracePt t="25437" x="7950200" y="2073275"/>
          <p14:tracePt t="25448" x="7959725" y="2073275"/>
          <p14:tracePt t="25459" x="7972425" y="2073275"/>
          <p14:tracePt t="25463" x="7981950" y="2073275"/>
          <p14:tracePt t="25475" x="8008938" y="2073275"/>
          <p14:tracePt t="25482" x="8035925" y="2073275"/>
          <p14:tracePt t="25486" x="8045450" y="2073275"/>
          <p14:tracePt t="25498" x="8081963" y="2073275"/>
          <p14:tracePt t="25502" x="8101013" y="2073275"/>
          <p14:tracePt t="25513" x="8113713" y="2073275"/>
          <p14:tracePt t="25520" x="8123238" y="2073275"/>
          <p14:tracePt t="25531" x="8150225" y="2073275"/>
          <p14:tracePt t="25546" x="8174038" y="2073275"/>
          <p14:tracePt t="25555" x="8201025" y="2073275"/>
          <p14:tracePt t="25564" x="8220075" y="2073275"/>
          <p14:tracePt t="25571" x="8237538" y="2073275"/>
          <p14:tracePt t="25580" x="8247063" y="2073275"/>
          <p14:tracePt t="25583" x="8259763" y="2073275"/>
          <p14:tracePt t="25594" x="8278813" y="2073275"/>
          <p14:tracePt t="25600" x="8288338" y="2073275"/>
          <p14:tracePt t="25609" x="8315325" y="2073275"/>
          <p14:tracePt t="25619" x="8342313" y="2073275"/>
          <p14:tracePt t="25626" x="8351838" y="2073275"/>
          <p14:tracePt t="25635" x="8374063" y="2073275"/>
          <p14:tracePt t="25643" x="8393113" y="2073275"/>
          <p14:tracePt t="25649" x="8434388" y="2073275"/>
          <p14:tracePt t="25660" x="8466138" y="2073275"/>
          <p14:tracePt t="25665" x="8493125" y="2073275"/>
          <p14:tracePt t="25680" x="8553450" y="2073275"/>
          <p14:tracePt t="25693" x="8593138" y="2073275"/>
          <p14:tracePt t="25699" x="8621713" y="2073275"/>
          <p14:tracePt t="25706" x="8629650" y="2073275"/>
          <p14:tracePt t="25715" x="8658225" y="2073275"/>
          <p14:tracePt t="25726" x="8675688" y="2073275"/>
          <p14:tracePt t="25735" x="8689975" y="2073275"/>
          <p14:tracePt t="25746" x="8699500" y="2073275"/>
          <p14:tracePt t="25755" x="8707438" y="2073275"/>
          <p14:tracePt t="25771" x="8716963" y="2073275"/>
          <p14:tracePt t="25785" x="8731250" y="2073275"/>
          <p14:tracePt t="25805" x="8739188" y="2073275"/>
          <p14:tracePt t="25826" x="8748713" y="2073275"/>
          <p14:tracePt t="25837" x="8753475" y="2073275"/>
          <p14:tracePt t="25862" x="8763000" y="2073275"/>
          <p14:tracePt t="25867" x="8772525" y="2073275"/>
          <p14:tracePt t="25882" x="8785225" y="2073275"/>
          <p14:tracePt t="25894" x="8804275" y="2073275"/>
          <p14:tracePt t="25901" x="8831263" y="2073275"/>
          <p14:tracePt t="25910" x="8840788" y="2073275"/>
          <p14:tracePt t="25917" x="8867775" y="2073275"/>
          <p14:tracePt t="25928" x="8894763" y="2073275"/>
          <p14:tracePt t="25937" x="8913813" y="2073275"/>
          <p14:tracePt t="25943" x="8921750" y="2073275"/>
          <p14:tracePt t="25948" x="8936038" y="2073275"/>
          <p14:tracePt t="25959" x="8945563" y="2073275"/>
          <p14:tracePt t="25964" x="8963025" y="2073275"/>
          <p14:tracePt t="25977" x="9013825" y="2073275"/>
          <p14:tracePt t="25987" x="9036050" y="2085975"/>
          <p14:tracePt t="25998" x="9040813" y="2085975"/>
          <p14:tracePt t="26010" x="9069388" y="2095500"/>
          <p14:tracePt t="26017" x="9077325" y="2095500"/>
          <p14:tracePt t="26027" x="9091613" y="2105025"/>
          <p14:tracePt t="26037" x="9109075" y="2114550"/>
          <p14:tracePt t="26044" x="9118600" y="2114550"/>
          <p14:tracePt t="26053" x="9155113" y="2114550"/>
          <p14:tracePt t="26063" x="9174163" y="2114550"/>
          <p14:tracePt t="26069" x="9201150" y="2114550"/>
          <p14:tracePt t="26079" x="9218613" y="2114550"/>
          <p14:tracePt t="26083" x="9228138" y="2114550"/>
          <p14:tracePt t="26094" x="9259888" y="2114550"/>
          <p14:tracePt t="26103" x="9291638" y="2114550"/>
          <p14:tracePt t="26114" x="9301163" y="2114550"/>
          <p14:tracePt t="26119" x="9305925" y="2114550"/>
          <p14:tracePt t="26147" x="9324975" y="2114550"/>
          <p14:tracePt t="26209" x="9332913" y="2114550"/>
          <p14:tracePt t="26230" x="9347200" y="2119313"/>
          <p14:tracePt t="26259" x="9356725" y="2119313"/>
          <p14:tracePt t="26285" x="9374188" y="2119313"/>
          <p14:tracePt t="26295" x="9378950" y="2119313"/>
          <p14:tracePt t="26305" x="9388475" y="2119313"/>
          <p14:tracePt t="26312" x="9398000" y="2119313"/>
          <p14:tracePt t="26321" x="9410700" y="2119313"/>
          <p14:tracePt t="26325" x="9429750" y="2119313"/>
          <p14:tracePt t="26335" x="9447213" y="2119313"/>
          <p14:tracePt t="26345" x="9456738" y="2127250"/>
          <p14:tracePt t="26351" x="9466263" y="2127250"/>
          <p14:tracePt t="26361" x="9471025" y="2127250"/>
          <p14:tracePt t="26365" x="9478963" y="2127250"/>
          <p14:tracePt t="26377" x="9498013" y="2127250"/>
          <p14:tracePt t="26385" x="9512300" y="2127250"/>
          <p14:tracePt t="26392" x="9544050" y="2136775"/>
          <p14:tracePt t="26401" x="9561513" y="2136775"/>
          <p14:tracePt t="26405" x="9580563" y="2136775"/>
          <p14:tracePt t="26416" x="9634538" y="2136775"/>
          <p14:tracePt t="26428" x="9661525" y="2136775"/>
          <p14:tracePt t="26431" x="9690100" y="2136775"/>
          <p14:tracePt t="26442" x="9731375" y="2136775"/>
          <p14:tracePt t="26447" x="9748838" y="2136775"/>
          <p14:tracePt t="26459" x="9790113" y="2136775"/>
          <p14:tracePt t="26467" x="9809163" y="2136775"/>
          <p14:tracePt t="26472" x="9826625" y="2136775"/>
          <p14:tracePt t="26482" x="9853613" y="2136775"/>
          <p14:tracePt t="26486" x="9863138" y="2136775"/>
          <p14:tracePt t="26502" x="9882188" y="2136775"/>
          <p14:tracePt t="26510" x="9909175" y="2136775"/>
          <p14:tracePt t="26525" x="9926638" y="2136775"/>
          <p14:tracePt t="26533" x="9936163" y="2136775"/>
          <p14:tracePt t="26543" x="9940925" y="2136775"/>
          <p14:tracePt t="26553" x="9958388" y="2136775"/>
          <p14:tracePt t="26563" x="9977438" y="2136775"/>
          <p14:tracePt t="26567" x="9986963" y="2136775"/>
          <p14:tracePt t="26578" x="10009188" y="2136775"/>
          <p14:tracePt t="26587" x="10018713" y="2136775"/>
          <p14:tracePt t="26594" x="10036175" y="2136775"/>
          <p14:tracePt t="26602" x="10064750" y="2136775"/>
          <p14:tracePt t="26608" x="10072688" y="2136775"/>
          <p14:tracePt t="26616" x="10077450" y="2136775"/>
          <p14:tracePt t="26627" x="10086975" y="2136775"/>
          <p14:tracePt t="26632" x="10096500" y="2136775"/>
          <p14:tracePt t="26693" x="10104438" y="2136775"/>
          <p14:tracePt t="27429" x="10109200" y="2136775"/>
          <p14:tracePt t="28358" x="10118725" y="2136775"/>
          <p14:tracePt t="28367" x="10137775" y="2136775"/>
          <p14:tracePt t="28373" x="10140950" y="2136775"/>
          <p14:tracePt t="28383" x="10169525" y="2136775"/>
          <p14:tracePt t="28393" x="10210800" y="2136775"/>
          <p14:tracePt t="28399" x="10252075" y="2132013"/>
          <p14:tracePt t="28410" x="10260013" y="2132013"/>
          <p14:tracePt t="28414" x="10279063" y="2122488"/>
          <p14:tracePt t="28426" x="10306050" y="2122488"/>
          <p14:tracePt t="28433" x="10325100" y="2122488"/>
          <p14:tracePt t="28441" x="10342563" y="2122488"/>
          <p14:tracePt t="28450" x="10398125" y="2122488"/>
          <p14:tracePt t="28453" x="10415588" y="2122488"/>
          <p14:tracePt t="28464" x="10525125" y="2122488"/>
          <p14:tracePt t="28475" x="10639425" y="2122488"/>
          <p14:tracePt t="28479" x="10731500" y="2122488"/>
          <p14:tracePt t="28491" x="10858500" y="2122488"/>
          <p14:tracePt t="28495" x="10899775" y="2122488"/>
          <p14:tracePt t="28505" x="11014075" y="2122488"/>
          <p14:tracePt t="28515" x="11068050" y="2122488"/>
          <p14:tracePt t="28519" x="11141075" y="2122488"/>
          <p14:tracePt t="28529" x="11201400" y="2122488"/>
          <p14:tracePt t="28535" x="11214100" y="2122488"/>
          <p14:tracePt t="28545" x="11255375" y="2122488"/>
          <p14:tracePt t="28555" x="11264900" y="2122488"/>
          <p14:tracePt t="28560" x="11274425" y="2122488"/>
          <p14:tracePt t="28666" x="11283950" y="2122488"/>
          <p14:tracePt t="28682" x="11296650" y="2122488"/>
          <p14:tracePt t="28697" x="11306175" y="2122488"/>
          <p14:tracePt t="28706" x="11333163" y="2122488"/>
          <p14:tracePt t="28718" x="11337925" y="2127250"/>
          <p14:tracePt t="28730" x="11347450" y="2136775"/>
          <p14:tracePt t="28733" x="11356975" y="2136775"/>
          <p14:tracePt t="28739" x="11369675" y="2136775"/>
          <p14:tracePt t="28748" x="11415713" y="2168525"/>
          <p14:tracePt t="28759" x="11474450" y="2182813"/>
          <p14:tracePt t="28762" x="11534775" y="2192338"/>
          <p14:tracePt t="28771" x="11617325" y="2219325"/>
          <p14:tracePt t="28777" x="11644313" y="2228850"/>
          <p14:tracePt t="28786" x="11744325" y="2255838"/>
          <p14:tracePt t="28797" x="11785600" y="2255838"/>
          <p14:tracePt t="28801" x="11826875" y="2255838"/>
          <p14:tracePt t="28812" x="11868150" y="2255838"/>
          <p14:tracePt t="28817" x="11899900" y="2255838"/>
          <p14:tracePt t="28828" x="11926888" y="2255838"/>
          <p14:tracePt t="28837" x="11953875" y="2255838"/>
          <p14:tracePt t="28843" x="11963400" y="2255838"/>
          <p14:tracePt t="34802" x="11972925" y="2268538"/>
          <p14:tracePt t="35079" x="5438775" y="6570663"/>
          <p14:tracePt t="35087" x="5224463" y="6076950"/>
          <p14:tracePt t="35098" x="5100638" y="5767388"/>
          <p14:tracePt t="35102" x="5059363" y="5665788"/>
          <p14:tracePt t="35112" x="4881563" y="5327650"/>
          <p14:tracePt t="35118" x="4840288" y="5264150"/>
          <p14:tracePt t="35128" x="4757738" y="5045075"/>
          <p14:tracePt t="35141" x="4689475" y="4884738"/>
          <p14:tracePt t="35152" x="4643438" y="4721225"/>
          <p14:tracePt t="35160" x="4643438" y="4689475"/>
          <p14:tracePt t="35167" x="4630738" y="4589463"/>
          <p14:tracePt t="35177" x="4630738" y="4575175"/>
          <p14:tracePt t="35181" x="4621213" y="4556125"/>
          <p14:tracePt t="35190" x="4621213" y="4502150"/>
          <p14:tracePt t="35205" x="4621213" y="4492625"/>
          <p14:tracePt t="35209" x="4611688" y="4475163"/>
          <p14:tracePt t="35245" x="4611688" y="4465638"/>
          <p14:tracePt t="35252" x="4611688" y="4443413"/>
          <p14:tracePt t="35262" x="4611688" y="4402138"/>
          <p14:tracePt t="35264" x="4611688" y="4360863"/>
          <p14:tracePt t="35274" x="4611688" y="4305300"/>
          <p14:tracePt t="35280" x="4611688" y="4287838"/>
          <p14:tracePt t="35287" x="4611688" y="4219575"/>
          <p14:tracePt t="35297" x="4602163" y="4186238"/>
          <p14:tracePt t="35302" x="4602163" y="4159250"/>
          <p14:tracePt t="35314" x="4594225" y="4149725"/>
          <p14:tracePt t="35323" x="4584700" y="4141788"/>
          <p14:tracePt t="35330" x="4584700" y="4137025"/>
          <p14:tracePt t="35350" x="4579938" y="4127500"/>
          <p14:tracePt t="35361" x="4570413" y="4117975"/>
          <p14:tracePt t="35370" x="4521200" y="4110038"/>
          <p14:tracePt t="35381" x="4502150" y="4076700"/>
          <p14:tracePt t="35396" x="4460875" y="4040188"/>
          <p14:tracePt t="35401" x="4443413" y="4032250"/>
          <p14:tracePt t="35410" x="4370388" y="3954463"/>
          <p14:tracePt t="35419" x="4338638" y="3944938"/>
          <p14:tracePt t="35427" x="4319588" y="3927475"/>
          <p14:tracePt t="35435" x="4268788" y="3867150"/>
          <p14:tracePt t="35439" x="4251325" y="3844925"/>
          <p14:tracePt t="35449" x="4229100" y="3789363"/>
          <p14:tracePt t="35459" x="4205288" y="3743325"/>
          <p14:tracePt t="35465" x="4195763" y="3735388"/>
          <p14:tracePt t="35475" x="4164013" y="3670300"/>
          <p14:tracePt t="35479" x="4164013" y="3662363"/>
          <p14:tracePt t="35495" x="4159250" y="3648075"/>
          <p14:tracePt t="35500" x="4159250" y="3638550"/>
          <p14:tracePt t="35577" x="4159250" y="3630613"/>
          <p14:tracePt t="35587" x="4159250" y="3602038"/>
          <p14:tracePt t="35598" x="4151313" y="3584575"/>
          <p14:tracePt t="35604" x="4151313" y="3579813"/>
          <p14:tracePt t="35616" x="4151313" y="3560763"/>
          <p14:tracePt t="35622" x="4151313" y="3552825"/>
          <p14:tracePt t="35691" x="4151313" y="3538538"/>
          <p14:tracePt t="35717" x="4127500" y="3516313"/>
          <p14:tracePt t="35737" x="4122738" y="3511550"/>
          <p14:tracePt t="35751" x="4122738" y="3502025"/>
          <p14:tracePt t="35756" x="4122738" y="3492500"/>
          <p14:tracePt t="41395" x="4122738" y="3487738"/>
          <p14:tracePt t="41399" x="5227638" y="5222875"/>
          <p14:tracePt t="42080" x="9593263" y="6237288"/>
          <p14:tracePt t="42089" x="9493250" y="6181725"/>
          <p14:tracePt t="42097" x="9361488" y="6103938"/>
          <p14:tracePt t="42104" x="9264650" y="6064250"/>
          <p14:tracePt t="42116" x="9128125" y="5972175"/>
          <p14:tracePt t="42119" x="9118600" y="5962650"/>
          <p14:tracePt t="42140" x="9091613" y="5940425"/>
          <p14:tracePt t="42169" x="9091613" y="5930900"/>
          <p14:tracePt t="42175" x="9091613" y="5918200"/>
          <p14:tracePt t="42200" x="9086850" y="5908675"/>
          <p14:tracePt t="42216" x="9086850" y="5899150"/>
          <p14:tracePt t="42225" x="9086850" y="5889625"/>
          <p14:tracePt t="42235" x="9086850" y="5884863"/>
          <p14:tracePt t="42246" x="9086850" y="5876925"/>
          <p14:tracePt t="42249" x="9086850" y="5867400"/>
          <p14:tracePt t="42265" x="9086850" y="5862638"/>
          <p14:tracePt t="42275" x="9086850" y="5835650"/>
          <p14:tracePt t="42281" x="9086850" y="5816600"/>
          <p14:tracePt t="42291" x="9086850" y="5807075"/>
          <p14:tracePt t="42296" x="9101138" y="5789613"/>
          <p14:tracePt t="42309" x="9101138" y="5784850"/>
          <p14:tracePt t="42315" x="9109075" y="5757863"/>
          <p14:tracePt t="42321" x="9109075" y="5748338"/>
          <p14:tracePt t="42332" x="9113838" y="5743575"/>
          <p14:tracePt t="42335" x="9123363" y="5726113"/>
          <p14:tracePt t="42346" x="9123363" y="5707063"/>
          <p14:tracePt t="42359" x="9123363" y="5665788"/>
          <p14:tracePt t="42363" x="9123363" y="5657850"/>
          <p14:tracePt t="42372" x="9123363" y="5629275"/>
          <p14:tracePt t="42376" x="9123363" y="5602288"/>
          <p14:tracePt t="42388" x="9123363" y="5584825"/>
          <p14:tracePt t="42398" x="9145588" y="5551488"/>
          <p14:tracePt t="42401" x="9145588" y="5548313"/>
          <p14:tracePt t="42412" x="9145588" y="5519738"/>
          <p14:tracePt t="42417" x="9145588" y="5511800"/>
          <p14:tracePt t="42429" x="9145588" y="5507038"/>
          <p14:tracePt t="42437" x="9145588" y="5497513"/>
          <p14:tracePt t="42443" x="9145588" y="5487988"/>
          <p14:tracePt t="42523" x="9145588" y="5478463"/>
          <p14:tracePt t="42538" x="9142413" y="5465763"/>
          <p14:tracePt t="42547" x="9132888" y="5434013"/>
          <p14:tracePt t="42563" x="9123363" y="5424488"/>
          <p14:tracePt t="42578" x="9113838" y="5410200"/>
          <p14:tracePt t="42715" x="9113838" y="5402263"/>
          <p14:tracePt t="42723" x="9113838" y="5392738"/>
          <p14:tracePt t="42736" x="9113838" y="5368925"/>
          <p14:tracePt t="42745" x="9113838" y="5360988"/>
          <p14:tracePt t="42750" x="9113838" y="5332413"/>
          <p14:tracePt t="42767" x="9128125" y="5283200"/>
          <p14:tracePt t="42777" x="9159875" y="5264150"/>
          <p14:tracePt t="42780" x="9178925" y="5254625"/>
          <p14:tracePt t="42792" x="9201150" y="5237163"/>
          <p14:tracePt t="42799" x="9228138" y="5214938"/>
          <p14:tracePt t="42808" x="9237663" y="5195888"/>
          <p14:tracePt t="42814" x="9259888" y="5178425"/>
          <p14:tracePt t="42818" x="9291638" y="5145088"/>
          <p14:tracePt t="42829" x="9320213" y="5122863"/>
          <p14:tracePt t="42847" x="9402763" y="5032375"/>
          <p14:tracePt t="42864" x="9451975" y="4876800"/>
          <p14:tracePt t="42873" x="9483725" y="4845050"/>
          <p14:tracePt t="42882" x="9575800" y="4706938"/>
          <p14:tracePt t="42886" x="9585325" y="4689475"/>
          <p14:tracePt t="42897" x="9607550" y="4602163"/>
          <p14:tracePt t="42901" x="9648825" y="4519613"/>
          <p14:tracePt t="42912" x="9661525" y="4460875"/>
          <p14:tracePt t="42921" x="9702800" y="4346575"/>
          <p14:tracePt t="42925" x="9726613" y="4314825"/>
          <p14:tracePt t="42934" x="9748838" y="4259263"/>
          <p14:tracePt t="42941" x="9763125" y="4183063"/>
          <p14:tracePt t="42950" x="9772650" y="4149725"/>
          <p14:tracePt t="42962" x="9794875" y="4076700"/>
          <p14:tracePt t="42966" x="9794875" y="4049713"/>
          <p14:tracePt t="42977" x="9794875" y="4008438"/>
          <p14:tracePt t="42980" x="9794875" y="3967163"/>
          <p14:tracePt t="42995" x="9794875" y="3927475"/>
          <p14:tracePt t="43002" x="9794875" y="3886200"/>
          <p14:tracePt t="43015" x="9794875" y="3867150"/>
          <p14:tracePt t="43019" x="9794875" y="3862388"/>
          <p14:tracePt t="43023" x="9794875" y="3844925"/>
          <p14:tracePt t="43034" x="9794875" y="3835400"/>
          <p14:tracePt t="43046" x="9794875" y="3798888"/>
          <p14:tracePt t="43052" x="9794875" y="3779838"/>
          <p14:tracePt t="43065" x="9794875" y="3752850"/>
          <p14:tracePt t="43076" x="9794875" y="3735388"/>
          <p14:tracePt t="43083" x="9794875" y="3667125"/>
          <p14:tracePt t="43087" x="9794875" y="3638550"/>
          <p14:tracePt t="43097" x="9794875" y="3597275"/>
          <p14:tracePt t="43104" x="9794875" y="3565525"/>
          <p14:tracePt t="43113" x="9790113" y="3497263"/>
          <p14:tracePt t="43124" x="9790113" y="3419475"/>
          <p14:tracePt t="43152" x="9790113" y="3282950"/>
          <p14:tracePt t="43156" x="9790113" y="3205163"/>
          <p14:tracePt t="43165" x="9790113" y="3095625"/>
          <p14:tracePt t="43170" x="9790113" y="3090863"/>
          <p14:tracePt t="43181" x="9790113" y="3054350"/>
          <p14:tracePt t="43186" x="9790113" y="3000375"/>
          <p14:tracePt t="43196" x="9790113" y="2959100"/>
          <p14:tracePt t="43205" x="9794875" y="2857500"/>
          <p14:tracePt t="43213" x="9804400" y="2849563"/>
          <p14:tracePt t="43220" x="9804400" y="2803525"/>
          <p14:tracePt t="43223" x="9804400" y="2771775"/>
          <p14:tracePt t="43233" x="9804400" y="2703513"/>
          <p14:tracePt t="43244" x="9804400" y="2647950"/>
          <p14:tracePt t="43249" x="9804400" y="2616200"/>
          <p14:tracePt t="43259" x="9804400" y="2589213"/>
          <p14:tracePt t="43263" x="9804400" y="2562225"/>
          <p14:tracePt t="43273" x="9804400" y="2520950"/>
          <p14:tracePt t="43282" x="9804400" y="2489200"/>
          <p14:tracePt t="43289" x="9799638" y="2479675"/>
          <p14:tracePt t="43301" x="9799638" y="2455863"/>
          <p14:tracePt t="43312" x="9790113" y="2438400"/>
          <p14:tracePt t="43318" x="9790113" y="2428875"/>
          <p14:tracePt t="43331" x="9780588" y="2374900"/>
          <p14:tracePt t="43342" x="9780588" y="2365375"/>
          <p14:tracePt t="43351" x="9739313" y="2324100"/>
          <p14:tracePt t="43362" x="9739313" y="2282825"/>
          <p14:tracePt t="43368" x="9731375" y="2255838"/>
          <p14:tracePt t="43370" x="9726613" y="2246313"/>
          <p14:tracePt t="43382" x="9707563" y="2228850"/>
          <p14:tracePt t="43385" x="9707563" y="2200275"/>
          <p14:tracePt t="43396" x="9698038" y="2192338"/>
          <p14:tracePt t="43408" x="9698038" y="2178050"/>
          <p14:tracePt t="43410" x="9698038" y="2168525"/>
          <p14:tracePt t="43420" x="9690100" y="2151063"/>
          <p14:tracePt t="43425" x="9680575" y="2141538"/>
          <p14:tracePt t="43434" x="9671050" y="2127250"/>
          <p14:tracePt t="43448" x="9671050" y="2109788"/>
          <p14:tracePt t="43452" x="9661525" y="2090738"/>
          <p14:tracePt t="43465" x="9648825" y="2073275"/>
          <p14:tracePt t="43481" x="9629775" y="2046288"/>
          <p14:tracePt t="43487" x="9598025" y="2027238"/>
          <p14:tracePt t="43493" x="9580563" y="2017713"/>
          <p14:tracePt t="43501" x="9551988" y="1995488"/>
          <p14:tracePt t="43509" x="9534525" y="1995488"/>
          <p14:tracePt t="43515" x="9502775" y="1985963"/>
          <p14:tracePt t="43525" x="9415463" y="1949450"/>
          <p14:tracePt t="43532" x="9398000" y="1939925"/>
          <p14:tracePt t="43546" x="9356725" y="1939925"/>
          <p14:tracePt t="43549" x="9324975" y="1931988"/>
          <p14:tracePt t="43563" x="9283700" y="1908175"/>
          <p14:tracePt t="43568" x="9205913" y="1908175"/>
          <p14:tracePt t="43573" x="9201150" y="1908175"/>
          <p14:tracePt t="43583" x="9150350" y="1908175"/>
          <p14:tracePt t="43588" x="9123363" y="1908175"/>
          <p14:tracePt t="43597" x="9069388" y="1908175"/>
          <p14:tracePt t="43608" x="9028113" y="1908175"/>
          <p14:tracePt t="43611" x="8986838" y="1908175"/>
          <p14:tracePt t="43621" x="8959850" y="1908175"/>
          <p14:tracePt t="43627" x="8872538" y="1917700"/>
          <p14:tracePt t="43639" x="8809038" y="1954213"/>
          <p14:tracePt t="43648" x="8689975" y="2012950"/>
          <p14:tracePt t="43653" x="8662988" y="2022475"/>
          <p14:tracePt t="43664" x="8597900" y="2082800"/>
          <p14:tracePt t="43667" x="8539163" y="2109788"/>
          <p14:tracePt t="43678" x="8475663" y="2146300"/>
          <p14:tracePt t="43689" x="8369300" y="2232025"/>
          <p14:tracePt t="43696" x="8351838" y="2255838"/>
          <p14:tracePt t="43706" x="8305800" y="2314575"/>
          <p14:tracePt t="43709" x="8269288" y="2360613"/>
          <p14:tracePt t="43719" x="8259763" y="2401888"/>
          <p14:tracePt t="43732" x="8220075" y="2465388"/>
          <p14:tracePt t="43735" x="8210550" y="2511425"/>
          <p14:tracePt t="43748" x="8174038" y="2630488"/>
          <p14:tracePt t="43760" x="8174038" y="2671763"/>
          <p14:tracePt t="43769" x="8159750" y="2803525"/>
          <p14:tracePt t="43774" x="8150225" y="2844800"/>
          <p14:tracePt t="43783" x="8137525" y="2954338"/>
          <p14:tracePt t="43790" x="8137525" y="3032125"/>
          <p14:tracePt t="43801" x="8118475" y="3159125"/>
          <p14:tracePt t="43814" x="8086725" y="3419475"/>
          <p14:tracePt t="43832" x="8045450" y="3716338"/>
          <p14:tracePt t="43843" x="8013700" y="3867150"/>
          <p14:tracePt t="43849" x="7981950" y="4073525"/>
          <p14:tracePt t="43853" x="7981950" y="4113213"/>
          <p14:tracePt t="43863" x="7967663" y="4227513"/>
          <p14:tracePt t="43869" x="7967663" y="4319588"/>
          <p14:tracePt t="43879" x="7967663" y="4410075"/>
          <p14:tracePt t="43897" x="7954963" y="4616450"/>
          <p14:tracePt t="43916" x="7954963" y="4808538"/>
          <p14:tracePt t="43920" x="7954963" y="4918075"/>
          <p14:tracePt t="43930" x="7954963" y="5100638"/>
          <p14:tracePt t="43935" x="7954963" y="5127625"/>
          <p14:tracePt t="43945" x="7962900" y="5227638"/>
          <p14:tracePt t="43948" x="7991475" y="5305425"/>
          <p14:tracePt t="43960" x="7999413" y="5383213"/>
          <p14:tracePt t="43969" x="7999413" y="5456238"/>
          <p14:tracePt t="43976" x="8013700" y="5502275"/>
          <p14:tracePt t="43985" x="8032750" y="5529263"/>
          <p14:tracePt t="43991" x="8040688" y="5561013"/>
          <p14:tracePt t="44001" x="8069263" y="5621338"/>
          <p14:tracePt t="44012" x="8096250" y="5653088"/>
          <p14:tracePt t="44016" x="8105775" y="5657850"/>
          <p14:tracePt t="44025" x="8123238" y="5684838"/>
          <p14:tracePt t="44033" x="8169275" y="5721350"/>
          <p14:tracePt t="44051" x="8186738" y="5730875"/>
          <p14:tracePt t="44058" x="8196263" y="5734050"/>
          <p14:tracePt t="44065" x="8205788" y="5743575"/>
          <p14:tracePt t="44072" x="8220075" y="5743575"/>
          <p14:tracePt t="44081" x="8251825" y="5767388"/>
          <p14:tracePt t="44091" x="8293100" y="5775325"/>
          <p14:tracePt t="44095" x="8301038" y="5775325"/>
          <p14:tracePt t="44108" x="8337550" y="5784850"/>
          <p14:tracePt t="44112" x="8366125" y="5784850"/>
          <p14:tracePt t="44121" x="8397875" y="5784850"/>
          <p14:tracePt t="44132" x="8439150" y="5784850"/>
          <p14:tracePt t="44137" x="8442325" y="5784850"/>
          <p14:tracePt t="44148" x="8493125" y="5784850"/>
          <p14:tracePt t="44151" x="8520113" y="5784850"/>
          <p14:tracePt t="44163" x="8529638" y="5784850"/>
          <p14:tracePt t="44171" x="8580438" y="5767388"/>
          <p14:tracePt t="44178" x="8589963" y="5767388"/>
          <p14:tracePt t="44187" x="8616950" y="5762625"/>
          <p14:tracePt t="44192" x="8621713" y="5753100"/>
          <p14:tracePt t="44201" x="8648700" y="5734050"/>
          <p14:tracePt t="44213" x="8666163" y="5734050"/>
          <p14:tracePt t="44217" x="8675688" y="5734050"/>
          <p14:tracePt t="44228" x="8689975" y="5726113"/>
          <p14:tracePt t="44233" x="8712200" y="5716588"/>
          <p14:tracePt t="44244" x="8731250" y="5707063"/>
          <p14:tracePt t="44254" x="8758238" y="5707063"/>
          <p14:tracePt t="44260" x="8775700" y="5689600"/>
          <p14:tracePt t="44267" x="8821738" y="5675313"/>
          <p14:tracePt t="44276" x="8840788" y="5665788"/>
          <p14:tracePt t="44283" x="8867775" y="5657850"/>
          <p14:tracePt t="44295" x="8909050" y="5648325"/>
          <p14:tracePt t="44297" x="8918575" y="5638800"/>
          <p14:tracePt t="44309" x="8950325" y="5597525"/>
          <p14:tracePt t="44313" x="8977313" y="5597525"/>
          <p14:tracePt t="44325" x="8996363" y="5580063"/>
          <p14:tracePt t="44333" x="9013825" y="5570538"/>
          <p14:tracePt t="44337" x="9023350" y="5561013"/>
          <p14:tracePt t="44353" x="9040813" y="5556250"/>
          <p14:tracePt t="44374" x="9050338" y="5548313"/>
          <p14:tracePt t="44379" x="9055100" y="5538788"/>
          <p14:tracePt t="44393" x="9064625" y="5519738"/>
          <p14:tracePt t="44395" x="9072563" y="5514975"/>
          <p14:tracePt t="44403" x="9091613" y="5497513"/>
          <p14:tracePt t="44414" x="9137650" y="5461000"/>
          <p14:tracePt t="44426" x="9142413" y="5456238"/>
          <p14:tracePt t="44430" x="9159875" y="5429250"/>
          <p14:tracePt t="44433" x="9191625" y="5397500"/>
          <p14:tracePt t="44444" x="9201150" y="5378450"/>
          <p14:tracePt t="44453" x="9237663" y="5332413"/>
          <p14:tracePt t="44460" x="9242425" y="5324475"/>
          <p14:tracePt t="44469" x="9251950" y="5319713"/>
          <p14:tracePt t="44476" x="9269413" y="5291138"/>
          <p14:tracePt t="44485" x="9288463" y="5259388"/>
          <p14:tracePt t="44496" x="9320213" y="5227638"/>
          <p14:tracePt t="44506" x="9342438" y="5210175"/>
          <p14:tracePt t="44511" x="9342438" y="5200650"/>
          <p14:tracePt t="44515" x="9361488" y="5164138"/>
          <p14:tracePt t="44527" x="9378950" y="5132388"/>
          <p14:tracePt t="44535" x="9393238" y="5076825"/>
          <p14:tracePt t="44546" x="9393238" y="5068888"/>
          <p14:tracePt t="44550" x="9398000" y="5059363"/>
          <p14:tracePt t="44558" x="9405938" y="5049838"/>
          <p14:tracePt t="44565" x="9405938" y="5035550"/>
          <p14:tracePt t="44576" x="9405938" y="5027613"/>
          <p14:tracePt t="44868" x="9405938" y="4999038"/>
          <p14:tracePt t="44875" x="9405938" y="4995863"/>
          <p14:tracePt t="44879" x="9405938" y="4976813"/>
          <p14:tracePt t="44889" x="9405938" y="4967288"/>
          <p14:tracePt t="44899" x="9405938" y="4954588"/>
          <p14:tracePt t="44905" x="9405938" y="4913313"/>
          <p14:tracePt t="44914" x="9405938" y="4840288"/>
          <p14:tracePt t="44919" x="9405938" y="4811713"/>
          <p14:tracePt t="44930" x="9405938" y="4772025"/>
          <p14:tracePt t="44933" x="9420225" y="4716463"/>
          <p14:tracePt t="44943" x="9420225" y="4657725"/>
          <p14:tracePt t="44956" x="9434513" y="4565650"/>
          <p14:tracePt t="44965" x="9434513" y="4548188"/>
          <p14:tracePt t="44970" x="9442450" y="4506913"/>
          <p14:tracePt t="44979" x="9442450" y="4487863"/>
          <p14:tracePt t="44984" x="9461500" y="4470400"/>
          <p14:tracePt t="44994" x="9483725" y="4397375"/>
          <p14:tracePt t="44999" x="9483725" y="4387850"/>
          <p14:tracePt t="45009" x="9483725" y="4368800"/>
          <p14:tracePt t="45013" x="9483725" y="4365625"/>
          <p14:tracePt t="45024" x="9483725" y="4337050"/>
          <p14:tracePt t="45036" x="9483725" y="4319588"/>
          <p14:tracePt t="45047" x="9493250" y="4310063"/>
          <p14:tracePt t="45050" x="9493250" y="4305300"/>
          <p14:tracePt t="45067" x="9493250" y="4295775"/>
          <p14:tracePt t="45079" x="9493250" y="4278313"/>
          <p14:tracePt t="45081" x="9493250" y="4264025"/>
          <p14:tracePt t="45092" x="9493250" y="4246563"/>
          <p14:tracePt t="45096" x="9493250" y="4237038"/>
          <p14:tracePt t="45108" x="9493250" y="4210050"/>
          <p14:tracePt t="45115" x="9493250" y="4168775"/>
          <p14:tracePt t="45118" x="9493250" y="4164013"/>
          <p14:tracePt t="45129" x="9493250" y="4127500"/>
          <p14:tracePt t="45134" x="9493250" y="4086225"/>
          <p14:tracePt t="45145" x="9488488" y="4044950"/>
          <p14:tracePt t="45164" x="9451975" y="3944938"/>
          <p14:tracePt t="45179" x="9442450" y="3862388"/>
          <p14:tracePt t="45187" x="9420225" y="3816350"/>
          <p14:tracePt t="45196" x="9420225" y="3762375"/>
          <p14:tracePt t="45203" x="9410700" y="3752850"/>
          <p14:tracePt t="45216" x="9393238" y="3684588"/>
          <p14:tracePt t="45225" x="9393238" y="3652838"/>
          <p14:tracePt t="45235" x="9369425" y="3597275"/>
          <p14:tracePt t="45241" x="9369425" y="3589338"/>
          <p14:tracePt t="45251" x="9361488" y="3579813"/>
          <p14:tracePt t="45257" x="9361488" y="3575050"/>
          <p14:tracePt t="45267" x="9361488" y="3557588"/>
          <p14:tracePt t="45277" x="9361488" y="3516313"/>
          <p14:tracePt t="45280" x="9356725" y="3506788"/>
          <p14:tracePt t="45297" x="9347200" y="3484563"/>
          <p14:tracePt t="45313" x="9337675" y="3460750"/>
          <p14:tracePt t="45328" x="9337675" y="3433763"/>
          <p14:tracePt t="45358" x="9337675" y="3424238"/>
          <p14:tracePt t="45424" x="9328150" y="3409950"/>
          <p14:tracePt t="45499" x="9296400" y="3387725"/>
          <p14:tracePt t="45645" x="9278938" y="3387725"/>
          <p14:tracePt t="45669" x="9269413" y="3387725"/>
          <p14:tracePt t="45679" x="9255125" y="3387725"/>
          <p14:tracePt t="45696" x="9247188" y="3387725"/>
          <p14:tracePt t="45911" x="9237663" y="3387725"/>
          <p14:tracePt t="46482" x="9232900" y="3387725"/>
          <p14:tracePt t="46554" x="9215438" y="3387725"/>
          <p14:tracePt t="46560" x="9205913" y="3387725"/>
          <p14:tracePt t="46564" x="9191625" y="3387725"/>
          <p14:tracePt t="46577" x="9182100" y="3387725"/>
          <p14:tracePt t="46579" x="9145588" y="3387725"/>
          <p14:tracePt t="46588" x="9105900" y="3387725"/>
          <p14:tracePt t="46598" x="9050338" y="3387725"/>
          <p14:tracePt t="46604" x="9040813" y="3387725"/>
          <p14:tracePt t="46614" x="9009063" y="3387725"/>
          <p14:tracePt t="46617" x="8967788" y="3387725"/>
          <p14:tracePt t="46630" x="8936038" y="3387725"/>
          <p14:tracePt t="46638" x="8909050" y="3387725"/>
          <p14:tracePt t="46646" x="8899525" y="3387725"/>
          <p14:tracePt t="46654" x="8872538" y="3387725"/>
          <p14:tracePt t="46661" x="8853488" y="3387725"/>
          <p14:tracePt t="46669" x="8812213" y="3387725"/>
          <p14:tracePt t="46680" x="8772525" y="3387725"/>
          <p14:tracePt t="46683" x="8767763" y="3387725"/>
          <p14:tracePt t="46693" x="8748713" y="3387725"/>
          <p14:tracePt t="46699" x="8707438" y="3387725"/>
          <p14:tracePt t="46709" x="8621713" y="3373438"/>
          <p14:tracePt t="46720" x="8493125" y="3346450"/>
          <p14:tracePt t="46725" x="8461375" y="3346450"/>
          <p14:tracePt t="46733" x="8361363" y="3333750"/>
          <p14:tracePt t="46741" x="8288338" y="3333750"/>
          <p14:tracePt t="46749" x="8196263" y="3333750"/>
          <p14:tracePt t="46759" x="8086725" y="3319463"/>
          <p14:tracePt t="46765" x="8069263" y="3319463"/>
          <p14:tracePt t="46776" x="8027988" y="3319463"/>
          <p14:tracePt t="46779" x="7996238" y="3319463"/>
          <p14:tracePt t="46792" x="7967663" y="3319463"/>
          <p14:tracePt t="46799" x="7950200" y="3319463"/>
          <p14:tracePt t="46805" x="7940675" y="3319463"/>
          <p14:tracePt t="46815" x="7935913" y="3319463"/>
          <p14:tracePt t="46819" x="7926388" y="3319463"/>
          <p14:tracePt t="46831" x="7918450" y="3314700"/>
          <p14:tracePt t="46843" x="7904163" y="3314700"/>
          <p14:tracePt t="46876" x="7894638" y="3314700"/>
          <p14:tracePt t="46885" x="7886700" y="3314700"/>
          <p14:tracePt t="46896" x="7877175" y="3314700"/>
          <p14:tracePt t="46901" x="7862888" y="3314700"/>
          <p14:tracePt t="46915" x="7853363" y="3314700"/>
          <p14:tracePt t="46921" x="7845425" y="3314700"/>
          <p14:tracePt t="46929" x="7840663" y="3314700"/>
          <p14:tracePt t="46962" x="7831138" y="3314700"/>
          <p14:tracePt t="46965" x="7821613" y="3314700"/>
          <p14:tracePt t="46976" x="7816850" y="3314700"/>
          <p14:tracePt t="47087" x="7835900" y="3314700"/>
          <p14:tracePt t="47097" x="7918450" y="3314700"/>
          <p14:tracePt t="47101" x="7996238" y="3314700"/>
          <p14:tracePt t="47113" x="8086725" y="3314700"/>
          <p14:tracePt t="47127" x="8242300" y="3314700"/>
          <p14:tracePt t="47145" x="8383588" y="3314700"/>
          <p14:tracePt t="47153" x="8424863" y="3314700"/>
          <p14:tracePt t="47163" x="8507413" y="3314700"/>
          <p14:tracePt t="47167" x="8524875" y="3314700"/>
          <p14:tracePt t="47178" x="8534400" y="3314700"/>
          <p14:tracePt t="47184" x="8553450" y="3314700"/>
          <p14:tracePt t="47259" x="8556625" y="3314700"/>
          <p14:tracePt t="47345" x="8575675" y="3314700"/>
          <p14:tracePt t="47366" x="8593138" y="3314700"/>
          <p14:tracePt t="47370" x="8597900" y="3314700"/>
          <p14:tracePt t="47379" x="8607425" y="3314700"/>
          <p14:tracePt t="47385" x="8643938" y="3314700"/>
          <p14:tracePt t="47398" x="8653463" y="3314700"/>
          <p14:tracePt t="47406" x="8680450" y="3314700"/>
          <p14:tracePt t="47413" x="8685213" y="3314700"/>
          <p14:tracePt t="47419" x="8702675" y="3314700"/>
          <p14:tracePt t="47427" x="8721725" y="3314700"/>
          <p14:tracePt t="47443" x="8726488" y="3314700"/>
          <p14:tracePt t="47447" x="8736013" y="3314700"/>
          <p14:tracePt t="48112" x="8731250" y="3314700"/>
          <p14:tracePt t="48124" x="8716963" y="3333750"/>
          <p14:tracePt t="48130" x="8694738" y="3351213"/>
          <p14:tracePt t="48136" x="8666163" y="3365500"/>
          <p14:tracePt t="48147" x="8607425" y="3397250"/>
          <p14:tracePt t="48152" x="8585200" y="3429000"/>
          <p14:tracePt t="48162" x="8566150" y="3438525"/>
          <p14:tracePt t="48167" x="8507413" y="3475038"/>
          <p14:tracePt t="48178" x="8488363" y="3492500"/>
          <p14:tracePt t="48188" x="8415338" y="3543300"/>
          <p14:tracePt t="48194" x="8397875" y="3552825"/>
          <p14:tracePt t="48202" x="8366125" y="3584575"/>
          <p14:tracePt t="48211" x="8342313" y="3602038"/>
          <p14:tracePt t="48217" x="8296275" y="3648075"/>
          <p14:tracePt t="48228" x="8251825" y="3684588"/>
          <p14:tracePt t="48232" x="8251825" y="3703638"/>
          <p14:tracePt t="48242" x="8228013" y="3748088"/>
          <p14:tracePt t="48247" x="8210550" y="3776663"/>
          <p14:tracePt t="48259" x="8186738" y="3821113"/>
          <p14:tracePt t="48267" x="8178800" y="3840163"/>
          <p14:tracePt t="48275" x="8169275" y="3849688"/>
          <p14:tracePt t="48283" x="8159750" y="3871913"/>
          <p14:tracePt t="48287" x="8159750" y="3881438"/>
          <p14:tracePt t="48298" x="8159750" y="3908425"/>
          <p14:tracePt t="48308" x="8150225" y="3940175"/>
          <p14:tracePt t="48314" x="8142288" y="3944938"/>
          <p14:tracePt t="48325" x="8142288" y="3954463"/>
          <p14:tracePt t="48328" x="8142288" y="3963988"/>
          <p14:tracePt t="48337" x="8142288" y="3976688"/>
          <p14:tracePt t="48348" x="8132763" y="4008438"/>
          <p14:tracePt t="48361" x="8132763" y="4017963"/>
          <p14:tracePt t="48365" x="8123238" y="4022725"/>
          <p14:tracePt t="48367" x="8118475" y="4032250"/>
          <p14:tracePt t="48378" x="8108950" y="4059238"/>
          <p14:tracePt t="48392" x="8091488" y="4068763"/>
          <p14:tracePt t="48394" x="8081963" y="4076700"/>
          <p14:tracePt t="48403" x="8072438" y="4081463"/>
          <p14:tracePt t="48409" x="8064500" y="4090988"/>
          <p14:tracePt t="48419" x="8050213" y="4100513"/>
          <p14:tracePt t="48429" x="8032750" y="4110038"/>
          <p14:tracePt t="48433" x="8023225" y="4110038"/>
          <p14:tracePt t="48443" x="8004175" y="4117975"/>
          <p14:tracePt t="48449" x="7996238" y="4117975"/>
          <p14:tracePt t="48459" x="7981950" y="4137025"/>
          <p14:tracePt t="48469" x="7962900" y="4137025"/>
          <p14:tracePt t="48475" x="7945438" y="4137025"/>
          <p14:tracePt t="48483" x="7926388" y="4137025"/>
          <p14:tracePt t="48492" x="7918450" y="4137025"/>
          <p14:tracePt t="48499" x="7913688" y="4141788"/>
          <p14:tracePt t="48512" x="7904163" y="4141788"/>
          <p14:tracePt t="48519" x="7894638" y="4141788"/>
          <p14:tracePt t="48529" x="7889875" y="4141788"/>
          <p14:tracePt t="48540" x="7872413" y="4141788"/>
          <p14:tracePt t="48549" x="7862888" y="4141788"/>
          <p14:tracePt t="48565" x="7858125" y="4141788"/>
          <p14:tracePt t="48612" x="7850188" y="4141788"/>
          <p14:tracePt t="48753" x="7858125" y="4141788"/>
          <p14:tracePt t="48761" x="7867650" y="4141788"/>
          <p14:tracePt t="48769" x="7931150" y="4137025"/>
          <p14:tracePt t="48780" x="8004175" y="4122738"/>
          <p14:tracePt t="48783" x="8064500" y="4122738"/>
          <p14:tracePt t="48793" x="8196263" y="4095750"/>
          <p14:tracePt t="48798" x="8223250" y="4086225"/>
          <p14:tracePt t="48809" x="8278813" y="4073525"/>
          <p14:tracePt t="48812" x="8310563" y="4064000"/>
          <p14:tracePt t="48825" x="8351838" y="4054475"/>
          <p14:tracePt t="48831" x="8415338" y="4027488"/>
          <p14:tracePt t="48837" x="8424863" y="4027488"/>
          <p14:tracePt t="48848" x="8429625" y="4022725"/>
          <p14:tracePt t="48875" x="8439150" y="4013200"/>
          <p14:tracePt t="48909" x="8447088" y="4013200"/>
          <p14:tracePt t="48917" x="8461375" y="4013200"/>
          <p14:tracePt t="48929" x="8488363" y="4013200"/>
          <p14:tracePt t="48936" x="8507413" y="4013200"/>
          <p14:tracePt t="48947" x="8534400" y="4003675"/>
          <p14:tracePt t="48953" x="8566150" y="4003675"/>
          <p14:tracePt t="48959" x="8570913" y="4003675"/>
          <p14:tracePt t="48968" x="8597900" y="3995738"/>
          <p14:tracePt t="48973" x="8607425" y="3995738"/>
          <p14:tracePt t="48984" x="8626475" y="3986213"/>
          <p14:tracePt t="48995" x="8643938" y="3986213"/>
          <p14:tracePt t="49000" x="8662988" y="3976688"/>
          <p14:tracePt t="49016" x="8702675" y="3967163"/>
          <p14:tracePt t="49030" x="8712200" y="3967163"/>
          <p14:tracePt t="49034" x="8743950" y="3967163"/>
          <p14:tracePt t="49049" x="8763000" y="3967163"/>
          <p14:tracePt t="49050" x="8772525" y="3967163"/>
          <p14:tracePt t="49053" x="8799513" y="3967163"/>
          <p14:tracePt t="49069" x="8804275" y="3967163"/>
          <p14:tracePt t="49076" x="8812213" y="3967163"/>
          <p14:tracePt t="49079" x="8821738" y="3967163"/>
          <p14:tracePt t="49095" x="8840788" y="3967163"/>
          <p14:tracePt t="49358" x="8826500" y="3967163"/>
          <p14:tracePt t="49368" x="8816975" y="3967163"/>
          <p14:tracePt t="49376" x="8799513" y="3949700"/>
          <p14:tracePt t="49380" x="8780463" y="3949700"/>
          <p14:tracePt t="49389" x="8763000" y="3949700"/>
          <p14:tracePt t="49399" x="8694738" y="3949700"/>
          <p14:tracePt t="49402" x="8675688" y="3949700"/>
          <p14:tracePt t="49413" x="8634413" y="3949700"/>
          <p14:tracePt t="49417" x="8580438" y="3949700"/>
          <p14:tracePt t="49428" x="8539163" y="3949700"/>
          <p14:tracePt t="49437" x="8456613" y="3949700"/>
          <p14:tracePt t="49446" x="8439150" y="3949700"/>
          <p14:tracePt t="49453" x="8434388" y="3949700"/>
          <p14:tracePt t="49458" x="8405813" y="3949700"/>
          <p14:tracePt t="49467" x="8397875" y="3949700"/>
          <p14:tracePt t="49477" x="8378825" y="3949700"/>
          <p14:tracePt t="49487" x="8366125" y="3949700"/>
          <p14:tracePt t="49497" x="8356600" y="3949700"/>
          <p14:tracePt t="49509" x="8337550" y="3949700"/>
          <p14:tracePt t="49517" x="8310563" y="3949700"/>
          <p14:tracePt t="49526" x="8293100" y="3949700"/>
          <p14:tracePt t="49533" x="8264525" y="3949700"/>
          <p14:tracePt t="49542" x="8232775" y="3949700"/>
          <p14:tracePt t="49549" x="8205788" y="3954463"/>
          <p14:tracePt t="49563" x="8077200" y="3976688"/>
          <p14:tracePt t="49576" x="8018463" y="3976688"/>
          <p14:tracePt t="49580" x="7926388" y="3976688"/>
          <p14:tracePt t="49592" x="7872413" y="3976688"/>
          <p14:tracePt t="49600" x="7813675" y="3990975"/>
          <p14:tracePt t="49603" x="7794625" y="3990975"/>
          <p14:tracePt t="49613" x="7753350" y="3990975"/>
          <p14:tracePt t="49619" x="7721600" y="3990975"/>
          <p14:tracePt t="49630" x="7694613" y="3990975"/>
          <p14:tracePt t="49643" x="7670800" y="3990975"/>
          <p14:tracePt t="49660" x="7662863" y="3990975"/>
          <p14:tracePt t="50229" x="7653338" y="3990975"/>
          <p14:tracePt t="50239" x="7685088" y="3990975"/>
          <p14:tracePt t="50250" x="7753350" y="3990975"/>
          <p14:tracePt t="50260" x="7881938" y="3990975"/>
          <p14:tracePt t="50265" x="7913688" y="3990975"/>
          <p14:tracePt t="50277" x="7981950" y="3990975"/>
          <p14:tracePt t="50280" x="8072438" y="4000500"/>
          <p14:tracePt t="50293" x="8150225" y="4000500"/>
          <p14:tracePt t="50299" x="8278813" y="4017963"/>
          <p14:tracePt t="50311" x="8305800" y="4017963"/>
          <p14:tracePt t="50316" x="8347075" y="4017963"/>
          <p14:tracePt t="50319" x="8434388" y="4027488"/>
          <p14:tracePt t="50330" x="8478838" y="4049713"/>
          <p14:tracePt t="50343" x="8556625" y="4064000"/>
          <p14:tracePt t="50346" x="8566150" y="4064000"/>
          <p14:tracePt t="50357" x="8589963" y="4073525"/>
          <p14:tracePt t="50365" x="8634413" y="4081463"/>
          <p14:tracePt t="55718" x="8639175" y="4081463"/>
          <p14:tracePt t="55732" x="11676063" y="3487738"/>
          <p14:tracePt t="55743" x="11685588" y="3470275"/>
          <p14:tracePt t="55750" x="11693525" y="3460750"/>
          <p14:tracePt t="55760" x="11698288" y="3455988"/>
          <p14:tracePt t="55763" x="11707813" y="3448050"/>
          <p14:tracePt t="55772" x="11734800" y="3419475"/>
          <p14:tracePt t="55783" x="11753850" y="3409950"/>
          <p14:tracePt t="55788" x="11763375" y="3392488"/>
          <p14:tracePt t="55799" x="11780838" y="3382963"/>
          <p14:tracePt t="55804" x="11790363" y="3382963"/>
          <p14:tracePt t="55813" x="11799888" y="3373438"/>
          <p14:tracePt t="55844" x="11804650" y="3365500"/>
          <p14:tracePt t="55853" x="11812588" y="3360738"/>
          <p14:tracePt t="55861" x="11822113" y="3351213"/>
          <p14:tracePt t="55867" x="11849100" y="3333750"/>
          <p14:tracePt t="55879" x="11868150" y="3300413"/>
          <p14:tracePt t="55883" x="11909425" y="3300413"/>
          <p14:tracePt t="55895" x="11968163" y="3268663"/>
          <p14:tracePt t="55899" x="11987213" y="3246438"/>
          <p14:tracePt t="55909" x="12031663" y="3214688"/>
          <p14:tracePt t="55919" x="12050713" y="3205163"/>
          <p14:tracePt t="55924" x="12060238" y="3195638"/>
          <p14:tracePt t="55933" x="12068175" y="3168650"/>
          <p14:tracePt t="55941" x="12087225" y="3159125"/>
          <p14:tracePt t="55949" x="12096750" y="3132138"/>
          <p14:tracePt t="55959" x="12118975" y="3109913"/>
          <p14:tracePt t="55963" x="12118975" y="3105150"/>
          <p14:tracePt t="55976" x="12128500" y="3078163"/>
          <p14:tracePt t="55979" x="12133263" y="3068638"/>
          <p14:tracePt t="55992" x="12133263" y="3049588"/>
          <p14:tracePt t="56049" x="12133263" y="3044825"/>
          <p14:tracePt t="56059" x="12133263" y="3036888"/>
          <p14:tracePt t="56070" x="12133263" y="3027363"/>
          <p14:tracePt t="56099" x="12133263" y="3022600"/>
          <p14:tracePt t="56115" x="12133263" y="3005138"/>
          <p14:tracePt t="56131" x="12133263" y="2976563"/>
          <p14:tracePt t="56142" x="12133263" y="2968625"/>
          <p14:tracePt t="56151" x="12114213" y="2949575"/>
          <p14:tracePt t="56163" x="12096750" y="2940050"/>
          <p14:tracePt t="56177" x="12077700" y="2927350"/>
          <p14:tracePt t="56215" x="12077700" y="2917825"/>
          <p14:tracePt t="56231" x="12068175" y="2890838"/>
          <p14:tracePt t="56241" x="12068175" y="2881313"/>
          <p14:tracePt t="56251" x="12068175" y="2857500"/>
          <p14:tracePt t="56257" x="12063413" y="2849563"/>
          <p14:tracePt t="56267" x="12063413" y="2840038"/>
          <p14:tracePt t="56271" x="12055475" y="2820988"/>
          <p14:tracePt t="56281" x="12045950" y="2794000"/>
          <p14:tracePt t="56292" x="12045950" y="2762250"/>
          <p14:tracePt t="56301" x="12031663" y="2735263"/>
          <p14:tracePt t="56312" x="12023725" y="2693988"/>
          <p14:tracePt t="56325" x="12023725" y="2684463"/>
          <p14:tracePt t="56329" x="12014200" y="2667000"/>
          <p14:tracePt t="56337" x="12014200" y="2625725"/>
          <p14:tracePt t="56348" x="12004675" y="2616200"/>
          <p14:tracePt t="56355" x="11999913" y="2611438"/>
          <p14:tracePt t="56364" x="11990388" y="2593975"/>
          <p14:tracePt t="56378" x="11982450" y="2584450"/>
          <p14:tracePt t="56383" x="11982450" y="2570163"/>
          <p14:tracePt t="56394" x="11963400" y="2547938"/>
          <p14:tracePt t="56403" x="11945938" y="2538413"/>
          <p14:tracePt t="56413" x="11926888" y="2520950"/>
          <p14:tracePt t="56417" x="11917363" y="2511425"/>
          <p14:tracePt t="56423" x="11899900" y="2484438"/>
          <p14:tracePt t="56434" x="11877675" y="2455863"/>
          <p14:tracePt t="56444" x="11836400" y="2433638"/>
          <p14:tracePt t="56447" x="11826875" y="2424113"/>
          <p14:tracePt t="56460" x="11776075" y="2392363"/>
          <p14:tracePt t="56464" x="11758613" y="2374900"/>
          <p14:tracePt t="56474" x="11666538" y="2324100"/>
          <p14:tracePt t="56483" x="11603038" y="2273300"/>
          <p14:tracePt t="56492" x="11593513" y="2273300"/>
          <p14:tracePt t="56499" x="11515725" y="2236788"/>
          <p14:tracePt t="56503" x="11488738" y="2228850"/>
          <p14:tracePt t="56513" x="11415713" y="2205038"/>
          <p14:tracePt t="56525" x="11369675" y="2182813"/>
          <p14:tracePt t="56529" x="11337925" y="2173288"/>
          <p14:tracePt t="56541" x="11283950" y="2159000"/>
          <p14:tracePt t="56544" x="11274425" y="2155825"/>
          <p14:tracePt t="56553" x="11201400" y="2132013"/>
          <p14:tracePt t="56564" x="11160125" y="2132013"/>
          <p14:tracePt t="56569" x="11141075" y="2122488"/>
          <p14:tracePt t="56579" x="11096625" y="2085975"/>
          <p14:tracePt t="56585" x="11077575" y="2085975"/>
          <p14:tracePt t="56595" x="11004550" y="2063750"/>
          <p14:tracePt t="56605" x="10987088" y="2054225"/>
          <p14:tracePt t="56611" x="10982325" y="2054225"/>
          <p14:tracePt t="56619" x="10945813" y="2054225"/>
          <p14:tracePt t="56627" x="10936288" y="2046288"/>
          <p14:tracePt t="56635" x="10917238" y="2046288"/>
          <p14:tracePt t="56645" x="10899775" y="2036763"/>
          <p14:tracePt t="56649" x="10880725" y="2027238"/>
          <p14:tracePt t="56660" x="10853738" y="2027238"/>
          <p14:tracePt t="56669" x="10844213" y="2027238"/>
          <p14:tracePt t="56676" x="10836275" y="2027238"/>
          <p14:tracePt t="56685" x="10831513" y="2027238"/>
          <p14:tracePt t="56696" x="10821988" y="2027238"/>
          <p14:tracePt t="56709" x="10812463" y="2027238"/>
          <p14:tracePt t="56715" x="10804525" y="2027238"/>
          <p14:tracePt t="56726" x="10799763" y="2027238"/>
          <p14:tracePt t="56731" x="10790238" y="2027238"/>
          <p14:tracePt t="56741" x="10753725" y="2027238"/>
          <p14:tracePt t="56751" x="10744200" y="2027238"/>
          <p14:tracePt t="56757" x="10721975" y="2027238"/>
          <p14:tracePt t="56765" x="10675938" y="2036763"/>
          <p14:tracePt t="56775" x="10671175" y="2041525"/>
          <p14:tracePt t="56781" x="10634663" y="2049463"/>
          <p14:tracePt t="56785" x="10602913" y="2063750"/>
          <p14:tracePt t="56796" x="10544175" y="2122488"/>
          <p14:tracePt t="56808" x="10510838" y="2141538"/>
          <p14:tracePt t="56812" x="10493375" y="2151063"/>
          <p14:tracePt t="56825" x="10461625" y="2182813"/>
          <p14:tracePt t="56828" x="10452100" y="2192338"/>
          <p14:tracePt t="56837" x="10425113" y="2209800"/>
          <p14:tracePt t="56848" x="10420350" y="2219325"/>
          <p14:tracePt t="56851" x="10410825" y="2224088"/>
          <p14:tracePt t="56863" x="10401300" y="2232025"/>
          <p14:tracePt t="56867" x="10383838" y="2260600"/>
          <p14:tracePt t="56878" x="10364788" y="2278063"/>
          <p14:tracePt t="56887" x="10347325" y="2309813"/>
          <p14:tracePt t="56897" x="10337800" y="2328863"/>
          <p14:tracePt t="56901" x="10328275" y="2346325"/>
          <p14:tracePt t="56909" x="10320338" y="2355850"/>
          <p14:tracePt t="56917" x="10301288" y="2392363"/>
          <p14:tracePt t="56929" x="10279063" y="2414588"/>
          <p14:tracePt t="56933" x="10279063" y="2428875"/>
          <p14:tracePt t="56944" x="10260013" y="2474913"/>
          <p14:tracePt t="56947" x="10252075" y="2484438"/>
          <p14:tracePt t="56959" x="10218738" y="2533650"/>
          <p14:tracePt t="56968" x="10210800" y="2543175"/>
          <p14:tracePt t="56975" x="10206038" y="2557463"/>
          <p14:tracePt t="56983" x="10191750" y="2579688"/>
          <p14:tracePt t="56988" x="10182225" y="2606675"/>
          <p14:tracePt t="56997" x="10182225" y="2625725"/>
          <p14:tracePt t="57010" x="10182225" y="2635250"/>
          <p14:tracePt t="57013" x="10182225" y="2638425"/>
          <p14:tracePt t="57026" x="10179050" y="2647950"/>
          <p14:tracePt t="57028" x="10169525" y="2667000"/>
          <p14:tracePt t="57037" x="10155238" y="2708275"/>
          <p14:tracePt t="57049" x="10155238" y="2725738"/>
          <p14:tracePt t="57053" x="10155238" y="2735263"/>
          <p14:tracePt t="57063" x="10155238" y="2794000"/>
          <p14:tracePt t="57069" x="10155238" y="2813050"/>
          <p14:tracePt t="57079" x="10118725" y="2886075"/>
          <p14:tracePt t="57092" x="10118725" y="2913063"/>
          <p14:tracePt t="57093" x="10118725" y="2944813"/>
          <p14:tracePt t="57103" x="10118725" y="3013075"/>
          <p14:tracePt t="57109" x="10118725" y="3032125"/>
          <p14:tracePt t="57119" x="10118725" y="3127375"/>
          <p14:tracePt t="57129" x="10109200" y="3168650"/>
          <p14:tracePt t="57143" x="10096500" y="3287713"/>
          <p14:tracePt t="57149" x="10096500" y="3305175"/>
          <p14:tracePt t="57159" x="10096500" y="3387725"/>
          <p14:tracePt t="57169" x="10086975" y="3419475"/>
          <p14:tracePt t="57176" x="10086975" y="3438525"/>
          <p14:tracePt t="57185" x="10086975" y="3506788"/>
          <p14:tracePt t="57192" x="10086975" y="3524250"/>
          <p14:tracePt t="57200" x="10086975" y="3606800"/>
          <p14:tracePt t="57210" x="10086975" y="3638550"/>
          <p14:tracePt t="57215" x="10086975" y="3667125"/>
          <p14:tracePt t="57226" x="10086975" y="3721100"/>
          <p14:tracePt t="57230" x="10086975" y="3740150"/>
          <p14:tracePt t="57241" x="10086975" y="3821113"/>
          <p14:tracePt t="57249" x="10086975" y="3881438"/>
          <p14:tracePt t="57257" x="10086975" y="3898900"/>
          <p14:tracePt t="57265" x="10086975" y="3981450"/>
          <p14:tracePt t="57269" x="10086975" y="3990975"/>
          <p14:tracePt t="57281" x="10086975" y="4086225"/>
          <p14:tracePt t="57291" x="10086975" y="4117975"/>
          <p14:tracePt t="57295" x="10086975" y="4159250"/>
          <p14:tracePt t="57307" x="10086975" y="4227513"/>
          <p14:tracePt t="57312" x="10086975" y="4268788"/>
          <p14:tracePt t="57324" x="10104438" y="4341813"/>
          <p14:tracePt t="57331" x="10104438" y="4383088"/>
          <p14:tracePt t="57335" x="10118725" y="4410075"/>
          <p14:tracePt t="57346" x="10140950" y="4470400"/>
          <p14:tracePt t="57351" x="10140950" y="4487863"/>
          <p14:tracePt t="57363" x="10179050" y="4560888"/>
          <p14:tracePt t="57376" x="10210800" y="4625975"/>
          <p14:tracePt t="57385" x="10260013" y="4711700"/>
          <p14:tracePt t="57397" x="10283825" y="4775200"/>
          <p14:tracePt t="57401" x="10291763" y="4803775"/>
          <p14:tracePt t="57412" x="10291763" y="4821238"/>
          <p14:tracePt t="57417" x="10291763" y="4830763"/>
          <p14:tracePt t="57428" x="10325100" y="4872038"/>
          <p14:tracePt t="57437" x="10333038" y="4889500"/>
          <p14:tracePt t="57442" x="10352088" y="4908550"/>
          <p14:tracePt t="57462" x="10369550" y="4918075"/>
          <p14:tracePt t="57467" x="10379075" y="4926013"/>
          <p14:tracePt t="57481" x="10415588" y="4945063"/>
          <p14:tracePt t="57492" x="10434638" y="4945063"/>
          <p14:tracePt t="57497" x="10452100" y="4954588"/>
          <p14:tracePt t="57508" x="10471150" y="4954588"/>
          <p14:tracePt t="57513" x="10479088" y="4962525"/>
          <p14:tracePt t="57526" x="10483850" y="4962525"/>
          <p14:tracePt t="57533" x="10510838" y="4972050"/>
          <p14:tracePt t="57547" x="10520363" y="4972050"/>
          <p14:tracePt t="57554" x="10539413" y="4972050"/>
          <p14:tracePt t="57564" x="10566400" y="4991100"/>
          <p14:tracePt t="57576" x="10588625" y="4999038"/>
          <p14:tracePt t="57583" x="10607675" y="5008563"/>
          <p14:tracePt t="57587" x="10625138" y="5027613"/>
          <p14:tracePt t="57594" x="10634663" y="5035550"/>
          <p14:tracePt t="57604" x="10671175" y="5054600"/>
          <p14:tracePt t="57615" x="10690225" y="5064125"/>
          <p14:tracePt t="57617" x="10717213" y="5064125"/>
          <p14:tracePt t="57629" x="10763250" y="5100638"/>
          <p14:tracePt t="57647" x="10812463" y="5141913"/>
          <p14:tracePt t="57765" x="11164888" y="5113338"/>
          <p14:tracePt t="57775" x="11169650" y="5113338"/>
          <p14:tracePt t="57785" x="11177588" y="5113338"/>
          <p14:tracePt t="57793" x="11206163" y="5113338"/>
          <p14:tracePt t="57796" x="11214100" y="5108575"/>
          <p14:tracePt t="57809" x="11228388" y="5091113"/>
          <p14:tracePt t="57815" x="11247438" y="5081588"/>
          <p14:tracePt t="57819" x="11255375" y="5081588"/>
          <p14:tracePt t="57830" x="11264900" y="5064125"/>
          <p14:tracePt t="57835" x="11274425" y="5045075"/>
          <p14:tracePt t="57845" x="11306175" y="5013325"/>
          <p14:tracePt t="57858" x="11328400" y="4981575"/>
          <p14:tracePt t="57862" x="11333163" y="4976813"/>
          <p14:tracePt t="57876" x="11388725" y="4889500"/>
          <p14:tracePt t="57885" x="11420475" y="4848225"/>
          <p14:tracePt t="57896" x="11437938" y="4826000"/>
          <p14:tracePt t="57908" x="11461750" y="4799013"/>
          <p14:tracePt t="57912" x="11471275" y="4789488"/>
          <p14:tracePt t="57926" x="11474450" y="4772025"/>
          <p14:tracePt t="57935" x="11483975" y="4762500"/>
          <p14:tracePt t="57942" x="11493500" y="4757738"/>
          <p14:tracePt t="57951" x="11503025" y="4757738"/>
          <p14:tracePt t="57957" x="11507788" y="4748213"/>
          <p14:tracePt t="57965" x="11525250" y="4738688"/>
          <p14:tracePt t="57978" x="11547475" y="4706938"/>
          <p14:tracePt t="57982" x="11557000" y="4679950"/>
          <p14:tracePt t="57992" x="11576050" y="4633913"/>
          <p14:tracePt t="57997" x="11583988" y="4625975"/>
          <p14:tracePt t="58008" x="11617325" y="4538663"/>
          <p14:tracePt t="58017" x="11644313" y="4475163"/>
          <p14:tracePt t="58026" x="11653838" y="4470400"/>
          <p14:tracePt t="58031" x="11685588" y="4378325"/>
          <p14:tracePt t="58037" x="11703050" y="4368800"/>
          <p14:tracePt t="58047" x="11726863" y="4314825"/>
          <p14:tracePt t="58059" x="11749088" y="4251325"/>
          <p14:tracePt t="58062" x="11763375" y="4219575"/>
          <p14:tracePt t="58075" x="11771313" y="4149725"/>
          <p14:tracePt t="58078" x="11780838" y="4132263"/>
          <p14:tracePt t="58087" x="11795125" y="4017963"/>
          <p14:tracePt t="58098" x="11807825" y="3959225"/>
          <p14:tracePt t="58104" x="11807825" y="3940175"/>
          <p14:tracePt t="58114" x="11817350" y="3840163"/>
          <p14:tracePt t="58117" x="11817350" y="3813175"/>
          <p14:tracePt t="58128" x="11831638" y="3694113"/>
          <p14:tracePt t="58148" x="11831638" y="3621088"/>
          <p14:tracePt t="58153" x="11831638" y="3492500"/>
          <p14:tracePt t="58160" x="11831638" y="3475038"/>
          <p14:tracePt t="58167" x="11831638" y="3378200"/>
          <p14:tracePt t="58178" x="11831638" y="3282950"/>
          <p14:tracePt t="58183" x="11831638" y="3278188"/>
          <p14:tracePt t="58194" x="11831638" y="3178175"/>
          <p14:tracePt t="58198" x="11831638" y="3159125"/>
          <p14:tracePt t="58209" x="11826875" y="3078163"/>
          <p14:tracePt t="58219" x="11812588" y="3000375"/>
          <p14:tracePt t="58223" x="11812588" y="2981325"/>
          <p14:tracePt t="58233" x="11776075" y="2894013"/>
          <p14:tracePt t="58240" x="11776075" y="2886075"/>
          <p14:tracePt t="58249" x="11753850" y="2835275"/>
          <p14:tracePt t="58260" x="11744325" y="2817813"/>
          <p14:tracePt t="58264" x="11744325" y="2798763"/>
          <p14:tracePt t="58275" x="11734800" y="2789238"/>
          <p14:tracePt t="58280" x="11734800" y="2776538"/>
          <p14:tracePt t="58292" x="11707813" y="2752725"/>
          <p14:tracePt t="58299" x="11707813" y="2735263"/>
          <p14:tracePt t="58303" x="11698288" y="2730500"/>
          <p14:tracePt t="58314" x="11680825" y="2689225"/>
          <p14:tracePt t="58319" x="11680825" y="2684463"/>
          <p14:tracePt t="58330" x="11671300" y="2647950"/>
          <p14:tracePt t="58342" x="11649075" y="2616200"/>
          <p14:tracePt t="58346" x="11649075" y="2606675"/>
          <p14:tracePt t="58358" x="11617325" y="2528888"/>
          <p14:tracePt t="58365" x="11617325" y="2516188"/>
          <p14:tracePt t="58369" x="11617325" y="2506663"/>
          <p14:tracePt t="58381" x="11617325" y="2470150"/>
          <p14:tracePt t="58385" x="11583988" y="2438400"/>
          <p14:tracePt t="58395" x="11583988" y="2382838"/>
          <p14:tracePt t="58399" x="11580813" y="2374900"/>
          <p14:tracePt t="58410" x="11571288" y="2346325"/>
          <p14:tracePt t="58419" x="11547475" y="2338388"/>
          <p14:tracePt t="58431" x="11547475" y="2319338"/>
          <p14:tracePt t="58443" x="11547475" y="2301875"/>
          <p14:tracePt t="58451" x="11530013" y="2282825"/>
          <p14:tracePt t="58462" x="11520488" y="2273300"/>
          <p14:tracePt t="59655" x="11520488" y="2278063"/>
          <p14:tracePt t="59661" x="11520488" y="2314575"/>
          <p14:tracePt t="59665" x="11530013" y="2346325"/>
          <p14:tracePt t="59676" x="11625263" y="2584450"/>
          <p14:tracePt t="59681" x="11634788" y="2616200"/>
          <p14:tracePt t="59692" x="11676063" y="2762250"/>
          <p14:tracePt t="59701" x="11722100" y="2913063"/>
          <p14:tracePt t="59710" x="11744325" y="2990850"/>
          <p14:tracePt t="59717" x="11822113" y="3336925"/>
          <p14:tracePt t="59722" x="11836400" y="3414713"/>
          <p14:tracePt t="59731" x="11890375" y="3730625"/>
          <p14:tracePt t="59743" x="11922125" y="3881438"/>
          <p14:tracePt t="59747" x="11931650" y="3940175"/>
          <p14:tracePt t="59759" x="11931650" y="4137025"/>
          <p14:tracePt t="59762" x="11931650" y="4191000"/>
          <p14:tracePt t="59775" x="11931650" y="4373563"/>
          <p14:tracePt t="59781" x="11931650" y="4483100"/>
          <p14:tracePt t="59790" x="11926888" y="4543425"/>
          <p14:tracePt t="59798" x="11807825" y="4748213"/>
          <p14:tracePt t="59801" x="11799888" y="4767263"/>
          <p14:tracePt t="59812" x="11634788" y="4995863"/>
          <p14:tracePt t="59825" x="11525250" y="5132388"/>
          <p14:tracePt t="59894" x="9831388" y="5867400"/>
          <p14:tracePt t="59903" x="9488488" y="5889625"/>
          <p14:tracePt t="59910" x="9361488" y="5903913"/>
          <p14:tracePt t="59918" x="8799513" y="5967413"/>
          <p14:tracePt t="59925" x="8670925" y="5981700"/>
          <p14:tracePt t="59933" x="8118475" y="6003925"/>
          <p14:tracePt t="59944" x="7777163" y="6022975"/>
          <p14:tracePt t="59949" x="7666038" y="6022975"/>
          <p14:tracePt t="59959" x="7196138" y="6022975"/>
          <p14:tracePt t="59963" x="7105650" y="6022975"/>
          <p14:tracePt t="59976" x="6721475" y="6022975"/>
          <p14:tracePt t="59983" x="6538913" y="6022975"/>
          <p14:tracePt t="59992" x="6480175" y="6018213"/>
          <p14:tracePt t="59999" x="6246813" y="5981700"/>
          <p14:tracePt t="60003" x="6219825" y="5972175"/>
          <p14:tracePt t="60013" x="6100763" y="5935663"/>
          <p14:tracePt t="60024" x="6040438" y="5908675"/>
          <p14:tracePt t="60029" x="6008688" y="5899150"/>
          <p14:tracePt t="60041" x="5976938" y="5889625"/>
          <p14:tracePt t="60044" x="5935663" y="5876925"/>
          <p14:tracePt t="60058" x="5918200" y="5867400"/>
          <p14:tracePt t="60066" x="5899150" y="5867400"/>
          <p14:tracePt t="60069" x="5891213" y="5848350"/>
          <p14:tracePt t="60079" x="5862638" y="5840413"/>
          <p14:tracePt t="60093" x="5840413" y="5830888"/>
          <p14:tracePt t="60099" x="5835650" y="5830888"/>
          <p14:tracePt t="60115" x="5826125" y="5821363"/>
          <p14:tracePt t="60129" x="5799138" y="5803900"/>
          <p14:tracePt t="60143" x="5789613" y="5803900"/>
          <p14:tracePt t="60146" x="5776913" y="5789613"/>
          <p14:tracePt t="60157" x="5745163" y="5767388"/>
          <p14:tracePt t="60159" x="5735638" y="5757863"/>
          <p14:tracePt t="60165" x="5716588" y="5743575"/>
          <p14:tracePt t="60176" x="5648325" y="5716588"/>
          <p14:tracePt t="60185" x="5584825" y="5694363"/>
          <p14:tracePt t="60191" x="5565775" y="5675313"/>
          <p14:tracePt t="60201" x="5492750" y="5648325"/>
          <p14:tracePt t="60207" x="5461000" y="5638800"/>
          <p14:tracePt t="60215" x="5346700" y="5624513"/>
          <p14:tracePt t="60227" x="5268913" y="5611813"/>
          <p14:tracePt t="60231" x="5241925" y="5602288"/>
          <p14:tracePt t="60241" x="5059363" y="5561013"/>
          <p14:tracePt t="60247" x="5018088" y="5561013"/>
          <p14:tracePt t="60258" x="4872038" y="5534025"/>
          <p14:tracePt t="60266" x="4745038" y="5519738"/>
          <p14:tracePt t="60273" x="4699000" y="5511800"/>
          <p14:tracePt t="60281" x="4492625" y="5478463"/>
          <p14:tracePt t="60291" x="4451350" y="5478463"/>
          <p14:tracePt t="60298" x="4324350" y="5424488"/>
          <p14:tracePt t="60309" x="4224338" y="5397500"/>
          <p14:tracePt t="60313" x="4210050" y="5397500"/>
          <p14:tracePt t="60324" x="4122738" y="5397500"/>
          <p14:tracePt t="60328" x="4064000" y="5373688"/>
          <p14:tracePt t="60342" x="4032250" y="5364163"/>
          <p14:tracePt t="60348" x="3990975" y="5364163"/>
          <p14:tracePt t="60351" x="3971925" y="5356225"/>
          <p14:tracePt t="60361" x="3963988" y="5337175"/>
          <p14:tracePt t="60369" x="3954463" y="5327650"/>
          <p14:tracePt t="60378" x="3949700" y="5327650"/>
          <p14:tracePt t="60391" x="3940175" y="5319713"/>
          <p14:tracePt t="60397" x="3922713" y="5310188"/>
          <p14:tracePt t="60409" x="3913188" y="5305425"/>
          <p14:tracePt t="60427" x="3898900" y="5287963"/>
          <p14:tracePt t="60442" x="3890963" y="5278438"/>
          <p14:tracePt t="60444" x="3886200" y="5278438"/>
          <p14:tracePt t="60459" x="3867150" y="5254625"/>
          <p14:tracePt t="61180" x="3867150" y="5246688"/>
          <p14:tracePt t="61190" x="3876675" y="5237163"/>
          <p14:tracePt t="61199" x="3940175" y="5205413"/>
          <p14:tracePt t="61210" x="4017963" y="5191125"/>
          <p14:tracePt t="61215" x="4022725" y="5191125"/>
          <p14:tracePt t="61228" x="4078288" y="5173663"/>
          <p14:tracePt t="61236" x="4090988" y="5173663"/>
          <p14:tracePt t="61243" x="4132263" y="5173663"/>
          <p14:tracePt t="61249" x="4151313" y="5173663"/>
          <p14:tracePt t="61260" x="4168775" y="5173663"/>
          <p14:tracePt t="61265" x="4210050" y="5173663"/>
          <p14:tracePt t="61277" x="4229100" y="5173663"/>
          <p14:tracePt t="61280" x="4237038" y="5173663"/>
          <p14:tracePt t="61294" x="4251325" y="5173663"/>
          <p14:tracePt t="61299" x="4283075" y="5173663"/>
          <p14:tracePt t="61307" x="4287838" y="5173663"/>
          <p14:tracePt t="61326" x="4297363" y="5173663"/>
          <p14:tracePt t="61331" x="4314825" y="5173663"/>
          <p14:tracePt t="61335" x="4329113" y="5173663"/>
          <p14:tracePt t="61362" x="4338638" y="5173663"/>
          <p14:tracePt t="61512" x="4333875" y="5173663"/>
          <p14:tracePt t="61523" x="4329113" y="5173663"/>
          <p14:tracePt t="61546" x="4319588" y="5173663"/>
          <p14:tracePt t="61555" x="4310063" y="5173663"/>
          <p14:tracePt t="61567" x="4297363" y="5173663"/>
          <p14:tracePt t="61589" x="4265613" y="5173663"/>
          <p14:tracePt t="61601" x="4260850" y="5173663"/>
          <p14:tracePt t="61605" x="4251325" y="5178425"/>
          <p14:tracePt t="61653" x="4241800" y="5178425"/>
          <p14:tracePt t="61657" x="4232275" y="5178425"/>
          <p14:tracePt t="61669" x="4229100" y="5181600"/>
          <p14:tracePt t="61683" x="4219575" y="5191125"/>
          <p14:tracePt t="61699" x="4210050" y="5191125"/>
          <p14:tracePt t="61724" x="4205288" y="5191125"/>
          <p14:tracePt t="61733" x="4195763" y="5191125"/>
          <p14:tracePt t="61742" x="4187825" y="5191125"/>
          <p14:tracePt t="61749" x="4183063" y="5191125"/>
          <p14:tracePt t="61760" x="4164013" y="5191125"/>
          <p14:tracePt t="61770" x="4132263" y="5200650"/>
          <p14:tracePt t="61779" x="4127500" y="5200650"/>
          <p14:tracePt t="61792" x="4119563" y="5200650"/>
          <p14:tracePt t="61865" x="4110038" y="5200650"/>
          <p14:tracePt t="61869" x="4100513" y="5200650"/>
          <p14:tracePt t="61875" x="4095750" y="5210175"/>
          <p14:tracePt t="61892" x="4086225" y="5218113"/>
          <p14:tracePt t="61961" x="4078288" y="5218113"/>
          <p14:tracePt t="61976" x="4073525" y="5218113"/>
          <p14:tracePt t="61985" x="4054475" y="5218113"/>
          <p14:tracePt t="62429" x="4044950" y="5218113"/>
          <p14:tracePt t="62459" x="4044950" y="5214938"/>
          <p14:tracePt t="62472" x="4044950" y="5195888"/>
          <p14:tracePt t="62497" x="4044950" y="5191125"/>
          <p14:tracePt t="62505" x="4044950" y="5164138"/>
          <p14:tracePt t="62516" x="4044950" y="5154613"/>
          <p14:tracePt t="62527" x="4044950" y="5137150"/>
          <p14:tracePt t="62535" x="4044950" y="5132388"/>
          <p14:tracePt t="62545" x="4049713" y="5113338"/>
          <p14:tracePt t="62557" x="4049713" y="5095875"/>
          <p14:tracePt t="62561" x="4049713" y="5086350"/>
          <p14:tracePt t="62575" x="4059238" y="5064125"/>
          <p14:tracePt t="62591" x="4059238" y="5049838"/>
          <p14:tracePt t="62597" x="4059238" y="5018088"/>
          <p14:tracePt t="62607" x="4059238" y="5008563"/>
          <p14:tracePt t="62612" x="4059238" y="5003800"/>
          <p14:tracePt t="62626" x="4059238" y="4986338"/>
          <p14:tracePt t="62643" x="4059238" y="4967288"/>
          <p14:tracePt t="62647" x="4059238" y="4962525"/>
          <p14:tracePt t="62651" x="4059238" y="4945063"/>
          <p14:tracePt t="62662" x="4059238" y="4935538"/>
          <p14:tracePt t="62667" x="4059238" y="4926013"/>
          <p14:tracePt t="62678" x="4059238" y="4922838"/>
          <p14:tracePt t="62681" x="4059238" y="4913313"/>
          <p14:tracePt t="62692" x="4059238" y="4894263"/>
          <p14:tracePt t="62697" x="4059238" y="4889500"/>
          <p14:tracePt t="62708" x="4068763" y="4862513"/>
          <p14:tracePt t="62717" x="4068763" y="4852988"/>
          <p14:tracePt t="62725" x="4068763" y="4845050"/>
          <p14:tracePt t="62733" x="4068763" y="4821238"/>
          <p14:tracePt t="62742" x="4068763" y="4811713"/>
          <p14:tracePt t="62747" x="4068763" y="4784725"/>
          <p14:tracePt t="62759" x="4068763" y="4767263"/>
          <p14:tracePt t="62763" x="4068763" y="4762500"/>
          <p14:tracePt t="62777" x="4068763" y="4735513"/>
          <p14:tracePt t="62779" x="4068763" y="4716463"/>
          <p14:tracePt t="62792" x="4078288" y="4684713"/>
          <p14:tracePt t="62797" x="4078288" y="4670425"/>
          <p14:tracePt t="62803" x="4078288" y="4662488"/>
          <p14:tracePt t="62813" x="4078288" y="4611688"/>
          <p14:tracePt t="62819" x="4086225" y="4606925"/>
          <p14:tracePt t="62829" x="4086225" y="4579938"/>
          <p14:tracePt t="62841" x="4086225" y="4552950"/>
          <p14:tracePt t="62844" x="4086225" y="4543425"/>
          <p14:tracePt t="62854" x="4086225" y="4506913"/>
          <p14:tracePt t="62861" x="4086225" y="4497388"/>
          <p14:tracePt t="62869" x="4086225" y="4451350"/>
          <p14:tracePt t="62879" x="4086225" y="4419600"/>
          <p14:tracePt t="62883" x="4086225" y="4405313"/>
          <p14:tracePt t="62895" x="4086225" y="4351338"/>
          <p14:tracePt t="62904" x="4086225" y="4332288"/>
          <p14:tracePt t="62910" x="4086225" y="4292600"/>
          <p14:tracePt t="62919" x="4086225" y="4273550"/>
          <p14:tracePt t="62926" x="4086225" y="4256088"/>
          <p14:tracePt t="62935" x="4086225" y="4227513"/>
          <p14:tracePt t="62941" x="4086225" y="4186238"/>
          <p14:tracePt t="62949" x="4086225" y="4146550"/>
          <p14:tracePt t="62960" x="4086225" y="4105275"/>
          <p14:tracePt t="62965" x="4086225" y="4086225"/>
          <p14:tracePt t="62977" x="4086225" y="4044950"/>
          <p14:tracePt t="62979" x="4086225" y="4017963"/>
          <p14:tracePt t="62992" x="4086225" y="3963988"/>
          <p14:tracePt t="62999" x="4086225" y="3903663"/>
          <p14:tracePt t="63009" x="4086225" y="3886200"/>
          <p14:tracePt t="63015" x="4078288" y="3830638"/>
          <p14:tracePt t="63019" x="4078288" y="3813175"/>
          <p14:tracePt t="63029" x="4068763" y="3730625"/>
          <p14:tracePt t="63041" x="4068763" y="3698875"/>
          <p14:tracePt t="63045" x="4068763" y="3689350"/>
          <p14:tracePt t="63059" x="4044950" y="3630613"/>
          <p14:tracePt t="63062" x="4037013" y="3611563"/>
          <p14:tracePt t="63075" x="4027488" y="3579813"/>
          <p14:tracePt t="63082" x="4027488" y="3538538"/>
          <p14:tracePt t="63085" x="4017963" y="3529013"/>
          <p14:tracePt t="63096" x="4008438" y="3502025"/>
          <p14:tracePt t="63101" x="4008438" y="3497263"/>
          <p14:tracePt t="63112" x="4008438" y="3448050"/>
          <p14:tracePt t="63126" x="3963988" y="3373438"/>
          <p14:tracePt t="63144" x="3963988" y="3336925"/>
          <p14:tracePt t="63151" x="3954463" y="3282950"/>
          <p14:tracePt t="63162" x="3954463" y="3251200"/>
          <p14:tracePt t="63167" x="3954463" y="3246438"/>
          <p14:tracePt t="63177" x="3954463" y="3182938"/>
          <p14:tracePt t="63191" x="3954463" y="3159125"/>
          <p14:tracePt t="63201" x="3954463" y="3151188"/>
          <p14:tracePt t="63208" x="3954463" y="3136900"/>
          <p14:tracePt t="63217" x="3954463" y="3117850"/>
          <p14:tracePt t="63224" x="3954463" y="3109913"/>
          <p14:tracePt t="63231" x="3954463" y="3100388"/>
          <p14:tracePt t="63248" x="3954463" y="3095625"/>
          <p14:tracePt t="63257" x="3954463" y="3078163"/>
          <p14:tracePt t="63267" x="3954463" y="3068638"/>
          <p14:tracePt t="63273" x="3954463" y="3063875"/>
          <p14:tracePt t="63284" x="3954463" y="3044825"/>
          <p14:tracePt t="63290" x="3954463" y="3036888"/>
          <p14:tracePt t="63298" x="3954463" y="3022600"/>
          <p14:tracePt t="63317" x="3954463" y="3013075"/>
          <p14:tracePt t="63334" x="3963988" y="3005138"/>
          <p14:tracePt t="63403" x="3971925" y="2995613"/>
          <p14:tracePt t="63409" x="3981450" y="2990850"/>
          <p14:tracePt t="63788" x="3995738" y="2990850"/>
          <p14:tracePt t="63798" x="4005263" y="2990850"/>
          <p14:tracePt t="63809" x="4013200" y="2971800"/>
          <p14:tracePt t="64805" x="4022725" y="2971800"/>
          <p14:tracePt t="66257" x="4022725" y="2976563"/>
          <p14:tracePt t="66274" x="4022725" y="2981325"/>
          <p14:tracePt t="66279" x="4022725" y="2990850"/>
          <p14:tracePt t="66294" x="4022725" y="3008313"/>
          <p14:tracePt t="66303" x="4022725" y="3013075"/>
          <p14:tracePt t="66310" x="4022725" y="3022600"/>
          <p14:tracePt t="66320" x="4022725" y="3049588"/>
          <p14:tracePt t="66325" x="4022725" y="3059113"/>
          <p14:tracePt t="66333" x="4022725" y="3073400"/>
          <p14:tracePt t="66344" x="4022725" y="3081338"/>
          <p14:tracePt t="66349" x="4022725" y="3090863"/>
          <p14:tracePt t="66359" x="4032250" y="3127375"/>
          <p14:tracePt t="66376" x="4032250" y="3132138"/>
          <p14:tracePt t="66384" x="4032250" y="3151188"/>
          <p14:tracePt t="66391" x="4032250" y="3159125"/>
          <p14:tracePt t="66409" x="4032250" y="3163888"/>
          <p14:tracePt t="66415" x="4032250" y="3190875"/>
          <p14:tracePt t="66445" x="4032250" y="3200400"/>
          <p14:tracePt t="66455" x="4032250" y="3209925"/>
          <p14:tracePt t="66476" x="4041775" y="3224213"/>
          <p14:tracePt t="66496" x="4041775" y="3232150"/>
          <p14:tracePt t="66504" x="4041775" y="3241675"/>
          <p14:tracePt t="66515" x="4044950" y="3268663"/>
          <p14:tracePt t="66525" x="4044950" y="3273425"/>
          <p14:tracePt t="66535" x="4044950" y="3292475"/>
          <p14:tracePt t="66545" x="4044950" y="3300413"/>
          <p14:tracePt t="66559" x="4054475" y="3328988"/>
          <p14:tracePt t="66565" x="4054475" y="3341688"/>
          <p14:tracePt t="66575" x="4054475" y="3360738"/>
          <p14:tracePt t="66585" x="4054475" y="3370263"/>
          <p14:tracePt t="66592" x="4064000" y="3387725"/>
          <p14:tracePt t="66601" x="4073525" y="3406775"/>
          <p14:tracePt t="66609" x="4073525" y="3424238"/>
          <p14:tracePt t="66615" x="4086225" y="3451225"/>
          <p14:tracePt t="66631" x="4086225" y="3460750"/>
          <p14:tracePt t="66641" x="4086225" y="3479800"/>
          <p14:tracePt t="66651" x="4095750" y="3506788"/>
          <p14:tracePt t="66659" x="4095750" y="3516313"/>
          <p14:tracePt t="66667" x="4110038" y="3524250"/>
          <p14:tracePt t="66675" x="4110038" y="3529013"/>
          <p14:tracePt t="66681" x="4119563" y="3557588"/>
          <p14:tracePt t="66691" x="4119563" y="3565525"/>
          <p14:tracePt t="66697" x="4127500" y="3602038"/>
          <p14:tracePt t="66709" x="4137025" y="3611563"/>
          <p14:tracePt t="66712" x="4137025" y="3616325"/>
          <p14:tracePt t="66723" x="4146550" y="3667125"/>
          <p14:tracePt t="66727" x="4146550" y="3675063"/>
          <p14:tracePt t="66740" x="4164013" y="3711575"/>
          <p14:tracePt t="66753" x="4164013" y="3721100"/>
          <p14:tracePt t="66763" x="4178300" y="3757613"/>
          <p14:tracePt t="66776" x="4178300" y="3767138"/>
          <p14:tracePt t="66777" x="4178300" y="3779838"/>
          <p14:tracePt t="66790" x="4187825" y="3813175"/>
          <p14:tracePt t="66798" x="4187825" y="3840163"/>
          <p14:tracePt t="66803" x="4187825" y="3849688"/>
          <p14:tracePt t="66809" x="4187825" y="3876675"/>
          <p14:tracePt t="66817" x="4187825" y="3917950"/>
          <p14:tracePt t="66828" x="4187825" y="3944938"/>
          <p14:tracePt t="66833" x="4187825" y="3954463"/>
          <p14:tracePt t="66844" x="4187825" y="4013200"/>
          <p14:tracePt t="66849" x="4187825" y="4032250"/>
          <p14:tracePt t="66859" x="4187825" y="4100513"/>
          <p14:tracePt t="66869" x="4187825" y="4141788"/>
          <p14:tracePt t="66876" x="4187825" y="4149725"/>
          <p14:tracePt t="66883" x="4187825" y="4237038"/>
          <p14:tracePt t="66891" x="4187825" y="4256088"/>
          <p14:tracePt t="66899" x="4187825" y="4351338"/>
          <p14:tracePt t="66910" x="4187825" y="4429125"/>
          <p14:tracePt t="66913" x="4187825" y="4433888"/>
          <p14:tracePt t="66923" x="4187825" y="4533900"/>
          <p14:tracePt t="66929" x="4192588" y="4543425"/>
          <p14:tracePt t="66941" x="4192588" y="4602163"/>
          <p14:tracePt t="66949" x="4205288" y="4662488"/>
          <p14:tracePt t="66955" x="4205288" y="4670425"/>
          <p14:tracePt t="66963" x="4214813" y="4743450"/>
          <p14:tracePt t="66969" x="4224338" y="4762500"/>
          <p14:tracePt t="66980" x="4237038" y="4794250"/>
          <p14:tracePt t="66992" x="4237038" y="4808538"/>
          <p14:tracePt t="66995" x="4237038" y="4816475"/>
          <p14:tracePt t="67008" x="4237038" y="4835525"/>
          <p14:tracePt t="67019" x="4237038" y="4840288"/>
          <p14:tracePt t="67035" x="4237038" y="4857750"/>
          <p14:tracePt t="67045" x="4237038" y="4867275"/>
          <p14:tracePt t="67049" x="4237038" y="4876800"/>
          <p14:tracePt t="67059" x="4237038" y="4889500"/>
          <p14:tracePt t="67070" x="4237038" y="4899025"/>
          <p14:tracePt t="67077" x="4237038" y="4913313"/>
          <p14:tracePt t="67085" x="4237038" y="4930775"/>
          <p14:tracePt t="67092" x="4237038" y="4949825"/>
          <p14:tracePt t="67101" x="4237038" y="4959350"/>
          <p14:tracePt t="67112" x="4237038" y="4972050"/>
          <p14:tracePt t="67123" x="4237038" y="4981575"/>
          <p14:tracePt t="67145" x="4237038" y="5035550"/>
          <p14:tracePt t="67159" x="4237038" y="5045075"/>
          <p14:tracePt t="67165" x="4237038" y="5059363"/>
          <p14:tracePt t="67176" x="4237038" y="5068888"/>
          <p14:tracePt t="67181" x="4237038" y="5105400"/>
          <p14:tracePt t="67192" x="4237038" y="5122863"/>
          <p14:tracePt t="67201" x="4237038" y="5149850"/>
          <p14:tracePt t="67212" x="4237038" y="5168900"/>
          <p14:tracePt t="67224" x="4237038" y="5186363"/>
          <p14:tracePt t="67242" x="4237038" y="5205413"/>
          <p14:tracePt t="67248" x="4237038" y="5218113"/>
          <p14:tracePt t="67259" x="4237038" y="5227638"/>
          <p14:tracePt t="67262" x="4237038" y="5246688"/>
          <p14:tracePt t="67378" x="4237038" y="5232400"/>
          <p14:tracePt t="67384" x="4237038" y="5214938"/>
          <p14:tracePt t="67395" x="4237038" y="5186363"/>
          <p14:tracePt t="67400" x="4237038" y="5145088"/>
          <p14:tracePt t="67410" x="4214813" y="5013325"/>
          <p14:tracePt t="67414" x="4183063" y="4981575"/>
          <p14:tracePt t="67428" x="4156075" y="4884738"/>
          <p14:tracePt t="67433" x="4127500" y="4826000"/>
          <p14:tracePt t="67443" x="4127500" y="4808538"/>
          <p14:tracePt t="67449" x="4078288" y="4716463"/>
          <p14:tracePt t="67454" x="4059238" y="4699000"/>
          <p14:tracePt t="67464" x="4049713" y="4657725"/>
          <p14:tracePt t="67476" x="4027488" y="4625975"/>
          <p14:tracePt t="67480" x="4017963" y="4606925"/>
          <p14:tracePt t="67491" x="3959225" y="4548188"/>
          <p14:tracePt t="67499" x="3935413" y="4516438"/>
          <p14:tracePt t="67503" x="3917950" y="4497388"/>
          <p14:tracePt t="67512" x="3871913" y="4460875"/>
          <p14:tracePt t="67520" x="3867150" y="4456113"/>
          <p14:tracePt t="67531" x="3798888" y="4387850"/>
          <p14:tracePt t="67534" x="3781425" y="4378325"/>
          <p14:tracePt t="67547" x="3662363" y="4300538"/>
          <p14:tracePt t="67562" x="3521075" y="4251325"/>
          <p14:tracePt t="67569" x="3287713" y="4105275"/>
          <p14:tracePt t="67575" x="3246438" y="4081463"/>
          <p14:tracePt t="67585" x="2927350" y="3867150"/>
          <p14:tracePt t="67595" x="2757488" y="3803650"/>
          <p14:tracePt t="67598" x="2713038" y="3779838"/>
          <p14:tracePt t="67609" x="2479675" y="3621088"/>
          <p14:tracePt t="67614" x="2428875" y="3584575"/>
          <p14:tracePt t="67625" x="2309813" y="3492500"/>
          <p14:tracePt t="67635" x="2265363" y="3460750"/>
          <p14:tracePt t="67641" x="2246313" y="3438525"/>
          <p14:tracePt t="67649" x="2214563" y="3419475"/>
          <p14:tracePt t="67658" x="2205038" y="3409950"/>
          <p14:tracePt t="67665" x="2200275" y="3402013"/>
          <p14:tracePt t="67676" x="2192338" y="3397250"/>
          <p14:tracePt t="67694" x="2182813" y="3378200"/>
          <p14:tracePt t="67696" x="2163763" y="3370263"/>
          <p14:tracePt t="67708" x="2132013" y="3336925"/>
          <p14:tracePt t="67715" x="2114550" y="3319463"/>
          <p14:tracePt t="67721" x="2105025" y="3309938"/>
          <p14:tracePt t="67731" x="2063750" y="3255963"/>
          <p14:tracePt t="67736" x="2046288" y="3236913"/>
          <p14:tracePt t="67745" x="1981200" y="3190875"/>
          <p14:tracePt t="67759" x="1949450" y="3159125"/>
          <p14:tracePt t="67762" x="1931988" y="3151188"/>
          <p14:tracePt t="67775" x="1900238" y="3117850"/>
          <p14:tracePt t="67778" x="1881188" y="3100388"/>
          <p14:tracePt t="67788" x="1835150" y="3063875"/>
          <p14:tracePt t="67797" x="1808163" y="3054350"/>
          <p14:tracePt t="67801" x="1790700" y="3044825"/>
          <p14:tracePt t="67812" x="1781175" y="3036888"/>
          <p14:tracePt t="67817" x="1771650" y="3036888"/>
          <p14:tracePt t="67828" x="1757363" y="3036888"/>
          <p14:tracePt t="67841" x="1739900" y="3036888"/>
          <p14:tracePt t="67852" x="1693863" y="2990850"/>
          <p14:tracePt t="67862" x="1676400" y="2990850"/>
          <p14:tracePt t="67867" x="1666875" y="2981325"/>
          <p14:tracePt t="67878" x="1630363" y="2981325"/>
          <p14:tracePt t="67881" x="1611313" y="2963863"/>
          <p14:tracePt t="67894" x="1579563" y="2963863"/>
          <p14:tracePt t="67897" x="1574800" y="2963863"/>
          <p14:tracePt t="67908" x="1547813" y="2963863"/>
          <p14:tracePt t="67917" x="1530350" y="2954338"/>
          <p14:tracePt t="67924" x="1520825" y="2954338"/>
          <p14:tracePt t="67933" x="1484313" y="2954338"/>
          <p14:tracePt t="67941" x="1479550" y="2954338"/>
          <p14:tracePt t="67947" x="1452563" y="2935288"/>
          <p14:tracePt t="67958" x="1443038" y="2935288"/>
          <p14:tracePt t="67963" x="1433513" y="2935288"/>
          <p14:tracePt t="67976" x="1428750" y="2935288"/>
          <p14:tracePt t="67983" x="1420813" y="2935288"/>
          <p14:tracePt t="67991" x="1401763" y="2917825"/>
          <p14:tracePt t="67997" x="1384300" y="2917825"/>
          <p14:tracePt t="68003" x="1374775" y="2917825"/>
          <p14:tracePt t="68013" x="1328738" y="2908300"/>
          <p14:tracePt t="68019" x="1319213" y="2908300"/>
          <p14:tracePt t="68029" x="1292225" y="2898775"/>
          <p14:tracePt t="68040" x="1265238" y="2898775"/>
          <p14:tracePt t="68043" x="1255713" y="2898775"/>
          <p14:tracePt t="68053" x="1228725" y="2898775"/>
          <p14:tracePt t="68061" x="1209675" y="2898775"/>
          <p14:tracePt t="68069" x="1182688" y="2890838"/>
          <p14:tracePt t="68795" x="1209675" y="2890838"/>
          <p14:tracePt t="68800" x="1228725" y="2890838"/>
          <p14:tracePt t="68812" x="1255713" y="2890838"/>
          <p14:tracePt t="68821" x="1287463" y="2890838"/>
          <p14:tracePt t="68827" x="1314450" y="2890838"/>
          <p14:tracePt t="68836" x="1384300" y="2890838"/>
          <p14:tracePt t="68841" x="1401763" y="2890838"/>
          <p14:tracePt t="68851" x="1501775" y="2890838"/>
          <p14:tracePt t="68862" x="1593850" y="2890838"/>
          <p14:tracePt t="68865" x="1625600" y="2890838"/>
          <p14:tracePt t="68876" x="1735138" y="2890838"/>
          <p14:tracePt t="68881" x="1793875" y="2890838"/>
          <p14:tracePt t="68891" x="1922463" y="2890838"/>
          <p14:tracePt t="68901" x="1995488" y="2890838"/>
          <p14:tracePt t="68909" x="2022475" y="2890838"/>
          <p14:tracePt t="68915" x="2124075" y="2890838"/>
          <p14:tracePt t="68926" x="2132013" y="2890838"/>
          <p14:tracePt t="68931" x="2219325" y="2890838"/>
          <p14:tracePt t="68943" x="2260600" y="2881313"/>
          <p14:tracePt t="68947" x="2270125" y="2881313"/>
          <p14:tracePt t="68958" x="2292350" y="2881313"/>
          <p14:tracePt t="68987" x="2309813" y="2881313"/>
          <p14:tracePt t="69008" x="2319338" y="2881313"/>
          <p14:tracePt t="69013" x="2338388" y="2881313"/>
          <p14:tracePt t="69021" x="2351088" y="2881313"/>
          <p14:tracePt t="69031" x="2382838" y="2881313"/>
          <p14:tracePt t="69044" x="2401888" y="2881313"/>
          <p14:tracePt t="69053" x="2406650" y="2881313"/>
          <p14:tracePt t="69063" x="2433638" y="2881313"/>
          <p14:tracePt t="69067" x="2443163" y="2881313"/>
          <p14:tracePt t="69078" x="2460625" y="2881313"/>
          <p14:tracePt t="69092" x="2489200" y="2881313"/>
          <p14:tracePt t="69095" x="2497138" y="2881313"/>
          <p14:tracePt t="69103" x="2501900" y="2881313"/>
          <p14:tracePt t="69108" x="2511425" y="2881313"/>
          <p14:tracePt t="69117" x="2547938" y="2881313"/>
          <p14:tracePt t="69128" x="2566988" y="2881313"/>
          <p14:tracePt t="69133" x="2620963" y="2881313"/>
          <p14:tracePt t="69144" x="2693988" y="2881313"/>
          <p14:tracePt t="69147" x="2703513" y="2881313"/>
          <p14:tracePt t="69159" x="2762250" y="2881313"/>
          <p14:tracePt t="69163" x="2781300" y="2881313"/>
          <p14:tracePt t="69174" x="2876550" y="2881313"/>
          <p14:tracePt t="69184" x="2917825" y="2881313"/>
          <p14:tracePt t="69191" x="2936875" y="2881313"/>
          <p14:tracePt t="69199" x="3005138" y="2881313"/>
          <p14:tracePt t="69203" x="3036888" y="2881313"/>
          <p14:tracePt t="69213" x="3105150" y="2881313"/>
          <p14:tracePt t="69225" x="3146425" y="2881313"/>
          <p14:tracePt t="69230" x="3173413" y="2881313"/>
          <p14:tracePt t="69242" x="3287713" y="2881313"/>
          <p14:tracePt t="69244" x="3306763" y="2881313"/>
          <p14:tracePt t="69258" x="3392488" y="2881313"/>
          <p14:tracePt t="69264" x="3448050" y="2881313"/>
          <p14:tracePt t="69270" x="3465513" y="2881313"/>
          <p14:tracePt t="69280" x="3533775" y="2881313"/>
          <p14:tracePt t="69285" x="3543300" y="2881313"/>
          <p14:tracePt t="69296" x="3589338" y="2881313"/>
          <p14:tracePt t="69308" x="3606800" y="2881313"/>
          <p14:tracePt t="69311" x="3625850" y="2881313"/>
          <p14:tracePt t="69320" x="3667125" y="2886075"/>
          <p14:tracePt t="69327" x="3684588" y="2886075"/>
          <p14:tracePt t="69335" x="3740150" y="2894013"/>
          <p14:tracePt t="69345" x="3822700" y="2922588"/>
          <p14:tracePt t="69348" x="3840163" y="2930525"/>
          <p14:tracePt t="69359" x="3922713" y="2944813"/>
          <p14:tracePt t="69369" x="3944938" y="2963863"/>
          <p14:tracePt t="69376" x="3971925" y="2971800"/>
          <p14:tracePt t="69385" x="3981450" y="2971800"/>
          <p14:tracePt t="69394" x="4000500" y="2981325"/>
          <p14:tracePt t="69401" x="4005263" y="2990850"/>
          <p14:tracePt t="69408" x="4013200" y="2990850"/>
          <p14:tracePt t="69415" x="4032250" y="3008313"/>
          <p14:tracePt t="69425" x="4041775" y="3013075"/>
          <p14:tracePt t="69591" x="4041775" y="3022600"/>
          <p14:tracePt t="69612" x="4037013" y="3022600"/>
          <p14:tracePt t="69643" x="4017963" y="3022600"/>
          <p14:tracePt t="69658" x="4013200" y="3022600"/>
          <p14:tracePt t="69667" x="4005263" y="3022600"/>
          <p14:tracePt t="69678" x="3986213" y="3022600"/>
          <p14:tracePt t="69683" x="3968750" y="3022600"/>
          <p14:tracePt t="69688" x="3954463" y="3022600"/>
          <p14:tracePt t="69697" x="3922713" y="3022600"/>
          <p14:tracePt t="69708" x="3895725" y="3022600"/>
          <p14:tracePt t="69717" x="3862388" y="3022600"/>
          <p14:tracePt t="69728" x="3840163" y="3022600"/>
          <p14:tracePt t="69742" x="3798888" y="3022600"/>
          <p14:tracePt t="69749" x="3744913" y="3022600"/>
          <p14:tracePt t="69754" x="3735388" y="3022600"/>
          <p14:tracePt t="69763" x="3676650" y="3032125"/>
          <p14:tracePt t="69769" x="3635375" y="3032125"/>
          <p14:tracePt t="69779" x="3589338" y="3054350"/>
          <p14:tracePt t="69792" x="3562350" y="3054350"/>
          <p14:tracePt t="69794" x="3543300" y="3054350"/>
          <p14:tracePt t="69808" x="3502025" y="3063875"/>
          <p14:tracePt t="69810" x="3484563" y="3063875"/>
          <p14:tracePt t="69819" x="3370263" y="3078163"/>
          <p14:tracePt t="69829" x="3297238" y="3078163"/>
          <p14:tracePt t="69833" x="3251200" y="3100388"/>
          <p14:tracePt t="69844" x="3159125" y="3100388"/>
          <p14:tracePt t="69849" x="3127375" y="3100388"/>
          <p14:tracePt t="69860" x="3000375" y="3100388"/>
          <p14:tracePt t="69869" x="2903538" y="3114675"/>
          <p14:tracePt t="69876" x="2890838" y="3114675"/>
          <p14:tracePt t="69885" x="2776538" y="3114675"/>
          <p14:tracePt t="69891" x="2744788" y="3114675"/>
          <p14:tracePt t="69899" x="2662238" y="3114675"/>
          <p14:tracePt t="69911" x="2603500" y="3114675"/>
          <p14:tracePt t="69915" x="2589213" y="3114675"/>
          <p14:tracePt t="69926" x="2543175" y="3122613"/>
          <p14:tracePt t="69929" x="2530475" y="3122613"/>
          <p14:tracePt t="69941" x="2497138" y="3122613"/>
          <p14:tracePt t="69949" x="2457450" y="3122613"/>
          <p14:tracePt t="69958" x="2438400" y="3122613"/>
          <p14:tracePt t="69965" x="2397125" y="3122613"/>
          <p14:tracePt t="69975" x="2392363" y="3122613"/>
          <p14:tracePt t="69982" x="2374900" y="3122613"/>
          <p14:tracePt t="69992" x="2365375" y="3122613"/>
          <p14:tracePt t="69995" x="2351088" y="3122613"/>
          <p14:tracePt t="70009" x="2319338" y="3122613"/>
          <p14:tracePt t="70012" x="2301875" y="3122613"/>
          <p14:tracePt t="70025" x="2251075" y="3122613"/>
          <p14:tracePt t="70031" x="2233613" y="3122613"/>
          <p14:tracePt t="70035" x="2214563" y="3122613"/>
          <p14:tracePt t="70045" x="2160588" y="3122613"/>
          <p14:tracePt t="70051" x="2151063" y="3122613"/>
          <p14:tracePt t="70062" x="2078038" y="3122613"/>
          <p14:tracePt t="70076" x="2012950" y="3122613"/>
          <p14:tracePt t="70088" x="1954213" y="3122613"/>
          <p14:tracePt t="70096" x="1944688" y="3122613"/>
          <p14:tracePt t="70101" x="1927225" y="3122613"/>
          <p14:tracePt t="70111" x="1912938" y="3122613"/>
          <p14:tracePt t="70117" x="1903413" y="3122613"/>
          <p14:tracePt t="70128" x="1895475" y="3122613"/>
          <p14:tracePt t="70144" x="1881188" y="3122613"/>
          <p14:tracePt t="70167" x="1863725" y="3122613"/>
          <p14:tracePt t="70177" x="1854200" y="3122613"/>
          <p14:tracePt t="70187" x="1849438" y="3122613"/>
          <p14:tracePt t="70198" x="1839913" y="3122613"/>
          <p14:tracePt t="70208" x="1830388" y="3122613"/>
          <p14:tracePt t="70215" x="1808163" y="3122613"/>
          <p14:tracePt t="70224" x="1798638" y="3122613"/>
          <p14:tracePt t="70240" x="1790700" y="3132138"/>
          <p14:tracePt t="80641" x="1835150" y="3132138"/>
          <p14:tracePt t="80654" x="12023725" y="3059113"/>
          <p14:tracePt t="80660" x="12087225" y="3017838"/>
          <p14:tracePt t="80664" x="12150725" y="2981325"/>
        </p14:tracePtLst>
      </p14:laserTraceLst>
    </p:ext>
  </p:extLs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2845D8C5-791D-40C3-A493-27BA65435990}"/>
              </a:ext>
            </a:extLst>
          </p:cNvPr>
          <p:cNvGraphicFramePr>
            <a:graphicFrameLocks noGrp="1"/>
          </p:cNvGraphicFramePr>
          <p:nvPr/>
        </p:nvGraphicFramePr>
        <p:xfrm>
          <a:off x="2957929" y="947412"/>
          <a:ext cx="5916085" cy="551560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70137">
                  <a:extLst>
                    <a:ext uri="{9D8B030D-6E8A-4147-A177-3AD203B41FA5}">
                      <a16:colId xmlns:a16="http://schemas.microsoft.com/office/drawing/2014/main" val="2599398815"/>
                    </a:ext>
                  </a:extLst>
                </a:gridCol>
                <a:gridCol w="1403619">
                  <a:extLst>
                    <a:ext uri="{9D8B030D-6E8A-4147-A177-3AD203B41FA5}">
                      <a16:colId xmlns:a16="http://schemas.microsoft.com/office/drawing/2014/main" val="3988832070"/>
                    </a:ext>
                  </a:extLst>
                </a:gridCol>
                <a:gridCol w="1347476">
                  <a:extLst>
                    <a:ext uri="{9D8B030D-6E8A-4147-A177-3AD203B41FA5}">
                      <a16:colId xmlns:a16="http://schemas.microsoft.com/office/drawing/2014/main" val="3436099630"/>
                    </a:ext>
                  </a:extLst>
                </a:gridCol>
                <a:gridCol w="1494853">
                  <a:extLst>
                    <a:ext uri="{9D8B030D-6E8A-4147-A177-3AD203B41FA5}">
                      <a16:colId xmlns:a16="http://schemas.microsoft.com/office/drawing/2014/main" val="668207001"/>
                    </a:ext>
                  </a:extLst>
                </a:gridCol>
              </a:tblGrid>
              <a:tr h="454182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us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v2.1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EFM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2247367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3S135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4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1541662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W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9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3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7828497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6S53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9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9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1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6474874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F1PO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5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4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730166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OX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4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8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1076819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8S117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3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2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8876910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1S1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2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4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6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2228777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8S5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1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9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9903633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S44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5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6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5736588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9S4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8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1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6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9166804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0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8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5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9103094"/>
                  </a:ext>
                </a:extLst>
              </a:tr>
              <a:tr h="28054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G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5.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3.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79535"/>
                  </a:ext>
                </a:extLst>
              </a:tr>
              <a:tr h="291662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2S1045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70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139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295.874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1535141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5S81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2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.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715183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3S31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0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1207788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7S82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5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3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114243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.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.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0297060"/>
                  </a:ext>
                </a:extLst>
              </a:tr>
              <a:tr h="23761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0S124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5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7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2205309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S165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.1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1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0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4366475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2S39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7.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5.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9451290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S133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9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7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847171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1ADCB32C-E561-4AA3-BBED-5C281BC75CE2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Per Locus LR of </a:t>
            </a:r>
            <a:r>
              <a:rPr lang="en-US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mix</a:t>
            </a:r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FM</a:t>
            </a:r>
            <a:endParaRPr lang="en-US" sz="2800" dirty="0"/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D055256B-C082-4349-A689-DA0A5E0D8FA9}"/>
              </a:ext>
            </a:extLst>
          </p:cNvPr>
          <p:cNvSpPr/>
          <p:nvPr/>
        </p:nvSpPr>
        <p:spPr>
          <a:xfrm rot="2759521">
            <a:off x="4873468" y="3795905"/>
            <a:ext cx="614760" cy="484632"/>
          </a:xfrm>
          <a:prstGeom prst="rightArrow">
            <a:avLst/>
          </a:prstGeom>
          <a:solidFill>
            <a:srgbClr val="CCCCFF">
              <a:alpha val="74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AC51210E-015D-4E49-911D-8C343655B727}"/>
              </a:ext>
            </a:extLst>
          </p:cNvPr>
          <p:cNvSpPr/>
          <p:nvPr/>
        </p:nvSpPr>
        <p:spPr>
          <a:xfrm rot="8070277">
            <a:off x="6570889" y="3803655"/>
            <a:ext cx="614760" cy="484632"/>
          </a:xfrm>
          <a:prstGeom prst="rightArrow">
            <a:avLst/>
          </a:prstGeom>
          <a:solidFill>
            <a:srgbClr val="CCCCFF">
              <a:alpha val="74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AE351D0-1ED7-4DD9-8DBA-BB2629FA2FA7}"/>
              </a:ext>
            </a:extLst>
          </p:cNvPr>
          <p:cNvSpPr/>
          <p:nvPr/>
        </p:nvSpPr>
        <p:spPr>
          <a:xfrm>
            <a:off x="4016382" y="3366361"/>
            <a:ext cx="1043876" cy="369332"/>
          </a:xfrm>
          <a:prstGeom prst="rect">
            <a:avLst/>
          </a:prstGeom>
          <a:solidFill>
            <a:srgbClr val="66FFFF"/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941040A-DD24-4D45-A5C0-E5C4FB772C33}"/>
              </a:ext>
            </a:extLst>
          </p:cNvPr>
          <p:cNvSpPr/>
          <p:nvPr/>
        </p:nvSpPr>
        <p:spPr>
          <a:xfrm>
            <a:off x="7030144" y="3376521"/>
            <a:ext cx="1107996" cy="369332"/>
          </a:xfrm>
          <a:prstGeom prst="rect">
            <a:avLst/>
          </a:prstGeom>
          <a:solidFill>
            <a:srgbClr val="66FFFF"/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</a:t>
            </a:r>
          </a:p>
        </p:txBody>
      </p:sp>
      <p:sp>
        <p:nvSpPr>
          <p:cNvPr id="11" name="Rectangle: Rounded Corners 10">
            <a:extLst>
              <a:ext uri="{FF2B5EF4-FFF2-40B4-BE49-F238E27FC236}">
                <a16:creationId xmlns:a16="http://schemas.microsoft.com/office/drawing/2014/main" id="{964E28D4-8A57-43E5-A1DE-B6ED068F63F2}"/>
              </a:ext>
            </a:extLst>
          </p:cNvPr>
          <p:cNvSpPr/>
          <p:nvPr/>
        </p:nvSpPr>
        <p:spPr>
          <a:xfrm>
            <a:off x="2957929" y="4293438"/>
            <a:ext cx="5924963" cy="287798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74125839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61821"/>
    </mc:Choice>
    <mc:Fallback xmlns="">
      <p:transition spd="slow" advTm="61821"/>
    </mc:Fallback>
  </mc:AlternateContent>
  <p:extLst>
    <p:ext uri="{3A86A75C-4F4B-4683-9AE1-C65F6400EC91}">
      <p14:laserTraceLst xmlns:p14="http://schemas.microsoft.com/office/powerpoint/2010/main">
        <p14:tracePtLst>
          <p14:tracePt t="1164" x="7597775" y="657225"/>
          <p14:tracePt t="1170" x="7502525" y="615950"/>
          <p14:tracePt t="1179" x="7196138" y="460375"/>
          <p14:tracePt t="1187" x="6808788" y="306388"/>
          <p14:tracePt t="1196" x="6470650" y="196850"/>
          <p14:tracePt t="1207" x="5840413" y="14288"/>
          <p14:tracePt t="1478" x="3214688" y="50800"/>
          <p14:tracePt t="1489" x="3214688" y="136525"/>
          <p14:tracePt t="1493" x="3214688" y="141288"/>
          <p14:tracePt t="1502" x="3214688" y="192088"/>
          <p14:tracePt t="1508" x="3214688" y="219075"/>
          <p14:tracePt t="1519" x="3214688" y="287338"/>
          <p14:tracePt t="1528" x="3214688" y="384175"/>
          <p14:tracePt t="1536" x="3214688" y="396875"/>
          <p14:tracePt t="1544" x="3214688" y="452438"/>
          <p14:tracePt t="1547" x="3219450" y="498475"/>
          <p14:tracePt t="1558" x="3219450" y="538163"/>
          <p14:tracePt t="1572" x="3246438" y="625475"/>
          <p14:tracePt t="1575" x="3255963" y="630238"/>
          <p14:tracePt t="1587" x="3255963" y="647700"/>
          <p14:tracePt t="1589" x="3265488" y="666750"/>
          <p14:tracePt t="1598" x="3265488" y="708025"/>
          <p14:tracePt t="1608" x="3282950" y="739775"/>
          <p14:tracePt t="1614" x="3292475" y="744538"/>
          <p14:tracePt t="1624" x="3302000" y="762000"/>
          <p14:tracePt t="1628" x="3319463" y="808038"/>
          <p14:tracePt t="1640" x="3328988" y="812800"/>
          <p14:tracePt t="1654" x="3379788" y="885825"/>
          <p14:tracePt t="1664" x="3402013" y="912813"/>
          <p14:tracePt t="1670" x="3433763" y="958850"/>
          <p14:tracePt t="1680" x="3470275" y="1009650"/>
          <p14:tracePt t="1689" x="3552825" y="1063625"/>
          <p14:tracePt t="1693" x="3562350" y="1068388"/>
          <p14:tracePt t="1704" x="3598863" y="1100138"/>
          <p14:tracePt t="1709" x="3630613" y="1119188"/>
          <p14:tracePt t="1720" x="3648075" y="1127125"/>
          <p14:tracePt t="1729" x="3708400" y="1155700"/>
          <p14:tracePt t="1735" x="3725863" y="1155700"/>
          <p14:tracePt t="1743" x="3730625" y="1160463"/>
          <p14:tracePt t="1751" x="3762375" y="1200150"/>
          <p14:tracePt t="1760" x="3767138" y="1209675"/>
          <p14:tracePt t="1770" x="3786188" y="1214438"/>
          <p14:tracePt t="1779" x="3794125" y="1214438"/>
          <p14:tracePt t="1989" x="3803650" y="1214438"/>
          <p14:tracePt t="2004" x="3817938" y="1223963"/>
          <p14:tracePt t="2014" x="3840163" y="1246188"/>
          <p14:tracePt t="2527" x="3844925" y="1246188"/>
          <p14:tracePt t="6260" x="3854450" y="1246188"/>
          <p14:tracePt t="6450" x="3840163" y="1233488"/>
          <p14:tracePt t="13025" x="3830638" y="1233488"/>
          <p14:tracePt t="13030" x="4830763" y="1095375"/>
          <p14:tracePt t="13040" x="4891088" y="1082675"/>
          <p14:tracePt t="13046" x="4908550" y="1073150"/>
          <p14:tracePt t="13057" x="4968875" y="1050925"/>
          <p14:tracePt t="13060" x="4986338" y="1041400"/>
          <p14:tracePt t="13073" x="5018088" y="1009650"/>
          <p14:tracePt t="13086" x="5032375" y="995363"/>
          <p14:tracePt t="13096" x="5041900" y="985838"/>
          <p14:tracePt t="13104" x="5054600" y="985838"/>
          <p14:tracePt t="13112" x="5064125" y="976313"/>
          <p14:tracePt t="13126" x="5081588" y="968375"/>
          <p14:tracePt t="13137" x="5091113" y="968375"/>
          <p14:tracePt t="13146" x="5114925" y="968375"/>
          <p14:tracePt t="13157" x="5141913" y="963613"/>
          <p14:tracePt t="13169" x="5227638" y="936625"/>
          <p14:tracePt t="13177" x="5256213" y="927100"/>
          <p14:tracePt t="13187" x="5273675" y="927100"/>
          <p14:tracePt t="13192" x="5341938" y="927100"/>
          <p14:tracePt t="13203" x="5375275" y="927100"/>
          <p14:tracePt t="13208" x="5456238" y="927100"/>
          <p14:tracePt t="13222" x="5516563" y="917575"/>
          <p14:tracePt t="13235" x="5557838" y="917575"/>
          <p14:tracePt t="13239" x="5589588" y="917575"/>
          <p14:tracePt t="13254" x="5594350" y="908050"/>
          <p14:tracePt t="16520" x="5584825" y="908050"/>
          <p14:tracePt t="17156" x="5575300" y="908050"/>
          <p14:tracePt t="17264" x="5575300" y="931863"/>
          <p14:tracePt t="17359" x="5565775" y="936625"/>
          <p14:tracePt t="17375" x="5561013" y="936625"/>
          <p14:tracePt t="17384" x="5543550" y="944563"/>
          <p14:tracePt t="17391" x="5524500" y="944563"/>
          <p14:tracePt t="17398" x="5516563" y="944563"/>
          <p14:tracePt t="17409" x="5502275" y="944563"/>
          <p14:tracePt t="17419" x="5465763" y="944563"/>
          <p14:tracePt t="17426" x="5438775" y="944563"/>
          <p14:tracePt t="17436" x="5429250" y="944563"/>
          <p14:tracePt t="17444" x="5402263" y="944563"/>
          <p14:tracePt t="17480" x="5383213" y="944563"/>
          <p14:tracePt t="17505" x="5378450" y="944563"/>
          <p14:tracePt t="17515" x="5370513" y="944563"/>
          <p14:tracePt t="17524" x="5341938" y="954088"/>
          <p14:tracePt t="17530" x="5334000" y="954088"/>
          <p14:tracePt t="17540" x="5302250" y="954088"/>
          <p14:tracePt t="17544" x="5292725" y="963613"/>
          <p14:tracePt t="17555" x="5264150" y="963613"/>
          <p14:tracePt t="17570" x="5224463" y="973138"/>
          <p14:tracePt t="17576" x="5214938" y="973138"/>
          <p14:tracePt t="17580" x="5205413" y="973138"/>
          <p14:tracePt t="17589" x="5200650" y="973138"/>
          <p14:tracePt t="17597" x="5183188" y="973138"/>
          <p14:tracePt t="17607" x="5164138" y="973138"/>
          <p14:tracePt t="17610" x="5146675" y="973138"/>
          <p14:tracePt t="17621" x="5091113" y="973138"/>
          <p14:tracePt t="17626" x="5086350" y="973138"/>
          <p14:tracePt t="17637" x="5059363" y="973138"/>
          <p14:tracePt t="17646" x="4991100" y="973138"/>
          <p14:tracePt t="17653" x="4949825" y="973138"/>
          <p14:tracePt t="17660" x="4881563" y="973138"/>
          <p14:tracePt t="17667" x="4862513" y="973138"/>
          <p14:tracePt t="17676" x="4830763" y="973138"/>
          <p14:tracePt t="17687" x="4776788" y="973138"/>
          <p14:tracePt t="17692" x="4772025" y="973138"/>
          <p14:tracePt t="17703" x="4752975" y="973138"/>
          <p14:tracePt t="17712" x="4745038" y="981075"/>
          <p14:tracePt t="17832" x="4730750" y="990600"/>
          <p14:tracePt t="17878" x="4721225" y="1009650"/>
          <p14:tracePt t="17888" x="4711700" y="1017588"/>
          <p14:tracePt t="17899" x="4703763" y="1022350"/>
          <p14:tracePt t="17907" x="4694238" y="1031875"/>
          <p14:tracePt t="17912" x="4689475" y="1041400"/>
          <p14:tracePt t="17926" x="4689475" y="1046163"/>
          <p14:tracePt t="17928" x="4689475" y="1054100"/>
          <p14:tracePt t="17946" x="4689475" y="1063625"/>
          <p14:tracePt t="17949" x="4679950" y="1109663"/>
          <p14:tracePt t="17958" x="4672013" y="1123950"/>
          <p14:tracePt t="17968" x="4635500" y="1196975"/>
          <p14:tracePt t="17976" x="4635500" y="1214438"/>
          <p14:tracePt t="17991" x="4635500" y="1314450"/>
          <p14:tracePt t="18001" x="4635500" y="1370013"/>
          <p14:tracePt t="18013" x="4621213" y="1447800"/>
          <p14:tracePt t="18017" x="4621213" y="1452563"/>
          <p14:tracePt t="18027" x="4621213" y="1538288"/>
          <p14:tracePt t="18030" x="4621213" y="1547813"/>
          <p14:tracePt t="18041" x="4621213" y="1593850"/>
          <p14:tracePt t="18052" x="4621213" y="1671638"/>
          <p14:tracePt t="18054" x="4621213" y="1698625"/>
          <p14:tracePt t="18065" x="4621213" y="1766888"/>
          <p14:tracePt t="18070" x="4621213" y="1776413"/>
          <p14:tracePt t="18081" x="4621213" y="1803400"/>
          <p14:tracePt t="18092" x="4621213" y="1898650"/>
          <p14:tracePt t="18095" x="4621213" y="1931988"/>
          <p14:tracePt t="18108" x="4621213" y="2012950"/>
          <p14:tracePt t="18112" x="4621213" y="2046288"/>
          <p14:tracePt t="18124" x="4621213" y="2114550"/>
          <p14:tracePt t="18133" x="4621213" y="2260600"/>
          <p14:tracePt t="18136" x="4621213" y="2301875"/>
          <p14:tracePt t="18145" x="4621213" y="2382838"/>
          <p14:tracePt t="18155" x="4621213" y="2414588"/>
          <p14:tracePt t="18160" x="4621213" y="2465388"/>
          <p14:tracePt t="18170" x="4621213" y="2593975"/>
          <p14:tracePt t="18176" x="4621213" y="2635250"/>
          <p14:tracePt t="18186" x="4638675" y="2708275"/>
          <p14:tracePt t="18190" x="4638675" y="2740025"/>
          <p14:tracePt t="18203" x="4652963" y="2794000"/>
          <p14:tracePt t="18210" x="4667250" y="2890838"/>
          <p14:tracePt t="18219" x="4667250" y="2894013"/>
          <p14:tracePt t="18226" x="4667250" y="2981325"/>
          <p14:tracePt t="18230" x="4675188" y="3013075"/>
          <p14:tracePt t="18240" x="4684713" y="3068638"/>
          <p14:tracePt t="18253" x="4699000" y="3182938"/>
          <p14:tracePt t="18256" x="4699000" y="3209925"/>
          <p14:tracePt t="18269" x="4711700" y="3297238"/>
          <p14:tracePt t="18272" x="4711700" y="3300413"/>
          <p14:tracePt t="18288" x="4711700" y="3365500"/>
          <p14:tracePt t="18293" x="4711700" y="3438525"/>
          <p14:tracePt t="18297" x="4711700" y="3479800"/>
          <p14:tracePt t="18308" x="4725988" y="3579813"/>
          <p14:tracePt t="18314" x="4725988" y="3597275"/>
          <p14:tracePt t="18326" x="4725988" y="3625850"/>
          <p14:tracePt t="18338" x="4725988" y="3767138"/>
          <p14:tracePt t="18348" x="4725988" y="3849688"/>
          <p14:tracePt t="18353" x="4725988" y="3867150"/>
          <p14:tracePt t="18362" x="4725988" y="3922713"/>
          <p14:tracePt t="18372" x="4725988" y="4032250"/>
          <p14:tracePt t="18378" x="4725988" y="4049713"/>
          <p14:tracePt t="18388" x="4725988" y="4205288"/>
          <p14:tracePt t="18392" x="4725988" y="4237038"/>
          <p14:tracePt t="18402" x="4725988" y="4305300"/>
          <p14:tracePt t="18412" x="4725988" y="4397375"/>
          <p14:tracePt t="18418" x="4725988" y="4438650"/>
          <p14:tracePt t="18427" x="4725988" y="4524375"/>
          <p14:tracePt t="18433" x="4725988" y="4529138"/>
          <p14:tracePt t="18443" x="4725988" y="4565650"/>
          <p14:tracePt t="18459" x="4721225" y="4629150"/>
          <p14:tracePt t="18476" x="4711700" y="4675188"/>
          <p14:tracePt t="18487" x="4711700" y="4730750"/>
          <p14:tracePt t="18492" x="4711700" y="4857750"/>
          <p14:tracePt t="18501" x="4711700" y="4872038"/>
          <p14:tracePt t="18508" x="4711700" y="4972050"/>
          <p14:tracePt t="18514" x="4703763" y="5003800"/>
          <p14:tracePt t="18524" x="4703763" y="5086350"/>
          <p14:tracePt t="18534" x="4703763" y="5178425"/>
          <p14:tracePt t="18537" x="4703763" y="5210175"/>
          <p14:tracePt t="18551" x="4703763" y="5291138"/>
          <p14:tracePt t="18558" x="4703763" y="5319713"/>
          <p14:tracePt t="18568" x="4703763" y="5405438"/>
          <p14:tracePt t="18574" x="4703763" y="5414963"/>
          <p14:tracePt t="18578" x="4703763" y="5419725"/>
          <p14:tracePt t="18588" x="4703763" y="5483225"/>
          <p14:tracePt t="18594" x="4703763" y="5497513"/>
          <p14:tracePt t="18606" x="4703763" y="5551488"/>
          <p14:tracePt t="18620" x="4703763" y="5592763"/>
          <p14:tracePt t="18621" x="4703763" y="5602288"/>
          <p14:tracePt t="18631" x="4703763" y="5675313"/>
          <p14:tracePt t="18636" x="4716463" y="5694363"/>
          <p14:tracePt t="18644" x="4730750" y="5726113"/>
          <p14:tracePt t="18655" x="4740275" y="5757863"/>
          <p14:tracePt t="18660" x="4740275" y="5762625"/>
          <p14:tracePt t="18670" x="4748213" y="5811838"/>
          <p14:tracePt t="18681" x="4757738" y="5821363"/>
          <p14:tracePt t="18688" x="4757738" y="5826125"/>
          <p14:tracePt t="18694" x="4757738" y="5862638"/>
          <p14:tracePt t="18703" x="4757738" y="5881688"/>
          <p14:tracePt t="18710" x="4767263" y="5913438"/>
          <p14:tracePt t="18719" x="4772025" y="5918200"/>
          <p14:tracePt t="18726" x="4781550" y="5935663"/>
          <p14:tracePt t="18739" x="4794250" y="5976938"/>
          <p14:tracePt t="18746" x="4813300" y="5999163"/>
          <p14:tracePt t="18756" x="4821238" y="6003925"/>
          <p14:tracePt t="18769" x="4826000" y="6022975"/>
          <p14:tracePt t="18777" x="4849813" y="6054725"/>
          <p14:tracePt t="18781" x="4857750" y="6072188"/>
          <p14:tracePt t="18790" x="4876800" y="6081713"/>
          <p14:tracePt t="18804" x="4895850" y="6100763"/>
          <p14:tracePt t="18810" x="4903788" y="6100763"/>
          <p14:tracePt t="18820" x="4922838" y="6108700"/>
          <p14:tracePt t="18830" x="4949825" y="6137275"/>
          <p14:tracePt t="18839" x="4964113" y="6137275"/>
          <p14:tracePt t="18846" x="4995863" y="6145213"/>
          <p14:tracePt t="18857" x="5022850" y="6145213"/>
          <p14:tracePt t="18862" x="5041900" y="6145213"/>
          <p14:tracePt t="18872" x="5081588" y="6159500"/>
          <p14:tracePt t="18887" x="5141913" y="6169025"/>
          <p14:tracePt t="18896" x="5219700" y="6169025"/>
          <p14:tracePt t="18902" x="5246688" y="6169025"/>
          <p14:tracePt t="18912" x="5346700" y="6181725"/>
          <p14:tracePt t="18919" x="5365750" y="6191250"/>
          <p14:tracePt t="18926" x="5451475" y="6200775"/>
          <p14:tracePt t="18937" x="5597525" y="6200775"/>
          <p14:tracePt t="18942" x="5626100" y="6200775"/>
          <p14:tracePt t="18952" x="5772150" y="6242050"/>
          <p14:tracePt t="18958" x="5799138" y="6242050"/>
          <p14:tracePt t="18969" x="5857875" y="6249988"/>
          <p14:tracePt t="18978" x="5935663" y="6264275"/>
          <p14:tracePt t="18984" x="5964238" y="6264275"/>
          <p14:tracePt t="18992" x="6032500" y="6278563"/>
          <p14:tracePt t="19000" x="6054725" y="6286500"/>
          <p14:tracePt t="19008" x="6110288" y="6286500"/>
          <p14:tracePt t="19018" x="6205538" y="6327775"/>
          <p14:tracePt t="19022" x="6224588" y="6327775"/>
          <p14:tracePt t="19035" x="6297613" y="6351588"/>
          <p14:tracePt t="19039" x="6315075" y="6359525"/>
          <p14:tracePt t="19048" x="6356350" y="6373813"/>
          <p14:tracePt t="19058" x="6365875" y="6373813"/>
          <p14:tracePt t="19246" x="6370638" y="6373813"/>
          <p14:tracePt t="19261" x="6370638" y="6359525"/>
          <p14:tracePt t="19275" x="6370638" y="6351588"/>
          <p14:tracePt t="19292" x="6370638" y="6337300"/>
          <p14:tracePt t="19304" x="6370638" y="6300788"/>
          <p14:tracePt t="19314" x="6370638" y="6283325"/>
          <p14:tracePt t="19317" x="6370638" y="6227763"/>
          <p14:tracePt t="19323" x="6346825" y="6210300"/>
          <p14:tracePt t="19331" x="6346825" y="6169025"/>
          <p14:tracePt t="19340" x="6324600" y="6122988"/>
          <p14:tracePt t="19346" x="6324600" y="6096000"/>
          <p14:tracePt t="19356" x="6288088" y="6008688"/>
          <p14:tracePt t="19360" x="6273800" y="5976938"/>
          <p14:tracePt t="19370" x="6264275" y="5935663"/>
          <p14:tracePt t="19382" x="6224588" y="5821363"/>
          <p14:tracePt t="19392" x="6224588" y="5811838"/>
          <p14:tracePt t="19397" x="6188075" y="5734050"/>
          <p14:tracePt t="19400" x="6188075" y="5707063"/>
          <p14:tracePt t="19413" x="6154738" y="5661025"/>
          <p14:tracePt t="19423" x="6154738" y="5588000"/>
          <p14:tracePt t="19427" x="6146800" y="5543550"/>
          <p14:tracePt t="19437" x="6115050" y="5378450"/>
          <p14:tracePt t="19442" x="6105525" y="5346700"/>
          <p14:tracePt t="19452" x="6091238" y="5264150"/>
          <p14:tracePt t="19461" x="6076950" y="5132388"/>
          <p14:tracePt t="19466" x="6069013" y="5091113"/>
          <p14:tracePt t="19475" x="6054725" y="4962525"/>
          <p14:tracePt t="19483" x="6040438" y="4922838"/>
          <p14:tracePt t="19491" x="6040438" y="4862513"/>
          <p14:tracePt t="19502" x="6027738" y="4772025"/>
          <p14:tracePt t="19506" x="6018213" y="4748213"/>
          <p14:tracePt t="19518" x="6018213" y="4735513"/>
          <p14:tracePt t="19694" x="6018213" y="4725988"/>
          <p14:tracePt t="19699" x="6022975" y="4716463"/>
          <p14:tracePt t="19708" x="6054725" y="4652963"/>
          <p14:tracePt t="19719" x="6100763" y="4538663"/>
          <p14:tracePt t="19724" x="6118225" y="4492625"/>
          <p14:tracePt t="19735" x="6210300" y="4246563"/>
          <p14:tracePt t="19739" x="6232525" y="4168775"/>
          <p14:tracePt t="19753" x="6324600" y="3922713"/>
          <p14:tracePt t="19758" x="6543675" y="3182938"/>
          <p14:tracePt t="19769" x="6570663" y="3068638"/>
          <p14:tracePt t="19774" x="6699250" y="2528888"/>
          <p14:tracePt t="19780" x="6711950" y="2433638"/>
          <p14:tracePt t="19791" x="6767513" y="2146300"/>
          <p14:tracePt t="19804" x="6894513" y="1676400"/>
          <p14:tracePt t="19819" x="6940550" y="1493838"/>
          <p14:tracePt t="19821" x="6950075" y="1447800"/>
          <p14:tracePt t="19830" x="6977063" y="1370013"/>
          <p14:tracePt t="19840" x="6977063" y="1296988"/>
          <p14:tracePt t="19845" x="6977063" y="1265238"/>
          <p14:tracePt t="19856" x="6986588" y="1223963"/>
          <p14:tracePt t="19860" x="6986588" y="1219200"/>
          <p14:tracePt t="19871" x="6986588" y="1155700"/>
          <p14:tracePt t="19880" x="6986588" y="1127125"/>
          <p14:tracePt t="19886" x="6986588" y="1119188"/>
          <p14:tracePt t="19896" x="6986588" y="1073150"/>
          <p14:tracePt t="19901" x="6986588" y="1063625"/>
          <p14:tracePt t="19910" x="6986588" y="1046163"/>
          <p14:tracePt t="19920" x="6986588" y="990600"/>
          <p14:tracePt t="19926" x="6986588" y="985838"/>
          <p14:tracePt t="19936" x="7018338" y="944563"/>
          <p14:tracePt t="19940" x="7027863" y="903288"/>
          <p14:tracePt t="19950" x="7064375" y="854075"/>
          <p14:tracePt t="19960" x="7105650" y="739775"/>
          <p14:tracePt t="19967" x="7105650" y="735013"/>
          <p14:tracePt t="19976" x="7105650" y="635000"/>
          <p14:tracePt t="19980" x="7123113" y="615950"/>
          <p14:tracePt t="19990" x="7123113" y="574675"/>
          <p14:tracePt t="20002" x="7137400" y="542925"/>
          <p14:tracePt t="20006" x="7142163" y="534988"/>
          <p14:tracePt t="20107" x="7150100" y="538163"/>
          <p14:tracePt t="20114" x="7159625" y="547688"/>
          <p14:tracePt t="20127" x="7169150" y="598488"/>
          <p14:tracePt t="20129" x="7178675" y="603250"/>
          <p14:tracePt t="20139" x="7186613" y="630238"/>
          <p14:tracePt t="20142" x="7196138" y="647700"/>
          <p14:tracePt t="20155" x="7205663" y="666750"/>
          <p14:tracePt t="20163" x="7205663" y="698500"/>
          <p14:tracePt t="20183" x="7205663" y="717550"/>
          <p14:tracePt t="20186" x="7215188" y="735013"/>
          <p14:tracePt t="20198" x="7215188" y="762000"/>
          <p14:tracePt t="20218" x="7215188" y="771525"/>
          <p14:tracePt t="20235" x="7215188" y="776288"/>
          <p14:tracePt t="20244" x="7215188" y="785813"/>
          <p14:tracePt t="20258" x="7215188" y="803275"/>
          <p14:tracePt t="20270" x="7210425" y="808038"/>
          <p14:tracePt t="20274" x="7200900" y="827088"/>
          <p14:tracePt t="20286" x="7169150" y="849313"/>
          <p14:tracePt t="20294" x="7154863" y="849313"/>
          <p14:tracePt t="20298" x="7146925" y="854075"/>
          <p14:tracePt t="20308" x="7127875" y="854075"/>
          <p14:tracePt t="20319" x="7123113" y="863600"/>
          <p14:tracePt t="20324" x="7113588" y="863600"/>
          <p14:tracePt t="20335" x="7105650" y="863600"/>
          <p14:tracePt t="20340" x="7077075" y="863600"/>
          <p14:tracePt t="20344" x="7073900" y="863600"/>
          <p14:tracePt t="20355" x="7045325" y="871538"/>
          <p14:tracePt t="20370" x="7018338" y="871538"/>
          <p14:tracePt t="20380" x="7004050" y="871538"/>
          <p14:tracePt t="20387" x="6996113" y="871538"/>
          <p14:tracePt t="20394" x="6967538" y="871538"/>
          <p14:tracePt t="20405" x="6913563" y="885825"/>
          <p14:tracePt t="20410" x="6904038" y="885825"/>
          <p14:tracePt t="20421" x="6877050" y="885825"/>
          <p14:tracePt t="20424" x="6862763" y="885825"/>
          <p14:tracePt t="20436" x="6831013" y="895350"/>
          <p14:tracePt t="20444" x="6784975" y="917575"/>
          <p14:tracePt t="20453" x="6757988" y="917575"/>
          <p14:tracePt t="20460" x="6684963" y="927100"/>
          <p14:tracePt t="20468" x="6657975" y="927100"/>
          <p14:tracePt t="20476" x="6570663" y="954088"/>
          <p14:tracePt t="20487" x="6516688" y="954088"/>
          <p14:tracePt t="20490" x="6497638" y="963613"/>
          <p14:tracePt t="20505" x="6456363" y="963613"/>
          <p14:tracePt t="20506" x="6424613" y="963613"/>
          <p14:tracePt t="20519" x="6383338" y="963613"/>
          <p14:tracePt t="20526" x="6315075" y="973138"/>
          <p14:tracePt t="20530" x="6297613" y="973138"/>
          <p14:tracePt t="20540" x="6256338" y="973138"/>
          <p14:tracePt t="20547" x="6246813" y="973138"/>
          <p14:tracePt t="20556" x="6219825" y="973138"/>
          <p14:tracePt t="20569" x="6191250" y="973138"/>
          <p14:tracePt t="20572" x="6183313" y="973138"/>
          <p14:tracePt t="20586" x="6169025" y="973138"/>
          <p14:tracePt t="20589" x="6159500" y="973138"/>
          <p14:tracePt t="20622" x="6142038" y="973138"/>
          <p14:tracePt t="20637" x="6137275" y="973138"/>
          <p14:tracePt t="20646" x="6118225" y="973138"/>
          <p14:tracePt t="20652" x="6110288" y="973138"/>
          <p14:tracePt t="20663" x="6073775" y="973138"/>
          <p14:tracePt t="20669" x="6059488" y="973138"/>
          <p14:tracePt t="20676" x="6037263" y="981075"/>
          <p14:tracePt t="20688" x="6032500" y="981075"/>
          <p14:tracePt t="20704" x="6013450" y="990600"/>
          <p14:tracePt t="20708" x="6008688" y="990600"/>
          <p14:tracePt t="20723" x="6000750" y="1009650"/>
          <p14:tracePt t="20753" x="5991225" y="1009650"/>
          <p14:tracePt t="20815" x="5981700" y="1014413"/>
          <p14:tracePt t="20825" x="5976938" y="1022350"/>
          <p14:tracePt t="20856" x="5976938" y="1031875"/>
          <p14:tracePt t="20866" x="5976938" y="1041400"/>
          <p14:tracePt t="20869" x="5967413" y="1046163"/>
          <p14:tracePt t="20879" x="5967413" y="1063625"/>
          <p14:tracePt t="20893" x="5967413" y="1104900"/>
          <p14:tracePt t="20900" x="5967413" y="1123950"/>
          <p14:tracePt t="20912" x="5967413" y="1146175"/>
          <p14:tracePt t="20925" x="5967413" y="1163638"/>
          <p14:tracePt t="20930" x="5967413" y="1192213"/>
          <p14:tracePt t="20937" x="5967413" y="1200150"/>
          <p14:tracePt t="20944" x="5967413" y="1260475"/>
          <p14:tracePt t="20960" x="5967413" y="1270000"/>
          <p14:tracePt t="20971" x="5967413" y="1277938"/>
          <p14:tracePt t="20980" x="5967413" y="1282700"/>
          <p14:tracePt t="20984" x="5967413" y="1301750"/>
          <p14:tracePt t="20990" x="5967413" y="1309688"/>
          <p14:tracePt t="21000" x="5967413" y="1323975"/>
          <p14:tracePt t="21010" x="5967413" y="1343025"/>
          <p14:tracePt t="21020" x="5967413" y="1350963"/>
          <p14:tracePt t="21024" x="5967413" y="1365250"/>
          <p14:tracePt t="21036" x="5967413" y="1374775"/>
          <p14:tracePt t="21046" x="5967413" y="1401763"/>
          <p14:tracePt t="21057" x="5967413" y="1411288"/>
          <p14:tracePt t="21069" x="5967413" y="1423988"/>
          <p14:tracePt t="21080" x="5967413" y="1433513"/>
          <p14:tracePt t="21091" x="5967413" y="1452563"/>
          <p14:tracePt t="21096" x="5967413" y="1455738"/>
          <p14:tracePt t="21117" x="5967413" y="1474788"/>
          <p14:tracePt t="21123" x="5967413" y="1484313"/>
          <p14:tracePt t="21130" x="5967413" y="1497013"/>
          <p14:tracePt t="21141" x="5967413" y="1506538"/>
          <p14:tracePt t="21157" x="5967413" y="1516063"/>
          <p14:tracePt t="21162" x="5967413" y="1520825"/>
          <p14:tracePt t="21173" x="5967413" y="1530350"/>
          <p14:tracePt t="21176" x="5967413" y="1547813"/>
          <p14:tracePt t="21186" x="5972175" y="1552575"/>
          <p14:tracePt t="21197" x="5972175" y="1562100"/>
          <p14:tracePt t="21219" x="5972175" y="1570038"/>
          <p14:tracePt t="21226" x="5972175" y="1584325"/>
          <p14:tracePt t="21258" x="5972175" y="1593850"/>
          <p14:tracePt t="21328" x="5972175" y="1603375"/>
          <p14:tracePt t="21334" x="5972175" y="1620838"/>
          <p14:tracePt t="22058" x="5972175" y="1625600"/>
          <p14:tracePt t="22069" x="5986463" y="1620838"/>
          <p14:tracePt t="22075" x="5986463" y="1616075"/>
          <p14:tracePt t="22080" x="5995988" y="1606550"/>
          <p14:tracePt t="22091" x="6013450" y="1570038"/>
          <p14:tracePt t="22094" x="6013450" y="1562100"/>
          <p14:tracePt t="22105" x="6013450" y="1511300"/>
          <p14:tracePt t="22118" x="6027738" y="1438275"/>
          <p14:tracePt t="22121" x="6037263" y="1428750"/>
          <p14:tracePt t="22130" x="6045200" y="1392238"/>
          <p14:tracePt t="22140" x="6045200" y="1382713"/>
          <p14:tracePt t="22347" x="6045200" y="1355725"/>
          <p14:tracePt t="22356" x="6054725" y="1338263"/>
          <p14:tracePt t="22373" x="6064250" y="1333500"/>
          <p14:tracePt t="22588" x="6076950" y="1323975"/>
          <p14:tracePt t="22694" x="6076950" y="1306513"/>
          <p14:tracePt t="22704" x="6086475" y="1296988"/>
          <p14:tracePt t="22860" x="6096000" y="1277938"/>
          <p14:tracePt t="22883" x="6105525" y="1277938"/>
          <p14:tracePt t="22943" x="6110288" y="1273175"/>
          <p14:tracePt t="22983" x="6118225" y="1273175"/>
          <p14:tracePt t="23003" x="6127750" y="1273175"/>
          <p14:tracePt t="23059" x="6132513" y="1265238"/>
          <p14:tracePt t="23078" x="6132513" y="1255713"/>
          <p14:tracePt t="23093" x="6132513" y="1250950"/>
          <p14:tracePt t="23099" x="6132513" y="1241425"/>
          <p14:tracePt t="23136" x="6132513" y="1223963"/>
          <p14:tracePt t="23143" x="6132513" y="1204913"/>
          <p14:tracePt t="23158" x="6132513" y="1200150"/>
          <p14:tracePt t="23215" x="6132513" y="1192213"/>
          <p14:tracePt t="23280" x="6142038" y="1182688"/>
          <p14:tracePt t="23294" x="6151563" y="1177925"/>
          <p14:tracePt t="23300" x="6159500" y="1177925"/>
          <p14:tracePt t="23310" x="6164263" y="1177925"/>
          <p14:tracePt t="23320" x="6183313" y="1177925"/>
          <p14:tracePt t="23331" x="6196013" y="1177925"/>
          <p14:tracePt t="23340" x="6251575" y="1177925"/>
          <p14:tracePt t="23346" x="6261100" y="1177925"/>
          <p14:tracePt t="23356" x="6297613" y="1177925"/>
          <p14:tracePt t="23360" x="6315075" y="1177925"/>
          <p14:tracePt t="23371" x="6342063" y="1177925"/>
          <p14:tracePt t="23385" x="6470650" y="1177925"/>
          <p14:tracePt t="23387" x="6488113" y="1177925"/>
          <p14:tracePt t="23397" x="6602413" y="1177925"/>
          <p14:tracePt t="23403" x="6621463" y="1177925"/>
          <p14:tracePt t="23410" x="6694488" y="1196975"/>
          <p14:tracePt t="23421" x="6858000" y="1241425"/>
          <p14:tracePt t="23426" x="6877050" y="1241425"/>
          <p14:tracePt t="23436" x="6964363" y="1250950"/>
          <p14:tracePt t="23440" x="6981825" y="1250950"/>
          <p14:tracePt t="23453" x="7023100" y="1250950"/>
          <p14:tracePt t="23462" x="7027863" y="1250950"/>
          <p14:tracePt t="23695" x="7037388" y="1260475"/>
          <p14:tracePt t="23705" x="7037388" y="1287463"/>
          <p14:tracePt t="23713" x="7037388" y="1296988"/>
          <p14:tracePt t="23726" x="7037388" y="1411288"/>
          <p14:tracePt t="23741" x="7059613" y="1465263"/>
          <p14:tracePt t="23745" x="7059613" y="1574800"/>
          <p14:tracePt t="23749" x="7059613" y="1606550"/>
          <p14:tracePt t="23760" x="7073900" y="1693863"/>
          <p14:tracePt t="23767" x="7073900" y="1698625"/>
          <p14:tracePt t="23777" x="7081838" y="1776413"/>
          <p14:tracePt t="23788" x="7096125" y="1903413"/>
          <p14:tracePt t="23789" x="7096125" y="1958975"/>
          <p14:tracePt t="23802" x="7127875" y="2127250"/>
          <p14:tracePt t="23804" x="7127875" y="2168525"/>
          <p14:tracePt t="23817" x="7142163" y="2282825"/>
          <p14:tracePt t="23823" x="7142163" y="2501900"/>
          <p14:tracePt t="23829" x="7150100" y="2543175"/>
          <p14:tracePt t="23840" x="7164388" y="2725738"/>
          <p14:tracePt t="23844" x="7164388" y="2767013"/>
          <p14:tracePt t="23854" x="7178675" y="2854325"/>
          <p14:tracePt t="23873" x="7200900" y="3013075"/>
          <p14:tracePt t="23890" x="7227888" y="3136900"/>
          <p14:tracePt t="23896" x="7227888" y="3195638"/>
          <p14:tracePt t="23909" x="7242175" y="3328988"/>
          <p14:tracePt t="23912" x="7242175" y="3333750"/>
          <p14:tracePt t="23926" x="7264400" y="3465513"/>
          <p14:tracePt t="23940" x="7264400" y="3533775"/>
          <p14:tracePt t="23947" x="7278688" y="3698875"/>
          <p14:tracePt t="23952" x="7278688" y="3730625"/>
          <p14:tracePt t="23960" x="7305675" y="3844925"/>
          <p14:tracePt t="23969" x="7305675" y="3871913"/>
          <p14:tracePt t="23976" x="7305675" y="3913188"/>
          <p14:tracePt t="23987" x="7305675" y="4013200"/>
          <p14:tracePt t="23991" x="7315200" y="4044950"/>
          <p14:tracePt t="24001" x="7315200" y="4127500"/>
          <p14:tracePt t="24006" x="7315200" y="4146550"/>
          <p14:tracePt t="24021" x="7337425" y="4205288"/>
          <p14:tracePt t="24028" x="7351713" y="4295775"/>
          <p14:tracePt t="24040" x="7351713" y="4314825"/>
          <p14:tracePt t="24043" x="7373938" y="4387850"/>
          <p14:tracePt t="24047" x="7373938" y="4405313"/>
          <p14:tracePt t="24058" x="7373938" y="4433888"/>
          <p14:tracePt t="24066" x="7388225" y="4519613"/>
          <p14:tracePt t="24072" x="7388225" y="4529138"/>
          <p14:tracePt t="24083" x="7388225" y="4602163"/>
          <p14:tracePt t="24086" x="7388225" y="4616450"/>
          <p14:tracePt t="24095" x="7410450" y="4675188"/>
          <p14:tracePt t="24108" x="7456488" y="4789488"/>
          <p14:tracePt t="24113" x="7475538" y="4811713"/>
          <p14:tracePt t="24124" x="7483475" y="4852988"/>
          <p14:tracePt t="24127" x="7483475" y="4881563"/>
          <p14:tracePt t="24143" x="7483475" y="4913313"/>
          <p14:tracePt t="24150" x="7497763" y="4995863"/>
          <p14:tracePt t="24154" x="7497763" y="5003800"/>
          <p14:tracePt t="24165" x="7497763" y="5064125"/>
          <p14:tracePt t="24170" x="7497763" y="5072063"/>
          <p14:tracePt t="24179" x="7497763" y="5100638"/>
          <p14:tracePt t="24190" x="7497763" y="5168900"/>
          <p14:tracePt t="24192" x="7497763" y="5178425"/>
          <p14:tracePt t="24203" x="7497763" y="5222875"/>
          <p14:tracePt t="24208" x="7497763" y="5251450"/>
          <p14:tracePt t="24223" x="7497763" y="5283200"/>
          <p14:tracePt t="24229" x="7475538" y="5397500"/>
          <p14:tracePt t="24236" x="7475538" y="5414963"/>
          <p14:tracePt t="24242" x="7475538" y="5514975"/>
          <p14:tracePt t="24251" x="7439025" y="5561013"/>
          <p14:tracePt t="24258" x="7429500" y="5602288"/>
          <p14:tracePt t="24268" x="7402513" y="5684838"/>
          <p14:tracePt t="24274" x="7392988" y="5702300"/>
          <p14:tracePt t="24285" x="7370763" y="5789613"/>
          <p14:tracePt t="24288" x="7370763" y="5794375"/>
          <p14:tracePt t="24307" x="7361238" y="5821363"/>
          <p14:tracePt t="24311" x="7346950" y="5894388"/>
          <p14:tracePt t="24321" x="7346950" y="5913438"/>
          <p14:tracePt t="24325" x="7324725" y="5967413"/>
          <p14:tracePt t="24341" x="7324725" y="6018213"/>
          <p14:tracePt t="24358" x="7319963" y="6076950"/>
          <p14:tracePt t="24366" x="7310438" y="6103938"/>
          <p14:tracePt t="24374" x="7310438" y="6113463"/>
          <p14:tracePt t="24380" x="7310438" y="6118225"/>
          <p14:tracePt t="24390" x="7310438" y="6137275"/>
          <p14:tracePt t="24394" x="7310438" y="6145213"/>
          <p14:tracePt t="24404" x="7300913" y="6154738"/>
          <p14:tracePt t="24421" x="7292975" y="6159500"/>
          <p14:tracePt t="24425" x="7292975" y="6176963"/>
          <p14:tracePt t="24432" x="7288213" y="6186488"/>
          <p14:tracePt t="24480" x="7288213" y="6191250"/>
          <p14:tracePt t="24484" x="7288213" y="6210300"/>
          <p14:tracePt t="24496" x="7288213" y="6218238"/>
          <p14:tracePt t="24506" x="7269163" y="6232525"/>
          <p14:tracePt t="24526" x="7269163" y="6242050"/>
          <p14:tracePt t="24551" x="7269163" y="6249988"/>
          <p14:tracePt t="24560" x="7269163" y="6259513"/>
          <p14:tracePt t="24587" x="7269163" y="6264275"/>
          <p14:tracePt t="24602" x="7259638" y="6283325"/>
          <p14:tracePt t="24612" x="7251700" y="6283325"/>
          <p14:tracePt t="24626" x="7232650" y="6283325"/>
          <p14:tracePt t="24635" x="7227888" y="6283325"/>
          <p14:tracePt t="24637" x="7210425" y="6283325"/>
          <p14:tracePt t="24647" x="7169150" y="6283325"/>
          <p14:tracePt t="24654" x="7150100" y="6283325"/>
          <p14:tracePt t="24663" x="7081838" y="6283325"/>
          <p14:tracePt t="24672" x="6991350" y="6283325"/>
          <p14:tracePt t="24676" x="6959600" y="6278563"/>
          <p14:tracePt t="24688" x="6816725" y="6249988"/>
          <p14:tracePt t="24692" x="6784975" y="6242050"/>
          <p14:tracePt t="24703" x="6716713" y="6227763"/>
          <p14:tracePt t="24713" x="6584950" y="6200775"/>
          <p14:tracePt t="24718" x="6553200" y="6200775"/>
          <p14:tracePt t="24729" x="6451600" y="6164263"/>
          <p14:tracePt t="24735" x="6443663" y="6164263"/>
          <p14:tracePt t="24742" x="6397625" y="6164263"/>
          <p14:tracePt t="24753" x="6319838" y="6149975"/>
          <p14:tracePt t="24758" x="6300788" y="6149975"/>
          <p14:tracePt t="24770" x="6188075" y="6122988"/>
          <p14:tracePt t="24772" x="6159500" y="6122988"/>
          <p14:tracePt t="24786" x="6142038" y="6122988"/>
          <p14:tracePt t="24792" x="6132513" y="6122988"/>
          <p14:tracePt t="24805" x="6122988" y="6122988"/>
          <p14:tracePt t="24898" x="6118225" y="6113463"/>
          <p14:tracePt t="24908" x="6118225" y="6076950"/>
          <p14:tracePt t="24915" x="6118225" y="6064250"/>
          <p14:tracePt t="24921" x="6122988" y="6045200"/>
          <p14:tracePt t="24928" x="6132513" y="5957888"/>
          <p14:tracePt t="24934" x="6178550" y="5935663"/>
          <p14:tracePt t="24944" x="6205538" y="5840413"/>
          <p14:tracePt t="24956" x="6251575" y="5670550"/>
          <p14:tracePt t="24960" x="6278563" y="5592763"/>
          <p14:tracePt t="24971" x="6310313" y="5387975"/>
          <p14:tracePt t="24975" x="6310313" y="5314950"/>
          <p14:tracePt t="24984" x="6310313" y="5113338"/>
          <p14:tracePt t="24994" x="6310313" y="4757738"/>
          <p14:tracePt t="25002" x="6310313" y="4662488"/>
          <p14:tracePt t="25010" x="6310313" y="4332288"/>
          <p14:tracePt t="25018" x="6310313" y="4278313"/>
          <p14:tracePt t="25024" x="6310313" y="4095750"/>
          <p14:tracePt t="25034" x="6278563" y="3784600"/>
          <p14:tracePt t="25040" x="6264275" y="3725863"/>
          <p14:tracePt t="25050" x="6251575" y="3470275"/>
          <p14:tracePt t="25054" x="6251575" y="3429000"/>
          <p14:tracePt t="25068" x="6251575" y="3328988"/>
          <p14:tracePt t="25076" x="6232525" y="3182938"/>
          <p14:tracePt t="25080" x="6224588" y="3163888"/>
          <p14:tracePt t="25091" x="6224588" y="3063875"/>
          <p14:tracePt t="25096" x="6224588" y="3059113"/>
          <p14:tracePt t="25107" x="6224588" y="2995613"/>
          <p14:tracePt t="25118" x="6210300" y="2903538"/>
          <p14:tracePt t="25122" x="6210300" y="2871788"/>
          <p14:tracePt t="25130" x="6188075" y="2757488"/>
          <p14:tracePt t="25138" x="6188075" y="2740025"/>
          <p14:tracePt t="25146" x="6159500" y="2652713"/>
          <p14:tracePt t="25156" x="6132513" y="2489200"/>
          <p14:tracePt t="25160" x="6118225" y="2447925"/>
          <p14:tracePt t="25171" x="6045200" y="2278063"/>
          <p14:tracePt t="25176" x="6045200" y="2246313"/>
          <p14:tracePt t="25186" x="6003925" y="2146300"/>
          <p14:tracePt t="25196" x="5991225" y="2000250"/>
          <p14:tracePt t="25206" x="5991225" y="1958975"/>
          <p14:tracePt t="25212" x="5976938" y="1885950"/>
          <p14:tracePt t="25218" x="5967413" y="1844675"/>
          <p14:tracePt t="25227" x="5967413" y="1825625"/>
          <p14:tracePt t="25237" x="5954713" y="1712913"/>
          <p14:tracePt t="25243" x="5954713" y="1703388"/>
          <p14:tracePt t="25253" x="5954713" y="1643063"/>
          <p14:tracePt t="25256" x="5954713" y="1611313"/>
          <p14:tracePt t="25270" x="5945188" y="1543050"/>
          <p14:tracePt t="25276" x="5945188" y="1452563"/>
          <p14:tracePt t="25285" x="5945188" y="1419225"/>
          <p14:tracePt t="25292" x="5945188" y="1350963"/>
          <p14:tracePt t="25301" x="5945188" y="1333500"/>
          <p14:tracePt t="25308" x="5945188" y="1292225"/>
          <p14:tracePt t="25318" x="5945188" y="1209675"/>
          <p14:tracePt t="25322" x="5945188" y="1200150"/>
          <p14:tracePt t="25336" x="5945188" y="1127125"/>
          <p14:tracePt t="25338" x="5945188" y="1100138"/>
          <p14:tracePt t="25352" x="5945188" y="1046163"/>
          <p14:tracePt t="25358" x="5945188" y="985838"/>
          <p14:tracePt t="25362" x="5945188" y="973138"/>
          <p14:tracePt t="25372" x="5945188" y="939800"/>
          <p14:tracePt t="25378" x="5945188" y="936625"/>
          <p14:tracePt t="25388" x="5945188" y="927100"/>
          <p14:tracePt t="25625" x="5945188" y="917575"/>
          <p14:tracePt t="25634" x="5954713" y="922338"/>
          <p14:tracePt t="25640" x="5964238" y="931863"/>
          <p14:tracePt t="25654" x="5981700" y="939800"/>
          <p14:tracePt t="25657" x="6027738" y="973138"/>
          <p14:tracePt t="25660" x="6069013" y="981075"/>
          <p14:tracePt t="25673" x="6151563" y="1022350"/>
          <p14:tracePt t="25681" x="6315075" y="1068388"/>
          <p14:tracePt t="25690" x="6361113" y="1090613"/>
          <p14:tracePt t="25697" x="6565900" y="1123950"/>
          <p14:tracePt t="25702" x="6597650" y="1123950"/>
          <p14:tracePt t="25710" x="6699250" y="1150938"/>
          <p14:tracePt t="25720" x="6845300" y="1163638"/>
          <p14:tracePt t="25726" x="6904038" y="1173163"/>
          <p14:tracePt t="25738" x="7086600" y="1192213"/>
          <p14:tracePt t="25740" x="7113588" y="1192213"/>
          <p14:tracePt t="25751" x="7186613" y="1192213"/>
          <p14:tracePt t="25762" x="7296150" y="1192213"/>
          <p14:tracePt t="25768" x="7324725" y="1192213"/>
          <p14:tracePt t="25776" x="7351713" y="1192213"/>
          <p14:tracePt t="25784" x="7361238" y="1192213"/>
          <p14:tracePt t="25792" x="7378700" y="1192213"/>
          <p14:tracePt t="25803" x="7419975" y="1192213"/>
          <p14:tracePt t="25812" x="7439025" y="1209675"/>
          <p14:tracePt t="25817" x="7456488" y="1228725"/>
          <p14:tracePt t="25826" x="7466013" y="1228725"/>
          <p14:tracePt t="25837" x="7483475" y="1236663"/>
          <p14:tracePt t="25842" x="7488238" y="1246188"/>
          <p14:tracePt t="25846" x="7497763" y="1246188"/>
          <p14:tracePt t="25856" x="7507288" y="1255713"/>
          <p14:tracePt t="25863" x="7516813" y="1255713"/>
          <p14:tracePt t="25872" x="7529513" y="1255713"/>
          <p14:tracePt t="25885" x="7561263" y="1265238"/>
          <p14:tracePt t="26049" x="7570788" y="1270000"/>
          <p14:tracePt t="26059" x="7570788" y="1287463"/>
          <p14:tracePt t="26095" x="7570788" y="1296988"/>
          <p14:tracePt t="26122" x="7570788" y="1301750"/>
          <p14:tracePt t="26140" x="7607300" y="1333500"/>
          <p14:tracePt t="26144" x="7626350" y="1333500"/>
          <p14:tracePt t="26154" x="7699375" y="1346200"/>
          <p14:tracePt t="26166" x="7858125" y="1346200"/>
          <p14:tracePt t="26170" x="7918450" y="1346200"/>
          <p14:tracePt t="26180" x="8101013" y="1392238"/>
          <p14:tracePt t="26184" x="8142288" y="1401763"/>
          <p14:tracePt t="26194" x="8269288" y="1401763"/>
          <p14:tracePt t="26204" x="8434388" y="1416050"/>
          <p14:tracePt t="26210" x="8451850" y="1416050"/>
          <p14:tracePt t="26221" x="8483600" y="1416050"/>
          <p14:tracePt t="26271" x="8488363" y="1416050"/>
          <p14:tracePt t="26281" x="8488363" y="1401763"/>
          <p14:tracePt t="26288" x="8456613" y="1382713"/>
          <p14:tracePt t="26290" x="8447088" y="1382713"/>
          <p14:tracePt t="26306" x="8402638" y="1382713"/>
          <p14:tracePt t="26318" x="8397875" y="1382713"/>
          <p14:tracePt t="26326" x="8361363" y="1382713"/>
          <p14:tracePt t="26330" x="8351838" y="1382713"/>
          <p14:tracePt t="26342" x="8337550" y="1382713"/>
          <p14:tracePt t="26346" x="8329613" y="1382713"/>
          <p14:tracePt t="26356" x="8310563" y="1382713"/>
          <p14:tracePt t="26585" x="8305800" y="1374775"/>
          <p14:tracePt t="26595" x="8305800" y="1370013"/>
          <p14:tracePt t="26605" x="8305800" y="1350963"/>
          <p14:tracePt t="26630" x="8305800" y="1209675"/>
          <p14:tracePt t="26650" x="8305800" y="1173163"/>
          <p14:tracePt t="26653" x="8305800" y="1141413"/>
          <p14:tracePt t="26656" x="8305800" y="1131888"/>
          <p14:tracePt t="26664" x="8305800" y="1119188"/>
          <p14:tracePt t="26674" x="8305800" y="1109663"/>
          <p14:tracePt t="26705" x="8305800" y="1100138"/>
          <p14:tracePt t="26710" x="8305800" y="1095375"/>
          <p14:tracePt t="26721" x="8305800" y="1087438"/>
          <p14:tracePt t="26737" x="8305800" y="1022350"/>
          <p14:tracePt t="26744" x="8256588" y="949325"/>
          <p14:tracePt t="26751" x="8247063" y="927100"/>
          <p14:tracePt t="26760" x="8237538" y="908050"/>
          <p14:tracePt t="26771" x="8215313" y="854075"/>
          <p14:tracePt t="26788" x="8205788" y="835025"/>
          <p14:tracePt t="26982" x="8205788" y="830263"/>
          <p14:tracePt t="26992" x="8186738" y="790575"/>
          <p14:tracePt t="27006" x="8178800" y="771525"/>
          <p14:tracePt t="27012" x="8164513" y="739775"/>
          <p14:tracePt t="27022" x="8159750" y="735013"/>
          <p14:tracePt t="27030" x="8137525" y="693738"/>
          <p14:tracePt t="27039" x="8137525" y="688975"/>
          <p14:tracePt t="27042" x="8137525" y="681038"/>
          <p14:tracePt t="27053" x="8137525" y="671513"/>
          <p14:tracePt t="27058" x="8132763" y="657225"/>
          <p14:tracePt t="27165" x="8132763" y="666750"/>
          <p14:tracePt t="27174" x="8132763" y="684213"/>
          <p14:tracePt t="27178" x="8132763" y="703263"/>
          <p14:tracePt t="27189" x="8132763" y="744538"/>
          <p14:tracePt t="27195" x="8132763" y="762000"/>
          <p14:tracePt t="27205" x="8132763" y="790575"/>
          <p14:tracePt t="27215" x="8137525" y="849313"/>
          <p14:tracePt t="27222" x="8137525" y="863600"/>
          <p14:tracePt t="27228" x="8150225" y="922338"/>
          <p14:tracePt t="27236" x="8150225" y="927100"/>
          <p14:tracePt t="27244" x="8150225" y="944563"/>
          <p14:tracePt t="27255" x="8150225" y="985838"/>
          <p14:tracePt t="27281" x="8150225" y="995363"/>
          <p14:tracePt t="27294" x="8150225" y="1009650"/>
          <p14:tracePt t="27427" x="8147050" y="995363"/>
          <p14:tracePt t="27433" x="8147050" y="954088"/>
          <p14:tracePt t="27439" x="8147050" y="939800"/>
          <p14:tracePt t="27447" x="8118475" y="881063"/>
          <p14:tracePt t="27457" x="8108950" y="803275"/>
          <p14:tracePt t="27461" x="8096250" y="771525"/>
          <p14:tracePt t="27471" x="8059738" y="698500"/>
          <p14:tracePt t="27476" x="8054975" y="693738"/>
          <p14:tracePt t="27488" x="8045450" y="666750"/>
          <p14:tracePt t="27497" x="8045450" y="647700"/>
          <p14:tracePt t="27505" x="8045450" y="639763"/>
          <p14:tracePt t="27513" x="8045450" y="635000"/>
          <p14:tracePt t="27523" x="8045450" y="625475"/>
          <p14:tracePt t="27684" x="8045450" y="630238"/>
          <p14:tracePt t="27690" x="8045450" y="644525"/>
          <p14:tracePt t="27699" x="8045450" y="684213"/>
          <p14:tracePt t="27703" x="8045450" y="693738"/>
          <p14:tracePt t="27715" x="8045450" y="739775"/>
          <p14:tracePt t="27720" x="8045450" y="771525"/>
          <p14:tracePt t="27730" x="8045450" y="798513"/>
          <p14:tracePt t="27740" x="8050213" y="885825"/>
          <p14:tracePt t="27745" x="8050213" y="895350"/>
          <p14:tracePt t="27756" x="8059738" y="931863"/>
          <p14:tracePt t="27758" x="8059738" y="944563"/>
          <p14:tracePt t="27769" x="8059738" y="954088"/>
          <p14:tracePt t="27865" x="8059738" y="949325"/>
          <p14:tracePt t="27874" x="8059738" y="917575"/>
          <p14:tracePt t="27883" x="8059738" y="900113"/>
          <p14:tracePt t="27890" x="8059738" y="858838"/>
          <p14:tracePt t="27905" x="8059738" y="771525"/>
          <p14:tracePt t="27920" x="8059738" y="717550"/>
          <p14:tracePt t="27924" x="8059738" y="703263"/>
          <p14:tracePt t="27935" x="8059738" y="684213"/>
          <p14:tracePt t="27944" x="8059738" y="652463"/>
          <p14:tracePt t="27958" x="8059738" y="639763"/>
          <p14:tracePt t="28097" x="8059738" y="647700"/>
          <p14:tracePt t="28103" x="8059738" y="657225"/>
          <p14:tracePt t="28108" x="8059738" y="671513"/>
          <p14:tracePt t="28118" x="8059738" y="681038"/>
          <p14:tracePt t="28126" x="8059738" y="688975"/>
          <p14:tracePt t="32555" x="8059738" y="693738"/>
          <p14:tracePt t="33071" x="8059738" y="703263"/>
          <p14:tracePt t="33545" x="8059738" y="712788"/>
          <p14:tracePt t="33695" x="8059738" y="717550"/>
          <p14:tracePt t="33702" x="8059738" y="725488"/>
          <p14:tracePt t="33747" x="8059738" y="744538"/>
          <p14:tracePt t="33757" x="8059738" y="754063"/>
          <p14:tracePt t="33788" x="8059738" y="766763"/>
          <p14:tracePt t="33797" x="8059738" y="776288"/>
          <p14:tracePt t="33805" x="8059738" y="785813"/>
          <p14:tracePt t="33827" x="8050213" y="790575"/>
          <p14:tracePt t="33842" x="8040688" y="798513"/>
          <p14:tracePt t="33854" x="8013700" y="827088"/>
          <p14:tracePt t="33860" x="8004175" y="827088"/>
          <p14:tracePt t="33870" x="7954963" y="849313"/>
          <p14:tracePt t="33876" x="7926388" y="858838"/>
          <p14:tracePt t="33886" x="7908925" y="858838"/>
          <p14:tracePt t="33892" x="7840663" y="858838"/>
          <p14:tracePt t="33902" x="7831138" y="858838"/>
          <p14:tracePt t="33906" x="7772400" y="858838"/>
          <p14:tracePt t="33917" x="7740650" y="858838"/>
          <p14:tracePt t="33927" x="7712075" y="858838"/>
          <p14:tracePt t="33935" x="7702550" y="863600"/>
          <p14:tracePt t="33942" x="7699375" y="863600"/>
          <p14:tracePt t="33951" x="7670800" y="863600"/>
          <p14:tracePt t="33958" x="7616825" y="863600"/>
          <p14:tracePt t="33963" x="7607300" y="863600"/>
          <p14:tracePt t="33972" x="7561263" y="863600"/>
          <p14:tracePt t="33978" x="7553325" y="863600"/>
          <p14:tracePt t="33989" x="7439025" y="858838"/>
          <p14:tracePt t="33999" x="7366000" y="858838"/>
          <p14:tracePt t="34005" x="7337425" y="858838"/>
          <p14:tracePt t="34012" x="7205663" y="830263"/>
          <p14:tracePt t="34018" x="7186613" y="830263"/>
          <p14:tracePt t="34028" x="7073900" y="830263"/>
          <p14:tracePt t="34040" x="7032625" y="830263"/>
          <p14:tracePt t="34042" x="7004050" y="830263"/>
          <p14:tracePt t="34053" x="6950075" y="830263"/>
          <p14:tracePt t="34058" x="6940550" y="830263"/>
          <p14:tracePt t="34068" x="6881813" y="830263"/>
          <p14:tracePt t="34078" x="6853238" y="830263"/>
          <p14:tracePt t="34084" x="6845300" y="830263"/>
          <p14:tracePt t="34094" x="6799263" y="830263"/>
          <p14:tracePt t="34100" x="6767513" y="830263"/>
          <p14:tracePt t="34108" x="6638925" y="830263"/>
          <p14:tracePt t="34119" x="6565900" y="830263"/>
          <p14:tracePt t="34124" x="6524625" y="830263"/>
          <p14:tracePt t="34135" x="6365875" y="830263"/>
          <p14:tracePt t="34139" x="6324600" y="830263"/>
          <p14:tracePt t="34147" x="6196013" y="830263"/>
          <p14:tracePt t="34159" x="6142038" y="830263"/>
          <p14:tracePt t="34169" x="6132513" y="830263"/>
          <p14:tracePt t="34174" x="6059488" y="830263"/>
          <p14:tracePt t="34186" x="6049963" y="830263"/>
          <p14:tracePt t="34190" x="6037263" y="830263"/>
          <p14:tracePt t="34201" x="6018213" y="830263"/>
          <p14:tracePt t="34205" x="6008688" y="830263"/>
          <p14:tracePt t="34218" x="5981700" y="830263"/>
          <p14:tracePt t="34235" x="5964238" y="830263"/>
          <p14:tracePt t="34240" x="5959475" y="830263"/>
          <p14:tracePt t="34252" x="5930900" y="830263"/>
          <p14:tracePt t="34271" x="5922963" y="830263"/>
          <p14:tracePt t="34286" x="5899150" y="830263"/>
          <p14:tracePt t="34297" x="5891213" y="835025"/>
          <p14:tracePt t="34307" x="5881688" y="844550"/>
          <p14:tracePt t="34310" x="5857875" y="844550"/>
          <p14:tracePt t="34321" x="5849938" y="844550"/>
          <p14:tracePt t="34337" x="5835650" y="844550"/>
          <p14:tracePt t="34340" x="5826125" y="844550"/>
          <p14:tracePt t="34351" x="5818188" y="844550"/>
          <p14:tracePt t="34371" x="5803900" y="844550"/>
          <p14:tracePt t="34452" x="5794375" y="844550"/>
          <p14:tracePt t="34492" x="5784850" y="849313"/>
          <p14:tracePt t="35208" x="5784850" y="858838"/>
          <p14:tracePt t="35218" x="5799138" y="858838"/>
          <p14:tracePt t="35235" x="5818188" y="858838"/>
          <p14:tracePt t="35239" x="5821363" y="858838"/>
          <p14:tracePt t="35245" x="5830888" y="858838"/>
          <p14:tracePt t="35255" x="5857875" y="858838"/>
          <p14:tracePt t="35269" x="5940425" y="844550"/>
          <p14:tracePt t="35278" x="6018213" y="793750"/>
          <p14:tracePt t="35287" x="6059488" y="793750"/>
          <p14:tracePt t="35294" x="6146800" y="757238"/>
          <p14:tracePt t="35305" x="6224588" y="744538"/>
          <p14:tracePt t="35308" x="6251575" y="735013"/>
          <p14:tracePt t="35319" x="6319838" y="735013"/>
          <p14:tracePt t="35326" x="6337300" y="735013"/>
          <p14:tracePt t="35335" x="6410325" y="735013"/>
          <p14:tracePt t="35344" x="6424613" y="735013"/>
          <p14:tracePt t="35352" x="6443663" y="735013"/>
          <p14:tracePt t="35360" x="6451600" y="735013"/>
          <p14:tracePt t="35369" x="6470650" y="735013"/>
          <p14:tracePt t="35374" x="6475413" y="735013"/>
          <p14:tracePt t="35390" x="6483350" y="735013"/>
          <p14:tracePt t="35404" x="6492875" y="735013"/>
          <p14:tracePt t="35637" x="6497638" y="735013"/>
          <p14:tracePt t="35647" x="6516688" y="735013"/>
          <p14:tracePt t="35660" x="6534150" y="749300"/>
          <p14:tracePt t="35675" x="6543675" y="757238"/>
          <p14:tracePt t="35683" x="6553200" y="771525"/>
          <p14:tracePt t="35693" x="6570663" y="793750"/>
          <p14:tracePt t="35719" x="6570663" y="798513"/>
          <p14:tracePt t="35733" x="6580188" y="808038"/>
          <p14:tracePt t="35759" x="6589713" y="817563"/>
          <p14:tracePt t="35770" x="6589713" y="822325"/>
          <p14:tracePt t="35779" x="6594475" y="830263"/>
          <p14:tracePt t="35805" x="6602413" y="858838"/>
          <p14:tracePt t="35809" x="6611938" y="866775"/>
          <p14:tracePt t="35835" x="6621463" y="881063"/>
          <p14:tracePt t="35845" x="6621463" y="890588"/>
          <p14:tracePt t="35854" x="6626225" y="900113"/>
          <p14:tracePt t="35858" x="6634163" y="908050"/>
          <p14:tracePt t="35874" x="6643688" y="922338"/>
          <p14:tracePt t="35888" x="6643688" y="931863"/>
          <p14:tracePt t="38467" x="6643688" y="939800"/>
          <p14:tracePt t="38477" x="6662738" y="949325"/>
          <p14:tracePt t="38488" x="6680200" y="968375"/>
          <p14:tracePt t="38504" x="6731000" y="1027113"/>
          <p14:tracePt t="38513" x="6748463" y="1046163"/>
          <p14:tracePt t="38517" x="6757988" y="1054100"/>
          <p14:tracePt t="38527" x="6784975" y="1073150"/>
          <p14:tracePt t="38539" x="6804025" y="1082675"/>
          <p14:tracePt t="38542" x="6813550" y="1100138"/>
          <p14:tracePt t="38552" x="6831013" y="1100138"/>
          <p14:tracePt t="38556" x="6850063" y="1119188"/>
          <p14:tracePt t="38579" x="6867525" y="1127125"/>
          <p14:tracePt t="38583" x="6886575" y="1136650"/>
          <p14:tracePt t="38592" x="6918325" y="1150938"/>
          <p14:tracePt t="38600" x="6945313" y="1160463"/>
          <p14:tracePt t="38608" x="7050088" y="1223963"/>
          <p14:tracePt t="38619" x="7110413" y="1236663"/>
          <p14:tracePt t="38622" x="7173913" y="1273175"/>
          <p14:tracePt t="38635" x="7283450" y="1287463"/>
          <p14:tracePt t="38638" x="7305675" y="1319213"/>
          <p14:tracePt t="38652" x="7392988" y="1355725"/>
          <p14:tracePt t="38658" x="7488238" y="1397000"/>
          <p14:tracePt t="38662" x="7539038" y="1433513"/>
          <p14:tracePt t="38672" x="7566025" y="1443038"/>
          <p14:tracePt t="38678" x="7597775" y="1452563"/>
          <p14:tracePt t="38688" x="7670800" y="1489075"/>
          <p14:tracePt t="38701" x="7694613" y="1520825"/>
          <p14:tracePt t="38705" x="7712075" y="1530350"/>
          <p14:tracePt t="38716" x="7731125" y="1552575"/>
          <p14:tracePt t="38730" x="7740650" y="1557338"/>
          <p14:tracePt t="38740" x="7753350" y="1566863"/>
          <p14:tracePt t="38757" x="7762875" y="1574800"/>
          <p14:tracePt t="38771" x="7772400" y="1584325"/>
          <p14:tracePt t="38780" x="7789863" y="1606550"/>
          <p14:tracePt t="38786" x="7808913" y="1620838"/>
          <p14:tracePt t="38797" x="7816850" y="1625600"/>
          <p14:tracePt t="38801" x="7821613" y="1635125"/>
          <p14:tracePt t="38820" x="7831138" y="1643063"/>
          <p14:tracePt t="38830" x="7840663" y="1643063"/>
          <p14:tracePt t="39062" x="7845425" y="1643063"/>
          <p14:tracePt t="39076" x="7853363" y="1643063"/>
          <p14:tracePt t="39092" x="7862888" y="1643063"/>
          <p14:tracePt t="39096" x="7872413" y="1643063"/>
          <p14:tracePt t="39113" x="7877175" y="1643063"/>
          <p14:tracePt t="39122" x="7886700" y="1643063"/>
          <p14:tracePt t="39135" x="7894638" y="1643063"/>
          <p14:tracePt t="39138" x="7899400" y="1643063"/>
          <p14:tracePt t="39151" x="7926388" y="1643063"/>
          <p14:tracePt t="39158" x="7945438" y="1643063"/>
          <p14:tracePt t="39162" x="7962900" y="1643063"/>
          <p14:tracePt t="39173" x="7967663" y="1643063"/>
          <p14:tracePt t="39178" x="7977188" y="1643063"/>
          <p14:tracePt t="39188" x="7996238" y="1643063"/>
          <p14:tracePt t="39202" x="8032750" y="1643063"/>
          <p14:tracePt t="39213" x="8035925" y="1643063"/>
          <p14:tracePt t="39219" x="8045450" y="1643063"/>
          <p14:tracePt t="39228" x="8054975" y="1643063"/>
          <p14:tracePt t="39238" x="8059738" y="1643063"/>
          <p14:tracePt t="39242" x="8069263" y="1643063"/>
          <p14:tracePt t="40322" x="8086725" y="1643063"/>
          <p14:tracePt t="40343" x="8086725" y="1657350"/>
          <p14:tracePt t="40348" x="8086725" y="1676400"/>
          <p14:tracePt t="40358" x="8086725" y="1708150"/>
          <p14:tracePt t="40364" x="8086725" y="1725613"/>
          <p14:tracePt t="40373" x="8086725" y="1766888"/>
          <p14:tracePt t="40379" x="8086725" y="1771650"/>
          <p14:tracePt t="40389" x="8086725" y="1808163"/>
          <p14:tracePt t="40398" x="8086725" y="1849438"/>
          <p14:tracePt t="40407" x="8086725" y="1858963"/>
          <p14:tracePt t="40420" x="8086725" y="1890713"/>
          <p14:tracePt t="40429" x="8086725" y="1939925"/>
          <p14:tracePt t="40439" x="8086725" y="1958975"/>
          <p14:tracePt t="40445" x="8086725" y="1985963"/>
          <p14:tracePt t="40454" x="8086725" y="1995488"/>
          <p14:tracePt t="40458" x="8086725" y="2009775"/>
          <p14:tracePt t="40469" x="8086725" y="2027238"/>
          <p14:tracePt t="40478" x="8086725" y="2046288"/>
          <p14:tracePt t="40485" x="8086725" y="2054225"/>
          <p14:tracePt t="40494" x="8086725" y="2068513"/>
          <p14:tracePt t="40503" x="8105775" y="2100263"/>
          <p14:tracePt t="40508" x="8105775" y="2109788"/>
          <p14:tracePt t="40518" x="8105775" y="2136775"/>
          <p14:tracePt t="40523" x="8105775" y="2141538"/>
          <p14:tracePt t="40534" x="8105775" y="2178050"/>
          <p14:tracePt t="40544" x="8105775" y="2209800"/>
          <p14:tracePt t="40555" x="8105775" y="2224088"/>
          <p14:tracePt t="40560" x="8105775" y="2232025"/>
          <p14:tracePt t="40567" x="8105775" y="2260600"/>
          <p14:tracePt t="40574" x="8105775" y="2287588"/>
          <p14:tracePt t="40585" x="8105775" y="2297113"/>
          <p14:tracePt t="40590" x="8105775" y="2355850"/>
          <p14:tracePt t="40602" x="8105775" y="2397125"/>
          <p14:tracePt t="40604" x="8105775" y="2452688"/>
          <p14:tracePt t="40618" x="8105775" y="2470150"/>
          <p14:tracePt t="40621" x="8105775" y="2489200"/>
          <p14:tracePt t="40635" x="8105775" y="2543175"/>
          <p14:tracePt t="40640" x="8105775" y="2562225"/>
          <p14:tracePt t="40652" x="8105775" y="2565400"/>
          <p14:tracePt t="40656" x="8105775" y="2601913"/>
          <p14:tracePt t="40680" x="8105775" y="2611438"/>
          <p14:tracePt t="41406" x="8105775" y="2620963"/>
          <p14:tracePt t="41416" x="8113713" y="2625725"/>
          <p14:tracePt t="41426" x="8132763" y="2635250"/>
          <p14:tracePt t="41438" x="8137525" y="2635250"/>
          <p14:tracePt t="41442" x="8154988" y="2635250"/>
          <p14:tracePt t="41453" x="8164513" y="2643188"/>
          <p14:tracePt t="41463" x="8178800" y="2643188"/>
          <p14:tracePt t="41472" x="8186738" y="2652713"/>
          <p14:tracePt t="41487" x="8196263" y="2652713"/>
          <p14:tracePt t="41493" x="8201025" y="2657475"/>
          <p14:tracePt t="41509" x="8242300" y="2679700"/>
          <p14:tracePt t="41522" x="8247063" y="2684463"/>
          <p14:tracePt t="41534" x="8264525" y="2703513"/>
          <p14:tracePt t="41542" x="8274050" y="2711450"/>
          <p14:tracePt t="41549" x="8301038" y="2740025"/>
          <p14:tracePt t="41558" x="8310563" y="2757488"/>
          <p14:tracePt t="41567" x="8329613" y="2776538"/>
          <p14:tracePt t="41574" x="8337550" y="2784475"/>
          <p14:tracePt t="41585" x="8356600" y="2803525"/>
          <p14:tracePt t="41589" x="8388350" y="2820988"/>
          <p14:tracePt t="41598" x="8397875" y="2840038"/>
          <p14:tracePt t="41606" x="8415338" y="2862263"/>
          <p14:tracePt t="41617" x="8424863" y="2903538"/>
          <p14:tracePt t="41624" x="8447088" y="2949575"/>
          <p14:tracePt t="41628" x="8456613" y="2954338"/>
          <p14:tracePt t="41638" x="8475663" y="2995613"/>
          <p14:tracePt t="41644" x="8497888" y="3027363"/>
          <p14:tracePt t="41654" x="8507413" y="3081338"/>
          <p14:tracePt t="41670" x="8543925" y="3187700"/>
          <p14:tracePt t="41686" x="8566150" y="3278188"/>
          <p14:tracePt t="41694" x="8593138" y="3346450"/>
          <p14:tracePt t="41705" x="8602663" y="3370263"/>
          <p14:tracePt t="41710" x="8607425" y="3373438"/>
          <p14:tracePt t="41721" x="8616950" y="3382963"/>
          <p14:tracePt t="41751" x="8643938" y="3378200"/>
          <p14:tracePt t="41760" x="8662988" y="3360738"/>
          <p14:tracePt t="41771" x="8685213" y="3314700"/>
          <p14:tracePt t="41774" x="8694738" y="3305175"/>
          <p14:tracePt t="41784" x="8699500" y="3292475"/>
          <p14:tracePt t="41792" x="8712200" y="3251200"/>
          <p14:tracePt t="41805" x="8712200" y="3219450"/>
          <p14:tracePt t="41808" x="8712200" y="3200400"/>
          <p14:tracePt t="41818" x="8712200" y="3132138"/>
          <p14:tracePt t="41826" x="8712200" y="3078163"/>
          <p14:tracePt t="41834" x="8712200" y="3059113"/>
          <p14:tracePt t="41860" x="8712200" y="3063875"/>
          <p14:tracePt t="41866" x="8699500" y="3078163"/>
          <p14:tracePt t="41870" x="8658225" y="3195638"/>
          <p14:tracePt t="41888" x="8575675" y="3406775"/>
          <p14:tracePt t="41907" x="8420100" y="3716338"/>
          <p14:tracePt t="41914" x="8374063" y="3881438"/>
          <p14:tracePt t="41929" x="8315325" y="4127500"/>
          <p14:tracePt t="41938" x="8283575" y="4387850"/>
          <p14:tracePt t="41949" x="8242300" y="4470400"/>
          <p14:tracePt t="41953" x="8228013" y="4543425"/>
          <p14:tracePt t="41962" x="8228013" y="4575175"/>
          <p14:tracePt t="41970" x="8228013" y="4579938"/>
          <p14:tracePt t="41976" x="8228013" y="4616450"/>
          <p14:tracePt t="41986" x="8228013" y="4625975"/>
          <p14:tracePt t="41992" x="8228013" y="4633913"/>
          <p14:tracePt t="42003" x="8242300" y="4643438"/>
          <p14:tracePt t="42011" x="8259763" y="4643438"/>
          <p14:tracePt t="42016" x="8269288" y="4643438"/>
          <p14:tracePt t="42029" x="8293100" y="4643438"/>
          <p14:tracePt t="42037" x="8324850" y="4652963"/>
          <p14:tracePt t="42059" x="8332788" y="4652963"/>
          <p14:tracePt t="42083" x="8374063" y="4652963"/>
          <p14:tracePt t="42092" x="8388350" y="4652963"/>
          <p14:tracePt t="42102" x="8405813" y="4652963"/>
          <p14:tracePt t="42112" x="8415338" y="4652963"/>
          <p14:tracePt t="42122" x="8424863" y="4652963"/>
          <p14:tracePt t="42128" x="8429625" y="4652963"/>
          <p14:tracePt t="42229" x="8439150" y="4652963"/>
          <p14:tracePt t="42234" x="8447088" y="4652963"/>
          <p14:tracePt t="42245" x="8475663" y="4679950"/>
          <p14:tracePt t="42260" x="8493125" y="4689475"/>
          <p14:tracePt t="42271" x="8502650" y="4689475"/>
          <p14:tracePt t="42274" x="8507413" y="4689475"/>
          <p14:tracePt t="42340" x="8515350" y="4689475"/>
          <p14:tracePt t="42354" x="8534400" y="4689475"/>
          <p14:tracePt t="42377" x="8539163" y="4689475"/>
          <p14:tracePt t="42390" x="8548688" y="4689475"/>
          <p14:tracePt t="42397" x="8556625" y="4689475"/>
          <p14:tracePt t="42418" x="8566150" y="4689475"/>
          <p14:tracePt t="42426" x="8570913" y="4689475"/>
          <p14:tracePt t="42480" x="8580438" y="4689475"/>
          <p14:tracePt t="42492" x="8589963" y="4689475"/>
          <p14:tracePt t="42503" x="8593138" y="4689475"/>
          <p14:tracePt t="42517" x="8612188" y="4689475"/>
          <p14:tracePt t="42526" x="8621713" y="4684713"/>
          <p14:tracePt t="42537" x="8634413" y="4675188"/>
          <p14:tracePt t="42554" x="8643938" y="4670425"/>
          <p14:tracePt t="42562" x="8643938" y="4662488"/>
          <p14:tracePt t="42572" x="8653463" y="4643438"/>
          <p14:tracePt t="42584" x="8670925" y="4633913"/>
          <p14:tracePt t="42601" x="8680450" y="4625975"/>
          <p14:tracePt t="42613" x="8689975" y="4625975"/>
          <p14:tracePt t="42634" x="8702675" y="4611688"/>
          <p14:tracePt t="42642" x="8712200" y="4602163"/>
          <p14:tracePt t="42652" x="8721725" y="4584700"/>
          <p14:tracePt t="42662" x="8731250" y="4570413"/>
          <p14:tracePt t="42672" x="8731250" y="4560888"/>
          <p14:tracePt t="42679" x="8748713" y="4524375"/>
          <p14:tracePt t="42688" x="8758238" y="4506913"/>
          <p14:tracePt t="42700" x="8767763" y="4460875"/>
          <p14:tracePt t="42702" x="8767763" y="4443413"/>
          <p14:tracePt t="42713" x="8785225" y="4424363"/>
          <p14:tracePt t="42719" x="8799513" y="4397375"/>
          <p14:tracePt t="42728" x="8809038" y="4351338"/>
          <p14:tracePt t="42735" x="8826500" y="4341813"/>
          <p14:tracePt t="42744" x="8840788" y="4287838"/>
          <p14:tracePt t="42755" x="8858250" y="4241800"/>
          <p14:tracePt t="42758" x="8858250" y="4222750"/>
          <p14:tracePt t="42769" x="8867775" y="4219575"/>
          <p14:tracePt t="42774" x="8867775" y="4200525"/>
          <p14:tracePt t="42785" x="8877300" y="4168775"/>
          <p14:tracePt t="42795" x="8877300" y="4164013"/>
          <p14:tracePt t="42801" x="8885238" y="4154488"/>
          <p14:tracePt t="43199" x="8885238" y="4146550"/>
          <p14:tracePt t="43207" x="8885238" y="4141788"/>
          <p14:tracePt t="43222" x="8894763" y="4122738"/>
          <p14:tracePt t="43230" x="8904288" y="4090988"/>
          <p14:tracePt t="43239" x="8913813" y="4081463"/>
          <p14:tracePt t="43252" x="8913813" y="4076700"/>
          <p14:tracePt t="43258" x="8913813" y="4068763"/>
          <p14:tracePt t="43268" x="8921750" y="4049713"/>
          <p14:tracePt t="43278" x="8926513" y="4044950"/>
          <p14:tracePt t="43324" x="8936038" y="4037013"/>
          <p14:tracePt t="43567" x="8945563" y="4017963"/>
          <p14:tracePt t="43627" x="8955088" y="4017963"/>
          <p14:tracePt t="46838" x="8963025" y="4032250"/>
          <p14:tracePt t="46844" x="8963025" y="4049713"/>
          <p14:tracePt t="49655" x="8963025" y="4068763"/>
          <p14:tracePt t="49665" x="8945563" y="4095750"/>
          <p14:tracePt t="49671" x="8913813" y="4117975"/>
          <p14:tracePt t="49679" x="8872538" y="4149725"/>
          <p14:tracePt t="49693" x="8816975" y="4232275"/>
          <p14:tracePt t="49694" x="8772525" y="4256088"/>
          <p14:tracePt t="49705" x="8675688" y="4283075"/>
          <p14:tracePt t="49708" x="8543925" y="4329113"/>
          <p14:tracePt t="49720" x="8374063" y="4373563"/>
          <p14:tracePt t="49728" x="8191500" y="4405313"/>
          <p14:tracePt t="49738" x="8108950" y="4429125"/>
          <p14:tracePt t="49744" x="7926388" y="4475163"/>
          <p14:tracePt t="49750" x="7694613" y="4511675"/>
          <p14:tracePt t="49760" x="7415213" y="4548188"/>
          <p14:tracePt t="49771" x="6799263" y="4648200"/>
          <p14:tracePt t="49774" x="6704013" y="4648200"/>
          <p14:tracePt t="49786" x="6456363" y="4648200"/>
          <p14:tracePt t="49790" x="6142038" y="4689475"/>
          <p14:tracePt t="49801" x="5903913" y="4706938"/>
          <p14:tracePt t="49810" x="5529263" y="4706938"/>
          <p14:tracePt t="49817" x="5451475" y="4721225"/>
          <p14:tracePt t="49824" x="5268913" y="4735513"/>
          <p14:tracePt t="49834" x="5122863" y="4748213"/>
          <p14:tracePt t="49840" x="4959350" y="4779963"/>
          <p14:tracePt t="49852" x="4721225" y="4830763"/>
          <p14:tracePt t="49854" x="4679950" y="4830763"/>
          <p14:tracePt t="49868" x="4579938" y="4852988"/>
          <p14:tracePt t="49871" x="4448175" y="4872038"/>
          <p14:tracePt t="49881" x="4356100" y="4884738"/>
          <p14:tracePt t="49890" x="4210050" y="4884738"/>
          <p14:tracePt t="49898" x="4178300" y="4903788"/>
          <p14:tracePt t="49905" x="4122738" y="4903788"/>
          <p14:tracePt t="49911" x="4032250" y="4903788"/>
          <p14:tracePt t="49922" x="3976688" y="4903788"/>
          <p14:tracePt t="49939" x="3781425" y="4903788"/>
          <p14:tracePt t="49952" x="3557588" y="4903788"/>
          <p14:tracePt t="49960" x="3448050" y="4903788"/>
          <p14:tracePt t="49970" x="3224213" y="4903788"/>
          <p14:tracePt t="49976" x="3168650" y="4903788"/>
          <p14:tracePt t="49987" x="3078163" y="4903788"/>
          <p14:tracePt t="49991" x="3036888" y="4903788"/>
          <p14:tracePt t="50002" x="3005138" y="4903788"/>
          <p14:tracePt t="50012" x="3000375" y="4903788"/>
          <p14:tracePt t="50169" x="2990850" y="4889500"/>
          <p14:tracePt t="50175" x="2990850" y="4884738"/>
          <p14:tracePt t="50184" x="3000375" y="4867275"/>
          <p14:tracePt t="50188" x="3009900" y="4857750"/>
          <p14:tracePt t="50192" x="3017838" y="4848225"/>
          <p14:tracePt t="50203" x="3027363" y="4835525"/>
          <p14:tracePt t="50215" x="3046413" y="4803775"/>
          <p14:tracePt t="50219" x="3054350" y="4794250"/>
          <p14:tracePt t="50238" x="3063875" y="4784725"/>
          <p14:tracePt t="50424" x="3078163" y="4772025"/>
          <p14:tracePt t="50457" x="3090863" y="4738688"/>
          <p14:tracePt t="50462" x="3109913" y="4730750"/>
          <p14:tracePt t="50477" x="3109913" y="4721225"/>
          <p14:tracePt t="50488" x="3119438" y="4706938"/>
          <p14:tracePt t="50507" x="3119438" y="4699000"/>
          <p14:tracePt t="50683" x="3122613" y="4689475"/>
          <p14:tracePt t="50722" x="3132138" y="4670425"/>
          <p14:tracePt t="50733" x="3141663" y="4670425"/>
          <p14:tracePt t="50740" x="3151188" y="4670425"/>
          <p14:tracePt t="50742" x="3163888" y="4670425"/>
          <p14:tracePt t="50754" x="3195638" y="4670425"/>
          <p14:tracePt t="50758" x="3224213" y="4670425"/>
          <p14:tracePt t="50769" x="3278188" y="4670425"/>
          <p14:tracePt t="50779" x="3355975" y="4662488"/>
          <p14:tracePt t="50787" x="3375025" y="4662488"/>
          <p14:tracePt t="50794" x="3470275" y="4662488"/>
          <p14:tracePt t="50800" x="3529013" y="4662488"/>
          <p14:tracePt t="50808" x="3602038" y="4662488"/>
          <p14:tracePt t="50818" x="3749675" y="4662488"/>
          <p14:tracePt t="50823" x="3757613" y="4662488"/>
          <p14:tracePt t="50834" x="3854450" y="4662488"/>
          <p14:tracePt t="50838" x="3981450" y="4662488"/>
          <p14:tracePt t="50848" x="4114800" y="4670425"/>
          <p14:tracePt t="50858" x="4338638" y="4684713"/>
          <p14:tracePt t="50867" x="4397375" y="4699000"/>
          <p14:tracePt t="50874" x="4475163" y="4711700"/>
          <p14:tracePt t="50879" x="4533900" y="4721225"/>
          <p14:tracePt t="50888" x="4611688" y="4735513"/>
          <p14:tracePt t="50900" x="4672013" y="4748213"/>
          <p14:tracePt t="50910" x="4689475" y="4748213"/>
          <p14:tracePt t="50921" x="4708525" y="4757738"/>
          <p14:tracePt t="51040" x="4716463" y="4757738"/>
          <p14:tracePt t="51057" x="4721225" y="4757738"/>
          <p14:tracePt t="51063" x="4730750" y="4757738"/>
          <p14:tracePt t="51067" x="4740275" y="4757738"/>
          <p14:tracePt t="51077" x="4745038" y="4757738"/>
          <p14:tracePt t="51084" x="4752975" y="4757738"/>
          <p14:tracePt t="51090" x="4772025" y="4757738"/>
          <p14:tracePt t="51107" x="4799013" y="4775200"/>
          <p14:tracePt t="51120" x="4821238" y="4775200"/>
          <p14:tracePt t="51135" x="4849813" y="4775200"/>
          <p14:tracePt t="51142" x="4908550" y="4784725"/>
          <p14:tracePt t="51146" x="4913313" y="4784725"/>
          <p14:tracePt t="51156" x="4949825" y="4784725"/>
          <p14:tracePt t="51169" x="4968875" y="4784725"/>
          <p14:tracePt t="51174" x="4976813" y="4784725"/>
          <p14:tracePt t="51189" x="5005388" y="4784725"/>
          <p14:tracePt t="51194" x="5008563" y="4784725"/>
          <p14:tracePt t="51203" x="5027613" y="4784725"/>
          <p14:tracePt t="51218" x="5037138" y="4784725"/>
          <p14:tracePt t="51226" x="5041900" y="4784725"/>
          <p14:tracePt t="51245" x="5049838" y="4784725"/>
          <p14:tracePt t="51313" x="5078413" y="4784725"/>
          <p14:tracePt t="51323" x="5086350" y="4784725"/>
          <p14:tracePt t="51339" x="5091113" y="4784725"/>
          <p14:tracePt t="51349" x="5110163" y="4784725"/>
          <p14:tracePt t="51374" x="5127625" y="4784725"/>
          <p14:tracePt t="51485" x="5132388" y="4784725"/>
          <p14:tracePt t="51495" x="5141913" y="4784725"/>
          <p14:tracePt t="51531" x="5151438" y="4775200"/>
          <p14:tracePt t="51541" x="5159375" y="4767263"/>
          <p14:tracePt t="51560" x="5164138" y="4757738"/>
          <p14:tracePt t="51584" x="5164138" y="4752975"/>
          <p14:tracePt t="51590" x="5173663" y="4743450"/>
          <p14:tracePt t="51627" x="5183188" y="4735513"/>
          <p14:tracePt t="51638" x="5187950" y="4730750"/>
          <p14:tracePt t="51662" x="5195888" y="4711700"/>
          <p14:tracePt t="51673" x="5214938" y="4702175"/>
          <p14:tracePt t="51691" x="5224463" y="4694238"/>
          <p14:tracePt t="51804" x="5241925" y="4684713"/>
          <p14:tracePt t="51833" x="5251450" y="4684713"/>
          <p14:tracePt t="51835" x="5256213" y="4684713"/>
          <p14:tracePt t="51842" x="5264150" y="4679950"/>
          <p14:tracePt t="51850" x="5273675" y="4670425"/>
          <p14:tracePt t="51869" x="5278438" y="4662488"/>
          <p14:tracePt t="51887" x="5287963" y="4662488"/>
          <p14:tracePt t="52303" x="5297488" y="4662488"/>
          <p14:tracePt t="52309" x="5297488" y="4665663"/>
          <p14:tracePt t="52640" x="5297488" y="4675188"/>
          <p14:tracePt t="52827" x="5297488" y="4689475"/>
          <p14:tracePt t="53023" x="5297488" y="4706938"/>
          <p14:tracePt t="53032" x="5297488" y="4716463"/>
          <p14:tracePt t="53079" x="5297488" y="4721225"/>
          <p14:tracePt t="53775" x="5297488" y="4730750"/>
          <p14:tracePt t="54410" x="5297488" y="4738688"/>
          <p14:tracePt t="54420" x="5324475" y="4748213"/>
          <p14:tracePt t="54424" x="5392738" y="4757738"/>
          <p14:tracePt t="54434" x="5434013" y="4772025"/>
          <p14:tracePt t="54444" x="5534025" y="4811713"/>
          <p14:tracePt t="54451" x="5543550" y="4811713"/>
          <p14:tracePt t="54460" x="5602288" y="4821238"/>
          <p14:tracePt t="54466" x="5634038" y="4830763"/>
          <p14:tracePt t="54475" x="5662613" y="4830763"/>
          <p14:tracePt t="54487" x="5703888" y="4845050"/>
          <p14:tracePt t="54490" x="5711825" y="4845050"/>
          <p14:tracePt t="54501" x="5740400" y="4845050"/>
          <p14:tracePt t="54506" x="5745163" y="4845050"/>
          <p14:tracePt t="54516" x="5762625" y="4845050"/>
          <p14:tracePt t="54526" x="5781675" y="4845050"/>
          <p14:tracePt t="54533" x="5789613" y="4845050"/>
          <p14:tracePt t="54540" x="5813425" y="4845050"/>
          <p14:tracePt t="54551" x="5821363" y="4845050"/>
          <p14:tracePt t="54556" x="5840413" y="4845050"/>
          <p14:tracePt t="54568" x="5867400" y="4845050"/>
          <p14:tracePt t="54570" x="5908675" y="4845050"/>
          <p14:tracePt t="54584" x="5918200" y="4845050"/>
          <p14:tracePt t="54587" x="5935663" y="4840288"/>
          <p14:tracePt t="54600" x="5976938" y="4826000"/>
          <p14:tracePt t="54606" x="5995988" y="4826000"/>
          <p14:tracePt t="54617" x="6000750" y="4826000"/>
          <p14:tracePt t="54622" x="6027738" y="4808538"/>
          <p14:tracePt t="54626" x="6045200" y="4808538"/>
          <p14:tracePt t="54637" x="6054725" y="4803775"/>
          <p14:tracePt t="54650" x="6069013" y="4803775"/>
          <p14:tracePt t="54653" x="6076950" y="4803775"/>
          <p14:tracePt t="54668" x="6105525" y="4794250"/>
          <p14:tracePt t="54676" x="6118225" y="4794250"/>
          <p14:tracePt t="54687" x="6127750" y="4784725"/>
          <p14:tracePt t="54729" x="6137275" y="4775200"/>
          <p14:tracePt t="54739" x="6142038" y="4772025"/>
          <p14:tracePt t="54758" x="6151563" y="4772025"/>
          <p14:tracePt t="54769" x="6159500" y="4762500"/>
          <p14:tracePt t="54779" x="6183313" y="4762500"/>
          <p14:tracePt t="54788" x="6191250" y="4752975"/>
          <p14:tracePt t="54803" x="6200775" y="4738688"/>
          <p14:tracePt t="54808" x="6210300" y="4738688"/>
          <p14:tracePt t="54823" x="6215063" y="4738688"/>
          <p14:tracePt t="54884" x="6224588" y="4738688"/>
          <p14:tracePt t="54888" x="6232525" y="4738688"/>
          <p14:tracePt t="54904" x="6251575" y="4738688"/>
          <p14:tracePt t="54916" x="6264275" y="4738688"/>
          <p14:tracePt t="54925" x="6283325" y="4738688"/>
          <p14:tracePt t="54928" x="6292850" y="4738688"/>
          <p14:tracePt t="54934" x="6300788" y="4738688"/>
          <p14:tracePt t="54944" x="6305550" y="4738688"/>
          <p14:tracePt t="54952" x="6324600" y="4738688"/>
          <p14:tracePt t="54960" x="6342063" y="4738688"/>
          <p14:tracePt t="54974" x="6346825" y="4738688"/>
          <p14:tracePt t="54985" x="6356350" y="4738688"/>
          <p14:tracePt t="54990" x="6365875" y="4738688"/>
          <p14:tracePt t="55382" x="6373813" y="4738688"/>
          <p14:tracePt t="55690" x="6388100" y="4738688"/>
          <p14:tracePt t="55731" x="6397625" y="4738688"/>
          <p14:tracePt t="55786" x="6415088" y="4738688"/>
          <p14:tracePt t="55816" x="6419850" y="4738688"/>
          <p14:tracePt t="55823" x="6429375" y="4738688"/>
          <p14:tracePt t="55833" x="6446838" y="4738688"/>
          <p14:tracePt t="55839" x="6461125" y="4738688"/>
          <p14:tracePt t="55854" x="6488113" y="4738688"/>
          <p14:tracePt t="55869" x="6492875" y="4738688"/>
          <p14:tracePt t="55872" x="6502400" y="4738688"/>
          <p14:tracePt t="55908" x="6521450" y="4738688"/>
          <p14:tracePt t="55949" x="6529388" y="4738688"/>
          <p14:tracePt t="56362" x="6534150" y="4738688"/>
          <p14:tracePt t="56479" x="6543675" y="4738688"/>
          <p14:tracePt t="56504" x="6553200" y="4730750"/>
          <p14:tracePt t="56618" x="6557963" y="4721225"/>
          <p14:tracePt t="60124" x="6575425" y="4711700"/>
          <p14:tracePt t="60130" x="6584950" y="4711700"/>
          <p14:tracePt t="60137" x="6611938" y="4711700"/>
          <p14:tracePt t="60144" x="6711950" y="4675188"/>
          <p14:tracePt t="60155" x="6753225" y="4665663"/>
          <p14:tracePt t="60161" x="6816725" y="4625975"/>
          <p14:tracePt t="60173" x="6862763" y="4602163"/>
          <p14:tracePt t="60175" x="6894513" y="4592638"/>
          <p14:tracePt t="60188" x="6967538" y="4556125"/>
          <p14:tracePt t="60196" x="7064375" y="4516438"/>
          <p14:tracePt t="60201" x="7196138" y="4487863"/>
          <p14:tracePt t="60210" x="7305675" y="4470400"/>
          <p14:tracePt t="60215" x="7383463" y="4460875"/>
          <p14:tracePt t="60224" x="7881938" y="4438650"/>
          <p14:tracePt t="60235" x="8293100" y="4438650"/>
          <p14:tracePt t="60239" x="8775700" y="4438650"/>
          <p14:tracePt t="60250" x="9259888" y="4438650"/>
          <p14:tracePt t="60255" x="9424988" y="4438650"/>
          <p14:tracePt t="60271" x="10109200" y="4438650"/>
          <p14:tracePt t="60278" x="10442575" y="4438650"/>
          <p14:tracePt t="60291" x="10972800" y="4438650"/>
          <p14:tracePt t="60304" x="11045825" y="4438650"/>
          <p14:tracePt t="60309" x="11296650" y="4419600"/>
          <p14:tracePt t="60324" x="11544300" y="4351338"/>
          <p14:tracePt t="60332" x="11639550" y="4324350"/>
          <p14:tracePt t="60341" x="11685588" y="4310063"/>
          <p14:tracePt t="60350" x="11799888" y="4251325"/>
          <p14:tracePt t="60356" x="11844338" y="4232275"/>
          <p14:tracePt t="60360" x="11877675" y="4200525"/>
          <p14:tracePt t="60372" x="11963400" y="4113213"/>
          <p14:tracePt t="60375" x="11995150" y="4081463"/>
          <p14:tracePt t="60386" x="12082463" y="3981450"/>
          <p14:tracePt t="60397" x="12087225" y="3971925"/>
          <p14:tracePt t="60402" x="12096750" y="3944938"/>
          <p14:tracePt t="60420" x="12141200" y="3922713"/>
          <p14:tracePt t="60428" x="12150725" y="3917950"/>
          <p14:tracePt t="60456" x="12155488" y="3908425"/>
          <p14:tracePt t="60483" x="12165013" y="3908425"/>
          <p14:tracePt t="60508" x="12172950" y="3908425"/>
          <p14:tracePt t="60518" x="12187238" y="3908425"/>
        </p14:tracePtLst>
      </p14:laserTraceLst>
    </p:ext>
  </p:extLs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100B1E81-62E7-4310-9AA3-7B62E11B8947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Mixture Profile containing D22S1045 </a:t>
            </a:r>
            <a:endParaRPr lang="en-US" sz="28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D7E2561-49C7-494B-AC15-C694B8CF391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5" r="1210"/>
          <a:stretch/>
        </p:blipFill>
        <p:spPr>
          <a:xfrm>
            <a:off x="1255928" y="551793"/>
            <a:ext cx="9729895" cy="6169493"/>
          </a:xfrm>
          <a:prstGeom prst="rect">
            <a:avLst/>
          </a:prstGeom>
          <a:effectLst>
            <a:glow rad="63500">
              <a:schemeClr val="tx1"/>
            </a:glow>
          </a:effectLst>
        </p:spPr>
      </p:pic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8580F163-6C2F-43A3-A1F0-61763358CAE4}"/>
              </a:ext>
            </a:extLst>
          </p:cNvPr>
          <p:cNvSpPr/>
          <p:nvPr/>
        </p:nvSpPr>
        <p:spPr>
          <a:xfrm>
            <a:off x="1255928" y="5184558"/>
            <a:ext cx="2045530" cy="1536727"/>
          </a:xfrm>
          <a:prstGeom prst="roundRect">
            <a:avLst>
              <a:gd name="adj" fmla="val 7029"/>
            </a:avLst>
          </a:prstGeom>
          <a:noFill/>
          <a:ln w="698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57930337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10528"/>
    </mc:Choice>
    <mc:Fallback xmlns="">
      <p:transition spd="slow" advTm="10528"/>
    </mc:Fallback>
  </mc:AlternateContent>
  <p:extLst>
    <p:ext uri="{3A86A75C-4F4B-4683-9AE1-C65F6400EC91}">
      <p14:laserTraceLst xmlns:p14="http://schemas.microsoft.com/office/powerpoint/2010/main">
        <p14:tracePtLst>
          <p14:tracePt t="4652" x="11634788" y="3871913"/>
          <p14:tracePt t="4663" x="11296650" y="3976688"/>
          <p14:tracePt t="4673" x="10661650" y="4159250"/>
          <p14:tracePt t="4676" x="10515600" y="4205288"/>
          <p14:tracePt t="4686" x="10082213" y="4310063"/>
          <p14:tracePt t="4692" x="9493250" y="4460875"/>
          <p14:tracePt t="4703" x="8867775" y="4621213"/>
          <p14:tracePt t="4713" x="7753350" y="4981575"/>
          <p14:tracePt t="4719" x="7519988" y="5072063"/>
          <p14:tracePt t="4728" x="6808788" y="5314950"/>
          <p14:tracePt t="4732" x="6137275" y="5534025"/>
          <p14:tracePt t="4742" x="5543550" y="5711825"/>
          <p14:tracePt t="4752" x="4716463" y="6027738"/>
          <p14:tracePt t="4758" x="4602163" y="6067425"/>
          <p14:tracePt t="4768" x="4329113" y="6176963"/>
          <p14:tracePt t="4772" x="4083050" y="6291263"/>
          <p14:tracePt t="4782" x="3932238" y="6369050"/>
          <p14:tracePt t="4792" x="3762375" y="6429375"/>
          <p14:tracePt t="4798" x="3744913" y="6437313"/>
          <p14:tracePt t="4808" x="3713163" y="6446838"/>
          <p14:tracePt t="4904" x="3708400" y="6446838"/>
          <p14:tracePt t="4914" x="3698875" y="6446838"/>
          <p14:tracePt t="4930" x="3689350" y="6442075"/>
          <p14:tracePt t="4935" x="3684588" y="6437313"/>
          <p14:tracePt t="4944" x="3684588" y="6429375"/>
          <p14:tracePt t="4955" x="3684588" y="6392863"/>
          <p14:tracePt t="4960" x="3684588" y="6383338"/>
          <p14:tracePt t="4971" x="3684588" y="6359525"/>
          <p14:tracePt t="4974" x="3684588" y="6327775"/>
          <p14:tracePt t="4985" x="3662363" y="6273800"/>
          <p14:tracePt t="4994" x="3602038" y="6137275"/>
          <p14:tracePt t="5001" x="3594100" y="6132513"/>
          <p14:tracePt t="5010" x="3562350" y="6076950"/>
          <p14:tracePt t="5014" x="3538538" y="6018213"/>
          <p14:tracePt t="5025" x="3511550" y="5954713"/>
          <p14:tracePt t="5036" x="3502025" y="5926138"/>
          <p14:tracePt t="5040" x="3492500" y="5908675"/>
          <p14:tracePt t="5051" x="3492500" y="5876925"/>
          <p14:tracePt t="5057" x="3492500" y="5857875"/>
          <p14:tracePt t="5067" x="3492500" y="5853113"/>
          <p14:tracePt t="5076" x="3492500" y="5835650"/>
          <p14:tracePt t="5081" x="3492500" y="5826125"/>
          <p14:tracePt t="5090" x="3492500" y="5799138"/>
          <p14:tracePt t="5097" x="3492500" y="5794375"/>
          <p14:tracePt t="5107" x="3492500" y="5784850"/>
          <p14:tracePt t="5116" x="3492500" y="5757863"/>
          <p14:tracePt t="5120" x="3492500" y="5753100"/>
          <p14:tracePt t="5131" x="3492500" y="5726113"/>
          <p14:tracePt t="5138" x="3492500" y="5707063"/>
          <p14:tracePt t="5147" x="3492500" y="5689600"/>
          <p14:tracePt t="5157" x="3484563" y="5634038"/>
          <p14:tracePt t="5162" x="3484563" y="5624513"/>
          <p14:tracePt t="5173" x="3475038" y="5607050"/>
          <p14:tracePt t="5176" x="3460750" y="5580063"/>
          <p14:tracePt t="5188" x="3452813" y="5538788"/>
          <p14:tracePt t="5198" x="3416300" y="5487988"/>
          <p14:tracePt t="5203" x="3416300" y="5478463"/>
          <p14:tracePt t="5213" x="3397250" y="5441950"/>
          <p14:tracePt t="5216" x="3379788" y="5424488"/>
          <p14:tracePt t="5226" x="3346450" y="5378450"/>
          <p14:tracePt t="5237" x="3292475" y="5314950"/>
          <p14:tracePt t="5242" x="3273425" y="5291138"/>
          <p14:tracePt t="5254" x="3209925" y="5232400"/>
          <p14:tracePt t="5256" x="3127375" y="5178425"/>
          <p14:tracePt t="5268" x="3082925" y="5154613"/>
          <p14:tracePt t="5278" x="3017838" y="5100638"/>
          <p14:tracePt t="5283" x="2976563" y="5091113"/>
          <p14:tracePt t="5291" x="2913063" y="5068888"/>
          <p14:tracePt t="5299" x="2854325" y="5040313"/>
          <p14:tracePt t="5308" x="2771775" y="4999038"/>
          <p14:tracePt t="5318" x="2657475" y="4972050"/>
          <p14:tracePt t="5321" x="2640013" y="4972050"/>
          <p14:tracePt t="5332" x="2570163" y="4972050"/>
          <p14:tracePt t="5338" x="2511425" y="4962525"/>
          <p14:tracePt t="5348" x="2360613" y="4930775"/>
          <p14:tracePt t="5358" x="2270125" y="4930775"/>
          <p14:tracePt t="5364" x="2241550" y="4930775"/>
          <p14:tracePt t="5372" x="2187575" y="4922838"/>
          <p14:tracePt t="5378" x="2109788" y="4922838"/>
          <p14:tracePt t="5388" x="2032000" y="4894263"/>
          <p14:tracePt t="5400" x="1885950" y="4894263"/>
          <p14:tracePt t="5405" x="1858963" y="4894263"/>
          <p14:tracePt t="5414" x="1803400" y="4894263"/>
          <p14:tracePt t="5419" x="1712913" y="4894263"/>
          <p14:tracePt t="5428" x="1635125" y="4894263"/>
          <p14:tracePt t="5438" x="1562100" y="4894263"/>
          <p14:tracePt t="5445" x="1520825" y="4894263"/>
          <p14:tracePt t="5455" x="1452563" y="4894263"/>
          <p14:tracePt t="5458" x="1420813" y="4899025"/>
          <p14:tracePt t="5469" x="1392238" y="4908550"/>
          <p14:tracePt t="5478" x="1319213" y="4930775"/>
          <p14:tracePt t="5486" x="1311275" y="4940300"/>
          <p14:tracePt t="5495" x="1282700" y="4949825"/>
          <p14:tracePt t="5501" x="1265238" y="4981575"/>
          <p14:tracePt t="5510" x="1255713" y="4991100"/>
          <p14:tracePt t="5521" x="1214438" y="5018088"/>
          <p14:tracePt t="5524" x="1209675" y="5027613"/>
          <p14:tracePt t="5536" x="1168400" y="5045075"/>
          <p14:tracePt t="5540" x="1150938" y="5076825"/>
          <p14:tracePt t="5551" x="1119188" y="5122863"/>
          <p14:tracePt t="5560" x="1027113" y="5241925"/>
          <p14:tracePt t="5564" x="1017588" y="5259388"/>
          <p14:tracePt t="5574" x="981075" y="5346700"/>
          <p14:tracePt t="5581" x="895350" y="5446713"/>
          <p14:tracePt t="5590" x="835025" y="5548313"/>
          <p14:tracePt t="5602" x="757238" y="5716588"/>
          <p14:tracePt t="5605" x="749300" y="5748338"/>
          <p14:tracePt t="5614" x="712788" y="5835650"/>
          <p14:tracePt t="5620" x="684213" y="5930900"/>
          <p14:tracePt t="5630" x="671513" y="6008688"/>
          <p14:tracePt t="5639" x="644525" y="6137275"/>
          <p14:tracePt t="5646" x="644525" y="6169025"/>
          <p14:tracePt t="5656" x="644525" y="6210300"/>
          <p14:tracePt t="5659" x="644525" y="6264275"/>
          <p14:tracePt t="5670" x="644525" y="6291263"/>
          <p14:tracePt t="5681" x="647700" y="6378575"/>
          <p14:tracePt t="5686" x="647700" y="6383338"/>
          <p14:tracePt t="5698" x="666750" y="6410325"/>
          <p14:tracePt t="5701" x="688975" y="6442075"/>
          <p14:tracePt t="5710" x="708025" y="6473825"/>
          <p14:tracePt t="5721" x="730250" y="6492875"/>
          <p14:tracePt t="5726" x="749300" y="6510338"/>
          <p14:tracePt t="5742" x="781050" y="6556375"/>
          <p14:tracePt t="5756" x="790575" y="6565900"/>
          <p14:tracePt t="5767" x="798513" y="6575425"/>
          <p14:tracePt t="5776" x="803275" y="6580188"/>
          <p14:tracePt t="5783" x="822325" y="6580188"/>
          <p14:tracePt t="5791" x="854075" y="6602413"/>
          <p14:tracePt t="5802" x="895350" y="6624638"/>
          <p14:tracePt t="5805" x="904875" y="6629400"/>
          <p14:tracePt t="5816" x="954088" y="6661150"/>
          <p14:tracePt t="5823" x="985838" y="6670675"/>
          <p14:tracePt t="5833" x="1058863" y="6721475"/>
          <p14:tracePt t="5842" x="1160463" y="6762750"/>
          <p14:tracePt t="5848" x="1163638" y="6762750"/>
          <p14:tracePt t="5858" x="1241425" y="6784975"/>
          <p14:tracePt t="5863" x="1287463" y="6807200"/>
          <p14:tracePt t="5873" x="1328738" y="6807200"/>
          <p14:tracePt t="5883" x="1374775" y="6838950"/>
          <p14:tracePt t="5888" x="1392238" y="6848475"/>
          <p14:tracePt t="5902" x="1433513" y="6848475"/>
          <p14:tracePt t="5903" x="1474788" y="6848475"/>
          <p14:tracePt t="6170" x="2574925" y="6811963"/>
          <p14:tracePt t="6180" x="2579688" y="6802438"/>
          <p14:tracePt t="6185" x="2606675" y="6775450"/>
          <p14:tracePt t="6199" x="2616200" y="6757988"/>
          <p14:tracePt t="6207" x="2647950" y="6734175"/>
          <p14:tracePt t="6218" x="2657475" y="6729413"/>
          <p14:tracePt t="6221" x="2657475" y="6721475"/>
          <p14:tracePt t="6230" x="2667000" y="6711950"/>
          <p14:tracePt t="6240" x="2667000" y="6702425"/>
          <p14:tracePt t="6247" x="2671763" y="6697663"/>
          <p14:tracePt t="6278" x="2671763" y="6680200"/>
          <p14:tracePt t="6287" x="2679700" y="6670675"/>
          <p14:tracePt t="6347" x="2679700" y="6665913"/>
          <p14:tracePt t="6356" x="2679700" y="6656388"/>
          <p14:tracePt t="6367" x="2689225" y="6638925"/>
          <p14:tracePt t="6376" x="2698750" y="6619875"/>
          <p14:tracePt t="6387" x="2708275" y="6592888"/>
          <p14:tracePt t="6398" x="2708275" y="6583363"/>
          <p14:tracePt t="6406" x="2725738" y="6565900"/>
          <p14:tracePt t="6422" x="2735263" y="6556375"/>
          <p14:tracePt t="6428" x="2740025" y="6551613"/>
          <p14:tracePt t="6438" x="2757488" y="6524625"/>
          <p14:tracePt t="6448" x="2781300" y="6502400"/>
          <p14:tracePt t="6458" x="2794000" y="6502400"/>
          <p14:tracePt t="6462" x="2813050" y="6502400"/>
          <p14:tracePt t="6470" x="2844800" y="6473825"/>
          <p14:tracePt t="6478" x="2927350" y="6415088"/>
          <p14:tracePt t="6488" x="3122613" y="6337300"/>
          <p14:tracePt t="6493" x="3182938" y="6310313"/>
          <p14:tracePt t="6503" x="3338513" y="6218238"/>
          <p14:tracePt t="6508" x="3538538" y="6118225"/>
          <p14:tracePt t="6519" x="3990975" y="5954713"/>
          <p14:tracePt t="6528" x="5032375" y="5597525"/>
          <p14:tracePt t="6534" x="5260975" y="5524500"/>
          <p14:tracePt t="6545" x="6040438" y="5273675"/>
          <p14:tracePt t="6549" x="6853238" y="5049838"/>
          <p14:tracePt t="6558" x="7670800" y="4799013"/>
          <p14:tracePt t="6568" x="8785225" y="4433888"/>
          <p14:tracePt t="6574" x="8955088" y="4373563"/>
          <p14:tracePt t="6585" x="9471025" y="4222750"/>
          <p14:tracePt t="6588" x="9986963" y="4076700"/>
          <p14:tracePt t="6599" x="10507663" y="3927475"/>
          <p14:tracePt t="6608" x="11250613" y="3706813"/>
          <p14:tracePt t="6615" x="11379200" y="3694113"/>
          <p14:tracePt t="6624" x="11671300" y="3638550"/>
          <p14:tracePt t="6628" x="11853863" y="3606800"/>
          <p14:tracePt t="6638" x="12018963" y="3594100"/>
        </p14:tracePtLst>
      </p14:laserTraceLst>
    </p:ext>
  </p:extLs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A837FC6-2D4A-461D-AEAB-3E353CA938B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8740"/>
          <a:stretch/>
        </p:blipFill>
        <p:spPr>
          <a:xfrm>
            <a:off x="6859915" y="1145219"/>
            <a:ext cx="4718348" cy="4048218"/>
          </a:xfrm>
          <a:prstGeom prst="rect">
            <a:avLst/>
          </a:prstGeom>
          <a:effectLst>
            <a:glow>
              <a:schemeClr val="tx1"/>
            </a:glow>
          </a:effectLst>
        </p:spPr>
      </p:pic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6E667A59-E869-4510-88DC-E61A5C9C9B77}"/>
              </a:ext>
            </a:extLst>
          </p:cNvPr>
          <p:cNvSpPr/>
          <p:nvPr/>
        </p:nvSpPr>
        <p:spPr>
          <a:xfrm>
            <a:off x="6582670" y="1015439"/>
            <a:ext cx="5299478" cy="4263831"/>
          </a:xfrm>
          <a:prstGeom prst="roundRect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02948D2-6DA2-409F-AAAF-18B77C019531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Interpretation at D22S1045 </a:t>
            </a:r>
            <a:endParaRPr lang="en-US" sz="28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8A40107-1F10-45EE-8C1F-CC93899984DB}"/>
              </a:ext>
            </a:extLst>
          </p:cNvPr>
          <p:cNvSpPr txBox="1"/>
          <p:nvPr/>
        </p:nvSpPr>
        <p:spPr>
          <a:xfrm>
            <a:off x="64474" y="1223119"/>
            <a:ext cx="6641562" cy="3693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§"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 allele at D22S1045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kely a forward stutter (FS)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M v2.1.0 does not model FS and has to account for 16 as either 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a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op-i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an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ele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M v2.1.0 is considering 16 as an allele instead of drop-in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move forward stutter peak from input file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interpret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BEE0500-03D8-4B29-9DB7-DE2222B4D06C}"/>
              </a:ext>
            </a:extLst>
          </p:cNvPr>
          <p:cNvSpPr txBox="1"/>
          <p:nvPr/>
        </p:nvSpPr>
        <p:spPr>
          <a:xfrm>
            <a:off x="6859914" y="2132727"/>
            <a:ext cx="20300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 (major): 15,15</a:t>
            </a:r>
          </a:p>
          <a:p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2 (minor): 14,15</a:t>
            </a:r>
          </a:p>
        </p:txBody>
      </p:sp>
      <p:sp>
        <p:nvSpPr>
          <p:cNvPr id="12" name="Arrow: Right 11">
            <a:extLst>
              <a:ext uri="{FF2B5EF4-FFF2-40B4-BE49-F238E27FC236}">
                <a16:creationId xmlns:a16="http://schemas.microsoft.com/office/drawing/2014/main" id="{36F787A9-A13D-4B17-84CD-31DE5FF33D06}"/>
              </a:ext>
            </a:extLst>
          </p:cNvPr>
          <p:cNvSpPr/>
          <p:nvPr/>
        </p:nvSpPr>
        <p:spPr>
          <a:xfrm rot="8070277">
            <a:off x="10147209" y="2927013"/>
            <a:ext cx="614760" cy="484632"/>
          </a:xfrm>
          <a:prstGeom prst="rightArrow">
            <a:avLst/>
          </a:prstGeom>
          <a:solidFill>
            <a:schemeClr val="tx1"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113773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76520"/>
    </mc:Choice>
    <mc:Fallback xmlns="">
      <p:transition spd="slow" advTm="76520"/>
    </mc:Fallback>
  </mc:AlternateContent>
  <p:extLst>
    <p:ext uri="{3A86A75C-4F4B-4683-9AE1-C65F6400EC91}">
      <p14:laserTraceLst xmlns:p14="http://schemas.microsoft.com/office/powerpoint/2010/main">
        <p14:tracePtLst>
          <p14:tracePt t="1530" x="12077700" y="3606800"/>
          <p14:tracePt t="1539" x="11899900" y="3633788"/>
          <p14:tracePt t="1546" x="11858625" y="3633788"/>
          <p14:tracePt t="1555" x="11653838" y="3675063"/>
          <p14:tracePt t="1565" x="11525250" y="3689350"/>
          <p14:tracePt t="1570" x="11483975" y="3703638"/>
          <p14:tracePt t="1579" x="11315700" y="3716338"/>
          <p14:tracePt t="1585" x="11287125" y="3716338"/>
          <p14:tracePt t="1596" x="11174413" y="3743325"/>
          <p14:tracePt t="1605" x="11133138" y="3743325"/>
          <p14:tracePt t="1610" x="11114088" y="3743325"/>
          <p14:tracePt t="1619" x="11082338" y="3752850"/>
          <p14:tracePt t="1629" x="11077575" y="3752850"/>
          <p14:tracePt t="1638" x="11068050" y="3762375"/>
          <p14:tracePt t="1647" x="11060113" y="3762375"/>
          <p14:tracePt t="1653" x="11050588" y="3776663"/>
          <p14:tracePt t="1666" x="11028363" y="3776663"/>
          <p14:tracePt t="1677" x="10977563" y="3789363"/>
          <p14:tracePt t="1685" x="10968038" y="3789363"/>
          <p14:tracePt t="1691" x="10953750" y="3794125"/>
          <p14:tracePt t="1701" x="10909300" y="3808413"/>
          <p14:tracePt t="1704" x="10904538" y="3808413"/>
          <p14:tracePt t="1715" x="10863263" y="3825875"/>
          <p14:tracePt t="1730" x="10821988" y="3835400"/>
          <p14:tracePt t="1734" x="10812463" y="3835400"/>
          <p14:tracePt t="1742" x="10785475" y="3862388"/>
          <p14:tracePt t="1748" x="10780713" y="3871913"/>
          <p14:tracePt t="1758" x="10739438" y="3889375"/>
          <p14:tracePt t="1767" x="10734675" y="3898900"/>
          <p14:tracePt t="1780" x="10726738" y="3898900"/>
          <p14:tracePt t="1798" x="10717213" y="3898900"/>
          <p14:tracePt t="1927" x="10707688" y="3898900"/>
          <p14:tracePt t="1933" x="10702925" y="3886200"/>
          <p14:tracePt t="1943" x="10690225" y="3711575"/>
          <p14:tracePt t="1948" x="10690225" y="3670300"/>
          <p14:tracePt t="1958" x="10639425" y="3392488"/>
          <p14:tracePt t="1968" x="10607675" y="3227388"/>
          <p14:tracePt t="1973" x="10585450" y="3151188"/>
          <p14:tracePt t="1984" x="10471150" y="2849563"/>
          <p14:tracePt t="1987" x="10442575" y="2784475"/>
          <p14:tracePt t="1998" x="10291763" y="2479675"/>
          <p14:tracePt t="2010" x="10215563" y="2360613"/>
          <p14:tracePt t="2015" x="10186988" y="2328863"/>
          <p14:tracePt t="2023" x="10064750" y="2192338"/>
          <p14:tracePt t="2029" x="10055225" y="2173288"/>
          <p14:tracePt t="2039" x="10031413" y="2151063"/>
          <p14:tracePt t="2050" x="10028238" y="2146300"/>
          <p14:tracePt t="2063" x="10018713" y="2146300"/>
          <p14:tracePt t="2079" x="10009188" y="2146300"/>
          <p14:tracePt t="2094" x="10004425" y="2146300"/>
          <p14:tracePt t="2103" x="9994900" y="2146300"/>
          <p14:tracePt t="2116" x="9977438" y="2136775"/>
          <p14:tracePt t="2119" x="9967913" y="2136775"/>
          <p14:tracePt t="2130" x="9945688" y="2127250"/>
          <p14:tracePt t="2135" x="9926638" y="2127250"/>
          <p14:tracePt t="2146" x="9885363" y="2119313"/>
          <p14:tracePt t="2150" x="9863138" y="2109788"/>
          <p14:tracePt t="2159" x="9836150" y="2085975"/>
          <p14:tracePt t="2169" x="9763125" y="2078038"/>
          <p14:tracePt t="2180" x="9731375" y="2054225"/>
          <p14:tracePt t="2185" x="9712325" y="2046288"/>
          <p14:tracePt t="2189" x="9694863" y="2036763"/>
          <p14:tracePt t="2200" x="9593263" y="1973263"/>
          <p14:tracePt t="2209" x="9498013" y="1944688"/>
          <p14:tracePt t="2216" x="9466263" y="1935163"/>
          <p14:tracePt t="2225" x="9218613" y="1803400"/>
          <p14:tracePt t="2232" x="9159875" y="1789113"/>
          <p14:tracePt t="2240" x="8853488" y="1657350"/>
          <p14:tracePt t="2250" x="8739188" y="1630363"/>
          <p14:tracePt t="2254" x="8680450" y="1603375"/>
          <p14:tracePt t="2265" x="8374063" y="1489075"/>
          <p14:tracePt t="2270" x="8315325" y="1465263"/>
          <p14:tracePt t="2281" x="8096250" y="1379538"/>
          <p14:tracePt t="2290" x="8050213" y="1360488"/>
          <p14:tracePt t="2295" x="8040688" y="1360488"/>
          <p14:tracePt t="2304" x="7991475" y="1314450"/>
          <p14:tracePt t="2856" x="7981950" y="1314450"/>
          <p14:tracePt t="3275" x="7981950" y="1319213"/>
          <p14:tracePt t="3305" x="7981950" y="1328738"/>
          <p14:tracePt t="3339" x="7981950" y="1333500"/>
          <p14:tracePt t="3359" x="7981950" y="1350963"/>
          <p14:tracePt t="3395" x="7981950" y="1360488"/>
          <p14:tracePt t="3401" x="7981950" y="1370013"/>
          <p14:tracePt t="3461" x="7981950" y="1382713"/>
          <p14:tracePt t="3528" x="7981950" y="1401763"/>
          <p14:tracePt t="3541" x="7996238" y="1419225"/>
          <p14:tracePt t="3578" x="8013700" y="1443038"/>
          <p14:tracePt t="3587" x="8027988" y="1470025"/>
          <p14:tracePt t="3601" x="8045450" y="1489075"/>
          <p14:tracePt t="3612" x="8045450" y="1506538"/>
          <p14:tracePt t="3617" x="8054975" y="1516063"/>
          <p14:tracePt t="3627" x="8072438" y="1552575"/>
          <p14:tracePt t="3637" x="8072438" y="1562100"/>
          <p14:tracePt t="3644" x="8081963" y="1579563"/>
          <p14:tracePt t="3653" x="8091488" y="1598613"/>
          <p14:tracePt t="3657" x="8096250" y="1606550"/>
          <p14:tracePt t="3667" x="8108950" y="1652588"/>
          <p14:tracePt t="3673" x="8118475" y="1671638"/>
          <p14:tracePt t="3683" x="8128000" y="1730375"/>
          <p14:tracePt t="3694" x="8128000" y="1757363"/>
          <p14:tracePt t="3698" x="8128000" y="1766888"/>
          <p14:tracePt t="3707" x="8137525" y="1825625"/>
          <p14:tracePt t="3713" x="8137525" y="1858963"/>
          <p14:tracePt t="3723" x="8164513" y="1973263"/>
          <p14:tracePt t="3733" x="8164513" y="2063750"/>
          <p14:tracePt t="3739" x="8164513" y="2095500"/>
          <p14:tracePt t="3749" x="8164513" y="2209800"/>
          <p14:tracePt t="3753" x="8164513" y="2251075"/>
          <p14:tracePt t="3764" x="8164513" y="2378075"/>
          <p14:tracePt t="3772" x="8164513" y="2452688"/>
          <p14:tracePt t="3779" x="8164513" y="2479675"/>
          <p14:tracePt t="3788" x="8164513" y="2552700"/>
          <p14:tracePt t="3793" x="8164513" y="2593975"/>
          <p14:tracePt t="3803" x="8164513" y="2689225"/>
          <p14:tracePt t="3814" x="8164513" y="2720975"/>
          <p14:tracePt t="3819" x="8164513" y="2747963"/>
          <p14:tracePt t="3830" x="8159750" y="2803525"/>
          <p14:tracePt t="3833" x="8147050" y="2835275"/>
          <p14:tracePt t="3844" x="8147050" y="2844800"/>
          <p14:tracePt t="3855" x="8147050" y="2857500"/>
          <p14:tracePt t="3860" x="8147050" y="2867025"/>
          <p14:tracePt t="3869" x="8147050" y="2886075"/>
          <p14:tracePt t="3880" x="8147050" y="2890838"/>
          <p14:tracePt t="3885" x="8142288" y="2898775"/>
          <p14:tracePt t="3916" x="8142288" y="2908300"/>
          <p14:tracePt t="3925" x="8132763" y="2913063"/>
          <p14:tracePt t="3946" x="8132763" y="2930525"/>
          <p14:tracePt t="3962" x="8123238" y="2940050"/>
          <p14:tracePt t="4091" x="8118475" y="2949575"/>
          <p14:tracePt t="4108" x="8118475" y="2935288"/>
          <p14:tracePt t="4111" x="8105775" y="2917825"/>
          <p14:tracePt t="4128" x="8105775" y="2908300"/>
          <p14:tracePt t="4137" x="8101013" y="2890838"/>
          <p14:tracePt t="4142" x="8101013" y="2886075"/>
          <p14:tracePt t="4152" x="8101013" y="2857500"/>
          <p14:tracePt t="4158" x="8101013" y="2849563"/>
          <p14:tracePt t="4168" x="8091488" y="2830513"/>
          <p14:tracePt t="4180" x="8081963" y="2813050"/>
          <p14:tracePt t="4182" x="8081963" y="2808288"/>
          <p14:tracePt t="4192" x="8072438" y="2798763"/>
          <p14:tracePt t="4198" x="8072438" y="2781300"/>
          <p14:tracePt t="4208" x="8072438" y="2776538"/>
          <p14:tracePt t="4217" x="8064500" y="2757488"/>
          <p14:tracePt t="4248" x="8054975" y="2747963"/>
          <p14:tracePt t="4258" x="8040688" y="2740025"/>
          <p14:tracePt t="4273" x="8032750" y="2730500"/>
          <p14:tracePt t="4287" x="8023225" y="2725738"/>
          <p14:tracePt t="4303" x="8013700" y="2708275"/>
          <p14:tracePt t="4330" x="8008938" y="2698750"/>
          <p14:tracePt t="4349" x="7999413" y="2671763"/>
          <p14:tracePt t="4353" x="7991475" y="2667000"/>
          <p14:tracePt t="4364" x="7991475" y="2657475"/>
          <p14:tracePt t="4369" x="7981950" y="2647950"/>
          <p14:tracePt t="4381" x="7962900" y="2635250"/>
          <p14:tracePt t="4393" x="7959725" y="2625725"/>
          <p14:tracePt t="4399" x="7950200" y="2616200"/>
          <p14:tracePt t="4414" x="7940675" y="2606675"/>
          <p14:tracePt t="4430" x="7935913" y="2606675"/>
          <p14:tracePt t="4435" x="7926388" y="2606675"/>
          <p14:tracePt t="4439" x="7918450" y="2601913"/>
          <p14:tracePt t="4460" x="7889875" y="2593975"/>
          <p14:tracePt t="4476" x="7886700" y="2593975"/>
          <p14:tracePt t="4480" x="7877175" y="2593975"/>
          <p14:tracePt t="4489" x="7850188" y="2584450"/>
          <p14:tracePt t="4500" x="7840663" y="2574925"/>
          <p14:tracePt t="4510" x="7813675" y="2557463"/>
          <p14:tracePt t="4529" x="7794625" y="2547938"/>
          <p14:tracePt t="4541" x="7789863" y="2538413"/>
          <p14:tracePt t="4546" x="7772400" y="2528888"/>
          <p14:tracePt t="4555" x="7753350" y="2528888"/>
          <p14:tracePt t="4571" x="7743825" y="2528888"/>
          <p14:tracePt t="4582" x="7740650" y="2525713"/>
          <p14:tracePt t="4591" x="7731125" y="2525713"/>
          <p14:tracePt t="4596" x="7721600" y="2516188"/>
          <p14:tracePt t="4615" x="7716838" y="2506663"/>
          <p14:tracePt t="4632" x="7707313" y="2506663"/>
          <p14:tracePt t="4646" x="7699375" y="2506663"/>
          <p14:tracePt t="4661" x="7680325" y="2506663"/>
          <p14:tracePt t="4677" x="7675563" y="2506663"/>
          <p14:tracePt t="4687" x="7666038" y="2506663"/>
          <p14:tracePt t="4691" x="7658100" y="2506663"/>
          <p14:tracePt t="4701" x="7653338" y="2506663"/>
          <p14:tracePt t="4707" x="7643813" y="2506663"/>
          <p14:tracePt t="4717" x="7634288" y="2506663"/>
          <p14:tracePt t="4726" x="7607300" y="2506663"/>
          <p14:tracePt t="4748" x="7602538" y="2506663"/>
          <p14:tracePt t="4756" x="7593013" y="2506663"/>
          <p14:tracePt t="4761" x="7585075" y="2506663"/>
          <p14:tracePt t="4774" x="7570788" y="2506663"/>
          <p14:tracePt t="4787" x="7553325" y="2506663"/>
          <p14:tracePt t="4808" x="7543800" y="2506663"/>
          <p14:tracePt t="4824" x="7529513" y="2506663"/>
          <p14:tracePt t="4867" x="7519988" y="2506663"/>
          <p14:tracePt t="4883" x="7512050" y="2506663"/>
          <p14:tracePt t="4896" x="7493000" y="2511425"/>
          <p14:tracePt t="5061" x="7493000" y="2520950"/>
          <p14:tracePt t="5070" x="7497763" y="2520950"/>
          <p14:tracePt t="5081" x="7507288" y="2520950"/>
          <p14:tracePt t="5087" x="7512050" y="2520950"/>
          <p14:tracePt t="5095" x="7519988" y="2520950"/>
          <p14:tracePt t="5105" x="7548563" y="2520950"/>
          <p14:tracePt t="5113" x="7556500" y="2520950"/>
          <p14:tracePt t="5121" x="7580313" y="2520950"/>
          <p14:tracePt t="5125" x="7597775" y="2520950"/>
          <p14:tracePt t="5134" x="7639050" y="2520950"/>
          <p14:tracePt t="5145" x="7658100" y="2520950"/>
          <p14:tracePt t="5150" x="7666038" y="2520950"/>
          <p14:tracePt t="5161" x="7680325" y="2520950"/>
          <p14:tracePt t="5165" x="7689850" y="2520950"/>
          <p14:tracePt t="6074" x="7699375" y="2520950"/>
          <p14:tracePt t="6093" x="7712075" y="2520950"/>
          <p14:tracePt t="6103" x="7731125" y="2520950"/>
          <p14:tracePt t="6110" x="7740650" y="2520950"/>
          <p14:tracePt t="6124" x="7767638" y="2520950"/>
          <p14:tracePt t="6150" x="7772400" y="2520950"/>
          <p14:tracePt t="8313" x="7789863" y="2520950"/>
          <p14:tracePt t="8323" x="7799388" y="2520950"/>
          <p14:tracePt t="8327" x="7813675" y="2520950"/>
          <p14:tracePt t="8333" x="7853363" y="2520950"/>
          <p14:tracePt t="8343" x="7894638" y="2520950"/>
          <p14:tracePt t="8349" x="7926388" y="2520950"/>
          <p14:tracePt t="8360" x="8040688" y="2533650"/>
          <p14:tracePt t="8369" x="8096250" y="2533650"/>
          <p14:tracePt t="8373" x="8186738" y="2533650"/>
          <p14:tracePt t="8383" x="8264525" y="2533650"/>
          <p14:tracePt t="8389" x="8269288" y="2533650"/>
          <p14:tracePt t="8400" x="8356600" y="2533650"/>
          <p14:tracePt t="8410" x="8447088" y="2533650"/>
          <p14:tracePt t="8413" x="8566150" y="2492375"/>
          <p14:tracePt t="8423" x="8629650" y="2443163"/>
          <p14:tracePt t="8429" x="8662988" y="2419350"/>
          <p14:tracePt t="8439" x="8716963" y="2397125"/>
          <p14:tracePt t="8449" x="8726488" y="2392363"/>
          <p14:tracePt t="8924" x="8726488" y="2382838"/>
          <p14:tracePt t="8933" x="8702675" y="2382838"/>
          <p14:tracePt t="8939" x="8689975" y="2382838"/>
          <p14:tracePt t="8949" x="8648700" y="2382838"/>
          <p14:tracePt t="8953" x="8575675" y="2414588"/>
          <p14:tracePt t="8965" x="8524875" y="2465388"/>
          <p14:tracePt t="8970" x="8502650" y="2484438"/>
          <p14:tracePt t="8980" x="8415338" y="2547938"/>
          <p14:tracePt t="8989" x="8366125" y="2598738"/>
          <p14:tracePt t="8994" x="8332788" y="2630488"/>
          <p14:tracePt t="9004" x="8301038" y="2647950"/>
          <p14:tracePt t="9010" x="8293100" y="2667000"/>
          <p14:tracePt t="9020" x="8247063" y="2711450"/>
          <p14:tracePt t="9030" x="8183563" y="2752725"/>
          <p14:tracePt t="9036" x="8164513" y="2784475"/>
          <p14:tracePt t="9046" x="8142288" y="2803525"/>
          <p14:tracePt t="9054" x="8123238" y="2820988"/>
          <p14:tracePt t="9251" x="8113713" y="2820988"/>
          <p14:tracePt t="9298" x="8108950" y="2817813"/>
          <p14:tracePt t="9308" x="8101013" y="2817813"/>
          <p14:tracePt t="9314" x="8081963" y="2817813"/>
          <p14:tracePt t="9318" x="8069263" y="2817813"/>
          <p14:tracePt t="9327" x="8050213" y="2817813"/>
          <p14:tracePt t="9332" x="8018463" y="2817813"/>
          <p14:tracePt t="9342" x="7977188" y="2817813"/>
          <p14:tracePt t="9352" x="7923213" y="2817813"/>
          <p14:tracePt t="9358" x="7894638" y="2817813"/>
          <p14:tracePt t="9370" x="7813675" y="2817813"/>
          <p14:tracePt t="9372" x="7780338" y="2817813"/>
          <p14:tracePt t="9385" x="7712075" y="2817813"/>
          <p14:tracePt t="9396" x="7685088" y="2817813"/>
          <p14:tracePt t="9400" x="7639050" y="2808288"/>
          <p14:tracePt t="9407" x="7621588" y="2798763"/>
          <p14:tracePt t="9414" x="7616825" y="2798763"/>
          <p14:tracePt t="9422" x="7597775" y="2771775"/>
          <p14:tracePt t="9661" x="7589838" y="2776538"/>
          <p14:tracePt t="9670" x="7589838" y="2784475"/>
          <p14:tracePt t="9677" x="7580313" y="2798763"/>
          <p14:tracePt t="9680" x="7580313" y="2808288"/>
          <p14:tracePt t="9689" x="7580313" y="2817813"/>
          <p14:tracePt t="9696" x="7580313" y="2830513"/>
          <p14:tracePt t="9705" x="7580313" y="2862263"/>
          <p14:tracePt t="9715" x="7580313" y="2881313"/>
          <p14:tracePt t="9718" x="7580313" y="2894013"/>
          <p14:tracePt t="9733" x="7580313" y="2903538"/>
          <p14:tracePt t="9737" x="7580313" y="2930525"/>
          <p14:tracePt t="9747" x="7580313" y="2940050"/>
          <p14:tracePt t="9757" x="7580313" y="2944813"/>
          <p14:tracePt t="9761" x="7580313" y="2954338"/>
          <p14:tracePt t="9782" x="7580313" y="2963863"/>
          <p14:tracePt t="9820" x="7580313" y="2968625"/>
          <p14:tracePt t="9847" x="7570788" y="2986088"/>
          <p14:tracePt t="10497" x="7570788" y="3005138"/>
          <p14:tracePt t="10507" x="7585075" y="3005138"/>
          <p14:tracePt t="10513" x="7593013" y="3005138"/>
          <p14:tracePt t="10517" x="7597775" y="3005138"/>
          <p14:tracePt t="10526" x="7626350" y="3005138"/>
          <p14:tracePt t="10538" x="7634288" y="3005138"/>
          <p14:tracePt t="10543" x="7670800" y="3005138"/>
          <p14:tracePt t="10554" x="7675563" y="3005138"/>
          <p14:tracePt t="10557" x="7694613" y="3005138"/>
          <p14:tracePt t="10567" x="7726363" y="3005138"/>
          <p14:tracePt t="10578" x="7740650" y="3005138"/>
          <p14:tracePt t="10583" x="7758113" y="3005138"/>
          <p14:tracePt t="10594" x="7777163" y="3005138"/>
          <p14:tracePt t="10604" x="7785100" y="3005138"/>
          <p14:tracePt t="10615" x="7808913" y="3005138"/>
          <p14:tracePt t="10643" x="7816850" y="3005138"/>
          <p14:tracePt t="10654" x="7835900" y="3005138"/>
          <p14:tracePt t="10664" x="7845425" y="3005138"/>
          <p14:tracePt t="10673" x="7858125" y="3005138"/>
          <p14:tracePt t="10683" x="7867650" y="3005138"/>
          <p14:tracePt t="10689" x="7877175" y="3005138"/>
          <p14:tracePt t="10699" x="7881938" y="3005138"/>
          <p14:tracePt t="10703" x="7908925" y="3000375"/>
          <p14:tracePt t="10714" x="7918450" y="3000375"/>
          <p14:tracePt t="10719" x="7945438" y="3000375"/>
          <p14:tracePt t="10729" x="7972425" y="2990850"/>
          <p14:tracePt t="10739" x="7991475" y="2981325"/>
          <p14:tracePt t="10743" x="7999413" y="2981325"/>
          <p14:tracePt t="10754" x="8027988" y="2971800"/>
          <p14:tracePt t="10766" x="8069263" y="2971800"/>
          <p14:tracePt t="10769" x="8086725" y="2971800"/>
          <p14:tracePt t="10780" x="8128000" y="2971800"/>
          <p14:tracePt t="10785" x="8154988" y="2971800"/>
          <p14:tracePt t="10796" x="8183563" y="2971800"/>
          <p14:tracePt t="10799" x="8215313" y="2971800"/>
          <p14:tracePt t="10809" x="8256588" y="2971800"/>
          <p14:tracePt t="10819" x="8310563" y="2971800"/>
          <p14:tracePt t="10826" x="8337550" y="2971800"/>
          <p14:tracePt t="10835" x="8356600" y="2971800"/>
          <p14:tracePt t="10838" x="8374063" y="2971800"/>
          <p14:tracePt t="10849" x="8383588" y="2971800"/>
          <p14:tracePt t="10859" x="8388350" y="2971800"/>
          <p14:tracePt t="10866" x="8397875" y="2971800"/>
          <p14:tracePt t="10877" x="8405813" y="2971800"/>
          <p14:tracePt t="11082" x="8410575" y="2971800"/>
          <p14:tracePt t="11098" x="8410575" y="2976563"/>
          <p14:tracePt t="11178" x="8429625" y="2981325"/>
          <p14:tracePt t="14774" x="8429625" y="3000375"/>
          <p14:tracePt t="14780" x="8429625" y="3008313"/>
          <p14:tracePt t="14806" x="8429625" y="3017838"/>
          <p14:tracePt t="15344" x="8429625" y="3022600"/>
          <p14:tracePt t="15370" x="8429625" y="3032125"/>
          <p14:tracePt t="15379" x="8429625" y="3041650"/>
          <p14:tracePt t="15389" x="8429625" y="3049588"/>
          <p14:tracePt t="15399" x="8429625" y="3073400"/>
          <p14:tracePt t="19445" x="8429625" y="3090863"/>
          <p14:tracePt t="19466" x="8429625" y="3100388"/>
          <p14:tracePt t="20227" x="8429625" y="3127375"/>
          <p14:tracePt t="20231" x="8429625" y="3132138"/>
          <p14:tracePt t="20237" x="8429625" y="3168650"/>
          <p14:tracePt t="20248" x="8429625" y="3255963"/>
          <p14:tracePt t="20251" x="8429625" y="3260725"/>
          <p14:tracePt t="20262" x="8439150" y="3287713"/>
          <p14:tracePt t="20271" x="8461375" y="3346450"/>
          <p14:tracePt t="20282" x="8470900" y="3365500"/>
          <p14:tracePt t="20287" x="8478838" y="3373438"/>
          <p14:tracePt t="20293" x="8478838" y="3378200"/>
          <p14:tracePt t="20301" x="8497888" y="3397250"/>
          <p14:tracePt t="20313" x="8497888" y="3429000"/>
          <p14:tracePt t="20322" x="8507413" y="3433763"/>
          <p14:tracePt t="20328" x="8520113" y="3451225"/>
          <p14:tracePt t="20337" x="8529638" y="3460750"/>
          <p14:tracePt t="20343" x="8539163" y="3470275"/>
          <p14:tracePt t="20353" x="8566150" y="3506788"/>
          <p14:tracePt t="20357" x="8585200" y="3516313"/>
          <p14:tracePt t="20367" x="8616950" y="3538538"/>
          <p14:tracePt t="20373" x="8634413" y="3548063"/>
          <p14:tracePt t="20383" x="8653463" y="3565525"/>
          <p14:tracePt t="20393" x="8716963" y="3625850"/>
          <p14:tracePt t="20398" x="8736013" y="3633788"/>
          <p14:tracePt t="20407" x="8826500" y="3725863"/>
          <p14:tracePt t="20413" x="8831263" y="3735388"/>
          <p14:tracePt t="20422" x="8872538" y="3762375"/>
          <p14:tracePt t="20432" x="8940800" y="3849688"/>
          <p14:tracePt t="20436" x="8950325" y="3857625"/>
          <p14:tracePt t="20448" x="9004300" y="3922713"/>
          <p14:tracePt t="20453" x="9013825" y="3930650"/>
          <p14:tracePt t="20463" x="9040813" y="3967163"/>
          <p14:tracePt t="20473" x="9109075" y="4054475"/>
          <p14:tracePt t="20480" x="9123363" y="4073525"/>
          <p14:tracePt t="20489" x="9182100" y="4159250"/>
          <p14:tracePt t="20495" x="9205913" y="4168775"/>
          <p14:tracePt t="20503" x="9223375" y="4191000"/>
          <p14:tracePt t="20513" x="9288463" y="4264025"/>
          <p14:tracePt t="20523" x="9305925" y="4283075"/>
          <p14:tracePt t="20531" x="9315450" y="4292600"/>
          <p14:tracePt t="20533" x="9320213" y="4300538"/>
          <p14:tracePt t="20550" x="9347200" y="4329113"/>
          <p14:tracePt t="20559" x="9366250" y="4337050"/>
          <p14:tracePt t="20569" x="9374188" y="4341813"/>
          <p14:tracePt t="20599" x="9383713" y="4351338"/>
          <p14:tracePt t="20609" x="9388475" y="4351338"/>
          <p14:tracePt t="20615" x="9398000" y="4360863"/>
          <p14:tracePt t="20630" x="9405938" y="4360863"/>
          <p14:tracePt t="20649" x="9415463" y="4360863"/>
          <p14:tracePt t="20658" x="9420225" y="4360863"/>
          <p14:tracePt t="20665" x="9429750" y="4360863"/>
          <p14:tracePt t="20676" x="9439275" y="4368800"/>
          <p14:tracePt t="20679" x="9442450" y="4368800"/>
          <p14:tracePt t="20692" x="9461500" y="4383088"/>
          <p14:tracePt t="20696" x="9471025" y="4383088"/>
          <p14:tracePt t="20705" x="9507538" y="4383088"/>
          <p14:tracePt t="20716" x="9551988" y="4429125"/>
          <p14:tracePt t="20726" x="9598025" y="4451350"/>
          <p14:tracePt t="20731" x="9617075" y="4460875"/>
          <p14:tracePt t="20735" x="9625013" y="4460875"/>
          <p14:tracePt t="20745" x="9661525" y="4483100"/>
          <p14:tracePt t="20755" x="9707563" y="4516438"/>
          <p14:tracePt t="20761" x="9717088" y="4516438"/>
          <p14:tracePt t="20771" x="9744075" y="4524375"/>
          <p14:tracePt t="20776" x="9753600" y="4533900"/>
          <p14:tracePt t="20858" x="9758363" y="4543425"/>
          <p14:tracePt t="20933" x="9767888" y="4543425"/>
          <p14:tracePt t="20993" x="9775825" y="4543425"/>
          <p14:tracePt t="21007" x="9785350" y="4543425"/>
          <p14:tracePt t="21013" x="9790113" y="4543425"/>
          <p14:tracePt t="21017" x="9799638" y="4543425"/>
          <p14:tracePt t="21027" x="9826625" y="4543425"/>
          <p14:tracePt t="21039" x="9853613" y="4543425"/>
          <p14:tracePt t="21050" x="9872663" y="4543425"/>
          <p14:tracePt t="21052" x="9882188" y="4543425"/>
          <p14:tracePt t="21059" x="9885363" y="4543425"/>
          <p14:tracePt t="21069" x="9904413" y="4543425"/>
          <p14:tracePt t="21080" x="9945688" y="4543425"/>
          <p14:tracePt t="21089" x="9955213" y="4543425"/>
          <p14:tracePt t="21093" x="9967913" y="4543425"/>
          <p14:tracePt t="21103" x="9977438" y="4543425"/>
          <p14:tracePt t="21109" x="9986963" y="4543425"/>
          <p14:tracePt t="21119" x="9999663" y="4543425"/>
          <p14:tracePt t="21123" x="10009188" y="4543425"/>
          <p14:tracePt t="21133" x="10018713" y="4543425"/>
          <p14:tracePt t="21139" x="10031413" y="4543425"/>
          <p14:tracePt t="21149" x="10040938" y="4543425"/>
          <p14:tracePt t="21159" x="10050463" y="4543425"/>
          <p14:tracePt t="21176" x="10059988" y="4543425"/>
          <p14:tracePt t="21179" x="10064750" y="4543425"/>
          <p14:tracePt t="21215" x="10082213" y="4543425"/>
          <p14:tracePt t="21235" x="10091738" y="4538663"/>
          <p14:tracePt t="21261" x="10091738" y="4529138"/>
          <p14:tracePt t="21355" x="10104438" y="4516438"/>
          <p14:tracePt t="21361" x="10113963" y="4516438"/>
          <p14:tracePt t="21365" x="10123488" y="4516438"/>
          <p14:tracePt t="21375" x="10133013" y="4516438"/>
          <p14:tracePt t="21381" x="10137775" y="4516438"/>
          <p14:tracePt t="21392" x="10155238" y="4516438"/>
          <p14:tracePt t="21401" x="10201275" y="4552950"/>
          <p14:tracePt t="21407" x="10210800" y="4560888"/>
          <p14:tracePt t="21417" x="10228263" y="4611688"/>
          <p14:tracePt t="21431" x="10228263" y="4616450"/>
          <p14:tracePt t="21442" x="10237788" y="4633913"/>
          <p14:tracePt t="21448" x="10237788" y="4643438"/>
          <p14:tracePt t="21459" x="10237788" y="4652963"/>
          <p14:tracePt t="21517" x="10237788" y="4657725"/>
          <p14:tracePt t="21523" x="10223500" y="4657725"/>
          <p14:tracePt t="21528" x="10218738" y="4657725"/>
          <p14:tracePt t="21537" x="10191750" y="4657725"/>
          <p14:tracePt t="21543" x="10182225" y="4657725"/>
          <p14:tracePt t="21553" x="10155238" y="4657725"/>
          <p14:tracePt t="21564" x="10101263" y="4638675"/>
          <p14:tracePt t="21573" x="10091738" y="4638675"/>
          <p14:tracePt t="21578" x="10082213" y="4629150"/>
          <p14:tracePt t="21583" x="10077450" y="4625975"/>
          <p14:tracePt t="21594" x="10059988" y="4597400"/>
          <p14:tracePt t="21603" x="10059988" y="4589463"/>
          <p14:tracePt t="21608" x="10050463" y="4579938"/>
          <p14:tracePt t="21619" x="10040938" y="4556125"/>
          <p14:tracePt t="21719" x="10064750" y="4556125"/>
          <p14:tracePt t="21730" x="10096500" y="4556125"/>
          <p14:tracePt t="21739" x="10123488" y="4570413"/>
          <p14:tracePt t="21746" x="10133013" y="4579938"/>
          <p14:tracePt t="21755" x="10140950" y="4592638"/>
          <p14:tracePt t="21766" x="10174288" y="4638675"/>
          <p14:tracePt t="21780" x="10174288" y="4648200"/>
          <p14:tracePt t="21795" x="10174288" y="4657725"/>
          <p14:tracePt t="21959" x="10174288" y="4652963"/>
          <p14:tracePt t="21968" x="10174288" y="4643438"/>
          <p14:tracePt t="21978" x="10174288" y="4638675"/>
          <p14:tracePt t="21984" x="10164763" y="4629150"/>
          <p14:tracePt t="21993" x="10164763" y="4611688"/>
          <p14:tracePt t="22001" x="10164763" y="4606925"/>
          <p14:tracePt t="22011" x="10164763" y="4589463"/>
          <p14:tracePt t="22019" x="10164763" y="4579938"/>
          <p14:tracePt t="22183" x="10164763" y="4592638"/>
          <p14:tracePt t="22189" x="10164763" y="4611688"/>
          <p14:tracePt t="22199" x="10164763" y="4629150"/>
          <p14:tracePt t="22210" x="10169525" y="4648200"/>
          <p14:tracePt t="22219" x="10179050" y="4652963"/>
          <p14:tracePt t="22223" x="10179050" y="4662488"/>
          <p14:tracePt t="22849" x="10186988" y="4670425"/>
          <p14:tracePt t="22919" x="10191750" y="4670425"/>
          <p14:tracePt t="23006" x="10201275" y="4670425"/>
          <p14:tracePt t="23012" x="10201275" y="4665663"/>
          <p14:tracePt t="23025" x="10210800" y="4638675"/>
          <p14:tracePt t="23032" x="10218738" y="4633913"/>
          <p14:tracePt t="23042" x="10218738" y="4616450"/>
          <p14:tracePt t="23046" x="10223500" y="4606925"/>
          <p14:tracePt t="23055" x="10223500" y="4602163"/>
          <p14:tracePt t="23063" x="10223500" y="4592638"/>
          <p14:tracePt t="23071" x="10223500" y="4584700"/>
          <p14:tracePt t="23486" x="10233025" y="4575175"/>
          <p14:tracePt t="23507" x="10252075" y="4575175"/>
          <p14:tracePt t="23517" x="10252075" y="4579938"/>
          <p14:tracePt t="23548" x="10288588" y="4621213"/>
          <p14:tracePt t="23558" x="10296525" y="4629150"/>
          <p14:tracePt t="23571" x="10306050" y="4629150"/>
          <p14:tracePt t="23584" x="10325100" y="4629150"/>
          <p14:tracePt t="23626" x="10328275" y="4629150"/>
          <p14:tracePt t="23641" x="10337800" y="4629150"/>
          <p14:tracePt t="23651" x="10356850" y="4629150"/>
          <p14:tracePt t="23680" x="10361613" y="4629150"/>
          <p14:tracePt t="23692" x="10379075" y="4629150"/>
          <p14:tracePt t="23728" x="10388600" y="4629150"/>
          <p14:tracePt t="23772" x="10410825" y="4629150"/>
          <p14:tracePt t="23837" x="10420350" y="4629150"/>
          <p14:tracePt t="23877" x="10437813" y="4629150"/>
          <p14:tracePt t="23908" x="10442575" y="4629150"/>
          <p14:tracePt t="23973" x="10452100" y="4629150"/>
          <p14:tracePt t="23979" x="10461625" y="4629150"/>
          <p14:tracePt t="23989" x="10488613" y="4625975"/>
          <p14:tracePt t="23993" x="10493375" y="4625975"/>
          <p14:tracePt t="24003" x="10510838" y="4625975"/>
          <p14:tracePt t="24013" x="10539413" y="4625975"/>
          <p14:tracePt t="24019" x="10556875" y="4625975"/>
          <p14:tracePt t="24030" x="10575925" y="4625975"/>
          <p14:tracePt t="24035" x="10585450" y="4616450"/>
          <p14:tracePt t="24115" x="10588625" y="4616450"/>
          <p14:tracePt t="24125" x="10598150" y="4616450"/>
          <p14:tracePt t="24135" x="10607675" y="4616450"/>
          <p14:tracePt t="24139" x="10617200" y="4616450"/>
          <p14:tracePt t="24151" x="10639425" y="4616450"/>
          <p14:tracePt t="24155" x="10648950" y="4616450"/>
          <p14:tracePt t="24165" x="10666413" y="4616450"/>
          <p14:tracePt t="24176" x="10707688" y="4616450"/>
          <p14:tracePt t="24181" x="10712450" y="4616450"/>
          <p14:tracePt t="24191" x="10739438" y="4616450"/>
          <p14:tracePt t="24201" x="10748963" y="4616450"/>
          <p14:tracePt t="24204" x="10758488" y="4616450"/>
          <p14:tracePt t="24216" x="10763250" y="4616450"/>
          <p14:tracePt t="24232" x="10771188" y="4616450"/>
          <p14:tracePt t="24927" x="10780713" y="4616450"/>
          <p14:tracePt t="24937" x="10785475" y="4621213"/>
          <p14:tracePt t="24983" x="10785475" y="4633913"/>
          <p14:tracePt t="24994" x="10795000" y="4643438"/>
          <p14:tracePt t="25533" x="10795000" y="4652963"/>
          <p14:tracePt t="26022" x="10795000" y="4648200"/>
          <p14:tracePt t="26031" x="10795000" y="4638675"/>
          <p14:tracePt t="26041" x="10795000" y="4625975"/>
          <p14:tracePt t="26051" x="10795000" y="4606925"/>
          <p14:tracePt t="26060" x="10780713" y="4589463"/>
          <p14:tracePt t="26067" x="10771188" y="4579938"/>
          <p14:tracePt t="26078" x="10753725" y="4570413"/>
          <p14:tracePt t="26087" x="10744200" y="4538663"/>
          <p14:tracePt t="26092" x="10726738" y="4529138"/>
          <p14:tracePt t="26100" x="10694988" y="4511675"/>
          <p14:tracePt t="26113" x="10675938" y="4502150"/>
          <p14:tracePt t="26117" x="10658475" y="4492625"/>
          <p14:tracePt t="26123" x="10648950" y="4483100"/>
          <p14:tracePt t="26133" x="10598150" y="4443413"/>
          <p14:tracePt t="26136" x="10588625" y="4443413"/>
          <p14:tracePt t="26147" x="10561638" y="4424363"/>
          <p14:tracePt t="26159" x="10507663" y="4410075"/>
          <p14:tracePt t="26163" x="10498138" y="4405313"/>
          <p14:tracePt t="26173" x="10437813" y="4383088"/>
          <p14:tracePt t="26177" x="10406063" y="4351338"/>
          <p14:tracePt t="26187" x="10374313" y="4341813"/>
          <p14:tracePt t="26199" x="10301288" y="4329113"/>
          <p14:tracePt t="26203" x="10283825" y="4310063"/>
          <p14:tracePt t="26213" x="10228263" y="4300538"/>
          <p14:tracePt t="26224" x="10210800" y="4300538"/>
          <p14:tracePt t="26233" x="10191750" y="4292600"/>
          <p14:tracePt t="26293" x="10174288" y="4292600"/>
          <p14:tracePt t="26323" x="10164763" y="4292600"/>
          <p14:tracePt t="26462" x="10160000" y="4292600"/>
          <p14:tracePt t="26476" x="10150475" y="4273550"/>
          <p14:tracePt t="26482" x="10133013" y="4273550"/>
          <p14:tracePt t="26486" x="10123488" y="4273550"/>
          <p14:tracePt t="26497" x="10104438" y="4264025"/>
          <p14:tracePt t="26501" x="10101263" y="4256088"/>
          <p14:tracePt t="26512" x="10091738" y="4251325"/>
          <p14:tracePt t="26521" x="10064750" y="4222750"/>
          <p14:tracePt t="26534" x="9982200" y="4183063"/>
          <p14:tracePt t="26542" x="9977438" y="4173538"/>
          <p14:tracePt t="26551" x="9967913" y="4173538"/>
          <p14:tracePt t="26561" x="9950450" y="4154488"/>
          <p14:tracePt t="26637" x="9931400" y="4137025"/>
          <p14:tracePt t="26641" x="9921875" y="4127500"/>
          <p14:tracePt t="26662" x="9913938" y="4117975"/>
          <p14:tracePt t="26671" x="9909175" y="4105275"/>
          <p14:tracePt t="26684" x="9899650" y="4095750"/>
          <p14:tracePt t="27767" x="9899650" y="4086225"/>
          <p14:tracePt t="27847" x="9904413" y="4086225"/>
          <p14:tracePt t="27858" x="9909175" y="4086225"/>
          <p14:tracePt t="27867" x="9926638" y="4086225"/>
          <p14:tracePt t="27878" x="9945688" y="4105275"/>
          <p14:tracePt t="27887" x="9955213" y="4110038"/>
          <p14:tracePt t="27899" x="9967913" y="4110038"/>
          <p14:tracePt t="27903" x="9977438" y="4110038"/>
          <p14:tracePt t="27915" x="10013950" y="4117975"/>
          <p14:tracePt t="27923" x="10023475" y="4117975"/>
          <p14:tracePt t="27929" x="10040938" y="4117975"/>
          <p14:tracePt t="27937" x="10067925" y="4141788"/>
          <p14:tracePt t="27942" x="10077450" y="4141788"/>
          <p14:tracePt t="27953" x="10104438" y="4141788"/>
          <p14:tracePt t="27963" x="10174288" y="4141788"/>
          <p14:tracePt t="27969" x="10191750" y="4149725"/>
          <p14:tracePt t="27980" x="10233025" y="4159250"/>
          <p14:tracePt t="27983" x="10242550" y="4159250"/>
          <p14:tracePt t="27993" x="10269538" y="4159250"/>
          <p14:tracePt t="28003" x="10288588" y="4159250"/>
          <p14:tracePt t="28008" x="10291763" y="4168775"/>
          <p14:tracePt t="28135" x="10320338" y="4168775"/>
          <p14:tracePt t="28150" x="10328275" y="4168775"/>
          <p14:tracePt t="28160" x="10333038" y="4168775"/>
          <p14:tracePt t="28169" x="10342563" y="4168775"/>
          <p14:tracePt t="28215" x="10352088" y="4168775"/>
          <p14:tracePt t="28225" x="10361613" y="4168775"/>
          <p14:tracePt t="28235" x="10364788" y="4168775"/>
          <p14:tracePt t="28241" x="10374313" y="4186238"/>
          <p14:tracePt t="28255" x="10406063" y="4195763"/>
          <p14:tracePt t="28276" x="10410825" y="4195763"/>
          <p14:tracePt t="28281" x="10420350" y="4195763"/>
          <p14:tracePt t="28295" x="10429875" y="4195763"/>
          <p14:tracePt t="28301" x="10437813" y="4195763"/>
          <p14:tracePt t="28309" x="10442575" y="4195763"/>
          <p14:tracePt t="28317" x="10471150" y="4195763"/>
          <p14:tracePt t="28328" x="10479088" y="4195763"/>
          <p14:tracePt t="28337" x="10493375" y="4195763"/>
          <p14:tracePt t="28342" x="10502900" y="4195763"/>
          <p14:tracePt t="28358" x="10520363" y="4195763"/>
          <p14:tracePt t="28361" x="10525125" y="4195763"/>
          <p14:tracePt t="28371" x="10534650" y="4195763"/>
          <p14:tracePt t="28381" x="10552113" y="4195763"/>
          <p14:tracePt t="28398" x="10571163" y="4195763"/>
          <p14:tracePt t="28401" x="10575925" y="4195763"/>
          <p14:tracePt t="28417" x="10585450" y="4195763"/>
          <p14:tracePt t="28423" x="10602913" y="4195763"/>
          <p14:tracePt t="28433" x="10607675" y="4195763"/>
          <p14:tracePt t="28448" x="10617200" y="4195763"/>
          <p14:tracePt t="28458" x="10625138" y="4195763"/>
          <p14:tracePt t="43140" x="10629900" y="4195763"/>
          <p14:tracePt t="43142" x="10707688" y="4926013"/>
          <p14:tracePt t="43313" x="10753725" y="5095875"/>
          <p14:tracePt t="43501" x="10753725" y="5091113"/>
          <p14:tracePt t="43531" x="10753725" y="5072063"/>
          <p14:tracePt t="43547" x="10753725" y="5045075"/>
          <p14:tracePt t="43557" x="10753725" y="5035550"/>
          <p14:tracePt t="43567" x="10753725" y="5032375"/>
          <p14:tracePt t="43587" x="10753725" y="5022850"/>
          <p14:tracePt t="43598" x="10753725" y="5013325"/>
          <p14:tracePt t="43607" x="10748963" y="5003800"/>
          <p14:tracePt t="43623" x="10748963" y="4999038"/>
          <p14:tracePt t="43628" x="10748963" y="4991100"/>
          <p14:tracePt t="43647" x="10739438" y="4962525"/>
          <p14:tracePt t="43678" x="10739438" y="4954588"/>
          <p14:tracePt t="43690" x="10731500" y="4949825"/>
          <p14:tracePt t="43694" x="10726738" y="4940300"/>
          <p14:tracePt t="43703" x="10717213" y="4930775"/>
          <p14:tracePt t="43713" x="10707688" y="4926013"/>
          <p14:tracePt t="43725" x="10702925" y="4918075"/>
          <p14:tracePt t="43741" x="10694988" y="4899025"/>
          <p14:tracePt t="43749" x="10685463" y="4889500"/>
          <p14:tracePt t="43764" x="10666413" y="4884738"/>
          <p14:tracePt t="43768" x="10639425" y="4862513"/>
          <p14:tracePt t="43780" x="10629900" y="4862513"/>
          <p14:tracePt t="43783" x="10612438" y="4862513"/>
          <p14:tracePt t="43789" x="10607675" y="4852988"/>
          <p14:tracePt t="43799" x="10580688" y="4845050"/>
          <p14:tracePt t="43810" x="10561638" y="4835525"/>
          <p14:tracePt t="43815" x="10552113" y="4835525"/>
          <p14:tracePt t="43826" x="10534650" y="4835525"/>
          <p14:tracePt t="43899" x="10515600" y="4835525"/>
          <p14:tracePt t="43991" x="10502900" y="4835525"/>
          <p14:tracePt t="44081" x="10493375" y="4835525"/>
          <p14:tracePt t="44098" x="10483850" y="4835525"/>
          <p14:tracePt t="44112" x="10474325" y="4835525"/>
          <p14:tracePt t="44121" x="10471150" y="4835525"/>
          <p14:tracePt t="44141" x="10461625" y="4835525"/>
          <p14:tracePt t="44148" x="10452100" y="4835525"/>
          <p14:tracePt t="44164" x="10447338" y="4835525"/>
          <p14:tracePt t="44409" x="10437813" y="4835525"/>
          <p14:tracePt t="44440" x="10420350" y="4821238"/>
          <p14:tracePt t="44449" x="10410825" y="4821238"/>
          <p14:tracePt t="44455" x="10406063" y="4811713"/>
          <p14:tracePt t="44477" x="10379075" y="4811713"/>
          <p14:tracePt t="44485" x="10361613" y="4803775"/>
          <p14:tracePt t="44526" x="10352088" y="4803775"/>
          <p14:tracePt t="44535" x="10342563" y="4794250"/>
          <p14:tracePt t="44943" x="10347325" y="4799013"/>
          <p14:tracePt t="44979" x="10356850" y="4816475"/>
          <p14:tracePt t="45192" x="10374313" y="4826000"/>
          <p14:tracePt t="49331" x="10383838" y="4826000"/>
          <p14:tracePt t="49639" x="10379075" y="4830763"/>
          <p14:tracePt t="49655" x="10369550" y="4840288"/>
          <p14:tracePt t="49660" x="10364788" y="4848225"/>
          <p14:tracePt t="49680" x="10356850" y="4852988"/>
          <p14:tracePt t="49696" x="10347325" y="4862513"/>
          <p14:tracePt t="49821" x="10342563" y="4872038"/>
          <p14:tracePt t="52697" x="10315575" y="4872038"/>
          <p14:tracePt t="52766" x="10296525" y="4872038"/>
          <p14:tracePt t="52770" x="10288588" y="4889500"/>
          <p14:tracePt t="52780" x="10288588" y="4899025"/>
          <p14:tracePt t="52807" x="10288588" y="4903788"/>
          <p14:tracePt t="52813" x="10288588" y="4913313"/>
          <p14:tracePt t="53427" x="10288588" y="4922838"/>
          <p14:tracePt t="53453" x="10291763" y="4922838"/>
          <p14:tracePt t="53503" x="10296525" y="4922838"/>
          <p14:tracePt t="53533" x="10306050" y="4922838"/>
          <p14:tracePt t="53558" x="10315575" y="4922838"/>
          <p14:tracePt t="53573" x="10342563" y="4918075"/>
          <p14:tracePt t="53593" x="10347325" y="4908550"/>
          <p14:tracePt t="53675" x="10356850" y="4889500"/>
          <p14:tracePt t="53685" x="10388600" y="4872038"/>
          <p14:tracePt t="53695" x="10388600" y="4862513"/>
          <p14:tracePt t="53699" x="10398125" y="4852988"/>
          <p14:tracePt t="53710" x="10401300" y="4848225"/>
          <p14:tracePt t="53715" x="10410825" y="4811713"/>
          <p14:tracePt t="53727" x="10410825" y="4803775"/>
          <p14:tracePt t="53731" x="10420350" y="4794250"/>
          <p14:tracePt t="53741" x="10437813" y="4757738"/>
          <p14:tracePt t="53745" x="10437813" y="4748213"/>
          <p14:tracePt t="53755" x="10437813" y="4711700"/>
          <p14:tracePt t="53764" x="10437813" y="4699000"/>
          <p14:tracePt t="53770" x="10437813" y="4689475"/>
          <p14:tracePt t="53780" x="10437813" y="4652963"/>
          <p14:tracePt t="53784" x="10437813" y="4643438"/>
          <p14:tracePt t="53795" x="10437813" y="4629150"/>
          <p14:tracePt t="53811" x="10437813" y="4611688"/>
          <p14:tracePt t="53906" x="10434638" y="4592638"/>
          <p14:tracePt t="53916" x="10410825" y="4548188"/>
          <p14:tracePt t="53930" x="10410825" y="4538663"/>
          <p14:tracePt t="53941" x="10374313" y="4502150"/>
          <p14:tracePt t="53950" x="10352088" y="4479925"/>
          <p14:tracePt t="53957" x="10347325" y="4475163"/>
          <p14:tracePt t="53967" x="10337800" y="4465638"/>
          <p14:tracePt t="53972" x="10328275" y="4456113"/>
          <p14:tracePt t="53998" x="10320338" y="4446588"/>
          <p14:tracePt t="54006" x="10315575" y="4443413"/>
          <p14:tracePt t="54109" x="10306050" y="4433888"/>
          <p14:tracePt t="54119" x="10296525" y="4433888"/>
          <p14:tracePt t="54130" x="10291763" y="4438650"/>
          <p14:tracePt t="54139" x="10283825" y="4443413"/>
          <p14:tracePt t="54145" x="10274300" y="4443413"/>
          <p14:tracePt t="54149" x="10264775" y="4451350"/>
          <p14:tracePt t="54159" x="10252075" y="4460875"/>
          <p14:tracePt t="54169" x="10228263" y="4479925"/>
          <p14:tracePt t="54174" x="10210800" y="4487863"/>
          <p14:tracePt t="54183" x="10191750" y="4497388"/>
          <p14:tracePt t="54199" x="10174288" y="4519613"/>
          <p14:tracePt t="54219" x="10164763" y="4524375"/>
          <p14:tracePt t="54239" x="10155238" y="4543425"/>
          <p14:tracePt t="54265" x="10145713" y="4560888"/>
          <p14:tracePt t="54417" x="10145713" y="4579938"/>
          <p14:tracePt t="54438" x="10140950" y="4589463"/>
          <p14:tracePt t="54589" x="10140950" y="4592638"/>
          <p14:tracePt t="54604" x="10140950" y="4611688"/>
          <p14:tracePt t="54720" x="10140950" y="4621213"/>
          <p14:tracePt t="54733" x="10140950" y="4633913"/>
          <p14:tracePt t="54739" x="10140950" y="4643438"/>
          <p14:tracePt t="54759" x="10140950" y="4652963"/>
          <p14:tracePt t="54770" x="10140950" y="4665663"/>
          <p14:tracePt t="54785" x="10140950" y="4675188"/>
          <p14:tracePt t="54790" x="10140950" y="4684713"/>
          <p14:tracePt t="54795" x="10140950" y="4694238"/>
          <p14:tracePt t="54805" x="10140950" y="4706938"/>
          <p14:tracePt t="54815" x="10140950" y="4725988"/>
          <p14:tracePt t="54826" x="10140950" y="4752975"/>
          <p14:tracePt t="54835" x="10140950" y="4762500"/>
          <p14:tracePt t="54846" x="10140950" y="4821238"/>
          <p14:tracePt t="54856" x="10160000" y="4867275"/>
          <p14:tracePt t="54859" x="10160000" y="4899025"/>
          <p14:tracePt t="54869" x="10182225" y="4972050"/>
          <p14:tracePt t="54876" x="10201275" y="4999038"/>
          <p14:tracePt t="54885" x="10228263" y="5072063"/>
          <p14:tracePt t="54895" x="10260013" y="5118100"/>
          <p14:tracePt t="54901" x="10269538" y="5127625"/>
          <p14:tracePt t="55167" x="10552113" y="5132388"/>
          <p14:tracePt t="55177" x="10552113" y="5113338"/>
          <p14:tracePt t="55183" x="10547350" y="5105400"/>
          <p14:tracePt t="55194" x="10539413" y="5086350"/>
          <p14:tracePt t="55199" x="10534650" y="5081588"/>
          <p14:tracePt t="55209" x="10525125" y="5072063"/>
          <p14:tracePt t="55217" x="10515600" y="5064125"/>
          <p14:tracePt t="55233" x="10510838" y="5059363"/>
          <p14:tracePt t="55249" x="10502900" y="5040313"/>
          <p14:tracePt t="55260" x="10493375" y="5032375"/>
          <p14:tracePt t="55264" x="10493375" y="5013325"/>
          <p14:tracePt t="55274" x="10474325" y="4995863"/>
          <p14:tracePt t="55280" x="10474325" y="4991100"/>
          <p14:tracePt t="55290" x="10474325" y="4962525"/>
          <p14:tracePt t="55299" x="10474325" y="4954588"/>
          <p14:tracePt t="55303" x="10474325" y="4926013"/>
          <p14:tracePt t="55313" x="10474325" y="4922838"/>
          <p14:tracePt t="55319" x="10474325" y="4903788"/>
          <p14:tracePt t="55329" x="10474325" y="4884738"/>
          <p14:tracePt t="55341" x="10474325" y="4876800"/>
          <p14:tracePt t="55356" x="10466388" y="4852988"/>
          <p14:tracePt t="55369" x="10466388" y="4845050"/>
          <p14:tracePt t="55471" x="10447338" y="4835525"/>
          <p14:tracePt t="55492" x="10437813" y="4835525"/>
          <p14:tracePt t="55511" x="10434638" y="4826000"/>
          <p14:tracePt t="55515" x="10425113" y="4826000"/>
          <p14:tracePt t="55601" x="10415588" y="4826000"/>
          <p14:tracePt t="55611" x="10410825" y="4826000"/>
          <p14:tracePt t="55870" x="10393363" y="4826000"/>
          <p14:tracePt t="55989" x="10383838" y="4826000"/>
          <p14:tracePt t="56025" x="10364788" y="4816475"/>
          <p14:tracePt t="56364" x="10361613" y="4816475"/>
          <p14:tracePt t="56575" x="10342563" y="4816475"/>
          <p14:tracePt t="56822" x="10333038" y="4816475"/>
          <p14:tracePt t="58219" x="10310813" y="4821238"/>
          <p14:tracePt t="62104" x="10320338" y="4821238"/>
          <p14:tracePt t="62107" x="10352088" y="4835525"/>
          <p14:tracePt t="62113" x="10369550" y="4835525"/>
          <p14:tracePt t="62124" x="10410825" y="4845050"/>
          <p14:tracePt t="62133" x="10429875" y="4845050"/>
          <p14:tracePt t="62137" x="10447338" y="4845050"/>
          <p14:tracePt t="62149" x="10488613" y="4845050"/>
          <p14:tracePt t="62153" x="10507663" y="4862513"/>
          <p14:tracePt t="62164" x="10561638" y="4862513"/>
          <p14:tracePt t="62174" x="10571163" y="4862513"/>
          <p14:tracePt t="62406" x="10585450" y="4862513"/>
          <p14:tracePt t="62426" x="10593388" y="4862513"/>
          <p14:tracePt t="62442" x="10602913" y="4862513"/>
          <p14:tracePt t="64731" x="10607675" y="4862513"/>
          <p14:tracePt t="64746" x="10552113" y="4857750"/>
          <p14:tracePt t="64751" x="10520363" y="4857750"/>
          <p14:tracePt t="64762" x="10437813" y="4845050"/>
          <p14:tracePt t="64771" x="10361613" y="4845050"/>
          <p14:tracePt t="64923" x="10347325" y="4845050"/>
          <p14:tracePt t="64927" x="10337800" y="4845050"/>
          <p14:tracePt t="65302" x="10337800" y="4835525"/>
          <p14:tracePt t="65311" x="10342563" y="4830763"/>
          <p14:tracePt t="65326" x="10342563" y="4821238"/>
          <p14:tracePt t="65335" x="10342563" y="4811713"/>
          <p14:tracePt t="65381" x="10342563" y="4808538"/>
          <p14:tracePt t="65452" x="10342563" y="4789488"/>
          <p14:tracePt t="65461" x="10342563" y="4779963"/>
          <p14:tracePt t="65513" x="10342563" y="4767263"/>
          <p14:tracePt t="66435" x="10342563" y="4757738"/>
          <p14:tracePt t="66462" x="10342563" y="4762500"/>
          <p14:tracePt t="71591" x="10347325" y="4767263"/>
          <p14:tracePt t="71596" x="10347325" y="4794250"/>
          <p14:tracePt t="71622" x="10347325" y="4803775"/>
          <p14:tracePt t="71632" x="10347325" y="4811713"/>
          <p14:tracePt t="71802" x="10347325" y="4789488"/>
          <p14:tracePt t="71807" x="10347325" y="4772025"/>
          <p14:tracePt t="71818" x="10347325" y="4730750"/>
          <p14:tracePt t="71829" x="10347325" y="4648200"/>
          <p14:tracePt t="71833" x="10347325" y="4629150"/>
          <p14:tracePt t="71845" x="10352088" y="4556125"/>
          <p14:tracePt t="71848" x="10352088" y="4548188"/>
          <p14:tracePt t="71856" x="10361613" y="4533900"/>
          <p14:tracePt t="71868" x="10361613" y="4479925"/>
          <p14:tracePt t="71874" x="10369550" y="4460875"/>
          <p14:tracePt t="71884" x="10369550" y="4443413"/>
          <p14:tracePt t="71895" x="10369550" y="4433888"/>
          <p14:tracePt t="71898" x="10369550" y="4405313"/>
          <p14:tracePt t="71907" x="10369550" y="4378325"/>
          <p14:tracePt t="71913" x="10369550" y="4360863"/>
          <p14:tracePt t="71924" x="10369550" y="4332288"/>
          <p14:tracePt t="71927" x="10369550" y="4324350"/>
          <p14:tracePt t="71936" x="10369550" y="4314825"/>
          <p14:tracePt t="71967" x="10369550" y="4310063"/>
          <p14:tracePt t="71982" x="10369550" y="4300538"/>
          <p14:tracePt t="71990" x="10369550" y="4292600"/>
          <p14:tracePt t="72216" x="10369550" y="4295775"/>
          <p14:tracePt t="72225" x="10364788" y="4305300"/>
          <p14:tracePt t="72227" x="10361613" y="4310063"/>
          <p14:tracePt t="72237" x="10361613" y="4329113"/>
          <p14:tracePt t="72246" x="10347325" y="4360863"/>
          <p14:tracePt t="72252" x="10342563" y="4365625"/>
          <p14:tracePt t="72263" x="10342563" y="4383088"/>
          <p14:tracePt t="72267" x="10333038" y="4392613"/>
          <p14:tracePt t="72279" x="10325100" y="4414838"/>
          <p14:tracePt t="72285" x="10315575" y="4446588"/>
          <p14:tracePt t="72291" x="10306050" y="4456113"/>
          <p14:tracePt t="72300" x="10264775" y="4506913"/>
          <p14:tracePt t="72307" x="10255250" y="4516438"/>
          <p14:tracePt t="72316" x="10247313" y="4533900"/>
          <p14:tracePt t="72327" x="10201275" y="4592638"/>
          <p14:tracePt t="72336" x="10191750" y="4621213"/>
          <p14:tracePt t="72340" x="10169525" y="4643438"/>
          <p14:tracePt t="72346" x="10150475" y="4684713"/>
          <p14:tracePt t="72357" x="10140950" y="4694238"/>
          <p14:tracePt t="72368" x="10101263" y="4743450"/>
          <p14:tracePt t="72373" x="10091738" y="4752975"/>
          <p14:tracePt t="72383" x="10072688" y="4789488"/>
          <p14:tracePt t="72392" x="10072688" y="4799013"/>
          <p14:tracePt t="72399" x="10064750" y="4808538"/>
          <p14:tracePt t="72408" x="10055225" y="4826000"/>
          <p14:tracePt t="72415" x="10050463" y="4830763"/>
          <p14:tracePt t="72425" x="10050463" y="4848225"/>
          <p14:tracePt t="72429" x="10050463" y="4857750"/>
          <p14:tracePt t="72438" x="10050463" y="4862513"/>
          <p14:tracePt t="72447" x="10040938" y="4872038"/>
          <p14:tracePt t="72458" x="10040938" y="4881563"/>
          <p14:tracePt t="72462" x="10031413" y="4889500"/>
          <p14:tracePt t="72488" x="10023475" y="4894263"/>
          <p14:tracePt t="72541" x="10018713" y="4903788"/>
          <p14:tracePt t="72646" x="10018713" y="4889500"/>
          <p14:tracePt t="72652" x="10018713" y="4884738"/>
          <p14:tracePt t="72657" x="10018713" y="4867275"/>
          <p14:tracePt t="72665" x="10045700" y="4779963"/>
          <p14:tracePt t="72670" x="10045700" y="4725988"/>
          <p14:tracePt t="72680" x="10045700" y="4665663"/>
          <p14:tracePt t="72690" x="10059988" y="4556125"/>
          <p14:tracePt t="72695" x="10059988" y="4538663"/>
          <p14:tracePt t="72706" x="10072688" y="4451350"/>
          <p14:tracePt t="72710" x="10072688" y="4446588"/>
          <p14:tracePt t="72718" x="10082213" y="4405313"/>
          <p14:tracePt t="72729" x="10082213" y="4351338"/>
          <p14:tracePt t="72738" x="10082213" y="4341813"/>
          <p14:tracePt t="72745" x="10082213" y="4319588"/>
          <p14:tracePt t="72762" x="10082213" y="4310063"/>
          <p14:tracePt t="72978" x="10091738" y="4324350"/>
          <p14:tracePt t="72983" x="10091738" y="4329113"/>
          <p14:tracePt t="72990" x="10091738" y="4346575"/>
          <p14:tracePt t="72995" x="10096500" y="4356100"/>
          <p14:tracePt t="73004" x="10123488" y="4373563"/>
          <p14:tracePt t="73014" x="10145713" y="4429125"/>
          <p14:tracePt t="73018" x="10155238" y="4438650"/>
          <p14:tracePt t="73029" x="10233025" y="4529138"/>
          <p14:tracePt t="73035" x="10242550" y="4538663"/>
          <p14:tracePt t="73045" x="10260013" y="4565650"/>
          <p14:tracePt t="73054" x="10306050" y="4611688"/>
          <p14:tracePt t="73057" x="10315575" y="4616450"/>
          <p14:tracePt t="73068" x="10342563" y="4643438"/>
          <p14:tracePt t="73072" x="10352088" y="4652963"/>
          <p14:tracePt t="73082" x="10356850" y="4662488"/>
          <p14:tracePt t="73093" x="10374313" y="4679950"/>
          <p14:tracePt t="73096" x="10383838" y="4684713"/>
          <p14:tracePt t="73109" x="10393363" y="4694238"/>
          <p14:tracePt t="73112" x="10398125" y="4694238"/>
          <p14:tracePt t="73123" x="10406063" y="4694238"/>
          <p14:tracePt t="73132" x="10425113" y="4702175"/>
          <p14:tracePt t="73139" x="10442575" y="4702175"/>
          <p14:tracePt t="73181" x="10447338" y="4711700"/>
          <p14:tracePt t="73190" x="10466388" y="4721225"/>
          <p14:tracePt t="73200" x="10474325" y="4721225"/>
          <p14:tracePt t="73215" x="10488613" y="4725988"/>
          <p14:tracePt t="73226" x="10498138" y="4735513"/>
          <p14:tracePt t="73231" x="10507663" y="4752975"/>
          <p14:tracePt t="75141" x="10510838" y="4752975"/>
          <p14:tracePt t="75151" x="10552113" y="4779963"/>
          <p14:tracePt t="75161" x="10625138" y="4779963"/>
          <p14:tracePt t="75164" x="10753725" y="4779963"/>
          <p14:tracePt t="75175" x="10880725" y="4779963"/>
          <p14:tracePt t="75187" x="11064875" y="4779963"/>
          <p14:tracePt t="75192" x="11118850" y="4779963"/>
          <p14:tracePt t="75201" x="11247438" y="4779963"/>
          <p14:tracePt t="75208" x="11415713" y="4738688"/>
          <p14:tracePt t="75217" x="11583988" y="4679950"/>
          <p14:tracePt t="75229" x="11863388" y="4548188"/>
          <p14:tracePt t="75231" x="11945938" y="4492625"/>
        </p14:tracePtLst>
      </p14:laserTraceLst>
    </p:ext>
  </p:extLst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0C09A00-D63C-4A7E-B994-9958346EBF34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Per Locus LR after EFM rerun</a:t>
            </a:r>
            <a:endParaRPr lang="en-US" sz="2800" dirty="0"/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37FFACD-44FB-48DB-933D-4F011794C158}"/>
              </a:ext>
            </a:extLst>
          </p:cNvPr>
          <p:cNvGraphicFramePr>
            <a:graphicFrameLocks noGrp="1"/>
          </p:cNvGraphicFramePr>
          <p:nvPr/>
        </p:nvGraphicFramePr>
        <p:xfrm>
          <a:off x="2961053" y="947412"/>
          <a:ext cx="6307991" cy="551560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80774">
                  <a:extLst>
                    <a:ext uri="{9D8B030D-6E8A-4147-A177-3AD203B41FA5}">
                      <a16:colId xmlns:a16="http://schemas.microsoft.com/office/drawing/2014/main" val="2599398815"/>
                    </a:ext>
                  </a:extLst>
                </a:gridCol>
                <a:gridCol w="1496601">
                  <a:extLst>
                    <a:ext uri="{9D8B030D-6E8A-4147-A177-3AD203B41FA5}">
                      <a16:colId xmlns:a16="http://schemas.microsoft.com/office/drawing/2014/main" val="3988832070"/>
                    </a:ext>
                  </a:extLst>
                </a:gridCol>
                <a:gridCol w="1436738">
                  <a:extLst>
                    <a:ext uri="{9D8B030D-6E8A-4147-A177-3AD203B41FA5}">
                      <a16:colId xmlns:a16="http://schemas.microsoft.com/office/drawing/2014/main" val="3436099630"/>
                    </a:ext>
                  </a:extLst>
                </a:gridCol>
                <a:gridCol w="1593878">
                  <a:extLst>
                    <a:ext uri="{9D8B030D-6E8A-4147-A177-3AD203B41FA5}">
                      <a16:colId xmlns:a16="http://schemas.microsoft.com/office/drawing/2014/main" val="668207001"/>
                    </a:ext>
                  </a:extLst>
                </a:gridCol>
              </a:tblGrid>
              <a:tr h="454182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us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v2.1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v2.1 rerun 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2247367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3S135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4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1541662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W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9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2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7828497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6S53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9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9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6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6474874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F1PO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5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4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4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730166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OX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4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8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5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1076819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8S117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3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8876910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1S1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2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4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7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2228777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8S5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1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9903633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S44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5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5736588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9S4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8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1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6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9166804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0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8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9103094"/>
                  </a:ext>
                </a:extLst>
              </a:tr>
              <a:tr h="28054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G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5.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3.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0.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79535"/>
                  </a:ext>
                </a:extLst>
              </a:tr>
              <a:tr h="291662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2S1045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70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139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22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1535141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5S81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2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.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.5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715183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3S31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0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8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1207788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7S82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5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4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114243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.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.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.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0297060"/>
                  </a:ext>
                </a:extLst>
              </a:tr>
              <a:tr h="23761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0S124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5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7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4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2205309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S165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.1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1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.7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4366475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2S39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7.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5.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2.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9451290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S133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9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7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847171"/>
                  </a:ext>
                </a:extLst>
              </a:tr>
            </a:tbl>
          </a:graphicData>
        </a:graphic>
      </p:graphicFrame>
      <p:sp>
        <p:nvSpPr>
          <p:cNvPr id="5" name="Arrow: Right 4">
            <a:extLst>
              <a:ext uri="{FF2B5EF4-FFF2-40B4-BE49-F238E27FC236}">
                <a16:creationId xmlns:a16="http://schemas.microsoft.com/office/drawing/2014/main" id="{5959998B-B83A-4875-9CD5-384FEC92A9A7}"/>
              </a:ext>
            </a:extLst>
          </p:cNvPr>
          <p:cNvSpPr/>
          <p:nvPr/>
        </p:nvSpPr>
        <p:spPr>
          <a:xfrm rot="2759521">
            <a:off x="4883798" y="3771564"/>
            <a:ext cx="614760" cy="513357"/>
          </a:xfrm>
          <a:prstGeom prst="rightArrow">
            <a:avLst/>
          </a:prstGeom>
          <a:solidFill>
            <a:srgbClr val="CCCCFF">
              <a:alpha val="74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EF3AF134-E8CD-4E9C-946F-7A2FB5CA6B7E}"/>
              </a:ext>
            </a:extLst>
          </p:cNvPr>
          <p:cNvSpPr/>
          <p:nvPr/>
        </p:nvSpPr>
        <p:spPr>
          <a:xfrm rot="8070277">
            <a:off x="8355637" y="3781514"/>
            <a:ext cx="614760" cy="513357"/>
          </a:xfrm>
          <a:prstGeom prst="rightArrow">
            <a:avLst/>
          </a:prstGeom>
          <a:solidFill>
            <a:srgbClr val="CCCCFF">
              <a:alpha val="74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12080FA-2C70-4E60-9A40-7E1C99079CA9}"/>
              </a:ext>
            </a:extLst>
          </p:cNvPr>
          <p:cNvSpPr/>
          <p:nvPr/>
        </p:nvSpPr>
        <p:spPr>
          <a:xfrm>
            <a:off x="4067182" y="3335881"/>
            <a:ext cx="1105748" cy="369332"/>
          </a:xfrm>
          <a:prstGeom prst="rect">
            <a:avLst/>
          </a:prstGeom>
          <a:solidFill>
            <a:srgbClr val="66FFFF"/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CB6FA5C1-F398-471F-B7CE-1D12A7CFB3F7}"/>
              </a:ext>
            </a:extLst>
          </p:cNvPr>
          <p:cNvSpPr/>
          <p:nvPr/>
        </p:nvSpPr>
        <p:spPr>
          <a:xfrm>
            <a:off x="2957929" y="4313758"/>
            <a:ext cx="6276142" cy="287798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7CEE8A3-2E14-4D0B-8C63-34AA31E412AA}"/>
              </a:ext>
            </a:extLst>
          </p:cNvPr>
          <p:cNvSpPr/>
          <p:nvPr/>
        </p:nvSpPr>
        <p:spPr>
          <a:xfrm>
            <a:off x="8547742" y="3335881"/>
            <a:ext cx="1105748" cy="369332"/>
          </a:xfrm>
          <a:prstGeom prst="rect">
            <a:avLst/>
          </a:prstGeom>
          <a:solidFill>
            <a:srgbClr val="66FFFF"/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85706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80443"/>
    </mc:Choice>
    <mc:Fallback xmlns="">
      <p:transition spd="slow" advTm="80443"/>
    </mc:Fallback>
  </mc:AlternateContent>
  <p:extLst>
    <p:ext uri="{3A86A75C-4F4B-4683-9AE1-C65F6400EC91}">
      <p14:laserTraceLst xmlns:p14="http://schemas.microsoft.com/office/powerpoint/2010/main">
        <p14:tracePtLst>
          <p14:tracePt t="944" x="9653588" y="2565400"/>
          <p14:tracePt t="952" x="9612313" y="2552700"/>
          <p14:tracePt t="962" x="9539288" y="2552700"/>
          <p14:tracePt t="973" x="9529763" y="2552700"/>
          <p14:tracePt t="1018" x="9502775" y="2552700"/>
          <p14:tracePt t="1024" x="9498013" y="2557463"/>
          <p14:tracePt t="1033" x="9488488" y="2557463"/>
          <p14:tracePt t="1059" x="9478963" y="2557463"/>
          <p14:tracePt t="1080" x="9471025" y="2565400"/>
          <p14:tracePt t="1089" x="9466263" y="2565400"/>
          <p14:tracePt t="1166" x="9456738" y="2565400"/>
          <p14:tracePt t="1212" x="9447213" y="2565400"/>
          <p14:tracePt t="1246" x="9434513" y="2562225"/>
          <p14:tracePt t="1256" x="9424988" y="2552700"/>
          <p14:tracePt t="1266" x="9415463" y="2543175"/>
          <p14:tracePt t="1278" x="9405938" y="2538413"/>
          <p14:tracePt t="1291" x="9402763" y="2528888"/>
          <p14:tracePt t="1319" x="9402763" y="2520950"/>
          <p14:tracePt t="1338" x="9402763" y="2516188"/>
          <p14:tracePt t="1350" x="9402763" y="2489200"/>
          <p14:tracePt t="1358" x="9402763" y="2479675"/>
          <p14:tracePt t="1368" x="9402763" y="2470150"/>
          <p14:tracePt t="1371" x="9402763" y="2455863"/>
          <p14:tracePt t="1381" x="9402763" y="2447925"/>
          <p14:tracePt t="1386" x="9402763" y="2411413"/>
          <p14:tracePt t="1397" x="9415463" y="2392363"/>
          <p14:tracePt t="1409" x="9447213" y="2346325"/>
          <p14:tracePt t="1413" x="9456738" y="2338388"/>
          <p14:tracePt t="1425" x="9488488" y="2301875"/>
          <p14:tracePt t="1427" x="9507538" y="2268538"/>
          <p14:tracePt t="1438" x="9515475" y="2251075"/>
          <p14:tracePt t="1449" x="9534525" y="2232025"/>
          <p14:tracePt t="1455" x="9566275" y="2232025"/>
          <p14:tracePt t="1466" x="9571038" y="2224088"/>
          <p14:tracePt t="1469" x="9580563" y="2214563"/>
          <p14:tracePt t="1485" x="9588500" y="2205038"/>
          <p14:tracePt t="1488" x="9607550" y="2200275"/>
          <p14:tracePt t="1505" x="9612313" y="2192338"/>
          <p14:tracePt t="1510" x="9639300" y="2182813"/>
          <p14:tracePt t="1519" x="9661525" y="2151063"/>
          <p14:tracePt t="1529" x="9690100" y="2141538"/>
          <p14:tracePt t="1532" x="9690100" y="2132013"/>
          <p14:tracePt t="1543" x="9690100" y="2127250"/>
          <p14:tracePt t="1550" x="9690100" y="2119313"/>
          <p14:tracePt t="1564" x="9690100" y="2090738"/>
          <p14:tracePt t="1571" x="9690100" y="2063750"/>
          <p14:tracePt t="1581" x="9690100" y="2046288"/>
          <p14:tracePt t="1583" x="9690100" y="2036763"/>
          <p14:tracePt t="1589" x="9690100" y="2022475"/>
          <p14:tracePt t="1599" x="9690100" y="1990725"/>
          <p14:tracePt t="1610" x="9675813" y="1958975"/>
          <p14:tracePt t="1614" x="9675813" y="1954213"/>
          <p14:tracePt t="1626" x="9666288" y="1944688"/>
          <p14:tracePt t="1629" x="9658350" y="1908175"/>
          <p14:tracePt t="1641" x="9639300" y="1890713"/>
          <p14:tracePt t="1651" x="9588500" y="1798638"/>
          <p14:tracePt t="1656" x="9566275" y="1781175"/>
          <p14:tracePt t="1667" x="9534525" y="1720850"/>
          <p14:tracePt t="1671" x="9478963" y="1657350"/>
          <p14:tracePt t="1688" x="9456738" y="1611313"/>
          <p14:tracePt t="1691" x="9402763" y="1511300"/>
          <p14:tracePt t="1696" x="9393238" y="1501775"/>
          <p14:tracePt t="1706" x="9374188" y="1465263"/>
          <p14:tracePt t="1712" x="9351963" y="1419225"/>
          <p14:tracePt t="1719" x="9342438" y="1411288"/>
          <p14:tracePt t="1730" x="9315450" y="1374775"/>
          <p14:tracePt t="1863" x="9315450" y="1365250"/>
          <p14:tracePt t="1871" x="9315450" y="1355725"/>
          <p14:tracePt t="1909" x="9315450" y="1350963"/>
          <p14:tracePt t="1933" x="9305925" y="1333500"/>
          <p14:tracePt t="1941" x="9305925" y="1323975"/>
          <p14:tracePt t="1952" x="9283700" y="1270000"/>
          <p14:tracePt t="1961" x="9283700" y="1236663"/>
          <p14:tracePt t="1975" x="9247188" y="1163638"/>
          <p14:tracePt t="1977" x="9247188" y="1160463"/>
          <p14:tracePt t="1986" x="9237663" y="1119188"/>
          <p14:tracePt t="1993" x="9218613" y="1090613"/>
          <p14:tracePt t="2003" x="9210675" y="1073150"/>
          <p14:tracePt t="2013" x="9174163" y="1014413"/>
          <p14:tracePt t="2026" x="9174163" y="1004888"/>
          <p14:tracePt t="2027" x="9164638" y="995363"/>
          <p14:tracePt t="2033" x="9159875" y="990600"/>
          <p14:tracePt t="2045" x="9159875" y="981075"/>
          <p14:tracePt t="2053" x="9142413" y="973138"/>
          <p14:tracePt t="2067" x="9118600" y="939800"/>
          <p14:tracePt t="2077" x="9113838" y="936625"/>
          <p14:tracePt t="2083" x="9105900" y="927100"/>
          <p14:tracePt t="2095" x="9069388" y="908050"/>
          <p14:tracePt t="2100" x="9059863" y="900113"/>
          <p14:tracePt t="2113" x="8999538" y="863600"/>
          <p14:tracePt t="2124" x="8959850" y="849313"/>
          <p14:tracePt t="2134" x="8899525" y="839788"/>
          <p14:tracePt t="2139" x="8872538" y="839788"/>
          <p14:tracePt t="2151" x="8848725" y="817563"/>
          <p14:tracePt t="2153" x="8780463" y="808038"/>
          <p14:tracePt t="2163" x="8763000" y="798513"/>
          <p14:tracePt t="2175" x="8716963" y="762000"/>
          <p14:tracePt t="2179" x="8685213" y="754063"/>
          <p14:tracePt t="2189" x="8666163" y="754063"/>
          <p14:tracePt t="2196" x="8639175" y="754063"/>
          <p14:tracePt t="2205" x="8585200" y="744538"/>
          <p14:tracePt t="2216" x="8566150" y="744538"/>
          <p14:tracePt t="2230" x="8539163" y="744538"/>
          <p14:tracePt t="2235" x="8534400" y="744538"/>
          <p14:tracePt t="2247" x="8515350" y="744538"/>
          <p14:tracePt t="2255" x="8488363" y="744538"/>
          <p14:tracePt t="2266" x="8478838" y="744538"/>
          <p14:tracePt t="2269" x="8461375" y="744538"/>
          <p14:tracePt t="2277" x="8456613" y="744538"/>
          <p14:tracePt t="2286" x="8429625" y="744538"/>
          <p14:tracePt t="2297" x="8374063" y="744538"/>
          <p14:tracePt t="2299" x="8356600" y="744538"/>
          <p14:tracePt t="2312" x="8329613" y="744538"/>
          <p14:tracePt t="2315" x="8274050" y="744538"/>
          <p14:tracePt t="2327" x="8228013" y="762000"/>
          <p14:tracePt t="2335" x="8150225" y="762000"/>
          <p14:tracePt t="2349" x="8123238" y="771525"/>
          <p14:tracePt t="2352" x="8050213" y="781050"/>
          <p14:tracePt t="2357" x="8008938" y="793750"/>
          <p14:tracePt t="2368" x="7954963" y="793750"/>
          <p14:tracePt t="2377" x="7858125" y="822325"/>
          <p14:tracePt t="2383" x="7826375" y="830263"/>
          <p14:tracePt t="2393" x="7785100" y="839788"/>
          <p14:tracePt t="2396" x="7767638" y="863600"/>
          <p14:tracePt t="2405" x="7707313" y="871538"/>
          <p14:tracePt t="2415" x="7666038" y="881063"/>
          <p14:tracePt t="2420" x="7658100" y="890588"/>
          <p14:tracePt t="2431" x="7643813" y="900113"/>
          <p14:tracePt t="2436" x="7621588" y="908050"/>
          <p14:tracePt t="2446" x="7616825" y="917575"/>
          <p14:tracePt t="2466" x="7589838" y="949325"/>
          <p14:tracePt t="2473" x="7580313" y="958850"/>
          <p14:tracePt t="2482" x="7553325" y="968375"/>
          <p14:tracePt t="2487" x="7543800" y="985838"/>
          <p14:tracePt t="2498" x="7524750" y="1031875"/>
          <p14:tracePt t="2512" x="7516813" y="1054100"/>
          <p14:tracePt t="2517" x="7507288" y="1090613"/>
          <p14:tracePt t="2529" x="7497763" y="1131888"/>
          <p14:tracePt t="2539" x="7497763" y="1173163"/>
          <p14:tracePt t="2549" x="7497763" y="1204913"/>
          <p14:tracePt t="2555" x="7497763" y="1233488"/>
          <p14:tracePt t="2564" x="7497763" y="1273175"/>
          <p14:tracePt t="2567" x="7497763" y="1328738"/>
          <p14:tracePt t="2577" x="7497763" y="1401763"/>
          <p14:tracePt t="2583" x="7497763" y="1419225"/>
          <p14:tracePt t="2594" x="7497763" y="1474788"/>
          <p14:tracePt t="2597" x="7497763" y="1533525"/>
          <p14:tracePt t="2610" x="7516813" y="1611313"/>
          <p14:tracePt t="2617" x="7516813" y="1703388"/>
          <p14:tracePt t="2627" x="7516813" y="1730375"/>
          <p14:tracePt t="2633" x="7529513" y="1789113"/>
          <p14:tracePt t="2637" x="7570788" y="1885950"/>
          <p14:tracePt t="2647" x="7570788" y="1917700"/>
          <p14:tracePt t="2661" x="7585075" y="2017713"/>
          <p14:tracePt t="2663" x="7585075" y="2046288"/>
          <p14:tracePt t="2677" x="7593013" y="2085975"/>
          <p14:tracePt t="2679" x="7602538" y="2119313"/>
          <p14:tracePt t="2689" x="7602538" y="2173288"/>
          <p14:tracePt t="2699" x="7602538" y="2214563"/>
          <p14:tracePt t="2704" x="7602538" y="2232025"/>
          <p14:tracePt t="2713" x="7612063" y="2260600"/>
          <p14:tracePt t="2720" x="7626350" y="2292350"/>
          <p14:tracePt t="2732" x="7626350" y="2333625"/>
          <p14:tracePt t="2741" x="7634288" y="2374900"/>
          <p14:tracePt t="2745" x="7634288" y="2382838"/>
          <p14:tracePt t="2754" x="7634288" y="2428875"/>
          <p14:tracePt t="2762" x="7634288" y="2447925"/>
          <p14:tracePt t="2772" x="7634288" y="2501900"/>
          <p14:tracePt t="2782" x="7658100" y="2562225"/>
          <p14:tracePt t="2785" x="7658100" y="2579688"/>
          <p14:tracePt t="2795" x="7670800" y="2638425"/>
          <p14:tracePt t="2798" x="7670800" y="2667000"/>
          <p14:tracePt t="2809" x="7680325" y="2740025"/>
          <p14:tracePt t="2820" x="7699375" y="2849563"/>
          <p14:tracePt t="2832" x="7699375" y="2857500"/>
          <p14:tracePt t="2836" x="7707313" y="2917825"/>
          <p14:tracePt t="2851" x="7716838" y="3036888"/>
          <p14:tracePt t="2861" x="7748588" y="3151188"/>
          <p14:tracePt t="2870" x="7748588" y="3163888"/>
          <p14:tracePt t="2876" x="7748588" y="3219450"/>
          <p14:tracePt t="2880" x="7785100" y="3282950"/>
          <p14:tracePt t="2892" x="7785100" y="3324225"/>
          <p14:tracePt t="2900" x="7799388" y="3409950"/>
          <p14:tracePt t="2904" x="7799388" y="3429000"/>
          <p14:tracePt t="2915" x="7799388" y="3484563"/>
          <p14:tracePt t="2921" x="7808913" y="3560763"/>
          <p14:tracePt t="2932" x="7808913" y="3602038"/>
          <p14:tracePt t="2945" x="7808913" y="3730625"/>
          <p14:tracePt t="2955" x="7808913" y="3813175"/>
          <p14:tracePt t="2962" x="7808913" y="3903663"/>
          <p14:tracePt t="2971" x="7808913" y="3963988"/>
          <p14:tracePt t="2982" x="7808913" y="4090988"/>
          <p14:tracePt t="2985" x="7808913" y="4117975"/>
          <p14:tracePt t="2996" x="7808913" y="4173538"/>
          <p14:tracePt t="3001" x="7808913" y="4246563"/>
          <p14:tracePt t="3012" x="7821613" y="4324350"/>
          <p14:tracePt t="3021" x="7821613" y="4414838"/>
          <p14:tracePt t="3028" x="7821613" y="4456113"/>
          <p14:tracePt t="3037" x="7821613" y="4497388"/>
          <p14:tracePt t="3044" x="7821613" y="4584700"/>
          <p14:tracePt t="3051" x="7821613" y="4657725"/>
          <p14:tracePt t="3062" x="7835900" y="4803775"/>
          <p14:tracePt t="3067" x="7835900" y="4811713"/>
          <p14:tracePt t="3078" x="7835900" y="4872038"/>
          <p14:tracePt t="3091" x="7862888" y="5008563"/>
          <p14:tracePt t="3101" x="7877175" y="5105400"/>
          <p14:tracePt t="3110" x="7877175" y="5108575"/>
          <p14:tracePt t="3117" x="7877175" y="5145088"/>
          <p14:tracePt t="3127" x="7886700" y="5205413"/>
          <p14:tracePt t="3133" x="7913688" y="5264150"/>
          <p14:tracePt t="3144" x="7940675" y="5341938"/>
          <p14:tracePt t="3148" x="7950200" y="5360988"/>
          <p14:tracePt t="3163" x="8018463" y="5483225"/>
          <p14:tracePt t="3179" x="8045450" y="5561013"/>
          <p14:tracePt t="3184" x="8081963" y="5607050"/>
          <p14:tracePt t="3187" x="8091488" y="5653088"/>
          <p14:tracePt t="3198" x="8101013" y="5670550"/>
          <p14:tracePt t="3203" x="8101013" y="5697538"/>
          <p14:tracePt t="3213" x="8123238" y="5743575"/>
          <p14:tracePt t="3227" x="8123238" y="5770563"/>
          <p14:tracePt t="3228" x="8132763" y="5780088"/>
          <p14:tracePt t="3244" x="8132763" y="5789613"/>
          <p14:tracePt t="3283" x="8132763" y="5803900"/>
          <p14:tracePt t="3300" x="8132763" y="5811838"/>
          <p14:tracePt t="3304" x="8142288" y="5830888"/>
          <p14:tracePt t="3323" x="8147050" y="5835650"/>
          <p14:tracePt t="3339" x="8147050" y="5843588"/>
          <p14:tracePt t="3365" x="8147050" y="5853113"/>
          <p14:tracePt t="3420" x="8147050" y="5876925"/>
          <p14:tracePt t="3572" x="8147050" y="5884863"/>
          <p14:tracePt t="3598" x="8147050" y="5894388"/>
          <p14:tracePt t="3757" x="8147050" y="5903913"/>
          <p14:tracePt t="3783" x="8147050" y="5908675"/>
          <p14:tracePt t="3809" x="8137525" y="5918200"/>
          <p14:tracePt t="3853" x="8128000" y="5926138"/>
          <p14:tracePt t="3869" x="8123238" y="5930900"/>
          <p14:tracePt t="3909" x="8123238" y="5957888"/>
          <p14:tracePt t="3919" x="8123238" y="5967413"/>
          <p14:tracePt t="3930" x="8123238" y="5976938"/>
          <p14:tracePt t="3939" x="8123238" y="5981700"/>
          <p14:tracePt t="3949" x="8123238" y="5991225"/>
          <p14:tracePt t="3962" x="8123238" y="5999163"/>
          <p14:tracePt t="3969" x="8123238" y="6003925"/>
          <p14:tracePt t="3979" x="8123238" y="6022975"/>
          <p14:tracePt t="3995" x="8123238" y="6030913"/>
          <p14:tracePt t="4005" x="8123238" y="6035675"/>
          <p14:tracePt t="4026" x="8123238" y="6045200"/>
          <p14:tracePt t="4042" x="8123238" y="6054725"/>
          <p14:tracePt t="4048" x="8132763" y="6064250"/>
          <p14:tracePt t="4061" x="8142288" y="6067425"/>
          <p14:tracePt t="4071" x="8147050" y="6076950"/>
          <p14:tracePt t="4077" x="8164513" y="6096000"/>
          <p14:tracePt t="4093" x="8174038" y="6113463"/>
          <p14:tracePt t="4111" x="8191500" y="6122988"/>
          <p14:tracePt t="4127" x="8201025" y="6132513"/>
          <p14:tracePt t="4141" x="8220075" y="6140450"/>
          <p14:tracePt t="4162" x="8228013" y="6140450"/>
          <p14:tracePt t="4171" x="8232775" y="6145213"/>
          <p14:tracePt t="4182" x="8242300" y="6145213"/>
          <p14:tracePt t="4194" x="8269288" y="6154738"/>
          <p14:tracePt t="4201" x="8278813" y="6173788"/>
          <p14:tracePt t="4213" x="8288338" y="6173788"/>
          <p14:tracePt t="4232" x="8293100" y="6173788"/>
          <p14:tracePt t="4246" x="8310563" y="6173788"/>
          <p14:tracePt t="4251" x="8320088" y="6173788"/>
          <p14:tracePt t="4262" x="8324850" y="6173788"/>
          <p14:tracePt t="4278" x="8342313" y="6173788"/>
          <p14:tracePt t="4283" x="8361363" y="6173788"/>
          <p14:tracePt t="4295" x="8366125" y="6173788"/>
          <p14:tracePt t="4303" x="8383588" y="6173788"/>
          <p14:tracePt t="4314" x="8393113" y="6173788"/>
          <p14:tracePt t="4317" x="8405813" y="6173788"/>
          <p14:tracePt t="4327" x="8415338" y="6173788"/>
          <p14:tracePt t="4333" x="8424863" y="6173788"/>
          <p14:tracePt t="4345" x="8451850" y="6173788"/>
          <p14:tracePt t="4361" x="8456613" y="6173788"/>
          <p14:tracePt t="4367" x="8475663" y="6173788"/>
          <p14:tracePt t="4377" x="8493125" y="6173788"/>
          <p14:tracePt t="4389" x="8497888" y="6173788"/>
          <p14:tracePt t="4394" x="8524875" y="6173788"/>
          <p14:tracePt t="4398" x="8534400" y="6181725"/>
          <p14:tracePt t="4409" x="8553450" y="6191250"/>
          <p14:tracePt t="4412" x="8556625" y="6191250"/>
          <p14:tracePt t="4434" x="8639175" y="6191250"/>
          <p14:tracePt t="4450" x="8662988" y="6191250"/>
          <p14:tracePt t="4454" x="8680450" y="6191250"/>
          <p14:tracePt t="4469" x="8699500" y="6191250"/>
          <p14:tracePt t="4483" x="8726488" y="6191250"/>
          <p14:tracePt t="4486" x="8736013" y="6191250"/>
          <p14:tracePt t="4490" x="8758238" y="6191250"/>
          <p14:tracePt t="4497" x="8767763" y="6191250"/>
          <p14:tracePt t="4505" x="8785225" y="6191250"/>
          <p14:tracePt t="4515" x="8812213" y="6173788"/>
          <p14:tracePt t="4527" x="8821738" y="6173788"/>
          <p14:tracePt t="4529" x="8831263" y="6173788"/>
          <p14:tracePt t="4543" x="8840788" y="6173788"/>
          <p14:tracePt t="4557" x="8845550" y="6169025"/>
          <p14:tracePt t="4615" x="8863013" y="6159500"/>
          <p14:tracePt t="4634" x="8882063" y="6149975"/>
          <p14:tracePt t="4641" x="8899525" y="6149975"/>
          <p14:tracePt t="4653" x="8918575" y="6140450"/>
          <p14:tracePt t="4656" x="8936038" y="6132513"/>
          <p14:tracePt t="4667" x="8955088" y="6122988"/>
          <p14:tracePt t="4676" x="8986838" y="6122988"/>
          <p14:tracePt t="4688" x="9004300" y="6091238"/>
          <p14:tracePt t="4698" x="9013825" y="6091238"/>
          <p14:tracePt t="4705" x="9023350" y="6081713"/>
          <p14:tracePt t="4715" x="9036050" y="6072188"/>
          <p14:tracePt t="4726" x="9069388" y="6064250"/>
          <p14:tracePt t="4737" x="9077325" y="6054725"/>
          <p14:tracePt t="4747" x="9091613" y="6049963"/>
          <p14:tracePt t="4761" x="9109075" y="6040438"/>
          <p14:tracePt t="4771" x="9132888" y="6027738"/>
          <p14:tracePt t="4778" x="9150350" y="6008688"/>
          <p14:tracePt t="4788" x="9169400" y="5991225"/>
          <p14:tracePt t="4799" x="9186863" y="5972175"/>
          <p14:tracePt t="4816" x="9215438" y="5945188"/>
          <p14:tracePt t="4818" x="9232900" y="5913438"/>
          <p14:tracePt t="4829" x="9264650" y="5894388"/>
          <p14:tracePt t="4839" x="9301163" y="5848350"/>
          <p14:tracePt t="4842" x="9301163" y="5830888"/>
          <p14:tracePt t="4860" x="9328150" y="5767388"/>
          <p14:tracePt t="4867" x="9342438" y="5726113"/>
          <p14:tracePt t="4879" x="9366250" y="5665788"/>
          <p14:tracePt t="4883" x="9366250" y="5634038"/>
          <p14:tracePt t="4893" x="9374188" y="5607050"/>
          <p14:tracePt t="4896" x="9398000" y="5575300"/>
          <p14:tracePt t="4916" x="9405938" y="5534025"/>
          <p14:tracePt t="4918" x="9405938" y="5475288"/>
          <p14:tracePt t="4934" x="9434513" y="5405438"/>
          <p14:tracePt t="4939" x="9439275" y="5387975"/>
          <p14:tracePt t="4949" x="9439275" y="5319713"/>
          <p14:tracePt t="4958" x="9439275" y="5291138"/>
          <p14:tracePt t="4964" x="9439275" y="5237163"/>
          <p14:tracePt t="4973" x="9439275" y="5195888"/>
          <p14:tracePt t="4980" x="9451975" y="5141913"/>
          <p14:tracePt t="4989" x="9451975" y="5100638"/>
          <p14:tracePt t="4999" x="9466263" y="4999038"/>
          <p14:tracePt t="5002" x="9466263" y="4981575"/>
          <p14:tracePt t="5013" x="9475788" y="4908550"/>
          <p14:tracePt t="5018" x="9488488" y="4867275"/>
          <p14:tracePt t="5030" x="9488488" y="4811713"/>
          <p14:tracePt t="5048" x="9512300" y="4702175"/>
          <p14:tracePt t="5054" x="9512300" y="4662488"/>
          <p14:tracePt t="5065" x="9534525" y="4606925"/>
          <p14:tracePt t="5070" x="9544050" y="4529138"/>
          <p14:tracePt t="5086" x="9556750" y="4368800"/>
          <p14:tracePt t="5098" x="9556750" y="4287838"/>
          <p14:tracePt t="5099" x="9571038" y="4173538"/>
          <p14:tracePt t="5111" x="9598025" y="4076700"/>
          <p14:tracePt t="5118" x="9598025" y="3881438"/>
          <p14:tracePt t="5128" x="9607550" y="3849688"/>
          <p14:tracePt t="5135" x="9621838" y="3748088"/>
          <p14:tracePt t="5139" x="9634538" y="3657600"/>
          <p14:tracePt t="5149" x="9634538" y="3543300"/>
          <p14:tracePt t="5161" x="9661525" y="3397250"/>
          <p14:tracePt t="5166" x="9671050" y="3355975"/>
          <p14:tracePt t="5177" x="9671050" y="3260725"/>
          <p14:tracePt t="5180" x="9671050" y="3151188"/>
          <p14:tracePt t="5192" x="9671050" y="3041650"/>
          <p14:tracePt t="5201" x="9671050" y="2820988"/>
          <p14:tracePt t="5205" x="9671050" y="2781300"/>
          <p14:tracePt t="5216" x="9671050" y="2679700"/>
          <p14:tracePt t="5221" x="9671050" y="2570163"/>
          <p14:tracePt t="5232" x="9671050" y="2479675"/>
          <p14:tracePt t="5243" x="9671050" y="2314575"/>
          <p14:tracePt t="5246" x="9666288" y="2273300"/>
          <p14:tracePt t="5255" x="9653588" y="2178050"/>
          <p14:tracePt t="5262" x="9653588" y="2085975"/>
          <p14:tracePt t="5271" x="9625013" y="1954213"/>
          <p14:tracePt t="5282" x="9593263" y="1789113"/>
          <p14:tracePt t="5285" x="9593263" y="1749425"/>
          <p14:tracePt t="5296" x="9571038" y="1635125"/>
          <p14:tracePt t="5301" x="9556750" y="1538288"/>
          <p14:tracePt t="5311" x="9544050" y="1443038"/>
          <p14:tracePt t="5322" x="9512300" y="1296988"/>
          <p14:tracePt t="5328" x="9502775" y="1277938"/>
          <p14:tracePt t="5337" x="9478963" y="1219200"/>
          <p14:tracePt t="5341" x="9478963" y="1177925"/>
          <p14:tracePt t="5351" x="9442450" y="1104900"/>
          <p14:tracePt t="5361" x="9405938" y="1058863"/>
          <p14:tracePt t="5367" x="9388475" y="1050925"/>
          <p14:tracePt t="5381" x="9347200" y="985838"/>
          <p14:tracePt t="5394" x="9315450" y="963613"/>
          <p14:tracePt t="5401" x="9274175" y="954088"/>
          <p14:tracePt t="5409" x="9255125" y="936625"/>
          <p14:tracePt t="5417" x="9215438" y="922338"/>
          <p14:tracePt t="5421" x="9196388" y="922338"/>
          <p14:tracePt t="5435" x="9178925" y="922338"/>
          <p14:tracePt t="5450" x="9064625" y="912813"/>
          <p14:tracePt t="5466" x="8967788" y="912813"/>
          <p14:tracePt t="5476" x="8936038" y="912813"/>
          <p14:tracePt t="5487" x="8809038" y="912813"/>
          <p14:tracePt t="5489" x="8794750" y="912813"/>
          <p14:tracePt t="5499" x="8763000" y="912813"/>
          <p14:tracePt t="5503" x="8721725" y="912813"/>
          <p14:tracePt t="5513" x="8680450" y="912813"/>
          <p14:tracePt t="5525" x="8639175" y="912813"/>
          <p14:tracePt t="5527" x="8629650" y="912813"/>
          <p14:tracePt t="5544" x="8626475" y="912813"/>
          <p14:tracePt t="5553" x="8616950" y="912813"/>
          <p14:tracePt t="5564" x="8597900" y="912813"/>
          <p14:tracePt t="5569" x="8589963" y="927100"/>
          <p14:tracePt t="5579" x="8585200" y="936625"/>
          <p14:tracePt t="5582" x="8575675" y="939800"/>
          <p14:tracePt t="5595" x="8566150" y="958850"/>
          <p14:tracePt t="5603" x="8556625" y="1031875"/>
          <p14:tracePt t="5612" x="8556625" y="1036638"/>
          <p14:tracePt t="5619" x="8556625" y="1087438"/>
          <p14:tracePt t="5627" x="8556625" y="1127125"/>
          <p14:tracePt t="5633" x="8556625" y="1168400"/>
          <p14:tracePt t="5645" x="8556625" y="1282700"/>
          <p14:tracePt t="5649" x="8556625" y="1338263"/>
          <p14:tracePt t="5662" x="8580438" y="1433513"/>
          <p14:tracePt t="5665" x="8616950" y="1516063"/>
          <p14:tracePt t="5679" x="8680450" y="1666875"/>
          <p14:tracePt t="5685" x="8780463" y="1890713"/>
          <p14:tracePt t="5693" x="8821738" y="1973263"/>
          <p14:tracePt t="5699" x="8945563" y="2200275"/>
          <p14:tracePt t="5705" x="9109075" y="2489200"/>
          <p14:tracePt t="5715" x="9328150" y="2789238"/>
          <p14:tracePt t="5727" x="9853613" y="3397250"/>
          <p14:tracePt t="5729" x="9940925" y="3502025"/>
          <p14:tracePt t="5745" x="10242550" y="3803650"/>
          <p14:tracePt t="5746" x="10593388" y="4105275"/>
          <p14:tracePt t="5755" x="11036300" y="4405313"/>
          <p14:tracePt t="5765" x="11812588" y="4889500"/>
          <p14:tracePt t="5771" x="11926888" y="4949825"/>
          <p14:tracePt t="8143" x="11557000" y="5013325"/>
          <p14:tracePt t="8207" x="9877425" y="5940425"/>
          <p14:tracePt t="8217" x="9831388" y="5962650"/>
          <p14:tracePt t="8223" x="9812338" y="5962650"/>
          <p14:tracePt t="8233" x="9809163" y="5967413"/>
          <p14:tracePt t="8257" x="9799638" y="5967413"/>
          <p14:tracePt t="8263" x="9772650" y="5967413"/>
          <p14:tracePt t="8271" x="9763125" y="5967413"/>
          <p14:tracePt t="8278" x="9748838" y="5957888"/>
          <p14:tracePt t="8287" x="9739313" y="5949950"/>
          <p14:tracePt t="8299" x="9721850" y="5921375"/>
          <p14:tracePt t="8301" x="9712325" y="5913438"/>
          <p14:tracePt t="8315" x="9694863" y="5899150"/>
          <p14:tracePt t="8317" x="9685338" y="5881688"/>
          <p14:tracePt t="8327" x="9661525" y="5821363"/>
          <p14:tracePt t="8337" x="9625013" y="5757863"/>
          <p14:tracePt t="8343" x="9602788" y="5726113"/>
          <p14:tracePt t="8353" x="9585325" y="5684838"/>
          <p14:tracePt t="8360" x="9548813" y="5634038"/>
          <p14:tracePt t="8367" x="9507538" y="5570538"/>
          <p14:tracePt t="8378" x="9420225" y="5451475"/>
          <p14:tracePt t="8383" x="9420225" y="5441950"/>
          <p14:tracePt t="8395" x="9366250" y="5378450"/>
          <p14:tracePt t="8398" x="9332913" y="5346700"/>
          <p14:tracePt t="8409" x="9296400" y="5300663"/>
          <p14:tracePt t="8417" x="9232900" y="5259388"/>
          <p14:tracePt t="8424" x="9215438" y="5251450"/>
          <p14:tracePt t="8433" x="9155113" y="5227638"/>
          <p14:tracePt t="8440" x="9128125" y="5218113"/>
          <p14:tracePt t="8449" x="9096375" y="5186363"/>
          <p14:tracePt t="8459" x="9064625" y="5178425"/>
          <p14:tracePt t="8476" x="9045575" y="5159375"/>
          <p14:tracePt t="8481" x="9036050" y="5149850"/>
          <p14:tracePt t="8493" x="9023350" y="5141913"/>
          <p14:tracePt t="8499" x="8999538" y="5108575"/>
          <p14:tracePt t="8510" x="8991600" y="5105400"/>
          <p14:tracePt t="8520" x="8986838" y="5086350"/>
          <p14:tracePt t="8530" x="8963025" y="5068888"/>
          <p14:tracePt t="8543" x="8945563" y="5045075"/>
          <p14:tracePt t="8550" x="8936038" y="5027613"/>
          <p14:tracePt t="8563" x="8918575" y="5008563"/>
          <p14:tracePt t="8569" x="8909050" y="4991100"/>
          <p14:tracePt t="8580" x="8885238" y="4972050"/>
          <p14:tracePt t="8593" x="8882063" y="4962525"/>
          <p14:tracePt t="8596" x="8863013" y="4945063"/>
          <p14:tracePt t="8600" x="8853488" y="4935538"/>
          <p14:tracePt t="8612" x="8836025" y="4918075"/>
          <p14:tracePt t="8619" x="8816975" y="4889500"/>
          <p14:tracePt t="8627" x="8809038" y="4881563"/>
          <p14:tracePt t="8636" x="8799513" y="4862513"/>
          <p14:tracePt t="8646" x="8789988" y="4857750"/>
          <p14:tracePt t="8655" x="8775700" y="4840288"/>
          <p14:tracePt t="8751" x="8767763" y="4830763"/>
          <p14:tracePt t="8756" x="8758238" y="4821238"/>
          <p14:tracePt t="8771" x="8748713" y="4816475"/>
          <p14:tracePt t="8781" x="8748713" y="4789488"/>
          <p14:tracePt t="8794" x="8731250" y="4772025"/>
          <p14:tracePt t="9005" x="8712200" y="4762500"/>
          <p14:tracePt t="9060" x="8702675" y="4762500"/>
          <p14:tracePt t="9084" x="8699500" y="4752975"/>
          <p14:tracePt t="9097" x="8689975" y="4752975"/>
          <p14:tracePt t="9119" x="8670925" y="4752975"/>
          <p14:tracePt t="9146" x="8666163" y="4752975"/>
          <p14:tracePt t="9150" x="8658225" y="4752975"/>
          <p14:tracePt t="9165" x="8648700" y="4752975"/>
          <p14:tracePt t="9189" x="8643938" y="4752975"/>
          <p14:tracePt t="9219" x="8634413" y="4743450"/>
          <p14:tracePt t="9246" x="8626475" y="4743450"/>
          <p14:tracePt t="9272" x="8616950" y="4735513"/>
          <p14:tracePt t="9335" x="8612188" y="4730750"/>
          <p14:tracePt t="9388" x="8602663" y="4711700"/>
          <p14:tracePt t="9473" x="8570913" y="4689475"/>
          <p14:tracePt t="9488" x="8561388" y="4684713"/>
          <p14:tracePt t="9504" x="8556625" y="4675188"/>
          <p14:tracePt t="9514" x="8548688" y="4665663"/>
          <p14:tracePt t="9659" x="8539163" y="4662488"/>
          <p14:tracePt t="9669" x="8534400" y="4652963"/>
          <p14:tracePt t="9699" x="8524875" y="4625975"/>
          <p14:tracePt t="9715" x="8524875" y="4616450"/>
          <p14:tracePt t="10412" x="8524875" y="4611688"/>
          <p14:tracePt t="10417" x="8461375" y="4611688"/>
          <p14:tracePt t="10427" x="8296275" y="4652963"/>
          <p14:tracePt t="10436" x="8164513" y="4679950"/>
          <p14:tracePt t="10446" x="7962900" y="4694238"/>
          <p14:tracePt t="10451" x="7439025" y="4738688"/>
          <p14:tracePt t="10455" x="7273925" y="4738688"/>
          <p14:tracePt t="10465" x="6826250" y="4779963"/>
          <p14:tracePt t="10472" x="6329363" y="4826000"/>
          <p14:tracePt t="10482" x="5949950" y="4848225"/>
          <p14:tracePt t="10494" x="5305425" y="4899025"/>
          <p14:tracePt t="10497" x="5210175" y="4913313"/>
          <p14:tracePt t="10512" x="4862513" y="4940300"/>
          <p14:tracePt t="10520" x="4789488" y="4954588"/>
          <p14:tracePt t="10531" x="4694238" y="4967288"/>
          <p14:tracePt t="10537" x="4675188" y="4976813"/>
          <p14:tracePt t="10547" x="4667250" y="4976813"/>
          <p14:tracePt t="10551" x="4657725" y="4976813"/>
          <p14:tracePt t="10562" x="4643438" y="4976813"/>
          <p14:tracePt t="10613" x="4635500" y="4976813"/>
          <p14:tracePt t="10629" x="4625975" y="4976813"/>
          <p14:tracePt t="10636" x="4621213" y="4976813"/>
          <p14:tracePt t="10653" x="4611688" y="4976813"/>
          <p14:tracePt t="10655" x="4594225" y="4976813"/>
          <p14:tracePt t="10664" x="4589463" y="4976813"/>
          <p14:tracePt t="10667" x="4570413" y="4976813"/>
          <p14:tracePt t="10678" x="4543425" y="4976813"/>
          <p14:tracePt t="10682" x="4511675" y="4976813"/>
          <p14:tracePt t="10693" x="4424363" y="4959350"/>
          <p14:tracePt t="10696" x="4406900" y="4949825"/>
          <p14:tracePt t="10709" x="4365625" y="4949825"/>
          <p14:tracePt t="10713" x="4278313" y="4922838"/>
          <p14:tracePt t="10725" x="4168775" y="4922838"/>
          <p14:tracePt t="10734" x="3968750" y="4908550"/>
          <p14:tracePt t="10748" x="3940175" y="4908550"/>
          <p14:tracePt t="10750" x="3825875" y="4894263"/>
          <p14:tracePt t="10755" x="3716338" y="4894263"/>
          <p14:tracePt t="10765" x="3584575" y="4867275"/>
          <p14:tracePt t="10775" x="3438525" y="4867275"/>
          <p14:tracePt t="10785" x="3419475" y="4867275"/>
          <p14:tracePt t="10791" x="3351213" y="4867275"/>
          <p14:tracePt t="10794" x="3309938" y="4867275"/>
          <p14:tracePt t="10803" x="3270250" y="4845050"/>
          <p14:tracePt t="10813" x="3236913" y="4845050"/>
          <p14:tracePt t="10900" x="3219450" y="4845050"/>
          <p14:tracePt t="10911" x="3214688" y="4835525"/>
          <p14:tracePt t="10920" x="3195638" y="4826000"/>
          <p14:tracePt t="10930" x="3187700" y="4821238"/>
          <p14:tracePt t="10940" x="3178175" y="4811713"/>
          <p14:tracePt t="11297" x="3178175" y="4803775"/>
          <p14:tracePt t="11303" x="3178175" y="4799013"/>
          <p14:tracePt t="11315" x="3192463" y="4789488"/>
          <p14:tracePt t="11419" x="3200400" y="4772025"/>
          <p14:tracePt t="11429" x="3209925" y="4762500"/>
          <p14:tracePt t="11441" x="3219450" y="4752975"/>
          <p14:tracePt t="11456" x="3224213" y="4743450"/>
          <p14:tracePt t="11464" x="3224213" y="4738688"/>
          <p14:tracePt t="11466" x="3224213" y="4730750"/>
          <p14:tracePt t="11479" x="3232150" y="4721225"/>
          <p14:tracePt t="11839" x="3241675" y="4721225"/>
          <p14:tracePt t="11941" x="3255963" y="4721225"/>
          <p14:tracePt t="11949" x="3278188" y="4711700"/>
          <p14:tracePt t="11959" x="3287713" y="4694238"/>
          <p14:tracePt t="11969" x="3292475" y="4684713"/>
          <p14:tracePt t="11979" x="3302000" y="4684713"/>
          <p14:tracePt t="11992" x="3309938" y="4684713"/>
          <p14:tracePt t="11999" x="3346450" y="4665663"/>
          <p14:tracePt t="12019" x="3365500" y="4657725"/>
          <p14:tracePt t="12035" x="3375025" y="4657725"/>
          <p14:tracePt t="12049" x="3382963" y="4657725"/>
          <p14:tracePt t="12065" x="3387725" y="4657725"/>
          <p14:tracePt t="12106" x="3406775" y="4648200"/>
          <p14:tracePt t="12126" x="3424238" y="4648200"/>
          <p14:tracePt t="12142" x="3452813" y="4648200"/>
          <p14:tracePt t="12151" x="3492500" y="4638675"/>
          <p14:tracePt t="12162" x="3606800" y="4638675"/>
          <p14:tracePt t="12170" x="3648075" y="4638675"/>
          <p14:tracePt t="12180" x="3757613" y="4638675"/>
          <p14:tracePt t="12182" x="3922713" y="4638675"/>
          <p14:tracePt t="12192" x="4049713" y="4638675"/>
          <p14:tracePt t="12201" x="4489450" y="4638675"/>
          <p14:tracePt t="12205" x="4584700" y="4638675"/>
          <p14:tracePt t="12216" x="4857750" y="4638675"/>
          <p14:tracePt t="12222" x="5122863" y="4638675"/>
          <p14:tracePt t="12232" x="5383213" y="4638675"/>
          <p14:tracePt t="12247" x="5903913" y="4638675"/>
          <p14:tracePt t="12260" x="6105525" y="4638675"/>
          <p14:tracePt t="12263" x="6288088" y="4638675"/>
          <p14:tracePt t="12271" x="6434138" y="4638675"/>
          <p14:tracePt t="12282" x="6653213" y="4638675"/>
          <p14:tracePt t="12287" x="6694488" y="4638675"/>
          <p14:tracePt t="12298" x="6808788" y="4638675"/>
          <p14:tracePt t="12301" x="6862763" y="4638675"/>
          <p14:tracePt t="12312" x="6940550" y="4638675"/>
          <p14:tracePt t="12321" x="7013575" y="4625975"/>
          <p14:tracePt t="12327" x="7023100" y="4625975"/>
          <p14:tracePt t="12338" x="7059613" y="4625975"/>
          <p14:tracePt t="12344" x="7113588" y="4625975"/>
          <p14:tracePt t="12353" x="7169150" y="4625975"/>
          <p14:tracePt t="12364" x="7246938" y="4625975"/>
          <p14:tracePt t="12367" x="7273925" y="4625975"/>
          <p14:tracePt t="12378" x="7342188" y="4625975"/>
          <p14:tracePt t="12383" x="7402513" y="4625975"/>
          <p14:tracePt t="12394" x="7475538" y="4625975"/>
          <p14:tracePt t="12403" x="7602538" y="4597400"/>
          <p14:tracePt t="12410" x="7634288" y="4597400"/>
          <p14:tracePt t="12417" x="7689850" y="4584700"/>
          <p14:tracePt t="12427" x="7780338" y="4584700"/>
          <p14:tracePt t="12433" x="7877175" y="4584700"/>
          <p14:tracePt t="12446" x="8054975" y="4584700"/>
          <p14:tracePt t="12447" x="8086725" y="4584700"/>
          <p14:tracePt t="12460" x="8154988" y="4584700"/>
          <p14:tracePt t="12464" x="8247063" y="4584700"/>
          <p14:tracePt t="12476" x="8288338" y="4584700"/>
          <p14:tracePt t="12483" x="8329613" y="4584700"/>
          <p14:tracePt t="12492" x="8337550" y="4584700"/>
          <p14:tracePt t="12499" x="8342313" y="4584700"/>
          <p14:tracePt t="12563" x="8351838" y="4584700"/>
          <p14:tracePt t="12569" x="8361363" y="4589463"/>
          <p14:tracePt t="12579" x="8369300" y="4597400"/>
          <p14:tracePt t="12599" x="8383588" y="4597400"/>
          <p14:tracePt t="12605" x="8393113" y="4606925"/>
          <p14:tracePt t="12613" x="8402638" y="4611688"/>
          <p14:tracePt t="12741" x="8405813" y="4621213"/>
          <p14:tracePt t="12842" x="8415338" y="4629150"/>
          <p14:tracePt t="12862" x="8415338" y="4633913"/>
          <p14:tracePt t="12984" x="8415338" y="4643438"/>
          <p14:tracePt t="13040" x="8415338" y="4662488"/>
          <p14:tracePt t="13422" x="8415338" y="4665663"/>
          <p14:tracePt t="13438" x="8410575" y="4675188"/>
          <p14:tracePt t="13448" x="8410575" y="4684713"/>
          <p14:tracePt t="13468" x="8405813" y="4694238"/>
          <p14:tracePt t="13508" x="8388350" y="4699000"/>
          <p14:tracePt t="13543" x="8378825" y="4706938"/>
          <p14:tracePt t="13554" x="8369300" y="4716463"/>
          <p14:tracePt t="13568" x="8366125" y="4735513"/>
          <p14:tracePt t="13579" x="8356600" y="4738688"/>
          <p14:tracePt t="13587" x="8356600" y="4748213"/>
          <p14:tracePt t="13594" x="8356600" y="4757738"/>
          <p14:tracePt t="13619" x="8356600" y="4762500"/>
          <p14:tracePt t="14043" x="8361363" y="4762500"/>
          <p14:tracePt t="14052" x="8361363" y="4752975"/>
          <p14:tracePt t="14064" x="8366125" y="4735513"/>
          <p14:tracePt t="14200" x="8356600" y="4735513"/>
          <p14:tracePt t="14209" x="8329613" y="4735513"/>
          <p14:tracePt t="14214" x="8324850" y="4735513"/>
          <p14:tracePt t="14225" x="8283575" y="4725988"/>
          <p14:tracePt t="14241" x="8201025" y="4725988"/>
          <p14:tracePt t="14255" x="8113713" y="4725988"/>
          <p14:tracePt t="14268" x="8086725" y="4725988"/>
          <p14:tracePt t="14269" x="8032750" y="4735513"/>
          <p14:tracePt t="14279" x="7991475" y="4735513"/>
          <p14:tracePt t="14293" x="7886700" y="4743450"/>
          <p14:tracePt t="14305" x="7799388" y="4757738"/>
          <p14:tracePt t="14311" x="7707313" y="4757738"/>
          <p14:tracePt t="14319" x="7580313" y="4757738"/>
          <p14:tracePt t="14329" x="7361238" y="4757738"/>
          <p14:tracePt t="14334" x="7329488" y="4757738"/>
          <p14:tracePt t="14345" x="7259638" y="4757738"/>
          <p14:tracePt t="14349" x="7169150" y="4757738"/>
          <p14:tracePt t="14359" x="7091363" y="4735513"/>
          <p14:tracePt t="14370" x="7059613" y="4735513"/>
          <p14:tracePt t="14380" x="7054850" y="4735513"/>
          <p14:tracePt t="14387" x="7045325" y="4730750"/>
          <p14:tracePt t="14496" x="7037388" y="4730750"/>
          <p14:tracePt t="14508" x="7027863" y="4730750"/>
          <p14:tracePt t="14519" x="7013575" y="4730750"/>
          <p14:tracePt t="14533" x="6996113" y="4735513"/>
          <p14:tracePt t="14550" x="6986588" y="4735513"/>
          <p14:tracePt t="14572" x="6977063" y="4735513"/>
          <p14:tracePt t="14579" x="6972300" y="4735513"/>
          <p14:tracePt t="14587" x="6954838" y="4735513"/>
          <p14:tracePt t="14594" x="6945313" y="4738688"/>
          <p14:tracePt t="14612" x="6931025" y="4738688"/>
          <p14:tracePt t="14631" x="6923088" y="4738688"/>
          <p14:tracePt t="14646" x="6913563" y="4748213"/>
          <p14:tracePt t="14673" x="6904038" y="4748213"/>
          <p14:tracePt t="14733" x="6899275" y="4748213"/>
          <p14:tracePt t="14849" x="6889750" y="4748213"/>
          <p14:tracePt t="14860" x="6881813" y="4748213"/>
          <p14:tracePt t="14950" x="6872288" y="4735513"/>
          <p14:tracePt t="15072" x="6845300" y="4716463"/>
          <p14:tracePt t="15086" x="6835775" y="4706938"/>
          <p14:tracePt t="15104" x="6835775" y="4699000"/>
          <p14:tracePt t="15118" x="6835775" y="4694238"/>
          <p14:tracePt t="15131" x="6826250" y="4684713"/>
          <p14:tracePt t="15148" x="6821488" y="4675188"/>
          <p14:tracePt t="15157" x="6813550" y="4657725"/>
          <p14:tracePt t="15191" x="6813550" y="4652963"/>
          <p14:tracePt t="16877" x="6813550" y="4643438"/>
          <p14:tracePt t="17140" x="6831013" y="4643438"/>
          <p14:tracePt t="17150" x="6886575" y="4643438"/>
          <p14:tracePt t="17161" x="6959600" y="4643438"/>
          <p14:tracePt t="17166" x="6991350" y="4643438"/>
          <p14:tracePt t="17175" x="7086600" y="4643438"/>
          <p14:tracePt t="17179" x="7196138" y="4643438"/>
          <p14:tracePt t="17191" x="7324725" y="4643438"/>
          <p14:tracePt t="17199" x="7548563" y="4643438"/>
          <p14:tracePt t="17208" x="7602538" y="4643438"/>
          <p14:tracePt t="17214" x="7731125" y="4643438"/>
          <p14:tracePt t="17218" x="7858125" y="4643438"/>
          <p14:tracePt t="17229" x="7967663" y="4643438"/>
          <p14:tracePt t="17249" x="8132763" y="4643438"/>
          <p14:tracePt t="17266" x="8220075" y="4662488"/>
          <p14:tracePt t="17270" x="8223250" y="4662488"/>
          <p14:tracePt t="17280" x="8242300" y="4662488"/>
          <p14:tracePt t="17437" x="8251825" y="4662488"/>
          <p14:tracePt t="17462" x="8256588" y="4662488"/>
          <p14:tracePt t="17482" x="8264525" y="4662488"/>
          <p14:tracePt t="17673" x="8274050" y="4670425"/>
          <p14:tracePt t="17839" x="8278813" y="4675188"/>
          <p14:tracePt t="17865" x="8296275" y="4694238"/>
          <p14:tracePt t="17884" x="8296275" y="4702175"/>
          <p14:tracePt t="17892" x="8305800" y="4721225"/>
          <p14:tracePt t="17905" x="8305800" y="4735513"/>
          <p14:tracePt t="17914" x="8315325" y="4767263"/>
          <p14:tracePt t="17926" x="8315325" y="4775200"/>
          <p14:tracePt t="17931" x="8315325" y="4779963"/>
          <p14:tracePt t="17943" x="8324850" y="4789488"/>
          <p14:tracePt t="17946" x="8324850" y="4816475"/>
          <p14:tracePt t="17958" x="8324850" y="4826000"/>
          <p14:tracePt t="17964" x="8332788" y="4840288"/>
          <p14:tracePt t="17970" x="8342313" y="4848225"/>
          <p14:tracePt t="18097" x="8356600" y="4857750"/>
          <p14:tracePt t="18113" x="8366125" y="4857750"/>
          <p14:tracePt t="79069" x="8415338" y="4857750"/>
        </p14:tracePtLst>
      </p14:laserTraceLst>
    </p:ext>
  </p:extLst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359E319-354A-4C59-8EE5-B555A2DA7B04}"/>
              </a:ext>
            </a:extLst>
          </p:cNvPr>
          <p:cNvSpPr/>
          <p:nvPr/>
        </p:nvSpPr>
        <p:spPr>
          <a:xfrm>
            <a:off x="-211008" y="5539275"/>
            <a:ext cx="4699061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mix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og</a:t>
            </a:r>
            <a:r>
              <a:rPr lang="en-US" sz="2000" b="1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R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AC1891B-4176-40F4-AB85-97A9EE1A4124}"/>
              </a:ext>
            </a:extLst>
          </p:cNvPr>
          <p:cNvSpPr/>
          <p:nvPr/>
        </p:nvSpPr>
        <p:spPr>
          <a:xfrm rot="16200000">
            <a:off x="-2200525" y="3348035"/>
            <a:ext cx="4699061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M Log</a:t>
            </a:r>
            <a:r>
              <a:rPr lang="en-US" sz="2000" b="1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R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1" name="Rounded Rectangle 6">
            <a:extLst>
              <a:ext uri="{FF2B5EF4-FFF2-40B4-BE49-F238E27FC236}">
                <a16:creationId xmlns:a16="http://schemas.microsoft.com/office/drawing/2014/main" id="{4C2C1900-A7C1-4811-BC1D-1A97C28AE111}"/>
              </a:ext>
            </a:extLst>
          </p:cNvPr>
          <p:cNvSpPr/>
          <p:nvPr/>
        </p:nvSpPr>
        <p:spPr>
          <a:xfrm>
            <a:off x="687134" y="1684080"/>
            <a:ext cx="721432" cy="506386"/>
          </a:xfrm>
          <a:prstGeom prst="roundRect">
            <a:avLst/>
          </a:prstGeom>
          <a:solidFill>
            <a:srgbClr val="CCCC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P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3109A086-B18E-4D8A-9F71-E473AC3E44CC}"/>
              </a:ext>
            </a:extLst>
          </p:cNvPr>
          <p:cNvGrpSpPr/>
          <p:nvPr/>
        </p:nvGrpSpPr>
        <p:grpSpPr>
          <a:xfrm>
            <a:off x="322153" y="1605751"/>
            <a:ext cx="3931920" cy="3796106"/>
            <a:chOff x="403625" y="1397524"/>
            <a:chExt cx="3931920" cy="379610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7A876B9-9BD0-4DD8-9B44-3747CCE3A0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19" t="7824" r="4805" b="5597"/>
            <a:stretch/>
          </p:blipFill>
          <p:spPr>
            <a:xfrm>
              <a:off x="403625" y="1397524"/>
              <a:ext cx="3931920" cy="3796106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4FA4E0DA-2475-4124-9C52-9AC146FC9160}"/>
                </a:ext>
              </a:extLst>
            </p:cNvPr>
            <p:cNvSpPr/>
            <p:nvPr/>
          </p:nvSpPr>
          <p:spPr>
            <a:xfrm>
              <a:off x="2948451" y="4381819"/>
              <a:ext cx="1335024" cy="5439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9A91D890-80A8-476A-B807-C4958F5ABD33}"/>
              </a:ext>
            </a:extLst>
          </p:cNvPr>
          <p:cNvGrpSpPr/>
          <p:nvPr/>
        </p:nvGrpSpPr>
        <p:grpSpPr>
          <a:xfrm>
            <a:off x="612722" y="1676060"/>
            <a:ext cx="2096781" cy="869929"/>
            <a:chOff x="5304134" y="5819738"/>
            <a:chExt cx="2096781" cy="869929"/>
          </a:xfrm>
          <a:noFill/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90BB3343-CC49-4B00-93A3-E3051DE9A25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351760" y="5840513"/>
              <a:ext cx="572157" cy="316192"/>
            </a:xfrm>
            <a:prstGeom prst="rect">
              <a:avLst/>
            </a:prstGeom>
            <a:grpFill/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4F74B13C-D05F-4DCF-811E-73BA32921BB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318952" y="6131884"/>
              <a:ext cx="632385" cy="248437"/>
            </a:xfrm>
            <a:prstGeom prst="rect">
              <a:avLst/>
            </a:prstGeom>
            <a:grpFill/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636B7BAA-1B56-4784-A309-BBA83AB4B16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304134" y="6388532"/>
              <a:ext cx="654969" cy="301135"/>
            </a:xfrm>
            <a:prstGeom prst="rect">
              <a:avLst/>
            </a:prstGeom>
            <a:grpFill/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8698F35-F4C2-4274-A150-409B7A44F791}"/>
                </a:ext>
              </a:extLst>
            </p:cNvPr>
            <p:cNvSpPr txBox="1"/>
            <p:nvPr/>
          </p:nvSpPr>
          <p:spPr>
            <a:xfrm>
              <a:off x="5870200" y="5819738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4EFBE6B-4C83-461F-8FB7-66DE92427AA8}"/>
                </a:ext>
              </a:extLst>
            </p:cNvPr>
            <p:cNvSpPr txBox="1"/>
            <p:nvPr/>
          </p:nvSpPr>
          <p:spPr>
            <a:xfrm>
              <a:off x="5863493" y="6100504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87296B8-6F97-456A-B484-381758DFB390}"/>
                </a:ext>
              </a:extLst>
            </p:cNvPr>
            <p:cNvSpPr txBox="1"/>
            <p:nvPr/>
          </p:nvSpPr>
          <p:spPr>
            <a:xfrm>
              <a:off x="5855530" y="6353649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6" name="Rounded Rectangle 6">
            <a:extLst>
              <a:ext uri="{FF2B5EF4-FFF2-40B4-BE49-F238E27FC236}">
                <a16:creationId xmlns:a16="http://schemas.microsoft.com/office/drawing/2014/main" id="{87100BCC-B916-4A73-A44C-6D421E6924E8}"/>
              </a:ext>
            </a:extLst>
          </p:cNvPr>
          <p:cNvSpPr/>
          <p:nvPr/>
        </p:nvSpPr>
        <p:spPr>
          <a:xfrm>
            <a:off x="636949" y="894409"/>
            <a:ext cx="721432" cy="50638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P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9BE50C3A-A14E-4566-A8C9-8760D630FC17}"/>
              </a:ext>
            </a:extLst>
          </p:cNvPr>
          <p:cNvCxnSpPr>
            <a:cxnSpLocks/>
          </p:cNvCxnSpPr>
          <p:nvPr/>
        </p:nvCxnSpPr>
        <p:spPr>
          <a:xfrm flipV="1">
            <a:off x="679251" y="1696835"/>
            <a:ext cx="3503849" cy="3460904"/>
          </a:xfrm>
          <a:prstGeom prst="line">
            <a:avLst/>
          </a:prstGeom>
          <a:ln w="19050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1">
            <a:extLst>
              <a:ext uri="{FF2B5EF4-FFF2-40B4-BE49-F238E27FC236}">
                <a16:creationId xmlns:a16="http://schemas.microsoft.com/office/drawing/2014/main" id="{18CC41C2-EDB2-49E9-83B1-1624A30A2BA0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2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. LR (</a:t>
            </a:r>
            <a:r>
              <a:rPr lang="en-US" sz="28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mix</a:t>
            </a:r>
            <a:r>
              <a:rPr lang="en-US" sz="2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&gt; LR (EFM)</a:t>
            </a:r>
          </a:p>
        </p:txBody>
      </p:sp>
      <p:sp>
        <p:nvSpPr>
          <p:cNvPr id="3" name="Oval 2">
            <a:extLst>
              <a:ext uri="{FF2B5EF4-FFF2-40B4-BE49-F238E27FC236}">
                <a16:creationId xmlns:a16="http://schemas.microsoft.com/office/drawing/2014/main" id="{0572BAA2-955B-415D-98D0-25D3F542C5AE}"/>
              </a:ext>
            </a:extLst>
          </p:cNvPr>
          <p:cNvSpPr/>
          <p:nvPr/>
        </p:nvSpPr>
        <p:spPr>
          <a:xfrm>
            <a:off x="3286742" y="2792522"/>
            <a:ext cx="278301" cy="309932"/>
          </a:xfrm>
          <a:prstGeom prst="ellipse">
            <a:avLst/>
          </a:prstGeom>
          <a:noFill/>
          <a:ln w="53975">
            <a:solidFill>
              <a:srgbClr val="0000FF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E8F11586-2B8A-4614-9FF6-FA6C7CFECBEE}"/>
              </a:ext>
            </a:extLst>
          </p:cNvPr>
          <p:cNvCxnSpPr>
            <a:cxnSpLocks/>
          </p:cNvCxnSpPr>
          <p:nvPr/>
        </p:nvCxnSpPr>
        <p:spPr>
          <a:xfrm flipH="1">
            <a:off x="3670442" y="2947488"/>
            <a:ext cx="1420450" cy="0"/>
          </a:xfrm>
          <a:prstGeom prst="straightConnector1">
            <a:avLst/>
          </a:prstGeom>
          <a:ln w="127000">
            <a:solidFill>
              <a:srgbClr val="00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1" name="Table 2">
            <a:extLst>
              <a:ext uri="{FF2B5EF4-FFF2-40B4-BE49-F238E27FC236}">
                <a16:creationId xmlns:a16="http://schemas.microsoft.com/office/drawing/2014/main" id="{9545FA2B-3B80-437C-9045-E92B3CED44D3}"/>
              </a:ext>
            </a:extLst>
          </p:cNvPr>
          <p:cNvGraphicFramePr>
            <a:graphicFrameLocks noGrp="1"/>
          </p:cNvGraphicFramePr>
          <p:nvPr/>
        </p:nvGraphicFramePr>
        <p:xfrm>
          <a:off x="5520238" y="2093912"/>
          <a:ext cx="6400615" cy="296544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87771">
                  <a:extLst>
                    <a:ext uri="{9D8B030D-6E8A-4147-A177-3AD203B41FA5}">
                      <a16:colId xmlns:a16="http://schemas.microsoft.com/office/drawing/2014/main" val="2608619990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338413170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2733097487"/>
                    </a:ext>
                  </a:extLst>
                </a:gridCol>
                <a:gridCol w="1361644">
                  <a:extLst>
                    <a:ext uri="{9D8B030D-6E8A-4147-A177-3AD203B41FA5}">
                      <a16:colId xmlns:a16="http://schemas.microsoft.com/office/drawing/2014/main" val="1576293174"/>
                    </a:ext>
                  </a:extLst>
                </a:gridCol>
              </a:tblGrid>
              <a:tr h="77088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ftware</a:t>
                      </a:r>
                    </a:p>
                    <a:p>
                      <a:pPr algn="l"/>
                      <a:endParaRPr lang="en-US" sz="2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</a:t>
                      </a:r>
                      <a:r>
                        <a:rPr lang="en-US" sz="1800" b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8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1 (major)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</a:t>
                      </a:r>
                      <a:r>
                        <a:rPr lang="en-US" sz="1800" b="1" baseline="-250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800" b="1" i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</a:t>
                      </a: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C2 (minor)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</a:t>
                      </a:r>
                      <a:r>
                        <a:rPr lang="en-US" sz="1800" b="1" baseline="-250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800" b="1" i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</a:t>
                      </a: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C2 (minor)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ru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3107896"/>
                  </a:ext>
                </a:extLst>
              </a:tr>
              <a:tr h="54247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6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42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4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6814504"/>
                  </a:ext>
                </a:extLst>
              </a:tr>
              <a:tr h="54247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</a:t>
                      </a:r>
                    </a:p>
                    <a:p>
                      <a:pPr algn="l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9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99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1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3276261"/>
                  </a:ext>
                </a:extLst>
              </a:tr>
              <a:tr h="77088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- EFM </a:t>
                      </a:r>
                    </a:p>
                    <a:p>
                      <a:pPr algn="l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9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b="1" i="1" u="sng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3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8879562"/>
                  </a:ext>
                </a:extLst>
              </a:tr>
            </a:tbl>
          </a:graphicData>
        </a:graphic>
      </p:graphicFrame>
      <p:sp>
        <p:nvSpPr>
          <p:cNvPr id="27" name="Rectangle 26">
            <a:extLst>
              <a:ext uri="{FF2B5EF4-FFF2-40B4-BE49-F238E27FC236}">
                <a16:creationId xmlns:a16="http://schemas.microsoft.com/office/drawing/2014/main" id="{D51D5CBF-1913-4E07-AF7A-ECD9A9880A2E}"/>
              </a:ext>
            </a:extLst>
          </p:cNvPr>
          <p:cNvSpPr/>
          <p:nvPr/>
        </p:nvSpPr>
        <p:spPr>
          <a:xfrm>
            <a:off x="10566478" y="3011703"/>
            <a:ext cx="1354375" cy="2047656"/>
          </a:xfrm>
          <a:prstGeom prst="rect">
            <a:avLst/>
          </a:prstGeom>
          <a:solidFill>
            <a:srgbClr val="66FFCC">
              <a:alpha val="1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96E3E4D-F3AB-48F4-8E8A-715276256ADD}"/>
              </a:ext>
            </a:extLst>
          </p:cNvPr>
          <p:cNvSpPr txBox="1"/>
          <p:nvPr/>
        </p:nvSpPr>
        <p:spPr>
          <a:xfrm>
            <a:off x="5699760" y="1605751"/>
            <a:ext cx="77014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stine DNA of total template amount 315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Ratio 1:4</a:t>
            </a:r>
          </a:p>
        </p:txBody>
      </p:sp>
    </p:spTree>
    <p:extLst>
      <p:ext uri="{BB962C8B-B14F-4D97-AF65-F5344CB8AC3E}">
        <p14:creationId xmlns:p14="http://schemas.microsoft.com/office/powerpoint/2010/main" val="40781491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21534"/>
    </mc:Choice>
    <mc:Fallback xmlns="">
      <p:transition spd="slow" advTm="21534"/>
    </mc:Fallback>
  </mc:AlternateContent>
  <p:extLst>
    <p:ext uri="{3A86A75C-4F4B-4683-9AE1-C65F6400EC91}">
      <p14:laserTraceLst xmlns:p14="http://schemas.microsoft.com/office/powerpoint/2010/main">
        <p14:tracePtLst>
          <p14:tracePt t="1733" x="12177713" y="3990975"/>
          <p14:tracePt t="1743" x="12150725" y="4008438"/>
          <p14:tracePt t="1747" x="12133263" y="4008438"/>
          <p14:tracePt t="1757" x="12104688" y="4027488"/>
          <p14:tracePt t="1769" x="12063413" y="4040188"/>
          <p14:tracePt t="1773" x="12041188" y="4049713"/>
          <p14:tracePt t="1786" x="12014200" y="4059238"/>
          <p14:tracePt t="1789" x="11995150" y="4068763"/>
          <p14:tracePt t="1797" x="11987213" y="4068763"/>
          <p14:tracePt t="1807" x="11958638" y="4068763"/>
          <p14:tracePt t="1813" x="11953875" y="4068763"/>
          <p14:tracePt t="1824" x="11936413" y="4068763"/>
          <p14:tracePt t="1827" x="11917363" y="4068763"/>
          <p14:tracePt t="1838" x="11890375" y="4068763"/>
          <p14:tracePt t="1847" x="11858625" y="4068763"/>
          <p14:tracePt t="1859" x="11853863" y="4068763"/>
          <p14:tracePt t="1870" x="11836400" y="4068763"/>
          <p14:tracePt t="1878" x="11826875" y="4068763"/>
          <p14:tracePt t="1903" x="11812588" y="4068763"/>
          <p14:tracePt t="2009" x="11804650" y="4068763"/>
          <p14:tracePt t="2015" x="11795125" y="4076700"/>
          <p14:tracePt t="2024" x="11785600" y="4090988"/>
          <p14:tracePt t="2029" x="11766550" y="4100513"/>
          <p14:tracePt t="2039" x="11763375" y="4110038"/>
          <p14:tracePt t="2050" x="11744325" y="4117975"/>
          <p14:tracePt t="2055" x="11734800" y="4127500"/>
          <p14:tracePt t="2066" x="11734800" y="4141788"/>
          <p14:tracePt t="2072" x="11726863" y="4149725"/>
          <p14:tracePt t="2079" x="11726863" y="4168775"/>
          <p14:tracePt t="2091" x="11726863" y="4173538"/>
          <p14:tracePt t="2101" x="11726863" y="4183063"/>
          <p14:tracePt t="2227" x="11722100" y="4183063"/>
          <p14:tracePt t="2236" x="11722100" y="4168775"/>
          <p14:tracePt t="2247" x="11722100" y="4164013"/>
          <p14:tracePt t="2252" x="11722100" y="4146550"/>
          <p14:tracePt t="2268" x="11722100" y="4137025"/>
          <p14:tracePt t="2271" x="11722100" y="4132263"/>
          <p14:tracePt t="2284" x="11722100" y="4122738"/>
          <p14:tracePt t="2291" x="11722100" y="4095750"/>
          <p14:tracePt t="2297" x="11722100" y="4090988"/>
          <p14:tracePt t="2307" x="11722100" y="4081463"/>
          <p14:tracePt t="2313" x="11722100" y="4064000"/>
          <p14:tracePt t="2327" x="11722100" y="4054475"/>
          <p14:tracePt t="2334" x="11722100" y="4040188"/>
          <p14:tracePt t="2338" x="11722100" y="4022725"/>
          <p14:tracePt t="2347" x="11722100" y="4003675"/>
          <p14:tracePt t="2353" x="11722100" y="3995738"/>
          <p14:tracePt t="2363" x="11722100" y="3981450"/>
          <p14:tracePt t="2372" x="11744325" y="3922713"/>
          <p14:tracePt t="2385" x="11753850" y="3913188"/>
          <p14:tracePt t="2387" x="11753850" y="3908425"/>
          <p14:tracePt t="2393" x="11753850" y="3898900"/>
          <p14:tracePt t="2403" x="11753850" y="3881438"/>
          <p14:tracePt t="2412" x="11753850" y="3840163"/>
          <p14:tracePt t="2423" x="11753850" y="3835400"/>
          <p14:tracePt t="2427" x="11753850" y="3825875"/>
          <p14:tracePt t="2435" x="11753850" y="3816350"/>
          <p14:tracePt t="2443" x="11753850" y="3803650"/>
          <p14:tracePt t="2453" x="11763375" y="3771900"/>
          <p14:tracePt t="2458" x="11763375" y="3762375"/>
          <p14:tracePt t="2469" x="11763375" y="3748088"/>
          <p14:tracePt t="2472" x="11763375" y="3730625"/>
          <p14:tracePt t="2485" x="11763375" y="3711575"/>
          <p14:tracePt t="2493" x="11763375" y="3684588"/>
          <p14:tracePt t="2501" x="11763375" y="3675063"/>
          <p14:tracePt t="2508" x="11763375" y="3667125"/>
          <p14:tracePt t="2513" x="11763375" y="3652838"/>
          <p14:tracePt t="2523" x="11763375" y="3643313"/>
          <p14:tracePt t="2535" x="11763375" y="3633788"/>
          <p14:tracePt t="2544" x="11739563" y="3606800"/>
          <p14:tracePt t="2559" x="11739563" y="3602038"/>
          <p14:tracePt t="2567" x="11739563" y="3594100"/>
          <p14:tracePt t="2575" x="11734800" y="3584575"/>
          <p14:tracePt t="2595" x="11726863" y="3565525"/>
          <p14:tracePt t="2605" x="11717338" y="3560763"/>
          <p14:tracePt t="2625" x="11717338" y="3533775"/>
          <p14:tracePt t="2639" x="11698288" y="3516313"/>
          <p14:tracePt t="3069" x="11698288" y="3506788"/>
          <p14:tracePt t="3073" x="11698288" y="3497263"/>
          <p14:tracePt t="3079" x="11707813" y="3487738"/>
          <p14:tracePt t="3089" x="11726863" y="3465513"/>
          <p14:tracePt t="3092" x="11726863" y="3455988"/>
          <p14:tracePt t="3104" x="11744325" y="3438525"/>
          <p14:tracePt t="3113" x="11763375" y="3419475"/>
          <p14:tracePt t="3119" x="11763375" y="3409950"/>
          <p14:tracePt t="3128" x="11771313" y="3402013"/>
          <p14:tracePt t="3135" x="11790363" y="3351213"/>
          <p14:tracePt t="3144" x="11804650" y="3324225"/>
          <p14:tracePt t="3156" x="11812588" y="3251200"/>
          <p14:tracePt t="3158" x="11822113" y="3224213"/>
          <p14:tracePt t="3169" x="11822113" y="3151188"/>
          <p14:tracePt t="3174" x="11836400" y="3078163"/>
          <p14:tracePt t="3185" x="11863388" y="2995613"/>
          <p14:tracePt t="3195" x="11890375" y="2849563"/>
          <p14:tracePt t="3200" x="11890375" y="2808288"/>
          <p14:tracePt t="3208" x="11904663" y="2708275"/>
          <p14:tracePt t="3216" x="11904663" y="2598738"/>
          <p14:tracePt t="3224" x="11904663" y="2452688"/>
          <p14:tracePt t="3235" x="11904663" y="2268538"/>
          <p14:tracePt t="3240" x="11904663" y="2214563"/>
          <p14:tracePt t="3250" x="11904663" y="2141538"/>
          <p14:tracePt t="3255" x="11904663" y="2063750"/>
          <p14:tracePt t="3267" x="11895138" y="1973263"/>
          <p14:tracePt t="3276" x="11880850" y="1895475"/>
          <p14:tracePt t="3285" x="11880850" y="1876425"/>
          <p14:tracePt t="3291" x="11880850" y="1858963"/>
          <p14:tracePt t="3294" x="11872913" y="1839913"/>
          <p14:tracePt t="3305" x="11872913" y="1830388"/>
          <p14:tracePt t="3341" x="11868150" y="1825625"/>
          <p14:tracePt t="3356" x="11849100" y="1825625"/>
          <p14:tracePt t="3367" x="11841163" y="1825625"/>
          <p14:tracePt t="3371" x="11836400" y="1825625"/>
          <p14:tracePt t="3377" x="11826875" y="1825625"/>
          <p14:tracePt t="3387" x="11807825" y="1825625"/>
          <p14:tracePt t="3396" x="11766550" y="1825625"/>
          <p14:tracePt t="3400" x="11749088" y="1825625"/>
          <p14:tracePt t="3411" x="11722100" y="1825625"/>
          <p14:tracePt t="3417" x="11693525" y="1825625"/>
          <p14:tracePt t="3427" x="11661775" y="1825625"/>
          <p14:tracePt t="3438" x="11547475" y="1825625"/>
          <p14:tracePt t="3440" x="11544300" y="1825625"/>
          <p14:tracePt t="3452" x="11493500" y="1825625"/>
          <p14:tracePt t="3457" x="11452225" y="1825625"/>
          <p14:tracePt t="3468" x="11410950" y="1825625"/>
          <p14:tracePt t="3477" x="11342688" y="1825625"/>
          <p14:tracePt t="3485" x="11333163" y="1825625"/>
          <p14:tracePt t="3492" x="11287125" y="1825625"/>
          <p14:tracePt t="3496" x="11228388" y="1830388"/>
          <p14:tracePt t="3506" x="11187113" y="1844675"/>
          <p14:tracePt t="3516" x="11091863" y="1858963"/>
          <p14:tracePt t="3522" x="11072813" y="1866900"/>
          <p14:tracePt t="3533" x="11041063" y="1885950"/>
          <p14:tracePt t="3536" x="10999788" y="1895475"/>
          <p14:tracePt t="3547" x="10968038" y="1908175"/>
          <p14:tracePt t="3556" x="10909300" y="1939925"/>
          <p14:tracePt t="3563" x="10904538" y="1949450"/>
          <p14:tracePt t="3573" x="10885488" y="1958975"/>
          <p14:tracePt t="3577" x="10841038" y="2005013"/>
          <p14:tracePt t="3589" x="10817225" y="2022475"/>
          <p14:tracePt t="3601" x="10768013" y="2114550"/>
          <p14:tracePt t="3604" x="10758488" y="2132013"/>
          <p14:tracePt t="3613" x="10734675" y="2205038"/>
          <p14:tracePt t="3619" x="10721975" y="2278063"/>
          <p14:tracePt t="3629" x="10707688" y="2392363"/>
          <p14:tracePt t="3639" x="10680700" y="2574925"/>
          <p14:tracePt t="3642" x="10680700" y="2616200"/>
          <p14:tracePt t="3653" x="10680700" y="2730500"/>
          <p14:tracePt t="3659" x="10680700" y="2857500"/>
          <p14:tracePt t="3670" x="10680700" y="2968625"/>
          <p14:tracePt t="3679" x="10680700" y="3214688"/>
          <p14:tracePt t="3685" x="10680700" y="3273425"/>
          <p14:tracePt t="3693" x="10690225" y="3402013"/>
          <p14:tracePt t="3700" x="10717213" y="3552825"/>
          <p14:tracePt t="3709" x="10748963" y="3679825"/>
          <p14:tracePt t="3720" x="10775950" y="3867150"/>
          <p14:tracePt t="3725" x="10790238" y="3908425"/>
          <p14:tracePt t="3735" x="10804525" y="4003675"/>
          <p14:tracePt t="3739" x="10804525" y="4059238"/>
          <p14:tracePt t="3749" x="10858500" y="4141788"/>
          <p14:tracePt t="3758" x="10950575" y="4292600"/>
          <p14:tracePt t="3768" x="10950575" y="4300538"/>
          <p14:tracePt t="3775" x="10958513" y="4351338"/>
          <p14:tracePt t="3778" x="10968038" y="4368800"/>
          <p14:tracePt t="3789" x="10977563" y="4424363"/>
          <p14:tracePt t="3800" x="10977563" y="4456113"/>
          <p14:tracePt t="3805" x="10987088" y="4475163"/>
          <p14:tracePt t="3815" x="10999788" y="4516438"/>
          <p14:tracePt t="3821" x="11004550" y="4524375"/>
          <p14:tracePt t="3835" x="11004550" y="4538663"/>
          <p14:tracePt t="3841" x="11031538" y="4611688"/>
          <p14:tracePt t="3844" x="11041063" y="4629150"/>
          <p14:tracePt t="3855" x="11041063" y="4648200"/>
          <p14:tracePt t="3860" x="11050588" y="4679950"/>
          <p14:tracePt t="3871" x="11082338" y="4725988"/>
          <p14:tracePt t="3883" x="11082338" y="4767263"/>
          <p14:tracePt t="3899" x="11104563" y="4803775"/>
          <p14:tracePt t="3903" x="11114088" y="4821238"/>
          <p14:tracePt t="3910" x="11133138" y="4862513"/>
          <p14:tracePt t="3921" x="11169650" y="4913313"/>
          <p14:tracePt t="3934" x="11177588" y="4922838"/>
          <p14:tracePt t="3938" x="11187113" y="4926013"/>
          <p14:tracePt t="3941" x="11223625" y="4945063"/>
          <p14:tracePt t="3950" x="11255375" y="4959350"/>
          <p14:tracePt t="3961" x="11301413" y="4991100"/>
          <p14:tracePt t="3967" x="11315700" y="4991100"/>
          <p14:tracePt t="3977" x="11333163" y="4999038"/>
          <p14:tracePt t="3983" x="11364913" y="5008563"/>
          <p14:tracePt t="3991" x="11383963" y="5008563"/>
          <p14:tracePt t="4000" x="11425238" y="5008563"/>
          <p14:tracePt t="4007" x="11442700" y="5008563"/>
          <p14:tracePt t="4017" x="11447463" y="5018088"/>
          <p14:tracePt t="4022" x="11466513" y="5018088"/>
          <p14:tracePt t="4033" x="11474450" y="5018088"/>
          <p14:tracePt t="4041" x="11503025" y="5018088"/>
          <p14:tracePt t="4048" x="11515725" y="5018088"/>
          <p14:tracePt t="4057" x="11547475" y="5018088"/>
          <p14:tracePt t="4063" x="11588750" y="5018088"/>
          <p14:tracePt t="4073" x="11607800" y="5013325"/>
          <p14:tracePt t="4083" x="11666538" y="4962525"/>
          <p14:tracePt t="4089" x="11676063" y="4959350"/>
          <p14:tracePt t="4097" x="11712575" y="4926013"/>
          <p14:tracePt t="4103" x="11734800" y="4908550"/>
          <p14:tracePt t="4113" x="11766550" y="4876800"/>
          <p14:tracePt t="4123" x="11776075" y="4845050"/>
          <p14:tracePt t="4126" x="11780838" y="4840288"/>
          <p14:tracePt t="4137" x="11799888" y="4821238"/>
          <p14:tracePt t="4143" x="11812588" y="4779963"/>
          <p14:tracePt t="4154" x="11822113" y="4762500"/>
          <p14:tracePt t="4163" x="11831638" y="4743450"/>
          <p14:tracePt t="4184" x="11831638" y="4735513"/>
          <p14:tracePt t="4562" x="11826875" y="4716463"/>
          <p14:tracePt t="4572" x="11795125" y="4716463"/>
          <p14:tracePt t="4583" x="11680825" y="4725988"/>
          <p14:tracePt t="4591" x="11653838" y="4725988"/>
          <p14:tracePt t="4598" x="11566525" y="4738688"/>
          <p14:tracePt t="4606" x="11420475" y="4738688"/>
          <p14:tracePt t="4611" x="11342688" y="4748213"/>
          <p14:tracePt t="4624" x="11055350" y="4803775"/>
          <p14:tracePt t="4627" x="10999788" y="4803775"/>
          <p14:tracePt t="4638" x="10848975" y="4862513"/>
          <p14:tracePt t="4642" x="10721975" y="4862513"/>
          <p14:tracePt t="4653" x="10434638" y="4899025"/>
          <p14:tracePt t="4662" x="9694863" y="4899025"/>
          <p14:tracePt t="4667" x="9529763" y="4899025"/>
          <p14:tracePt t="4678" x="9091613" y="4899025"/>
          <p14:tracePt t="4688" x="8493125" y="4899025"/>
          <p14:tracePt t="4695" x="7862888" y="4899025"/>
          <p14:tracePt t="4706" x="6789738" y="4899025"/>
          <p14:tracePt t="4710" x="6611938" y="4899025"/>
          <p14:tracePt t="4721" x="6132513" y="4845050"/>
          <p14:tracePt t="4724" x="5630863" y="4772025"/>
          <p14:tracePt t="4734" x="5200650" y="4702175"/>
          <p14:tracePt t="4742" x="4638675" y="4524375"/>
          <p14:tracePt t="4750" x="4543425" y="4483100"/>
          <p14:tracePt t="4760" x="4392613" y="4424363"/>
          <p14:tracePt t="4764" x="4260850" y="4378325"/>
          <p14:tracePt t="4774" x="4159250" y="4319588"/>
          <p14:tracePt t="4786" x="4073525" y="4251325"/>
          <p14:tracePt t="4790" x="4064000" y="4232275"/>
          <p14:tracePt t="4805" x="4044950" y="4195763"/>
          <p14:tracePt t="4813" x="4044950" y="4178300"/>
          <p14:tracePt t="4823" x="4044950" y="4122738"/>
          <p14:tracePt t="4828" x="4044950" y="4113213"/>
          <p14:tracePt t="4838" x="4044950" y="4076700"/>
          <p14:tracePt t="4842" x="4044950" y="4037013"/>
          <p14:tracePt t="4854" x="4044950" y="3995738"/>
          <p14:tracePt t="4866" x="4044950" y="3913188"/>
          <p14:tracePt t="4868" x="4044950" y="3894138"/>
          <p14:tracePt t="4880" x="4037013" y="3825875"/>
          <p14:tracePt t="4895" x="4037013" y="3752850"/>
          <p14:tracePt t="4908" x="4037013" y="3684588"/>
          <p14:tracePt t="4911" x="4037013" y="3657600"/>
          <p14:tracePt t="4923" x="4037013" y="3625850"/>
          <p14:tracePt t="4926" x="4037013" y="3606800"/>
          <p14:tracePt t="4937" x="4037013" y="3565525"/>
          <p14:tracePt t="4947" x="4037013" y="3529013"/>
          <p14:tracePt t="4954" x="4037013" y="3521075"/>
          <p14:tracePt t="4960" x="4037013" y="3484563"/>
          <p14:tracePt t="4965" x="4037013" y="3475038"/>
          <p14:tracePt t="4974" x="4037013" y="3460750"/>
          <p14:tracePt t="4985" x="4027488" y="3438525"/>
          <p14:tracePt t="4990" x="4017963" y="3433763"/>
          <p14:tracePt t="5001" x="4000500" y="3406775"/>
          <p14:tracePt t="5005" x="3990975" y="3397250"/>
          <p14:tracePt t="5015" x="3976688" y="3387725"/>
          <p14:tracePt t="5026" x="3898900" y="3351213"/>
          <p14:tracePt t="5032" x="3886200" y="3351213"/>
          <p14:tracePt t="5043" x="3840163" y="3341688"/>
          <p14:tracePt t="5047" x="3798888" y="3319463"/>
          <p14:tracePt t="5057" x="3767138" y="3309938"/>
          <p14:tracePt t="5067" x="3713163" y="3297238"/>
          <p14:tracePt t="5077" x="3694113" y="3297238"/>
          <p14:tracePt t="5084" x="3684588" y="3297238"/>
          <p14:tracePt t="5089" x="3667125" y="3297238"/>
          <p14:tracePt t="5096" x="3648075" y="3278188"/>
          <p14:tracePt t="5106" x="3606800" y="3278188"/>
          <p14:tracePt t="5127" x="3598863" y="3278188"/>
          <p14:tracePt t="5138" x="3584575" y="3278188"/>
          <p14:tracePt t="5170" x="3543300" y="3268663"/>
          <p14:tracePt t="5178" x="3533775" y="3260725"/>
          <p14:tracePt t="5190" x="3516313" y="3236913"/>
          <p14:tracePt t="5203" x="3511550" y="3227388"/>
          <p14:tracePt t="5206" x="3502025" y="3219450"/>
          <p14:tracePt t="5217" x="3492500" y="3200400"/>
          <p14:tracePt t="5226" x="3484563" y="3195638"/>
          <p14:tracePt t="5233" x="3484563" y="3187700"/>
          <p14:tracePt t="5242" x="3475038" y="3159125"/>
          <p14:tracePt t="5246" x="3475038" y="3151188"/>
          <p14:tracePt t="5256" x="3470275" y="3146425"/>
          <p14:tracePt t="5904" x="3470275" y="3168650"/>
          <p14:tracePt t="5911" x="3470275" y="3173413"/>
          <p14:tracePt t="5921" x="3502025" y="3214688"/>
          <p14:tracePt t="5930" x="3602038" y="3300413"/>
          <p14:tracePt t="5937" x="3611563" y="3309938"/>
          <p14:tracePt t="5943" x="3652838" y="3336925"/>
          <p14:tracePt t="5953" x="3735388" y="3406775"/>
          <p14:tracePt t="5960" x="3835400" y="3465513"/>
          <p14:tracePt t="5969" x="3917950" y="3521075"/>
          <p14:tracePt t="5973" x="3944938" y="3538538"/>
          <p14:tracePt t="5983" x="4037013" y="3579813"/>
          <p14:tracePt t="5989" x="4114800" y="3616325"/>
          <p14:tracePt t="5998" x="4195763" y="3670300"/>
          <p14:tracePt t="6008" x="4392613" y="3752850"/>
          <p14:tracePt t="6017" x="4456113" y="3779838"/>
          <p14:tracePt t="6025" x="4602163" y="3808413"/>
          <p14:tracePt t="6028" x="4752975" y="3886200"/>
          <p14:tracePt t="6040" x="4922838" y="3913188"/>
          <p14:tracePt t="6050" x="5210175" y="3967163"/>
          <p14:tracePt t="6055" x="5292725" y="4008438"/>
          <p14:tracePt t="6066" x="5402263" y="4022725"/>
          <p14:tracePt t="6070" x="5570538" y="4054475"/>
          <p14:tracePt t="6079" x="5716588" y="4081463"/>
          <p14:tracePt t="6090" x="6013450" y="4178300"/>
          <p14:tracePt t="6095" x="6076950" y="4186238"/>
          <p14:tracePt t="6106" x="6224588" y="4219575"/>
          <p14:tracePt t="6109" x="6388100" y="4232275"/>
          <p14:tracePt t="6121" x="6538913" y="4278313"/>
          <p14:tracePt t="6133" x="6867525" y="4278313"/>
          <p14:tracePt t="6139" x="6945313" y="4278313"/>
          <p14:tracePt t="6144" x="7164388" y="4278313"/>
          <p14:tracePt t="6151" x="7466013" y="4278313"/>
          <p14:tracePt t="6160" x="7762875" y="4278313"/>
          <p14:tracePt t="6171" x="8356600" y="4278313"/>
          <p14:tracePt t="6174" x="8470900" y="4278313"/>
          <p14:tracePt t="6185" x="8666163" y="4278313"/>
          <p14:tracePt t="6190" x="8848725" y="4278313"/>
          <p14:tracePt t="6202" x="9013825" y="4292600"/>
          <p14:tracePt t="6211" x="9291638" y="4310063"/>
          <p14:tracePt t="6215" x="9351963" y="4310063"/>
          <p14:tracePt t="6225" x="9461500" y="4310063"/>
          <p14:tracePt t="6235" x="9551988" y="4310063"/>
          <p14:tracePt t="6240" x="9625013" y="4310063"/>
          <p14:tracePt t="6251" x="9772650" y="4310063"/>
          <p14:tracePt t="6257" x="9790113" y="4310063"/>
          <p14:tracePt t="6268" x="9845675" y="4310063"/>
          <p14:tracePt t="6271" x="9899650" y="4310063"/>
          <p14:tracePt t="6283" x="9958388" y="4310063"/>
          <p14:tracePt t="6290" x="10031413" y="4310063"/>
          <p14:tracePt t="6297" x="10050463" y="4310063"/>
          <p14:tracePt t="6307" x="10077450" y="4310063"/>
          <p14:tracePt t="6310" x="10109200" y="4310063"/>
          <p14:tracePt t="6322" x="10164763" y="4310063"/>
          <p14:tracePt t="6334" x="10218738" y="4310063"/>
          <p14:tracePt t="6337" x="10247313" y="4310063"/>
          <p14:tracePt t="6347" x="10279063" y="4310063"/>
          <p14:tracePt t="6353" x="10347325" y="4310063"/>
          <p14:tracePt t="6363" x="10388600" y="4310063"/>
          <p14:tracePt t="6373" x="10456863" y="4310063"/>
          <p14:tracePt t="6377" x="10466388" y="4310063"/>
          <p14:tracePt t="6387" x="10502900" y="4310063"/>
          <p14:tracePt t="6393" x="10529888" y="4310063"/>
          <p14:tracePt t="6403" x="10547350" y="4310063"/>
          <p14:tracePt t="6413" x="10575925" y="4310063"/>
          <p14:tracePt t="6423" x="10585450" y="4310063"/>
          <p14:tracePt t="6426" x="10593388" y="4310063"/>
          <p14:tracePt t="6435" x="10602913" y="4310063"/>
          <p14:tracePt t="6443" x="10607675" y="4310063"/>
          <p14:tracePt t="6469" x="10617200" y="4310063"/>
          <p14:tracePt t="6503" x="10625138" y="4310063"/>
          <p14:tracePt t="6509" x="10629900" y="4310063"/>
          <p14:tracePt t="6512" x="10648950" y="4310063"/>
          <p14:tracePt t="6523" x="10658475" y="4310063"/>
          <p14:tracePt t="6535" x="10675938" y="4295775"/>
          <p14:tracePt t="6543" x="10680700" y="4295775"/>
          <p14:tracePt t="6553" x="10707688" y="4295775"/>
          <p14:tracePt t="6570" x="10717213" y="4295775"/>
          <p14:tracePt t="6573" x="10721975" y="4295775"/>
          <p14:tracePt t="6585" x="10731500" y="4295775"/>
          <p14:tracePt t="6595" x="10748963" y="4295775"/>
          <p14:tracePt t="6606" x="10753725" y="4295775"/>
          <p14:tracePt t="6617" x="10790238" y="4295775"/>
          <p14:tracePt t="6625" x="10821988" y="4295775"/>
          <p14:tracePt t="6628" x="10877550" y="4295775"/>
          <p14:tracePt t="6636" x="10895013" y="4295775"/>
          <p14:tracePt t="6645" x="10909300" y="4295775"/>
          <p14:tracePt t="6656" x="10941050" y="4295775"/>
          <p14:tracePt t="6658" x="10968038" y="4295775"/>
          <p14:tracePt t="6669" x="10999788" y="4287838"/>
          <p14:tracePt t="6674" x="11028363" y="4278313"/>
          <p14:tracePt t="6685" x="11050588" y="4268788"/>
          <p14:tracePt t="6694" x="11150600" y="4227513"/>
          <p14:tracePt t="6701" x="11169650" y="4227513"/>
          <p14:tracePt t="6711" x="11210925" y="4227513"/>
          <p14:tracePt t="6717" x="11269663" y="4183063"/>
          <p14:tracePt t="6724" x="11310938" y="4183063"/>
          <p14:tracePt t="6735" x="11398250" y="4146550"/>
          <p14:tracePt t="6741" x="11406188" y="4146550"/>
          <p14:tracePt t="6753" x="11434763" y="4137025"/>
          <p14:tracePt t="6755" x="11461750" y="4113213"/>
          <p14:tracePt t="6768" x="11471275" y="4095750"/>
          <p14:tracePt t="6775" x="11515725" y="4073525"/>
          <p14:tracePt t="6785" x="11525250" y="4073525"/>
          <p14:tracePt t="6791" x="11539538" y="4068763"/>
          <p14:tracePt t="7215" x="11539538" y="4059238"/>
          <p14:tracePt t="7235" x="11503025" y="4059238"/>
          <p14:tracePt t="7239" x="11493500" y="4059238"/>
          <p14:tracePt t="7248" x="11456988" y="4059238"/>
          <p14:tracePt t="7255" x="11430000" y="4059238"/>
          <p14:tracePt t="7268" x="11388725" y="4059238"/>
          <p14:tracePt t="7275" x="11320463" y="4059238"/>
          <p14:tracePt t="7284" x="11310938" y="4059238"/>
          <p14:tracePt t="7291" x="11274425" y="4059238"/>
          <p14:tracePt t="7295" x="11247438" y="4059238"/>
          <p14:tracePt t="7305" x="11214100" y="4059238"/>
          <p14:tracePt t="7318" x="11174413" y="4059238"/>
          <p14:tracePt t="7322" x="11155363" y="4059238"/>
          <p14:tracePt t="7336" x="11123613" y="4059238"/>
          <p14:tracePt t="7345" x="11104563" y="4059238"/>
          <p14:tracePt t="7355" x="11072813" y="4059238"/>
          <p14:tracePt t="7360" x="11060113" y="4059238"/>
          <p14:tracePt t="7372" x="11018838" y="4059238"/>
          <p14:tracePt t="7374" x="10995025" y="4049713"/>
          <p14:tracePt t="7386" x="10982325" y="4049713"/>
          <p14:tracePt t="7397" x="10909300" y="4049713"/>
          <p14:tracePt t="7402" x="10904538" y="4049713"/>
          <p14:tracePt t="7410" x="10877550" y="4049713"/>
          <p14:tracePt t="7418" x="10836275" y="4037013"/>
          <p14:tracePt t="7426" x="10804525" y="4037013"/>
          <p14:tracePt t="7438" x="10748963" y="4037013"/>
          <p14:tracePt t="7440" x="10744200" y="4037013"/>
          <p14:tracePt t="7452" x="10707688" y="4027488"/>
          <p14:tracePt t="7457" x="10690225" y="4027488"/>
          <p14:tracePt t="7468" x="10658475" y="4027488"/>
          <p14:tracePt t="7477" x="10629900" y="4027488"/>
          <p14:tracePt t="7484" x="10621963" y="4027488"/>
          <p14:tracePt t="7490" x="10607675" y="4027488"/>
          <p14:tracePt t="7497" x="10598150" y="4027488"/>
          <p14:tracePt t="7507" x="10580688" y="4027488"/>
          <p14:tracePt t="7518" x="10525125" y="4027488"/>
          <p14:tracePt t="7523" x="10510838" y="4027488"/>
          <p14:tracePt t="7534" x="10502900" y="4027488"/>
          <p14:tracePt t="7537" x="10483850" y="4027488"/>
          <p14:tracePt t="7547" x="10456863" y="4027488"/>
          <p14:tracePt t="7557" x="10425113" y="4027488"/>
          <p14:tracePt t="7563" x="10420350" y="4027488"/>
          <p14:tracePt t="7573" x="10401300" y="4027488"/>
          <p14:tracePt t="7577" x="10374313" y="4027488"/>
          <p14:tracePt t="7588" x="10333038" y="4027488"/>
          <p14:tracePt t="7597" x="10301288" y="4027488"/>
          <p14:tracePt t="7603" x="10296525" y="4027488"/>
          <p14:tracePt t="7613" x="10269538" y="4027488"/>
          <p14:tracePt t="7619" x="10237788" y="4027488"/>
          <p14:tracePt t="7629" x="10182225" y="4027488"/>
          <p14:tracePt t="7639" x="10140950" y="4027488"/>
          <p14:tracePt t="7643" x="10113963" y="4027488"/>
          <p14:tracePt t="7653" x="10096500" y="4027488"/>
          <p14:tracePt t="7659" x="10077450" y="4027488"/>
          <p14:tracePt t="7670" x="10064750" y="4027488"/>
          <p14:tracePt t="7679" x="10023475" y="4027488"/>
          <p14:tracePt t="7689" x="10013950" y="4027488"/>
          <p14:tracePt t="7694" x="10004425" y="4027488"/>
          <p14:tracePt t="7698" x="9994900" y="4027488"/>
          <p14:tracePt t="7709" x="9963150" y="4027488"/>
          <p14:tracePt t="7720" x="9945688" y="4027488"/>
          <p14:tracePt t="7723" x="9936163" y="4027488"/>
          <p14:tracePt t="7735" x="9926638" y="4027488"/>
          <p14:tracePt t="7745" x="9921875" y="4027488"/>
          <p14:tracePt t="7759" x="9913938" y="4027488"/>
          <p14:tracePt t="7866" x="9894888" y="4027488"/>
          <p14:tracePt t="7873" x="9890125" y="4027488"/>
          <p14:tracePt t="8002" x="9899650" y="4027488"/>
          <p14:tracePt t="8012" x="9918700" y="4027488"/>
          <p14:tracePt t="8021" x="9921875" y="4027488"/>
          <p14:tracePt t="8032" x="9931400" y="4027488"/>
          <p14:tracePt t="8040" x="9950450" y="4027488"/>
          <p14:tracePt t="8047" x="9963150" y="4027488"/>
          <p14:tracePt t="8056" x="9972675" y="4027488"/>
          <p14:tracePt t="8060" x="9991725" y="4027488"/>
          <p14:tracePt t="8071" x="10009188" y="4027488"/>
          <p14:tracePt t="8083" x="10077450" y="4027488"/>
          <p14:tracePt t="8088" x="10096500" y="4027488"/>
          <p14:tracePt t="8097" x="10109200" y="4027488"/>
          <p14:tracePt t="8103" x="10140950" y="4027488"/>
          <p14:tracePt t="8112" x="10169525" y="4027488"/>
          <p14:tracePt t="8122" x="10223500" y="4027488"/>
          <p14:tracePt t="8127" x="10242550" y="4027488"/>
          <p14:tracePt t="8137" x="10283825" y="4027488"/>
          <p14:tracePt t="8143" x="10315575" y="4008438"/>
          <p14:tracePt t="8153" x="10342563" y="4008438"/>
          <p14:tracePt t="8163" x="10442575" y="4008438"/>
          <p14:tracePt t="8171" x="10452100" y="4008438"/>
          <p14:tracePt t="8177" x="10498138" y="4008438"/>
          <p14:tracePt t="8184" x="10552113" y="4008438"/>
          <p14:tracePt t="8193" x="10648950" y="4008438"/>
          <p14:tracePt t="8204" x="10721975" y="4008438"/>
          <p14:tracePt t="8208" x="10748963" y="4008438"/>
          <p14:tracePt t="8219" x="10836275" y="4008438"/>
          <p14:tracePt t="8223" x="10877550" y="4008438"/>
          <p14:tracePt t="8235" x="10917238" y="4008438"/>
          <p14:tracePt t="8243" x="10999788" y="4008438"/>
          <p14:tracePt t="8251" x="11018838" y="4008438"/>
          <p14:tracePt t="8259" x="11060113" y="4008438"/>
          <p14:tracePt t="8262" x="11101388" y="4008438"/>
          <p14:tracePt t="8273" x="11128375" y="4013200"/>
          <p14:tracePt t="8284" x="11174413" y="4022725"/>
          <p14:tracePt t="8293" x="11187113" y="4022725"/>
          <p14:tracePt t="8305" x="11196638" y="4022725"/>
          <p14:tracePt t="8483" x="11206163" y="4022725"/>
          <p14:tracePt t="8581" x="11206163" y="4032250"/>
          <p14:tracePt t="8587" x="11201400" y="4032250"/>
          <p14:tracePt t="8597" x="11174413" y="4032250"/>
          <p14:tracePt t="8606" x="11104563" y="4044950"/>
          <p14:tracePt t="8610" x="11096625" y="4044950"/>
          <p14:tracePt t="8621" x="11060113" y="4054475"/>
          <p14:tracePt t="8626" x="11004550" y="4054475"/>
          <p14:tracePt t="8637" x="10926763" y="4068763"/>
          <p14:tracePt t="8647" x="10836275" y="4068763"/>
          <p14:tracePt t="8657" x="10795000" y="4068763"/>
          <p14:tracePt t="8663" x="10753725" y="4068763"/>
          <p14:tracePt t="8668" x="10698163" y="4068763"/>
          <p14:tracePt t="8677" x="10639425" y="4068763"/>
          <p14:tracePt t="8687" x="10515600" y="4068763"/>
          <p14:tracePt t="8693" x="10498138" y="4068763"/>
          <p14:tracePt t="8704" x="10456863" y="4068763"/>
          <p14:tracePt t="8706" x="10401300" y="4068763"/>
          <p14:tracePt t="8718" x="10310813" y="4068763"/>
          <p14:tracePt t="8726" x="10215563" y="4068763"/>
          <p14:tracePt t="8734" x="10201275" y="4068763"/>
          <p14:tracePt t="8742" x="10160000" y="4068763"/>
          <p14:tracePt t="8747" x="10118725" y="4068763"/>
          <p14:tracePt t="8757" x="10086975" y="4068763"/>
          <p14:tracePt t="8768" x="10045700" y="4068763"/>
          <p14:tracePt t="8772" x="10040938" y="4068763"/>
          <p14:tracePt t="8784" x="10023475" y="4068763"/>
          <p14:tracePt t="8789" x="10013950" y="4068763"/>
          <p14:tracePt t="8823" x="9999663" y="4068763"/>
          <p14:tracePt t="8843" x="9991725" y="4068763"/>
          <p14:tracePt t="8854" x="9982200" y="4068763"/>
          <p14:tracePt t="8869" x="9972675" y="4068763"/>
          <p14:tracePt t="8889" x="9967913" y="4068763"/>
          <p14:tracePt t="9112" x="9958388" y="4073525"/>
          <p14:tracePt t="9183" x="9982200" y="4090988"/>
          <p14:tracePt t="9192" x="10023475" y="4090988"/>
          <p14:tracePt t="9201" x="10040938" y="4090988"/>
          <p14:tracePt t="9212" x="10096500" y="4105275"/>
          <p14:tracePt t="9217" x="10104438" y="4105275"/>
          <p14:tracePt t="9228" x="10140950" y="4105275"/>
          <p14:tracePt t="9237" x="10182225" y="4105275"/>
          <p14:tracePt t="9243" x="10210800" y="4105275"/>
          <p14:tracePt t="9253" x="10296525" y="4105275"/>
          <p14:tracePt t="9256" x="10310813" y="4105275"/>
          <p14:tracePt t="9268" x="10383838" y="4105275"/>
          <p14:tracePt t="9272" x="10410825" y="4105275"/>
          <p14:tracePt t="9283" x="10456863" y="4122738"/>
          <p14:tracePt t="9292" x="10483850" y="4122738"/>
          <p14:tracePt t="9296" x="10502900" y="4122738"/>
          <p14:tracePt t="9306" x="10529888" y="4122738"/>
          <p14:tracePt t="9313" x="10547350" y="4122738"/>
          <p14:tracePt t="9323" x="10566400" y="4122738"/>
          <p14:tracePt t="9334" x="10585450" y="4122738"/>
          <p14:tracePt t="9337" x="10588625" y="4122738"/>
          <p14:tracePt t="9347" x="10598150" y="4122738"/>
          <p14:tracePt t="9354" x="10607675" y="4132263"/>
          <p14:tracePt t="9362" x="10621963" y="4132263"/>
          <p14:tracePt t="9373" x="10653713" y="4132263"/>
          <p14:tracePt t="9389" x="10680700" y="4132263"/>
          <p14:tracePt t="9392" x="10690225" y="4132263"/>
          <p14:tracePt t="9409" x="10698163" y="4132263"/>
          <p14:tracePt t="9412" x="10712450" y="4132263"/>
          <p14:tracePt t="9429" x="10721975" y="4132263"/>
          <p14:tracePt t="9434" x="10739438" y="4132263"/>
          <p14:tracePt t="9451" x="10744200" y="4132263"/>
          <p14:tracePt t="9453" x="10763250" y="4132263"/>
          <p14:tracePt t="9469" x="10771188" y="4132263"/>
          <p14:tracePt t="9671" x="10775950" y="4132263"/>
          <p14:tracePt t="9711" x="10785475" y="4132263"/>
          <p14:tracePt t="13019" x="10795000" y="4132263"/>
          <p14:tracePt t="13036" x="10795000" y="4149725"/>
          <p14:tracePt t="13045" x="10795000" y="4178300"/>
          <p14:tracePt t="13051" x="10795000" y="4186238"/>
          <p14:tracePt t="13061" x="10790238" y="4214813"/>
          <p14:tracePt t="13075" x="10790238" y="4219575"/>
          <p14:tracePt t="13086" x="10790238" y="4227513"/>
          <p14:tracePt t="13091" x="10790238" y="4237038"/>
          <p14:tracePt t="13116" x="10790238" y="4256088"/>
          <p14:tracePt t="13132" x="10790238" y="4268788"/>
          <p14:tracePt t="13145" x="10790238" y="4278313"/>
          <p14:tracePt t="13152" x="10790238" y="4287838"/>
          <p14:tracePt t="13161" x="10790238" y="4292600"/>
          <p14:tracePt t="13177" x="10790238" y="4300538"/>
          <p14:tracePt t="13187" x="10790238" y="4329113"/>
          <p14:tracePt t="13211" x="10790238" y="4337050"/>
          <p14:tracePt t="13440" x="10790238" y="4351338"/>
          <p14:tracePt t="13454" x="10780713" y="4360863"/>
          <p14:tracePt t="13465" x="10780713" y="4378325"/>
          <p14:tracePt t="13475" x="10780713" y="4383088"/>
          <p14:tracePt t="13480" x="10771188" y="4419600"/>
          <p14:tracePt t="13490" x="10771188" y="4429125"/>
          <p14:tracePt t="13493" x="10771188" y="4438650"/>
          <p14:tracePt t="13505" x="10763250" y="4465638"/>
          <p14:tracePt t="13519" x="10763250" y="4511675"/>
          <p14:tracePt t="13528" x="10763250" y="4529138"/>
          <p14:tracePt t="13535" x="10763250" y="4533900"/>
          <p14:tracePt t="13544" x="10763250" y="4584700"/>
          <p14:tracePt t="13554" x="10763250" y="4602163"/>
          <p14:tracePt t="13558" x="10763250" y="4621213"/>
          <p14:tracePt t="13571" x="10763250" y="4648200"/>
          <p14:tracePt t="13580" x="10763250" y="4657725"/>
          <p14:tracePt t="13591" x="10763250" y="4670425"/>
          <p14:tracePt t="13602" x="10763250" y="4679950"/>
          <p14:tracePt t="13608" x="10763250" y="4689475"/>
          <p14:tracePt t="13617" x="10763250" y="4694238"/>
          <p14:tracePt t="13624" x="10763250" y="4702175"/>
          <p14:tracePt t="13635" x="10763250" y="4721225"/>
          <p14:tracePt t="13640" x="10763250" y="4738688"/>
          <p14:tracePt t="13654" x="10763250" y="4743450"/>
          <p14:tracePt t="13671" x="10768013" y="4772025"/>
          <p14:tracePt t="13688" x="10768013" y="4779963"/>
          <p14:tracePt t="13692" x="10775950" y="4799013"/>
          <p14:tracePt t="13696" x="10785475" y="4803775"/>
          <p14:tracePt t="13709" x="10795000" y="4821238"/>
          <p14:tracePt t="13715" x="10821988" y="4845050"/>
          <p14:tracePt t="13725" x="10844213" y="4862513"/>
          <p14:tracePt t="13737" x="10848975" y="4862513"/>
          <p14:tracePt t="13746" x="10877550" y="4881563"/>
          <p14:tracePt t="13756" x="10909300" y="4889500"/>
          <p14:tracePt t="13760" x="10936288" y="4899025"/>
          <p14:tracePt t="13770" x="10953750" y="4899025"/>
          <p14:tracePt t="13776" x="10963275" y="4899025"/>
          <p14:tracePt t="13789" x="11009313" y="4899025"/>
          <p14:tracePt t="13805" x="11060113" y="4899025"/>
          <p14:tracePt t="13812" x="11064875" y="4899025"/>
          <p14:tracePt t="13821" x="11072813" y="4899025"/>
          <p14:tracePt t="13828" x="11091863" y="4899025"/>
          <p14:tracePt t="13841" x="11109325" y="4899025"/>
          <p14:tracePt t="13855" x="11133138" y="4899025"/>
          <p14:tracePt t="13863" x="11141075" y="4899025"/>
          <p14:tracePt t="13869" x="11145838" y="4899025"/>
          <p14:tracePt t="13876" x="11155363" y="4899025"/>
          <p14:tracePt t="13884" x="11164888" y="4899025"/>
          <p14:tracePt t="13892" x="11169650" y="4899025"/>
          <p14:tracePt t="13901" x="11187113" y="4899025"/>
          <p14:tracePt t="13918" x="11196638" y="4899025"/>
          <p14:tracePt t="13923" x="11210925" y="4899025"/>
          <p14:tracePt t="13935" x="11218863" y="4899025"/>
          <p14:tracePt t="13937" x="11228388" y="4899025"/>
          <p14:tracePt t="13952" x="11255375" y="4876800"/>
          <p14:tracePt t="13957" x="11274425" y="4876800"/>
          <p14:tracePt t="13963" x="11301413" y="4876800"/>
          <p14:tracePt t="13973" x="11310938" y="4867275"/>
          <p14:tracePt t="13978" x="11315700" y="4862513"/>
          <p14:tracePt t="13989" x="11323638" y="4862513"/>
          <p14:tracePt t="14001" x="11333163" y="4852988"/>
          <p14:tracePt t="14023" x="11352213" y="4845050"/>
          <p14:tracePt t="14034" x="11356975" y="4835525"/>
          <p14:tracePt t="14053" x="11364913" y="4830763"/>
          <p14:tracePt t="14063" x="11374438" y="4811713"/>
          <p14:tracePt t="14070" x="11383963" y="4803775"/>
          <p14:tracePt t="14085" x="11388725" y="4799013"/>
          <p14:tracePt t="14095" x="11398250" y="4789488"/>
          <p14:tracePt t="14100" x="11415713" y="4779963"/>
          <p14:tracePt t="14125" x="11425238" y="4772025"/>
          <p14:tracePt t="14205" x="11430000" y="4772025"/>
          <p14:tracePt t="14215" x="11437938" y="4772025"/>
          <p14:tracePt t="14225" x="11447463" y="4767263"/>
          <p14:tracePt t="14231" x="11452225" y="4767263"/>
          <p14:tracePt t="14245" x="11461750" y="4757738"/>
          <p14:tracePt t="14265" x="11471275" y="4738688"/>
          <p14:tracePt t="14397" x="11479213" y="4730750"/>
          <p14:tracePt t="14487" x="11483975" y="4725988"/>
          <p14:tracePt t="14499" x="11493500" y="4716463"/>
          <p14:tracePt t="14518" x="11503025" y="4716463"/>
          <p14:tracePt t="14538" x="11507788" y="4706938"/>
          <p14:tracePt t="14563" x="11515725" y="4702175"/>
          <p14:tracePt t="14584" x="11525250" y="4694238"/>
          <p14:tracePt t="14629" x="11534775" y="4684713"/>
          <p14:tracePt t="14685" x="11547475" y="4665663"/>
          <p14:tracePt t="14699" x="11557000" y="4662488"/>
          <p14:tracePt t="14729" x="11566525" y="4643438"/>
          <p14:tracePt t="14957" x="11566525" y="4633913"/>
          <p14:tracePt t="14968" x="11566525" y="4625975"/>
          <p14:tracePt t="14977" x="11566525" y="4621213"/>
          <p14:tracePt t="15386" x="11566525" y="4611688"/>
          <p14:tracePt t="15393" x="11544300" y="4611688"/>
          <p14:tracePt t="15401" x="11461750" y="4611688"/>
          <p14:tracePt t="15410" x="11420475" y="4616450"/>
          <p14:tracePt t="15418" x="11250613" y="4633913"/>
          <p14:tracePt t="15424" x="11141075" y="4633913"/>
          <p14:tracePt t="15433" x="11014075" y="4648200"/>
          <p14:tracePt t="15440" x="10917238" y="4662488"/>
          <p14:tracePt t="15444" x="10844213" y="4662488"/>
          <p14:tracePt t="15454" x="10661650" y="4662488"/>
          <p14:tracePt t="15466" x="10588625" y="4675188"/>
          <p14:tracePt t="15472" x="10510838" y="4675188"/>
          <p14:tracePt t="15488" x="10466388" y="4675188"/>
          <p14:tracePt t="15504" x="10401300" y="4675188"/>
          <p14:tracePt t="15509" x="10398125" y="4675188"/>
          <p14:tracePt t="15617" x="10388600" y="4675188"/>
          <p14:tracePt t="15643" x="10379075" y="4675188"/>
          <p14:tracePt t="15657" x="10374313" y="4675188"/>
          <p14:tracePt t="15667" x="10364788" y="4675188"/>
          <p14:tracePt t="15672" x="10356850" y="4675188"/>
          <p14:tracePt t="15684" x="10337800" y="4689475"/>
          <p14:tracePt t="15687" x="10333038" y="4699000"/>
          <p14:tracePt t="15701" x="10315575" y="4699000"/>
          <p14:tracePt t="15709" x="10260013" y="4711700"/>
          <p14:tracePt t="15712" x="10218738" y="4711700"/>
          <p14:tracePt t="15723" x="10160000" y="4735513"/>
          <p14:tracePt t="15729" x="10150475" y="4738688"/>
          <p14:tracePt t="15740" x="10077450" y="4752975"/>
          <p14:tracePt t="15751" x="10013950" y="4789488"/>
          <p14:tracePt t="15754" x="9972675" y="4799013"/>
          <p14:tracePt t="15762" x="9940925" y="4811713"/>
          <p14:tracePt t="15769" x="9913938" y="4821238"/>
          <p14:tracePt t="15778" x="9867900" y="4830763"/>
          <p14:tracePt t="15789" x="9840913" y="4840288"/>
          <p14:tracePt t="15792" x="9831388" y="4848225"/>
          <p14:tracePt t="15925" x="9821863" y="4857750"/>
          <p14:tracePt t="16127" x="9817100" y="4857750"/>
          <p14:tracePt t="16154" x="9809163" y="4857750"/>
          <p14:tracePt t="16168" x="9799638" y="4857750"/>
          <p14:tracePt t="16188" x="9794875" y="4857750"/>
          <p14:tracePt t="16263" x="9785350" y="4857750"/>
          <p14:tracePt t="17532" x="9775825" y="4857750"/>
          <p14:tracePt t="17544" x="9790113" y="4857750"/>
          <p14:tracePt t="17555" x="9817100" y="4857750"/>
          <p14:tracePt t="17558" x="9836150" y="4857750"/>
          <p14:tracePt t="17569" x="9877425" y="4857750"/>
          <p14:tracePt t="17575" x="9894888" y="4857750"/>
          <p14:tracePt t="17585" x="9977438" y="4857750"/>
          <p14:tracePt t="17595" x="10023475" y="4881563"/>
          <p14:tracePt t="17601" x="10055225" y="4889500"/>
          <p14:tracePt t="17608" x="10082213" y="4889500"/>
          <p14:tracePt t="17618" x="10123488" y="4899025"/>
          <p14:tracePt t="17625" x="10155238" y="4908550"/>
          <p14:tracePt t="17635" x="10182225" y="4922838"/>
          <p14:tracePt t="17639" x="10215563" y="4930775"/>
          <p14:tracePt t="17650" x="10223500" y="4930775"/>
          <p14:tracePt t="17655" x="10228263" y="4930775"/>
          <p14:tracePt t="17668" x="10237788" y="4930775"/>
          <p14:tracePt t="17685" x="10274300" y="4930775"/>
          <p14:tracePt t="17695" x="10283825" y="4930775"/>
          <p14:tracePt t="17705" x="10310813" y="4930775"/>
          <p14:tracePt t="17715" x="10325100" y="4930775"/>
          <p14:tracePt t="17721" x="10342563" y="4930775"/>
          <p14:tracePt t="17734" x="10383838" y="4930775"/>
          <p14:tracePt t="17741" x="10437813" y="4930775"/>
          <p14:tracePt t="17745" x="10456863" y="4930775"/>
          <p14:tracePt t="17755" x="10483850" y="4930775"/>
          <p14:tracePt t="17761" x="10515600" y="4930775"/>
          <p14:tracePt t="17771" x="10544175" y="4930775"/>
          <p14:tracePt t="17776" x="10552113" y="4930775"/>
          <p14:tracePt t="17787" x="10612438" y="4930775"/>
          <p14:tracePt t="17800" x="10644188" y="4930775"/>
          <p14:tracePt t="17802" x="10685463" y="4930775"/>
          <p14:tracePt t="17811" x="10702925" y="4926013"/>
          <p14:tracePt t="17818" x="10721975" y="4926013"/>
          <p14:tracePt t="17826" x="10790238" y="4899025"/>
          <p14:tracePt t="17837" x="10831513" y="4899025"/>
          <p14:tracePt t="17841" x="10863263" y="4899025"/>
          <p14:tracePt t="17851" x="10890250" y="4881563"/>
          <p14:tracePt t="17856" x="10922000" y="4881563"/>
          <p14:tracePt t="17868" x="10995025" y="4857750"/>
          <p14:tracePt t="17876" x="10999788" y="4857750"/>
          <p14:tracePt t="17885" x="11018838" y="4857750"/>
          <p14:tracePt t="17903" x="11064875" y="4848225"/>
          <p14:tracePt t="17913" x="11072813" y="4840288"/>
          <p14:tracePt t="19991" x="11082338" y="4840288"/>
          <p14:tracePt t="20002" x="11109325" y="4830763"/>
          <p14:tracePt t="20007" x="11150600" y="4830763"/>
          <p14:tracePt t="20014" x="11155363" y="4830763"/>
          <p14:tracePt t="20022" x="11218863" y="4821238"/>
          <p14:tracePt t="20025" x="11315700" y="4808538"/>
          <p14:tracePt t="20035" x="11374438" y="4779963"/>
          <p14:tracePt t="20046" x="11507788" y="4767263"/>
          <p14:tracePt t="20052" x="11566525" y="4757738"/>
          <p14:tracePt t="20061" x="11676063" y="4738688"/>
          <p14:tracePt t="20068" x="11790363" y="4725988"/>
          <p14:tracePt t="20075" x="11917363" y="4699000"/>
          <p14:tracePt t="20088" x="12104688" y="4652963"/>
          <p14:tracePt t="20091" x="12133263" y="4643438"/>
        </p14:tracePtLst>
      </p14:laserTraceLst>
    </p:ext>
  </p:extLst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7.8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43.6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3.5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7.4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487</Words>
  <Application>Microsoft Office PowerPoint</Application>
  <PresentationFormat>Widescreen</PresentationFormat>
  <Paragraphs>251</Paragraphs>
  <Slides>7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man, Sarah (Assoc)</dc:creator>
  <cp:lastModifiedBy>Riman, Sarah (Assoc)</cp:lastModifiedBy>
  <cp:revision>19</cp:revision>
  <dcterms:created xsi:type="dcterms:W3CDTF">2020-11-13T02:00:42Z</dcterms:created>
  <dcterms:modified xsi:type="dcterms:W3CDTF">2021-08-19T05:09:05Z</dcterms:modified>
</cp:coreProperties>
</file>